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notesSlides/notesSlide2.xml" ContentType="application/vnd.openxmlformats-officedocument.presentationml.notesSlide+xml"/>
  <Override PartName="/ppt/charts/chart16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17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18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19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20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21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22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23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24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25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26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27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28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29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23" r:id="rId2"/>
    <p:sldId id="327" r:id="rId3"/>
  </p:sldIdLst>
  <p:sldSz cx="7562850" cy="10442575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49" userDrawn="1">
          <p15:clr>
            <a:srgbClr val="A4A3A4"/>
          </p15:clr>
        </p15:guide>
        <p15:guide id="2" pos="238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C74F4D"/>
    <a:srgbClr val="8065A0"/>
    <a:srgbClr val="A0BE6B"/>
    <a:srgbClr val="4282BB"/>
    <a:srgbClr val="386131"/>
    <a:srgbClr val="55904A"/>
    <a:srgbClr val="A2C09D"/>
    <a:srgbClr val="A4C19B"/>
    <a:srgbClr val="7EAB6F"/>
    <a:srgbClr val="5A914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795"/>
    <p:restoredTop sz="91866"/>
  </p:normalViewPr>
  <p:slideViewPr>
    <p:cSldViewPr snapToObjects="1">
      <p:cViewPr varScale="1">
        <p:scale>
          <a:sx n="85" d="100"/>
          <a:sy n="85" d="100"/>
        </p:scale>
        <p:origin x="3320" y="192"/>
      </p:cViewPr>
      <p:guideLst>
        <p:guide orient="horz" pos="5149"/>
        <p:guide pos="238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lslawinski\Documents\r&#233;daction%20th&#232;se\18.07.2017%20mesures%20physio%20corrections%202\28.07.2017%20tableau%20ge&#769;ants%20cine&#769;tiques%20valeurs%20DCt%20v&#233;rifi&#233;es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lslawinski\Documents\r&#233;daction%20th&#232;se\18.07.2017%20mesures%20physio%20corrections%202\28.07.2017%20tableau%20ge&#769;ants%20cine&#769;tiques%20valeurs%20DCt%20v&#233;rifi&#233;es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lslawinski\Documents\r&#233;daction%20th&#232;se\18.07.2017%20mesures%20physio%20corrections%202\28.07.2017%20tableau%20ge&#769;ants%20cine&#769;tiques%20valeurs%20DCt%20v&#233;rifi&#233;es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lslawinski\Documents\r&#233;daction%20th&#232;se\18.07.2017%20mesures%20physio%20corrections%202\28.07.2017%20tableau%20ge&#769;ants%20cine&#769;tiques%20valeurs%20DCt%20v&#233;rifi&#233;es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lslawinski\Documents\r&#233;daction%20th&#232;se\18.07.2017%20mesures%20physio%20corrections%202\28.07.2017%20tableau%20ge&#769;ants%20cine&#769;tiques%20valeurs%20DCt%20v&#233;rifi&#233;es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lslawinski\Documents\r&#233;daction%20th&#232;se\18.07.2017%20mesures%20physio%20corrections%202\28.07.2017%20tableau%20ge&#769;ants%20cine&#769;tiques%20valeurs%20DCt%20v&#233;rifi&#233;es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lslawinski\Documents\r&#233;daction%20th&#232;se\18.07.2017%20mesures%20physio%20corrections%202\28.07.2017%20tableau%20ge&#769;ants%20cine&#769;tiques%20valeurs%20DCt%20v&#233;rifi&#233;es.xlsx" TargetMode="Externa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andreebourbouloux\Desktop\Papier%20mutants\2021%20analysis%20MF,%20MS%20Abir%20esl3+col0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andreebourbouloux\Desktop\Papier%20mutants\2021%20analysis%20MF,%20MS%20Abir%20esl3+col0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andreebourbouloux\Desktop\Papier%20mutants\2021%20analysis%20MF,%20MS%20Abir%20esl3+col0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andreebourbouloux\Desktop\Papier%20mutants\2021%20analysis%20MF,%20MS%20Abir%20esl3+col0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lslawinski\Documents\r&#233;daction%20th&#232;se\18.07.2017%20mesures%20physio%20corrections%202\28.07.2017%20tableau%20ge&#769;ants%20cine&#769;tiques%20valeurs%20DCt%20v&#233;rifi&#233;es.xlsx" TargetMode="Externa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andreebourbouloux\Desktop\Papier%20mutants\2021%20analysis%20MF,%20MS%20Abir%20esl3+col0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andreebourbouloux\Desktop\Papier%20mutants\2021%20analysis%20MF,%20MS%20Abir%20esl3+col0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andreebourbouloux\Desktop\Papier%20mutants\2021%20analysis%20MF,%20MS%20Abir%20esl3+col0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andreebourbouloux\Desktop\Papier%20mutants\2021%20analysis%20MF,%20MS%20Abir%20esl3+col0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andreebourbouloux\Desktop\Papier%20mutants\2021%20analysis%20MF,%20MS%20Abir%20esl3+col0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andreebourbouloux\Desktop\Papier%20mutants\2021%20analysis%20MF,%20MS%20Abir%20esl3+col0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andreebourbouloux\Desktop\Papier%20mutants\2021%20analysis%20MF,%20MS%20Abir%20esl3+col0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27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andreebourbouloux\Desktop\Papier%20mutants\2021%20analysis%20MF,%20MS%20Abir%20esl3+col0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28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andreebourbouloux\Desktop\Papier%20mutants\2021%20analysis%20MF,%20MS%20Abir%20esl3+col0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29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andreebourbouloux\Desktop\Papier%20mutants\2021%20analysis%20MF,%20MS%20Abir%20esl3+col0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lslawinski\Documents\r&#233;daction%20th&#232;se\18.07.2017%20mesures%20physio%20corrections%202\28.07.2017%20tableau%20ge&#769;ants%20cine&#769;tiques%20valeurs%20DCt%20v&#233;rifi&#233;es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lslawinski\Documents\r&#233;daction%20th&#232;se\18.07.2017%20mesures%20physio%20corrections%202\28.07.2017%20tableau%20ge&#769;ants%20cine&#769;tiques%20valeurs%20DCt%20v&#233;rifi&#233;es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lslawinski\Documents\r&#233;daction%20th&#232;se\18.07.2017%20mesures%20physio%20corrections%202\28.07.2017%20tableau%20ge&#769;ants%20cine&#769;tiques%20valeurs%20DCt%20v&#233;rifi&#233;es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lslawinski\Documents\r&#233;daction%20th&#232;se\18.07.2017%20mesures%20physio%20corrections%202\28.07.2017%20tableau%20ge&#769;ants%20cine&#769;tiques%20valeurs%20DCt%20v&#233;rifi&#233;es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lslawinski\Documents\r&#233;daction%20th&#232;se\18.07.2017%20mesures%20physio%20corrections%202\28.07.2017%20tableau%20ge&#769;ants%20cine&#769;tiques%20valeurs%20DCt%20v&#233;rifi&#233;es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lslawinski\Documents\r&#233;daction%20th&#232;se\18.07.2017%20mesures%20physio%20corrections%202\28.07.2017%20tableau%20ge&#769;ants%20cine&#769;tiques%20valeurs%20DCt%20v&#233;rifi&#233;es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/C:\Users\lslawinski\Documents\r&#233;daction%20th&#232;se\18.07.2017%20mesures%20physio%20corrections%202\28.07.2017%20tableau%20ge&#769;ants%20cine&#769;tiques%20valeurs%20DCt%20v&#233;rifi&#233;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330473545688863"/>
          <c:y val="0.10475332398633708"/>
          <c:w val="0.77340306793710389"/>
          <c:h val="0.75453831170664232"/>
        </c:manualLayout>
      </c:layout>
      <c:scatterChart>
        <c:scatterStyle val="lineMarker"/>
        <c:varyColors val="0"/>
        <c:ser>
          <c:idx val="0"/>
          <c:order val="0"/>
          <c:tx>
            <c:v>Col0</c:v>
          </c:tx>
          <c:spPr>
            <a:ln w="63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bg1">
                  <a:lumMod val="50000"/>
                </a:schemeClr>
              </a:solidFill>
              <a:ln w="9525">
                <a:solidFill>
                  <a:schemeClr val="bg1">
                    <a:lumMod val="50000"/>
                  </a:schemeClr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Col0!$G$29,Col0!$G$57,Col0!$G$85,Col0!$G$113,Col0!$G$141,Col0!$G$169,Col0!$G$197,Col0!$G$225,Col0!$G$253,Col0!$G$269,Col0!$G$285,Col0!$G$313)</c:f>
                <c:numCache>
                  <c:formatCode>General</c:formatCode>
                  <c:ptCount val="12"/>
                  <c:pt idx="0">
                    <c:v>4.4264163272596602E-3</c:v>
                  </c:pt>
                  <c:pt idx="1">
                    <c:v>1.0077224171347101E-2</c:v>
                  </c:pt>
                  <c:pt idx="2">
                    <c:v>1.55266763595717E-2</c:v>
                  </c:pt>
                  <c:pt idx="3">
                    <c:v>1.5088904977478499E-2</c:v>
                  </c:pt>
                  <c:pt idx="4">
                    <c:v>3.4515137089688702E-2</c:v>
                  </c:pt>
                  <c:pt idx="5">
                    <c:v>2.6949565482428699E-2</c:v>
                  </c:pt>
                  <c:pt idx="6">
                    <c:v>2.3611368684649098E-2</c:v>
                  </c:pt>
                  <c:pt idx="7">
                    <c:v>2.3618231461200099E-2</c:v>
                  </c:pt>
                  <c:pt idx="8">
                    <c:v>3.5426768485011903E-2</c:v>
                  </c:pt>
                  <c:pt idx="11">
                    <c:v>2.8714944175862199E-2</c:v>
                  </c:pt>
                </c:numCache>
              </c:numRef>
            </c:plus>
            <c:minus>
              <c:numRef>
                <c:f>(Col0!$G$29,Col0!$G$57,Col0!$G$85,Col0!$G$113,Col0!$G$141,Col0!$G$169,Col0!$G$197,Col0!$G$225,Col0!$G$253,Col0!$G$269,Col0!$G$285,Col0!$G$313)</c:f>
                <c:numCache>
                  <c:formatCode>General</c:formatCode>
                  <c:ptCount val="12"/>
                  <c:pt idx="0">
                    <c:v>4.4264163272596602E-3</c:v>
                  </c:pt>
                  <c:pt idx="1">
                    <c:v>1.0077224171347101E-2</c:v>
                  </c:pt>
                  <c:pt idx="2">
                    <c:v>1.55266763595717E-2</c:v>
                  </c:pt>
                  <c:pt idx="3">
                    <c:v>1.5088904977478499E-2</c:v>
                  </c:pt>
                  <c:pt idx="4">
                    <c:v>3.4515137089688702E-2</c:v>
                  </c:pt>
                  <c:pt idx="5">
                    <c:v>2.6949565482428699E-2</c:v>
                  </c:pt>
                  <c:pt idx="6">
                    <c:v>2.3611368684649098E-2</c:v>
                  </c:pt>
                  <c:pt idx="7">
                    <c:v>2.3618231461200099E-2</c:v>
                  </c:pt>
                  <c:pt idx="8">
                    <c:v>3.5426768485011903E-2</c:v>
                  </c:pt>
                  <c:pt idx="11">
                    <c:v>2.871494417586219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(Col0!$C$3,Col0!$C$31,Col0!$C$59,Col0!$C$87,Col0!$C$115,Col0!$C$143,Col0!$C$171,Col0!$C$199,Col0!$C$227,Col0!$C$255,Col0!$C$271,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Col0!$G$28,Col0!$G$56,Col0!$G$84,Col0!$G$112,Col0!$G$140,Col0!$G$168,Col0!$G$196,Col0!$G$224,Col0!$G$252,Col0!$G$268,Col0!$G$284,Col0!$G$312)</c:f>
              <c:numCache>
                <c:formatCode>0.000</c:formatCode>
                <c:ptCount val="12"/>
                <c:pt idx="0">
                  <c:v>1.53172581246333E-2</c:v>
                </c:pt>
                <c:pt idx="1">
                  <c:v>2.6186327924194099E-2</c:v>
                </c:pt>
                <c:pt idx="2">
                  <c:v>4.8260169605818602E-2</c:v>
                </c:pt>
                <c:pt idx="3">
                  <c:v>5.8869656435973798E-2</c:v>
                </c:pt>
                <c:pt idx="4">
                  <c:v>8.0018759128901606E-2</c:v>
                </c:pt>
                <c:pt idx="5">
                  <c:v>9.9880940969897594E-2</c:v>
                </c:pt>
                <c:pt idx="6">
                  <c:v>0.105166444626532</c:v>
                </c:pt>
                <c:pt idx="7">
                  <c:v>0.12647814382266601</c:v>
                </c:pt>
                <c:pt idx="8">
                  <c:v>0.13524547477964899</c:v>
                </c:pt>
                <c:pt idx="9">
                  <c:v>0.16126877268527801</c:v>
                </c:pt>
                <c:pt idx="10">
                  <c:v>0.19516125440953</c:v>
                </c:pt>
                <c:pt idx="11">
                  <c:v>0.200713513356424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9CA-D548-9B66-83F2BA232001}"/>
            </c:ext>
          </c:extLst>
        </c:ser>
        <c:ser>
          <c:idx val="1"/>
          <c:order val="1"/>
          <c:tx>
            <c:v>at1g08920</c:v>
          </c:tx>
          <c:spPr>
            <a:ln w="6350" cap="rnd">
              <a:solidFill>
                <a:schemeClr val="accent2"/>
              </a:solidFill>
              <a:round/>
            </a:ln>
            <a:effectLst/>
          </c:spPr>
          <c:marker>
            <c:symbol val="x"/>
            <c:size val="4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8920'!$G$29,'08920'!$G$57,'08920'!$G$85,'08920'!$G$113,'08920'!$G$141,'08920'!$G$169,'08920'!$G$197,'08920'!$G$225,'08920'!$G$253,'08920'!$G$276,'08920'!$G$299,'08920'!$G$327)</c:f>
                <c:numCache>
                  <c:formatCode>General</c:formatCode>
                  <c:ptCount val="12"/>
                  <c:pt idx="0">
                    <c:v>3.9686518723274101E-3</c:v>
                  </c:pt>
                  <c:pt idx="1">
                    <c:v>8.1380235301957201E-3</c:v>
                  </c:pt>
                  <c:pt idx="2">
                    <c:v>1.5529773288283999E-2</c:v>
                  </c:pt>
                  <c:pt idx="3">
                    <c:v>2.1760841412231498E-2</c:v>
                  </c:pt>
                  <c:pt idx="4">
                    <c:v>1.3989081667517901E-2</c:v>
                  </c:pt>
                  <c:pt idx="5">
                    <c:v>1.7103682878875998E-2</c:v>
                  </c:pt>
                  <c:pt idx="6">
                    <c:v>2.0694975999196299E-2</c:v>
                  </c:pt>
                  <c:pt idx="7">
                    <c:v>2.5680921372712499E-2</c:v>
                  </c:pt>
                  <c:pt idx="8">
                    <c:v>3.2251065033808202E-2</c:v>
                  </c:pt>
                  <c:pt idx="9">
                    <c:v>5.4557414825638702E-2</c:v>
                  </c:pt>
                  <c:pt idx="10">
                    <c:v>5.0643321692672501E-2</c:v>
                  </c:pt>
                  <c:pt idx="11">
                    <c:v>3.9067448939214301E-2</c:v>
                  </c:pt>
                </c:numCache>
              </c:numRef>
            </c:plus>
            <c:minus>
              <c:numRef>
                <c:f>('08920'!$G$29,'08920'!$G$57,'08920'!$G$85,'08920'!$G$113,'08920'!$G$141,'08920'!$G$169,'08920'!$G$197,'08920'!$G$225,'08920'!$G$253,'08920'!$G$276,'08920'!$G$299,'08920'!$G$327)</c:f>
                <c:numCache>
                  <c:formatCode>General</c:formatCode>
                  <c:ptCount val="12"/>
                  <c:pt idx="0">
                    <c:v>3.9686518723274101E-3</c:v>
                  </c:pt>
                  <c:pt idx="1">
                    <c:v>8.1380235301957201E-3</c:v>
                  </c:pt>
                  <c:pt idx="2">
                    <c:v>1.5529773288283999E-2</c:v>
                  </c:pt>
                  <c:pt idx="3">
                    <c:v>2.1760841412231498E-2</c:v>
                  </c:pt>
                  <c:pt idx="4">
                    <c:v>1.3989081667517901E-2</c:v>
                  </c:pt>
                  <c:pt idx="5">
                    <c:v>1.7103682878875998E-2</c:v>
                  </c:pt>
                  <c:pt idx="6">
                    <c:v>2.0694975999196299E-2</c:v>
                  </c:pt>
                  <c:pt idx="7">
                    <c:v>2.5680921372712499E-2</c:v>
                  </c:pt>
                  <c:pt idx="8">
                    <c:v>3.2251065033808202E-2</c:v>
                  </c:pt>
                  <c:pt idx="9">
                    <c:v>5.4557414825638702E-2</c:v>
                  </c:pt>
                  <c:pt idx="10">
                    <c:v>5.0643321692672501E-2</c:v>
                  </c:pt>
                  <c:pt idx="11">
                    <c:v>3.9067448939214301E-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Col0!$C$3,Col0!$C$31,Col0!$C$59,Col0!$C$87,Col0!$C$115,Col0!$C$143,Col0!$C$171,Col0!$C$199,Col0!$C$227,Col0!$C$255,Col0!$C$271,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'08920'!$G$28,'08920'!$G$56,'08920'!$G$84,'08920'!$G$112,'08920'!$G$140,'08920'!$G$168,'08920'!$G$196,'08920'!$G$224,'08920'!$G$252,'08920'!$G$275,'08920'!$G$298,'08920'!$G$326)</c:f>
              <c:numCache>
                <c:formatCode>0.000</c:formatCode>
                <c:ptCount val="12"/>
                <c:pt idx="0">
                  <c:v>1.2069622764293899E-2</c:v>
                </c:pt>
                <c:pt idx="1">
                  <c:v>2.4911555097152399E-2</c:v>
                </c:pt>
                <c:pt idx="2">
                  <c:v>4.5336729002273299E-2</c:v>
                </c:pt>
                <c:pt idx="3">
                  <c:v>5.8900363420305302E-2</c:v>
                </c:pt>
                <c:pt idx="4">
                  <c:v>8.0784021743158102E-2</c:v>
                </c:pt>
                <c:pt idx="5">
                  <c:v>9.0658049613285802E-2</c:v>
                </c:pt>
                <c:pt idx="6">
                  <c:v>0.102727365669805</c:v>
                </c:pt>
                <c:pt idx="7">
                  <c:v>0.112709567307827</c:v>
                </c:pt>
                <c:pt idx="8">
                  <c:v>0.13356389568455501</c:v>
                </c:pt>
                <c:pt idx="9">
                  <c:v>0.16491901173144399</c:v>
                </c:pt>
                <c:pt idx="10">
                  <c:v>0.176772623840803</c:v>
                </c:pt>
                <c:pt idx="11">
                  <c:v>0.22453642577422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39CA-D548-9B66-83F2BA232001}"/>
            </c:ext>
          </c:extLst>
        </c:ser>
        <c:ser>
          <c:idx val="2"/>
          <c:order val="2"/>
          <c:tx>
            <c:v>at1g75220</c:v>
          </c:tx>
          <c:spPr>
            <a:ln w="6350" cap="rnd">
              <a:solidFill>
                <a:schemeClr val="accent3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75220'!$G$29,'75220'!$G$57,'75220'!$G$85,'75220'!$G$113,'75220'!$G$141,'75220'!$G$169,'75220'!$G$197,'75220'!$G$225,'75220'!$G$253,'75220'!$G$276,'75220'!$G$299,'75220'!$G$327)</c:f>
                <c:numCache>
                  <c:formatCode>General</c:formatCode>
                  <c:ptCount val="12"/>
                  <c:pt idx="0">
                    <c:v>7.0867635286332303E-3</c:v>
                  </c:pt>
                  <c:pt idx="1">
                    <c:v>1.02280984759518E-2</c:v>
                  </c:pt>
                  <c:pt idx="2">
                    <c:v>1.5365103880252E-2</c:v>
                  </c:pt>
                  <c:pt idx="3">
                    <c:v>2.0884526441342401E-2</c:v>
                  </c:pt>
                  <c:pt idx="4">
                    <c:v>1.91105177475022E-2</c:v>
                  </c:pt>
                  <c:pt idx="5">
                    <c:v>2.4068208988931999E-2</c:v>
                  </c:pt>
                  <c:pt idx="6">
                    <c:v>3.4171367194557802E-2</c:v>
                  </c:pt>
                  <c:pt idx="7">
                    <c:v>4.2049837337053399E-2</c:v>
                  </c:pt>
                  <c:pt idx="8">
                    <c:v>4.6804934452515899E-2</c:v>
                  </c:pt>
                  <c:pt idx="9">
                    <c:v>5.2569979180074E-2</c:v>
                  </c:pt>
                  <c:pt idx="10">
                    <c:v>4.8018799241955297E-2</c:v>
                  </c:pt>
                  <c:pt idx="11">
                    <c:v>6.5281599474246096E-2</c:v>
                  </c:pt>
                </c:numCache>
              </c:numRef>
            </c:plus>
            <c:minus>
              <c:numRef>
                <c:f>('75220'!$G$29,'75220'!$G$57,'75220'!$G$85,'75220'!$G$113,'75220'!$G$141,'75220'!$G$169,'75220'!$G$197,'75220'!$G$225,'75220'!$G$253,'75220'!$G$276,'75220'!$G$299,'75220'!$G$327)</c:f>
                <c:numCache>
                  <c:formatCode>General</c:formatCode>
                  <c:ptCount val="12"/>
                  <c:pt idx="0">
                    <c:v>7.0867635286332303E-3</c:v>
                  </c:pt>
                  <c:pt idx="1">
                    <c:v>1.02280984759518E-2</c:v>
                  </c:pt>
                  <c:pt idx="2">
                    <c:v>1.5365103880252E-2</c:v>
                  </c:pt>
                  <c:pt idx="3">
                    <c:v>2.0884526441342401E-2</c:v>
                  </c:pt>
                  <c:pt idx="4">
                    <c:v>1.91105177475022E-2</c:v>
                  </c:pt>
                  <c:pt idx="5">
                    <c:v>2.4068208988931999E-2</c:v>
                  </c:pt>
                  <c:pt idx="6">
                    <c:v>3.4171367194557802E-2</c:v>
                  </c:pt>
                  <c:pt idx="7">
                    <c:v>4.2049837337053399E-2</c:v>
                  </c:pt>
                  <c:pt idx="8">
                    <c:v>4.6804934452515899E-2</c:v>
                  </c:pt>
                  <c:pt idx="9">
                    <c:v>5.2569979180074E-2</c:v>
                  </c:pt>
                  <c:pt idx="10">
                    <c:v>4.8018799241955297E-2</c:v>
                  </c:pt>
                  <c:pt idx="11">
                    <c:v>6.5281599474246096E-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[1]Col0!$C$3,[1]Col0!$C$31,[1]Col0!$C$59,[1]Col0!$C$87,[1]Col0!$C$115,[1]Col0!$C$143,[1]Col0!$C$171,[1]Col0!$C$199,[1]Col0!$C$227,[1]Col0!$C$255,[1]Col0!$C$271,[1]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'75220'!$G$28,'75220'!$G$56,'75220'!$G$84,'75220'!$G$112,'75220'!$G$140,'75220'!$G$168,'75220'!$G$196,'75220'!$G$224,'75220'!$G$252,'75220'!$G$275,'75220'!$G$298,'75220'!$G$326)</c:f>
              <c:numCache>
                <c:formatCode>0.000</c:formatCode>
                <c:ptCount val="12"/>
                <c:pt idx="0">
                  <c:v>1.3958631274406001E-2</c:v>
                </c:pt>
                <c:pt idx="1">
                  <c:v>2.1602951515008899E-2</c:v>
                </c:pt>
                <c:pt idx="2">
                  <c:v>3.9236128379668403E-2</c:v>
                </c:pt>
                <c:pt idx="3">
                  <c:v>6.3105693332005497E-2</c:v>
                </c:pt>
                <c:pt idx="4">
                  <c:v>7.8329672116332905E-2</c:v>
                </c:pt>
                <c:pt idx="5">
                  <c:v>9.0452134816629795E-2</c:v>
                </c:pt>
                <c:pt idx="6">
                  <c:v>9.7593319208460497E-2</c:v>
                </c:pt>
                <c:pt idx="7">
                  <c:v>0.115548536079908</c:v>
                </c:pt>
                <c:pt idx="8">
                  <c:v>0.124423280741098</c:v>
                </c:pt>
                <c:pt idx="9">
                  <c:v>0.157728834694253</c:v>
                </c:pt>
                <c:pt idx="10">
                  <c:v>0.17468951580108599</c:v>
                </c:pt>
                <c:pt idx="11">
                  <c:v>0.182542597218377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39CA-D548-9B66-83F2BA232001}"/>
            </c:ext>
          </c:extLst>
        </c:ser>
        <c:ser>
          <c:idx val="3"/>
          <c:order val="3"/>
          <c:tx>
            <c:v>at3g04760</c:v>
          </c:tx>
          <c:spPr>
            <a:ln w="6350" cap="rnd">
              <a:solidFill>
                <a:schemeClr val="accent4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accent4"/>
              </a:solidFill>
              <a:ln w="6350">
                <a:solidFill>
                  <a:schemeClr val="accent4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4760'!$G$29,'04760'!$G$57,'04760'!$G$85,'04760'!$G$113,'04760'!$G$141,'04760'!$G$169,'04760'!$G$197,'04760'!$G$225,'04760'!$G$253,'04760'!$G$276,'04760'!$G$299,'04760'!$G$327)</c:f>
                <c:numCache>
                  <c:formatCode>General</c:formatCode>
                  <c:ptCount val="12"/>
                  <c:pt idx="0">
                    <c:v>3.94521541984933E-3</c:v>
                  </c:pt>
                  <c:pt idx="1">
                    <c:v>8.7287872120236296E-3</c:v>
                  </c:pt>
                  <c:pt idx="2">
                    <c:v>1.75531300496258E-2</c:v>
                  </c:pt>
                  <c:pt idx="3">
                    <c:v>2.9125256133429801E-2</c:v>
                  </c:pt>
                  <c:pt idx="4">
                    <c:v>1.7331835730980402E-2</c:v>
                  </c:pt>
                  <c:pt idx="5">
                    <c:v>1.87692526614812E-2</c:v>
                  </c:pt>
                  <c:pt idx="6">
                    <c:v>2.8680206029259501E-2</c:v>
                  </c:pt>
                  <c:pt idx="7">
                    <c:v>2.67799611066393E-2</c:v>
                  </c:pt>
                  <c:pt idx="8">
                    <c:v>3.3097465665281399E-2</c:v>
                  </c:pt>
                  <c:pt idx="9">
                    <c:v>3.7203317325369099E-2</c:v>
                  </c:pt>
                  <c:pt idx="10">
                    <c:v>5.45686090319355E-2</c:v>
                  </c:pt>
                  <c:pt idx="11">
                    <c:v>5.85260160535453E-2</c:v>
                  </c:pt>
                </c:numCache>
              </c:numRef>
            </c:plus>
            <c:minus>
              <c:numRef>
                <c:f>('04760'!$G$29,'04760'!$G$57,'04760'!$G$85,'04760'!$G$113,'04760'!$G$141,'04760'!$G$169,'04760'!$G$197,'04760'!$G$225,'04760'!$G$253,'04760'!$G$276,'04760'!$G$299,'04760'!$G$327)</c:f>
                <c:numCache>
                  <c:formatCode>General</c:formatCode>
                  <c:ptCount val="12"/>
                  <c:pt idx="0">
                    <c:v>3.94521541984933E-3</c:v>
                  </c:pt>
                  <c:pt idx="1">
                    <c:v>8.7287872120236296E-3</c:v>
                  </c:pt>
                  <c:pt idx="2">
                    <c:v>1.75531300496258E-2</c:v>
                  </c:pt>
                  <c:pt idx="3">
                    <c:v>2.9125256133429801E-2</c:v>
                  </c:pt>
                  <c:pt idx="4">
                    <c:v>1.7331835730980402E-2</c:v>
                  </c:pt>
                  <c:pt idx="5">
                    <c:v>1.87692526614812E-2</c:v>
                  </c:pt>
                  <c:pt idx="6">
                    <c:v>2.8680206029259501E-2</c:v>
                  </c:pt>
                  <c:pt idx="7">
                    <c:v>2.67799611066393E-2</c:v>
                  </c:pt>
                  <c:pt idx="8">
                    <c:v>3.3097465665281399E-2</c:v>
                  </c:pt>
                  <c:pt idx="9">
                    <c:v>3.7203317325369099E-2</c:v>
                  </c:pt>
                  <c:pt idx="10">
                    <c:v>5.45686090319355E-2</c:v>
                  </c:pt>
                  <c:pt idx="11">
                    <c:v>5.85260160535453E-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Col0!$C$3,Col0!$C$31,Col0!$C$59,Col0!$C$87,Col0!$C$115,Col0!$C$143,Col0!$C$171,Col0!$C$199,Col0!$C$227,Col0!$C$255,Col0!$C$271,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'04760'!$G$28,'04760'!$G$56,'04760'!$G$84,'04760'!$G$112,'04760'!$G$140,'04760'!$G$168,'04760'!$G$196,'04760'!$G$224,'04760'!$G$252,'04760'!$G$275,'04760'!$G$298,'04760'!$G$326)</c:f>
              <c:numCache>
                <c:formatCode>0.000</c:formatCode>
                <c:ptCount val="12"/>
                <c:pt idx="0">
                  <c:v>9.9575797310491806E-3</c:v>
                </c:pt>
                <c:pt idx="1">
                  <c:v>2.29535207609773E-2</c:v>
                </c:pt>
                <c:pt idx="2">
                  <c:v>4.07321987234876E-2</c:v>
                </c:pt>
                <c:pt idx="3">
                  <c:v>5.1256185319480403E-2</c:v>
                </c:pt>
                <c:pt idx="4">
                  <c:v>6.1756655354120699E-2</c:v>
                </c:pt>
                <c:pt idx="5">
                  <c:v>6.6064636661242002E-2</c:v>
                </c:pt>
                <c:pt idx="6">
                  <c:v>8.5709832063680796E-2</c:v>
                </c:pt>
                <c:pt idx="7">
                  <c:v>0.101023458182656</c:v>
                </c:pt>
                <c:pt idx="8">
                  <c:v>0.119311928614784</c:v>
                </c:pt>
                <c:pt idx="9">
                  <c:v>0.13843023777503899</c:v>
                </c:pt>
                <c:pt idx="10">
                  <c:v>0.14627474738555499</c:v>
                </c:pt>
                <c:pt idx="11">
                  <c:v>0.1595773076473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39CA-D548-9B66-83F2BA2320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90470168"/>
        <c:axId val="804937592"/>
      </c:scatterChart>
      <c:valAx>
        <c:axId val="790470168"/>
        <c:scaling>
          <c:orientation val="minMax"/>
          <c:max val="51"/>
          <c:min val="35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04937592"/>
        <c:crosses val="autoZero"/>
        <c:crossBetween val="midCat"/>
        <c:majorUnit val="1"/>
      </c:valAx>
      <c:valAx>
        <c:axId val="804937592"/>
        <c:scaling>
          <c:orientation val="minMax"/>
          <c:max val="0.30000000000000004"/>
          <c:min val="0"/>
        </c:scaling>
        <c:delete val="0"/>
        <c:axPos val="l"/>
        <c:majorGridlines>
          <c:spPr>
            <a:ln w="6350">
              <a:solidFill>
                <a:schemeClr val="bg1">
                  <a:lumMod val="85000"/>
                </a:schemeClr>
              </a:solidFill>
            </a:ln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fr-FR" sz="1200" b="0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W (g)</a:t>
                </a:r>
                <a:endParaRPr lang="fr-FR" sz="1200" b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4398137991981258E-2"/>
              <c:y val="0.285193375206305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.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790470168"/>
        <c:crossesAt val="0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91516436932935"/>
          <c:y val="6.9820658655536633E-2"/>
          <c:w val="0.7227306906667843"/>
          <c:h val="0.7839550031660385"/>
        </c:manualLayout>
      </c:layout>
      <c:scatterChart>
        <c:scatterStyle val="lineMarker"/>
        <c:varyColors val="0"/>
        <c:ser>
          <c:idx val="0"/>
          <c:order val="0"/>
          <c:tx>
            <c:v>Col0</c:v>
          </c:tx>
          <c:spPr>
            <a:ln w="63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Col0!$F$29,Col0!$F$369,Col0!$F$397,Col0!$F$425,Col0!$F$453,Col0!$F$481,Col0!$F$509,Col0!$F$537,Col0!$F$565,Col0!$F$581,Col0!$F$597,Col0!$F$620)</c:f>
                <c:numCache>
                  <c:formatCode>General</c:formatCode>
                  <c:ptCount val="12"/>
                  <c:pt idx="0">
                    <c:v>6.8129549101544298E-2</c:v>
                  </c:pt>
                  <c:pt idx="1">
                    <c:v>0.164953440957186</c:v>
                  </c:pt>
                  <c:pt idx="2">
                    <c:v>0.318328288027248</c:v>
                  </c:pt>
                  <c:pt idx="3">
                    <c:v>0.19078983284249701</c:v>
                  </c:pt>
                  <c:pt idx="4">
                    <c:v>0.353104686861405</c:v>
                  </c:pt>
                  <c:pt idx="5">
                    <c:v>0.24069635842301901</c:v>
                  </c:pt>
                  <c:pt idx="6">
                    <c:v>0.363713869445905</c:v>
                  </c:pt>
                  <c:pt idx="7">
                    <c:v>0.21162954892253</c:v>
                  </c:pt>
                  <c:pt idx="8">
                    <c:v>0.18681480351747501</c:v>
                  </c:pt>
                  <c:pt idx="11">
                    <c:v>0.27051725942570398</c:v>
                  </c:pt>
                </c:numCache>
              </c:numRef>
            </c:plus>
            <c:minus>
              <c:numRef>
                <c:f>(Col0!$F$29,Col0!$F$369,Col0!$F$397,Col0!$F$425,Col0!$F$453,Col0!$F$481,Col0!$F$509,Col0!$F$537,Col0!$F$565,Col0!$F$581,Col0!$F$597,Col0!$F$620)</c:f>
                <c:numCache>
                  <c:formatCode>General</c:formatCode>
                  <c:ptCount val="12"/>
                  <c:pt idx="0">
                    <c:v>6.8129549101544298E-2</c:v>
                  </c:pt>
                  <c:pt idx="1">
                    <c:v>0.164953440957186</c:v>
                  </c:pt>
                  <c:pt idx="2">
                    <c:v>0.318328288027248</c:v>
                  </c:pt>
                  <c:pt idx="3">
                    <c:v>0.19078983284249701</c:v>
                  </c:pt>
                  <c:pt idx="4">
                    <c:v>0.353104686861405</c:v>
                  </c:pt>
                  <c:pt idx="5">
                    <c:v>0.24069635842301901</c:v>
                  </c:pt>
                  <c:pt idx="6">
                    <c:v>0.363713869445905</c:v>
                  </c:pt>
                  <c:pt idx="7">
                    <c:v>0.21162954892253</c:v>
                  </c:pt>
                  <c:pt idx="8">
                    <c:v>0.18681480351747501</c:v>
                  </c:pt>
                  <c:pt idx="11">
                    <c:v>0.27051725942570398</c:v>
                  </c:pt>
                </c:numCache>
              </c:numRef>
            </c:minus>
            <c:spPr>
              <a:ln w="6350"/>
            </c:spPr>
          </c:errBars>
          <c:xVal>
            <c:numRef>
              <c:f>(Col0!$C$2,Col0!$C$30,Col0!$C$58,Col0!$C$86,Col0!$C$114)</c:f>
              <c:numCache>
                <c:formatCode>General</c:formatCode>
                <c:ptCount val="5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</c:numCache>
            </c:numRef>
          </c:xVal>
          <c:yVal>
            <c:numRef>
              <c:f>(Col0!$F$28,Col0!$F$368,Col0!$F$396,Col0!$F$424,Col0!$F$452)</c:f>
              <c:numCache>
                <c:formatCode>0.000</c:formatCode>
                <c:ptCount val="5"/>
                <c:pt idx="0">
                  <c:v>0.25528777238508799</c:v>
                </c:pt>
                <c:pt idx="1">
                  <c:v>0.42823229183370898</c:v>
                </c:pt>
                <c:pt idx="2">
                  <c:v>0.70133841441789302</c:v>
                </c:pt>
                <c:pt idx="3">
                  <c:v>0.97920291267039095</c:v>
                </c:pt>
                <c:pt idx="4">
                  <c:v>1.04219901358995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046-9941-9107-3B2376A4C6D6}"/>
            </c:ext>
          </c:extLst>
        </c:ser>
        <c:ser>
          <c:idx val="1"/>
          <c:order val="1"/>
          <c:tx>
            <c:v>at1g08920</c:v>
          </c:tx>
          <c:spPr>
            <a:ln w="6350" cap="rnd">
              <a:solidFill>
                <a:schemeClr val="accent2"/>
              </a:solidFill>
              <a:round/>
            </a:ln>
            <a:effectLst/>
          </c:spPr>
          <c:marker>
            <c:symbol val="x"/>
            <c:size val="4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8920'!$F$29,'08920'!$F$383,'08920'!$F$411,'08920'!$F$439,'08920'!$F$467,'08920'!$F$495,'08920'!$F$523,'08920'!$F$551,'08920'!$F$579,'08920'!$F$602,'08920'!$F$625,'08920'!$F$648)</c:f>
                <c:numCache>
                  <c:formatCode>General</c:formatCode>
                  <c:ptCount val="12"/>
                  <c:pt idx="0">
                    <c:v>4.8696388401985202E-2</c:v>
                  </c:pt>
                  <c:pt idx="1">
                    <c:v>0.210933405197573</c:v>
                  </c:pt>
                  <c:pt idx="2">
                    <c:v>0.20856688511991101</c:v>
                  </c:pt>
                  <c:pt idx="3">
                    <c:v>0.238997503767436</c:v>
                  </c:pt>
                  <c:pt idx="4">
                    <c:v>0.295507307500468</c:v>
                  </c:pt>
                  <c:pt idx="5">
                    <c:v>0.243015845659899</c:v>
                  </c:pt>
                  <c:pt idx="6">
                    <c:v>0.31488404772362699</c:v>
                  </c:pt>
                  <c:pt idx="7">
                    <c:v>0.31250934109647199</c:v>
                  </c:pt>
                  <c:pt idx="8">
                    <c:v>0.20779699444181601</c:v>
                  </c:pt>
                  <c:pt idx="9">
                    <c:v>0.33291878740543202</c:v>
                  </c:pt>
                  <c:pt idx="10">
                    <c:v>0.29702071792660201</c:v>
                  </c:pt>
                  <c:pt idx="11">
                    <c:v>0.24852512590399001</c:v>
                  </c:pt>
                </c:numCache>
              </c:numRef>
            </c:plus>
            <c:minus>
              <c:numRef>
                <c:f>('08920'!$F$29,'08920'!$F$383,'08920'!$F$411,'08920'!$F$439,'08920'!$F$467,'08920'!$F$495,'08920'!$F$523,'08920'!$F$551,'08920'!$F$579,'08920'!$F$602,'08920'!$F$625,'08920'!$F$648)</c:f>
                <c:numCache>
                  <c:formatCode>General</c:formatCode>
                  <c:ptCount val="12"/>
                  <c:pt idx="0">
                    <c:v>4.8696388401985202E-2</c:v>
                  </c:pt>
                  <c:pt idx="1">
                    <c:v>0.210933405197573</c:v>
                  </c:pt>
                  <c:pt idx="2">
                    <c:v>0.20856688511991101</c:v>
                  </c:pt>
                  <c:pt idx="3">
                    <c:v>0.238997503767436</c:v>
                  </c:pt>
                  <c:pt idx="4">
                    <c:v>0.295507307500468</c:v>
                  </c:pt>
                  <c:pt idx="5">
                    <c:v>0.243015845659899</c:v>
                  </c:pt>
                  <c:pt idx="6">
                    <c:v>0.31488404772362699</c:v>
                  </c:pt>
                  <c:pt idx="7">
                    <c:v>0.31250934109647199</c:v>
                  </c:pt>
                  <c:pt idx="8">
                    <c:v>0.20779699444181601</c:v>
                  </c:pt>
                  <c:pt idx="9">
                    <c:v>0.33291878740543202</c:v>
                  </c:pt>
                  <c:pt idx="10">
                    <c:v>0.29702071792660201</c:v>
                  </c:pt>
                  <c:pt idx="11">
                    <c:v>0.24852512590399001</c:v>
                  </c:pt>
                </c:numCache>
              </c:numRef>
            </c:minus>
            <c:spPr>
              <a:ln w="6350"/>
            </c:spPr>
          </c:errBars>
          <c:xVal>
            <c:numRef>
              <c:f>(Col0!$C$2,Col0!$C$30,Col0!$C$58,Col0!$C$86,Col0!$C$114)</c:f>
              <c:numCache>
                <c:formatCode>General</c:formatCode>
                <c:ptCount val="5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</c:numCache>
            </c:numRef>
          </c:xVal>
          <c:yVal>
            <c:numRef>
              <c:f>('08920'!$F$28,'08920'!$F$382,'08920'!$F$410,'08920'!$F$438,'08920'!$F$466,'08920'!$F$494)</c:f>
              <c:numCache>
                <c:formatCode>0.000</c:formatCode>
                <c:ptCount val="6"/>
                <c:pt idx="0">
                  <c:v>0.240704247946986</c:v>
                </c:pt>
                <c:pt idx="1">
                  <c:v>0.477054005229329</c:v>
                </c:pt>
                <c:pt idx="2">
                  <c:v>0.89099699448874603</c:v>
                </c:pt>
                <c:pt idx="3">
                  <c:v>0.96886332444247203</c:v>
                </c:pt>
                <c:pt idx="4">
                  <c:v>1.0303982863838841</c:v>
                </c:pt>
                <c:pt idx="5">
                  <c:v>1.20190005167942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A046-9941-9107-3B2376A4C6D6}"/>
            </c:ext>
          </c:extLst>
        </c:ser>
        <c:ser>
          <c:idx val="2"/>
          <c:order val="2"/>
          <c:tx>
            <c:v>at1g75220</c:v>
          </c:tx>
          <c:spPr>
            <a:ln w="6350" cap="rnd">
              <a:solidFill>
                <a:schemeClr val="accent3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75220'!$F$29,'75220'!$F$383,'75220'!$F$411,'75220'!$F$439,'75220'!$F$467,'75220'!$F$495,'75220'!$F$523,'75220'!$F$551,'75220'!$F$579,'75220'!$F$602,'75220'!$F$625,'75220'!$F$648)</c:f>
                <c:numCache>
                  <c:formatCode>General</c:formatCode>
                  <c:ptCount val="12"/>
                  <c:pt idx="0">
                    <c:v>9.9850579791842003E-2</c:v>
                  </c:pt>
                  <c:pt idx="1">
                    <c:v>0.113045058587596</c:v>
                  </c:pt>
                  <c:pt idx="2">
                    <c:v>0.25070970429919198</c:v>
                  </c:pt>
                  <c:pt idx="3">
                    <c:v>0.26320263947941402</c:v>
                  </c:pt>
                  <c:pt idx="4">
                    <c:v>0.33058245537207098</c:v>
                  </c:pt>
                  <c:pt idx="5">
                    <c:v>0.25388301663998802</c:v>
                  </c:pt>
                  <c:pt idx="6">
                    <c:v>0.27283525563865602</c:v>
                  </c:pt>
                  <c:pt idx="7">
                    <c:v>0.17756658696143701</c:v>
                  </c:pt>
                  <c:pt idx="8">
                    <c:v>0.20202420708400201</c:v>
                  </c:pt>
                  <c:pt idx="9">
                    <c:v>0.30381568577263401</c:v>
                  </c:pt>
                  <c:pt idx="10">
                    <c:v>0.226510561333714</c:v>
                  </c:pt>
                  <c:pt idx="11">
                    <c:v>0.23930104233445201</c:v>
                  </c:pt>
                </c:numCache>
              </c:numRef>
            </c:plus>
            <c:minus>
              <c:numRef>
                <c:f>('75220'!$F$29,'75220'!$F$383,'75220'!$F$411,'75220'!$F$439,'75220'!$F$467,'75220'!$F$495,'75220'!$F$523,'75220'!$F$551,'75220'!$F$579,'75220'!$F$602,'75220'!$F$625,'75220'!$F$648)</c:f>
                <c:numCache>
                  <c:formatCode>General</c:formatCode>
                  <c:ptCount val="12"/>
                  <c:pt idx="0">
                    <c:v>9.9850579791842003E-2</c:v>
                  </c:pt>
                  <c:pt idx="1">
                    <c:v>0.113045058587596</c:v>
                  </c:pt>
                  <c:pt idx="2">
                    <c:v>0.25070970429919198</c:v>
                  </c:pt>
                  <c:pt idx="3">
                    <c:v>0.26320263947941402</c:v>
                  </c:pt>
                  <c:pt idx="4">
                    <c:v>0.33058245537207098</c:v>
                  </c:pt>
                  <c:pt idx="5">
                    <c:v>0.25388301663998802</c:v>
                  </c:pt>
                  <c:pt idx="6">
                    <c:v>0.27283525563865602</c:v>
                  </c:pt>
                  <c:pt idx="7">
                    <c:v>0.17756658696143701</c:v>
                  </c:pt>
                  <c:pt idx="8">
                    <c:v>0.20202420708400201</c:v>
                  </c:pt>
                  <c:pt idx="9">
                    <c:v>0.30381568577263401</c:v>
                  </c:pt>
                  <c:pt idx="10">
                    <c:v>0.226510561333714</c:v>
                  </c:pt>
                  <c:pt idx="11">
                    <c:v>0.23930104233445201</c:v>
                  </c:pt>
                </c:numCache>
              </c:numRef>
            </c:minus>
            <c:spPr>
              <a:ln w="6350"/>
            </c:spPr>
          </c:errBars>
          <c:xVal>
            <c:numRef>
              <c:f>('75220'!$C$2,'75220'!$C$30,'75220'!$C$58,'75220'!$C$86,'75220'!$C$114)</c:f>
              <c:numCache>
                <c:formatCode>General</c:formatCode>
                <c:ptCount val="5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</c:numCache>
            </c:numRef>
          </c:xVal>
          <c:yVal>
            <c:numRef>
              <c:f>('75220'!$F$28,'75220'!$F$382,'75220'!$F$410,'75220'!$F$438,'75220'!$F$466)</c:f>
              <c:numCache>
                <c:formatCode>0.000</c:formatCode>
                <c:ptCount val="5"/>
                <c:pt idx="0">
                  <c:v>0.22364253162452699</c:v>
                </c:pt>
                <c:pt idx="1">
                  <c:v>0.43092901555819302</c:v>
                </c:pt>
                <c:pt idx="2">
                  <c:v>0.72403589516728895</c:v>
                </c:pt>
                <c:pt idx="3">
                  <c:v>0.88750827912164398</c:v>
                </c:pt>
                <c:pt idx="4">
                  <c:v>0.977854486738105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A046-9941-9107-3B2376A4C6D6}"/>
            </c:ext>
          </c:extLst>
        </c:ser>
        <c:ser>
          <c:idx val="3"/>
          <c:order val="3"/>
          <c:tx>
            <c:v>at3g04760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4760'!$F$29,'04760'!$F$383,'04760'!$F$411,'04760'!$F$439,'04760'!$F$467,'04760'!$F$495,'04760'!$F$523,'04760'!$F$551,'04760'!$F$579,'04760'!$F$602,'04760'!$F$625,'04760'!$F$648)</c:f>
                <c:numCache>
                  <c:formatCode>General</c:formatCode>
                  <c:ptCount val="12"/>
                  <c:pt idx="0">
                    <c:v>6.2285542783769403E-2</c:v>
                  </c:pt>
                  <c:pt idx="1">
                    <c:v>0.14014055089476599</c:v>
                  </c:pt>
                  <c:pt idx="2">
                    <c:v>0.220821715388135</c:v>
                  </c:pt>
                  <c:pt idx="3">
                    <c:v>0.21468008674705799</c:v>
                  </c:pt>
                  <c:pt idx="4">
                    <c:v>0.244554961770346</c:v>
                  </c:pt>
                  <c:pt idx="5">
                    <c:v>0.17671286237415401</c:v>
                  </c:pt>
                  <c:pt idx="6">
                    <c:v>0.22435415173380399</c:v>
                  </c:pt>
                  <c:pt idx="7">
                    <c:v>0.24582855670312301</c:v>
                  </c:pt>
                  <c:pt idx="8">
                    <c:v>0.19070831283587</c:v>
                  </c:pt>
                  <c:pt idx="9">
                    <c:v>0.36952040830011301</c:v>
                  </c:pt>
                  <c:pt idx="10">
                    <c:v>0.17871929582446799</c:v>
                  </c:pt>
                  <c:pt idx="11">
                    <c:v>0.20967027858164999</c:v>
                  </c:pt>
                </c:numCache>
              </c:numRef>
            </c:plus>
            <c:minus>
              <c:numRef>
                <c:f>('04760'!$F$29,'04760'!$F$383,'04760'!$F$411,'04760'!$F$439,'04760'!$F$467,'04760'!$F$495,'04760'!$F$523,'04760'!$F$551,'04760'!$F$579,'04760'!$F$602,'04760'!$F$625,'04760'!$F$648)</c:f>
                <c:numCache>
                  <c:formatCode>General</c:formatCode>
                  <c:ptCount val="12"/>
                  <c:pt idx="0">
                    <c:v>6.2285542783769403E-2</c:v>
                  </c:pt>
                  <c:pt idx="1">
                    <c:v>0.14014055089476599</c:v>
                  </c:pt>
                  <c:pt idx="2">
                    <c:v>0.220821715388135</c:v>
                  </c:pt>
                  <c:pt idx="3">
                    <c:v>0.21468008674705799</c:v>
                  </c:pt>
                  <c:pt idx="4">
                    <c:v>0.244554961770346</c:v>
                  </c:pt>
                  <c:pt idx="5">
                    <c:v>0.17671286237415401</c:v>
                  </c:pt>
                  <c:pt idx="6">
                    <c:v>0.22435415173380399</c:v>
                  </c:pt>
                  <c:pt idx="7">
                    <c:v>0.24582855670312301</c:v>
                  </c:pt>
                  <c:pt idx="8">
                    <c:v>0.19070831283587</c:v>
                  </c:pt>
                  <c:pt idx="9">
                    <c:v>0.36952040830011301</c:v>
                  </c:pt>
                  <c:pt idx="10">
                    <c:v>0.17871929582446799</c:v>
                  </c:pt>
                  <c:pt idx="11">
                    <c:v>0.20967027858164999</c:v>
                  </c:pt>
                </c:numCache>
              </c:numRef>
            </c:minus>
            <c:spPr>
              <a:ln w="6350"/>
            </c:spPr>
          </c:errBars>
          <c:xVal>
            <c:numRef>
              <c:f>('04760'!$C$2,'04760'!$C$30,'04760'!$C$58,'04760'!$C$86,'04760'!$C$114)</c:f>
              <c:numCache>
                <c:formatCode>General</c:formatCode>
                <c:ptCount val="5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</c:numCache>
            </c:numRef>
          </c:xVal>
          <c:yVal>
            <c:numRef>
              <c:f>('04760'!$F$28,'04760'!$F$382,'04760'!$F$410,'04760'!$F$438,'04760'!$F$466)</c:f>
              <c:numCache>
                <c:formatCode>0.000</c:formatCode>
                <c:ptCount val="5"/>
                <c:pt idx="0">
                  <c:v>0.181028203754766</c:v>
                </c:pt>
                <c:pt idx="1">
                  <c:v>0.461930187656035</c:v>
                </c:pt>
                <c:pt idx="2">
                  <c:v>0.78405338763209298</c:v>
                </c:pt>
                <c:pt idx="3">
                  <c:v>0.93195424243152702</c:v>
                </c:pt>
                <c:pt idx="4">
                  <c:v>1.064992069393450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A046-9941-9107-3B2376A4C6D6}"/>
            </c:ext>
          </c:extLst>
        </c:ser>
        <c:ser>
          <c:idx val="4"/>
          <c:order val="4"/>
          <c:tx>
            <c:v>Col0 J8 J12</c:v>
          </c:tx>
          <c:spPr>
            <a:ln w="6350">
              <a:solidFill>
                <a:schemeClr val="accent1"/>
              </a:solidFill>
            </a:ln>
          </c:spPr>
          <c:marker>
            <c:symbol val="circle"/>
            <c:size val="4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Col0!$D$446,Col0!$F$481,Col0!$F$509,Col0!$F$537,Col0!$F$565)</c:f>
                <c:numCache>
                  <c:formatCode>General</c:formatCode>
                  <c:ptCount val="5"/>
                  <c:pt idx="1">
                    <c:v>0.24069635842301901</c:v>
                  </c:pt>
                  <c:pt idx="2">
                    <c:v>0.363713869445905</c:v>
                  </c:pt>
                  <c:pt idx="3">
                    <c:v>0.21162954892253</c:v>
                  </c:pt>
                  <c:pt idx="4">
                    <c:v>0.18681480351747501</c:v>
                  </c:pt>
                </c:numCache>
              </c:numRef>
            </c:plus>
            <c:minus>
              <c:numRef>
                <c:f>(Col0!$D$446,Col0!$F$481,Col0!$F$509,Col0!$F$537,Col0!$F$565)</c:f>
                <c:numCache>
                  <c:formatCode>General</c:formatCode>
                  <c:ptCount val="5"/>
                  <c:pt idx="1">
                    <c:v>0.24069635842301901</c:v>
                  </c:pt>
                  <c:pt idx="2">
                    <c:v>0.363713869445905</c:v>
                  </c:pt>
                  <c:pt idx="3">
                    <c:v>0.21162954892253</c:v>
                  </c:pt>
                  <c:pt idx="4">
                    <c:v>0.18681480351747501</c:v>
                  </c:pt>
                </c:numCache>
              </c:numRef>
            </c:minus>
          </c:errBars>
          <c:xVal>
            <c:numRef>
              <c:f>(Col0!$C$426,Col0!$C$454,Col0!$C$482,Col0!$C$510,Col0!$C$538)</c:f>
              <c:numCache>
                <c:formatCode>General</c:formatCode>
                <c:ptCount val="5"/>
                <c:pt idx="0">
                  <c:v>8</c:v>
                </c:pt>
                <c:pt idx="1">
                  <c:v>9</c:v>
                </c:pt>
                <c:pt idx="2">
                  <c:v>10</c:v>
                </c:pt>
                <c:pt idx="3">
                  <c:v>11</c:v>
                </c:pt>
                <c:pt idx="4">
                  <c:v>12</c:v>
                </c:pt>
              </c:numCache>
            </c:numRef>
          </c:xVal>
          <c:yVal>
            <c:numRef>
              <c:f>(Col0!$F$452,Col0!$F$480,Col0!$F$508,Col0!$F$536,Col0!$F$564)</c:f>
              <c:numCache>
                <c:formatCode>0.000</c:formatCode>
                <c:ptCount val="5"/>
                <c:pt idx="0">
                  <c:v>1.042199013589955</c:v>
                </c:pt>
                <c:pt idx="1">
                  <c:v>1.0944316372195171</c:v>
                </c:pt>
                <c:pt idx="2">
                  <c:v>1.193958151870302</c:v>
                </c:pt>
                <c:pt idx="3">
                  <c:v>1.1463412430605551</c:v>
                </c:pt>
                <c:pt idx="4">
                  <c:v>1.20087751687327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A046-9941-9107-3B2376A4C6D6}"/>
            </c:ext>
          </c:extLst>
        </c:ser>
        <c:ser>
          <c:idx val="5"/>
          <c:order val="5"/>
          <c:tx>
            <c:v>08920 J8 J12</c:v>
          </c:tx>
          <c:spPr>
            <a:ln w="6350">
              <a:solidFill>
                <a:schemeClr val="accent2"/>
              </a:solidFill>
            </a:ln>
          </c:spPr>
          <c:marker>
            <c:symbol val="square"/>
            <c:size val="4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08920'!$C$441,'08920'!$F$495,'08920'!$F$523,'08920'!$F$551,'08920'!$F$579)</c:f>
                <c:numCache>
                  <c:formatCode>General</c:formatCode>
                  <c:ptCount val="5"/>
                  <c:pt idx="1">
                    <c:v>0.243015845659899</c:v>
                  </c:pt>
                  <c:pt idx="2">
                    <c:v>0.31488404772362699</c:v>
                  </c:pt>
                  <c:pt idx="3">
                    <c:v>0.31250934109647199</c:v>
                  </c:pt>
                  <c:pt idx="4">
                    <c:v>0.20779699444181601</c:v>
                  </c:pt>
                </c:numCache>
              </c:numRef>
            </c:plus>
            <c:minus>
              <c:numRef>
                <c:f>('08920'!$C$441,'08920'!$F$495,'08920'!$F$523,'08920'!$F$551,'08920'!$F$579)</c:f>
                <c:numCache>
                  <c:formatCode>General</c:formatCode>
                  <c:ptCount val="5"/>
                  <c:pt idx="1">
                    <c:v>0.243015845659899</c:v>
                  </c:pt>
                  <c:pt idx="2">
                    <c:v>0.31488404772362699</c:v>
                  </c:pt>
                  <c:pt idx="3">
                    <c:v>0.31250934109647199</c:v>
                  </c:pt>
                  <c:pt idx="4">
                    <c:v>0.20779699444181601</c:v>
                  </c:pt>
                </c:numCache>
              </c:numRef>
            </c:minus>
            <c:spPr>
              <a:ln w="6350"/>
            </c:spPr>
          </c:errBars>
          <c:xVal>
            <c:numRef>
              <c:f>('08920'!$C$440,'08920'!$C$468,'08920'!$C$496,'08920'!$C$524,'08920'!$C$552)</c:f>
              <c:numCache>
                <c:formatCode>General</c:formatCode>
                <c:ptCount val="5"/>
                <c:pt idx="0">
                  <c:v>8</c:v>
                </c:pt>
                <c:pt idx="1">
                  <c:v>9</c:v>
                </c:pt>
                <c:pt idx="2">
                  <c:v>10</c:v>
                </c:pt>
                <c:pt idx="3">
                  <c:v>11</c:v>
                </c:pt>
                <c:pt idx="4">
                  <c:v>12</c:v>
                </c:pt>
              </c:numCache>
            </c:numRef>
          </c:xVal>
          <c:yVal>
            <c:numRef>
              <c:f>('08920'!$F$466,'08920'!$F$494,'08920'!$F$522,'08920'!$F$550,'08920'!$F$578)</c:f>
              <c:numCache>
                <c:formatCode>0.000</c:formatCode>
                <c:ptCount val="5"/>
                <c:pt idx="0">
                  <c:v>1.0303982863838841</c:v>
                </c:pt>
                <c:pt idx="1">
                  <c:v>1.201900051679426</c:v>
                </c:pt>
                <c:pt idx="2">
                  <c:v>1.245734549471434</c:v>
                </c:pt>
                <c:pt idx="3">
                  <c:v>1.187055971775447</c:v>
                </c:pt>
                <c:pt idx="4">
                  <c:v>1.17577545625057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A046-9941-9107-3B2376A4C6D6}"/>
            </c:ext>
          </c:extLst>
        </c:ser>
        <c:ser>
          <c:idx val="6"/>
          <c:order val="6"/>
          <c:tx>
            <c:v>75220 J8 J12</c:v>
          </c:tx>
          <c:spPr>
            <a:ln w="6350">
              <a:solidFill>
                <a:schemeClr val="bg1">
                  <a:lumMod val="65000"/>
                </a:schemeClr>
              </a:solidFill>
            </a:ln>
          </c:spPr>
          <c:marker>
            <c:symbol val="triangle"/>
            <c:size val="4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75220'!$D$441,'75220'!$F$467,'75220'!$F$495,'75220'!$F$523,'75220'!$F$551)</c:f>
                <c:numCache>
                  <c:formatCode>General</c:formatCode>
                  <c:ptCount val="5"/>
                  <c:pt idx="1">
                    <c:v>0.33058245537207098</c:v>
                  </c:pt>
                  <c:pt idx="2">
                    <c:v>0.25388301663998802</c:v>
                  </c:pt>
                  <c:pt idx="3">
                    <c:v>0.27283525563865602</c:v>
                  </c:pt>
                  <c:pt idx="4">
                    <c:v>0.17756658696143701</c:v>
                  </c:pt>
                </c:numCache>
              </c:numRef>
            </c:plus>
            <c:minus>
              <c:numRef>
                <c:f>('75220'!$D$441,'75220'!$F$467,'75220'!$F$495,'75220'!$F$523,'75220'!$F$551)</c:f>
                <c:numCache>
                  <c:formatCode>General</c:formatCode>
                  <c:ptCount val="5"/>
                  <c:pt idx="1">
                    <c:v>0.33058245537207098</c:v>
                  </c:pt>
                  <c:pt idx="2">
                    <c:v>0.25388301663998802</c:v>
                  </c:pt>
                  <c:pt idx="3">
                    <c:v>0.27283525563865602</c:v>
                  </c:pt>
                  <c:pt idx="4">
                    <c:v>0.17756658696143701</c:v>
                  </c:pt>
                </c:numCache>
              </c:numRef>
            </c:minus>
            <c:spPr>
              <a:ln w="6350"/>
            </c:spPr>
          </c:errBars>
          <c:xVal>
            <c:numRef>
              <c:f>('75220'!$C$440,'75220'!$C$468,'75220'!$C$496,'75220'!$C$524,'75220'!$C$552)</c:f>
              <c:numCache>
                <c:formatCode>General</c:formatCode>
                <c:ptCount val="5"/>
                <c:pt idx="0">
                  <c:v>8</c:v>
                </c:pt>
                <c:pt idx="1">
                  <c:v>9</c:v>
                </c:pt>
                <c:pt idx="2">
                  <c:v>10</c:v>
                </c:pt>
                <c:pt idx="3">
                  <c:v>11</c:v>
                </c:pt>
                <c:pt idx="4">
                  <c:v>12</c:v>
                </c:pt>
              </c:numCache>
            </c:numRef>
          </c:xVal>
          <c:yVal>
            <c:numRef>
              <c:f>('75220'!$F$466,'75220'!$F$494,'75220'!$F$522,'75220'!$F$550,'75220'!$F$578)</c:f>
              <c:numCache>
                <c:formatCode>0.000</c:formatCode>
                <c:ptCount val="5"/>
                <c:pt idx="0">
                  <c:v>0.97785448673810504</c:v>
                </c:pt>
                <c:pt idx="1">
                  <c:v>0.97283074113194101</c:v>
                </c:pt>
                <c:pt idx="2">
                  <c:v>1.2633892212844731</c:v>
                </c:pt>
                <c:pt idx="3">
                  <c:v>1.0804213472405351</c:v>
                </c:pt>
                <c:pt idx="4">
                  <c:v>1.1087319404352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A046-9941-9107-3B2376A4C6D6}"/>
            </c:ext>
          </c:extLst>
        </c:ser>
        <c:ser>
          <c:idx val="7"/>
          <c:order val="7"/>
          <c:tx>
            <c:v>04760 J8 J12</c:v>
          </c:tx>
          <c:spPr>
            <a:ln w="6350">
              <a:solidFill>
                <a:schemeClr val="accent4"/>
              </a:solidFill>
            </a:ln>
          </c:spPr>
          <c:marker>
            <c:symbol val="diamond"/>
            <c:size val="4"/>
            <c:spPr>
              <a:solidFill>
                <a:schemeClr val="accent4"/>
              </a:solidFill>
              <a:ln>
                <a:solidFill>
                  <a:schemeClr val="accent4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04760'!$C$441,'04760'!$F$495,'04760'!$F$523,'04760'!$F$551,'04760'!$F$579)</c:f>
                <c:numCache>
                  <c:formatCode>General</c:formatCode>
                  <c:ptCount val="5"/>
                  <c:pt idx="1">
                    <c:v>0.17671286237415401</c:v>
                  </c:pt>
                  <c:pt idx="2">
                    <c:v>0.22435415173380399</c:v>
                  </c:pt>
                  <c:pt idx="3">
                    <c:v>0.24582855670312301</c:v>
                  </c:pt>
                  <c:pt idx="4">
                    <c:v>0.19070831283587</c:v>
                  </c:pt>
                </c:numCache>
              </c:numRef>
            </c:plus>
            <c:minus>
              <c:numRef>
                <c:f>('04760'!$C$441,'04760'!$F$495,'04760'!$F$523,'04760'!$F$551,'04760'!$F$579)</c:f>
                <c:numCache>
                  <c:formatCode>General</c:formatCode>
                  <c:ptCount val="5"/>
                  <c:pt idx="1">
                    <c:v>0.17671286237415401</c:v>
                  </c:pt>
                  <c:pt idx="2">
                    <c:v>0.22435415173380399</c:v>
                  </c:pt>
                  <c:pt idx="3">
                    <c:v>0.24582855670312301</c:v>
                  </c:pt>
                  <c:pt idx="4">
                    <c:v>0.19070831283587</c:v>
                  </c:pt>
                </c:numCache>
              </c:numRef>
            </c:minus>
          </c:errBars>
          <c:xVal>
            <c:numRef>
              <c:f>('04760'!$C$440,'04760'!$C$468,'04760'!$C$496,'04760'!$C$524,'04760'!$C$552)</c:f>
              <c:numCache>
                <c:formatCode>General</c:formatCode>
                <c:ptCount val="5"/>
                <c:pt idx="0">
                  <c:v>8</c:v>
                </c:pt>
                <c:pt idx="1">
                  <c:v>9</c:v>
                </c:pt>
                <c:pt idx="2">
                  <c:v>10</c:v>
                </c:pt>
                <c:pt idx="3">
                  <c:v>11</c:v>
                </c:pt>
                <c:pt idx="4">
                  <c:v>12</c:v>
                </c:pt>
              </c:numCache>
            </c:numRef>
          </c:xVal>
          <c:yVal>
            <c:numRef>
              <c:f>('04760'!$F$466,'04760'!$F$494,'04760'!$F$522,'04760'!$F$550,'04760'!$F$578)</c:f>
              <c:numCache>
                <c:formatCode>0.000</c:formatCode>
                <c:ptCount val="5"/>
                <c:pt idx="0">
                  <c:v>1.0649920693934509</c:v>
                </c:pt>
                <c:pt idx="1">
                  <c:v>1.109953117179854</c:v>
                </c:pt>
                <c:pt idx="2">
                  <c:v>1.1971305366888121</c:v>
                </c:pt>
                <c:pt idx="3">
                  <c:v>1.1357874931386731</c:v>
                </c:pt>
                <c:pt idx="4">
                  <c:v>1.14326191220963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A046-9941-9107-3B2376A4C6D6}"/>
            </c:ext>
          </c:extLst>
        </c:ser>
        <c:ser>
          <c:idx val="8"/>
          <c:order val="8"/>
          <c:tx>
            <c:v>Col0 J12 J15</c:v>
          </c:tx>
          <c:spPr>
            <a:ln w="6350">
              <a:solidFill>
                <a:schemeClr val="accent1"/>
              </a:solidFill>
            </a:ln>
          </c:spPr>
          <c:marker>
            <c:symbol val="circle"/>
            <c:size val="4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</c:spPr>
          </c:marker>
          <c:trendline>
            <c:spPr>
              <a:ln>
                <a:noFill/>
              </a:ln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Col0!$C$539,Col0!$F$581,Col0!$F$597,Col0!$F$620)</c:f>
                <c:numCache>
                  <c:formatCode>General</c:formatCode>
                  <c:ptCount val="4"/>
                  <c:pt idx="3">
                    <c:v>0.27051725942570398</c:v>
                  </c:pt>
                </c:numCache>
              </c:numRef>
            </c:plus>
            <c:minus>
              <c:numRef>
                <c:f>(Col0!$C$539,Col0!$F$581,Col0!$F$597,Col0!$F$620)</c:f>
                <c:numCache>
                  <c:formatCode>General</c:formatCode>
                  <c:ptCount val="4"/>
                  <c:pt idx="3">
                    <c:v>0.27051725942570398</c:v>
                  </c:pt>
                </c:numCache>
              </c:numRef>
            </c:minus>
          </c:errBars>
          <c:xVal>
            <c:numRef>
              <c:f>(Col0!$C$538,Col0!$C$566,Col0!$C$582,Col0!$C$598)</c:f>
              <c:numCache>
                <c:formatCode>General</c:formatCode>
                <c:ptCount val="4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</c:numCache>
            </c:numRef>
          </c:xVal>
          <c:yVal>
            <c:numRef>
              <c:f>(Col0!$F$564,Col0!$F$580,Col0!$F$596,Col0!$F$619)</c:f>
              <c:numCache>
                <c:formatCode>0.000</c:formatCode>
                <c:ptCount val="4"/>
                <c:pt idx="0">
                  <c:v>1.2008775168732799</c:v>
                </c:pt>
                <c:pt idx="1">
                  <c:v>0.99467114236634602</c:v>
                </c:pt>
                <c:pt idx="2">
                  <c:v>0.79460326092091005</c:v>
                </c:pt>
                <c:pt idx="3">
                  <c:v>0.695802484572968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A046-9941-9107-3B2376A4C6D6}"/>
            </c:ext>
          </c:extLst>
        </c:ser>
        <c:ser>
          <c:idx val="9"/>
          <c:order val="9"/>
          <c:tx>
            <c:v>08 J12 J15</c:v>
          </c:tx>
          <c:spPr>
            <a:ln w="6350">
              <a:solidFill>
                <a:schemeClr val="accent2"/>
              </a:solidFill>
            </a:ln>
          </c:spPr>
          <c:marker>
            <c:symbol val="square"/>
            <c:size val="4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</c:spPr>
          </c:marker>
          <c:trendline>
            <c:spPr>
              <a:ln>
                <a:noFill/>
              </a:ln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8920'!$D$584,'08920'!$F$602,'08920'!$F$625,'08920'!$F$648)</c:f>
                <c:numCache>
                  <c:formatCode>General</c:formatCode>
                  <c:ptCount val="4"/>
                  <c:pt idx="1">
                    <c:v>0.33291878740543202</c:v>
                  </c:pt>
                  <c:pt idx="2">
                    <c:v>0.29702071792660201</c:v>
                  </c:pt>
                  <c:pt idx="3">
                    <c:v>0.24852512590399001</c:v>
                  </c:pt>
                </c:numCache>
              </c:numRef>
            </c:plus>
            <c:minus>
              <c:numRef>
                <c:f>('08920'!$D$584,'08920'!$F$602,'08920'!$F$625,'08920'!$F$648)</c:f>
                <c:numCache>
                  <c:formatCode>General</c:formatCode>
                  <c:ptCount val="4"/>
                  <c:pt idx="1">
                    <c:v>0.33291878740543202</c:v>
                  </c:pt>
                  <c:pt idx="2">
                    <c:v>0.29702071792660201</c:v>
                  </c:pt>
                  <c:pt idx="3">
                    <c:v>0.24852512590399001</c:v>
                  </c:pt>
                </c:numCache>
              </c:numRef>
            </c:minus>
            <c:spPr>
              <a:ln w="6350"/>
            </c:spPr>
          </c:errBars>
          <c:xVal>
            <c:numRef>
              <c:f>('08920'!$C$552,'08920'!$C$580,'08920'!$C$603,'08920'!$C$626)</c:f>
              <c:numCache>
                <c:formatCode>General</c:formatCode>
                <c:ptCount val="4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</c:numCache>
            </c:numRef>
          </c:xVal>
          <c:yVal>
            <c:numRef>
              <c:f>('08920'!$F$578,'08920'!$F$601,'08920'!$F$624,'08920'!$F$647)</c:f>
              <c:numCache>
                <c:formatCode>0.000</c:formatCode>
                <c:ptCount val="4"/>
                <c:pt idx="0">
                  <c:v>1.175775456250576</c:v>
                </c:pt>
                <c:pt idx="1">
                  <c:v>1.00479226955951</c:v>
                </c:pt>
                <c:pt idx="2">
                  <c:v>0.63474374572666403</c:v>
                </c:pt>
                <c:pt idx="3">
                  <c:v>0.715871122024602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A046-9941-9107-3B2376A4C6D6}"/>
            </c:ext>
          </c:extLst>
        </c:ser>
        <c:ser>
          <c:idx val="10"/>
          <c:order val="10"/>
          <c:tx>
            <c:v>75 J12 J15</c:v>
          </c:tx>
          <c:spPr>
            <a:ln w="6350">
              <a:solidFill>
                <a:schemeClr val="bg1">
                  <a:lumMod val="65000"/>
                </a:schemeClr>
              </a:solidFill>
            </a:ln>
          </c:spPr>
          <c:marker>
            <c:symbol val="triangle"/>
            <c:size val="4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</c:spPr>
          </c:marker>
          <c:trendline>
            <c:spPr>
              <a:ln>
                <a:noFill/>
              </a:ln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75220'!$D$598,'75220'!$F$602,'75220'!$F$625,'75220'!$F$648)</c:f>
                <c:numCache>
                  <c:formatCode>General</c:formatCode>
                  <c:ptCount val="4"/>
                  <c:pt idx="1">
                    <c:v>0.30381568577263401</c:v>
                  </c:pt>
                  <c:pt idx="2">
                    <c:v>0.226510561333714</c:v>
                  </c:pt>
                  <c:pt idx="3">
                    <c:v>0.23930104233445201</c:v>
                  </c:pt>
                </c:numCache>
              </c:numRef>
            </c:plus>
            <c:minus>
              <c:numRef>
                <c:f>('75220'!$D$598,'75220'!$F$602,'75220'!$F$625,'75220'!$F$648)</c:f>
                <c:numCache>
                  <c:formatCode>General</c:formatCode>
                  <c:ptCount val="4"/>
                  <c:pt idx="1">
                    <c:v>0.30381568577263401</c:v>
                  </c:pt>
                  <c:pt idx="2">
                    <c:v>0.226510561333714</c:v>
                  </c:pt>
                  <c:pt idx="3">
                    <c:v>0.23930104233445201</c:v>
                  </c:pt>
                </c:numCache>
              </c:numRef>
            </c:minus>
            <c:spPr>
              <a:ln w="6350"/>
            </c:spPr>
          </c:errBars>
          <c:xVal>
            <c:numRef>
              <c:f>('75220'!$C$552,'75220'!$C$580,'75220'!$C$603,'75220'!$C$626)</c:f>
              <c:numCache>
                <c:formatCode>General</c:formatCode>
                <c:ptCount val="4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</c:numCache>
            </c:numRef>
          </c:xVal>
          <c:yVal>
            <c:numRef>
              <c:f>('75220'!$F$578,'75220'!$F$601,'75220'!$F$624,'75220'!$F$647)</c:f>
              <c:numCache>
                <c:formatCode>0.000</c:formatCode>
                <c:ptCount val="4"/>
                <c:pt idx="0">
                  <c:v>1.108731940435203</c:v>
                </c:pt>
                <c:pt idx="1">
                  <c:v>1.020524313748377</c:v>
                </c:pt>
                <c:pt idx="2">
                  <c:v>0.64098404567577505</c:v>
                </c:pt>
                <c:pt idx="3">
                  <c:v>0.714857707480675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A046-9941-9107-3B2376A4C6D6}"/>
            </c:ext>
          </c:extLst>
        </c:ser>
        <c:ser>
          <c:idx val="11"/>
          <c:order val="11"/>
          <c:tx>
            <c:v>47 J12 J15</c:v>
          </c:tx>
          <c:spPr>
            <a:ln w="6350">
              <a:solidFill>
                <a:schemeClr val="accent4"/>
              </a:solidFill>
            </a:ln>
          </c:spPr>
          <c:marker>
            <c:symbol val="diamond"/>
            <c:size val="4"/>
            <c:spPr>
              <a:solidFill>
                <a:schemeClr val="accent4"/>
              </a:solidFill>
              <a:ln>
                <a:solidFill>
                  <a:schemeClr val="accent4"/>
                </a:solidFill>
              </a:ln>
            </c:spPr>
          </c:marker>
          <c:trendline>
            <c:spPr>
              <a:ln>
                <a:noFill/>
              </a:ln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4760'!$D$553,'04760'!$F$602,'04760'!$F$625,'04760'!$F$648)</c:f>
                <c:numCache>
                  <c:formatCode>General</c:formatCode>
                  <c:ptCount val="4"/>
                  <c:pt idx="1">
                    <c:v>0.36952040830011301</c:v>
                  </c:pt>
                  <c:pt idx="2">
                    <c:v>0.17871929582446799</c:v>
                  </c:pt>
                  <c:pt idx="3">
                    <c:v>0.20967027858164999</c:v>
                  </c:pt>
                </c:numCache>
              </c:numRef>
            </c:plus>
            <c:minus>
              <c:numRef>
                <c:f>('04760'!$D$553,'04760'!$F$602,'04760'!$F$625,'04760'!$F$648)</c:f>
                <c:numCache>
                  <c:formatCode>General</c:formatCode>
                  <c:ptCount val="4"/>
                  <c:pt idx="1">
                    <c:v>0.36952040830011301</c:v>
                  </c:pt>
                  <c:pt idx="2">
                    <c:v>0.17871929582446799</c:v>
                  </c:pt>
                  <c:pt idx="3">
                    <c:v>0.20967027858164999</c:v>
                  </c:pt>
                </c:numCache>
              </c:numRef>
            </c:minus>
            <c:spPr>
              <a:ln w="6350"/>
            </c:spPr>
          </c:errBars>
          <c:xVal>
            <c:numRef>
              <c:f>('04760'!$C$552,'04760'!$C$580,'04760'!$C$603,'04760'!$C$626)</c:f>
              <c:numCache>
                <c:formatCode>General</c:formatCode>
                <c:ptCount val="4"/>
                <c:pt idx="0">
                  <c:v>12</c:v>
                </c:pt>
                <c:pt idx="1">
                  <c:v>13</c:v>
                </c:pt>
                <c:pt idx="2">
                  <c:v>14</c:v>
                </c:pt>
                <c:pt idx="3">
                  <c:v>15</c:v>
                </c:pt>
              </c:numCache>
            </c:numRef>
          </c:xVal>
          <c:yVal>
            <c:numRef>
              <c:f>('04760'!$F$578,'04760'!$F$601,'04760'!$F$624,'04760'!$F$647)</c:f>
              <c:numCache>
                <c:formatCode>0.000</c:formatCode>
                <c:ptCount val="4"/>
                <c:pt idx="0">
                  <c:v>1.143261912209637</c:v>
                </c:pt>
                <c:pt idx="1">
                  <c:v>1.0944322676517011</c:v>
                </c:pt>
                <c:pt idx="2">
                  <c:v>0.68244059346442898</c:v>
                </c:pt>
                <c:pt idx="3">
                  <c:v>0.617239643507085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A046-9941-9107-3B2376A4C6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20965720"/>
        <c:axId val="813269944"/>
      </c:scatterChart>
      <c:valAx>
        <c:axId val="820965720"/>
        <c:scaling>
          <c:orientation val="minMax"/>
          <c:max val="15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13269944"/>
        <c:crosses val="autoZero"/>
        <c:crossBetween val="midCat"/>
        <c:majorUnit val="1"/>
      </c:valAx>
      <c:valAx>
        <c:axId val="813269944"/>
        <c:scaling>
          <c:orientation val="minMax"/>
          <c:max val="4"/>
          <c:min val="0"/>
        </c:scaling>
        <c:delete val="0"/>
        <c:axPos val="l"/>
        <c:majorGridlines>
          <c:spPr>
            <a:ln w="6350">
              <a:solidFill>
                <a:schemeClr val="bg1">
                  <a:lumMod val="85000"/>
                </a:schemeClr>
              </a:solidFill>
            </a:ln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fr-FR" sz="1200" b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W </a:t>
                </a:r>
                <a:r>
                  <a:rPr lang="fr-FR" sz="1200" b="0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g)</a:t>
                </a:r>
                <a:endParaRPr lang="fr-FR" sz="1200" b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4100735320038117E-2"/>
              <c:y val="0.2634878451405792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20965720"/>
        <c:crossesAt val="0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601758713775647"/>
          <c:y val="0.16166992509911662"/>
          <c:w val="0.75879690246217091"/>
          <c:h val="0.706736842105263"/>
        </c:manualLayout>
      </c:layout>
      <c:scatterChart>
        <c:scatterStyle val="lineMarker"/>
        <c:varyColors val="0"/>
        <c:ser>
          <c:idx val="0"/>
          <c:order val="0"/>
          <c:tx>
            <c:v>Col0</c:v>
          </c:tx>
          <c:spPr>
            <a:ln w="63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Col0!$I$29,Col0!$I$369,Col0!$I$397,Col0!$I$425,Col0!$I$453,Col0!$I$481,Col0!$I$509,Col0!$I$537,Col0!$I$565,Col0!$I$581,Col0!$I$597,Col0!$I$620)</c:f>
                <c:numCache>
                  <c:formatCode>General</c:formatCode>
                  <c:ptCount val="12"/>
                  <c:pt idx="0">
                    <c:v>5.109020964045988</c:v>
                  </c:pt>
                  <c:pt idx="1">
                    <c:v>3.8322187577105038</c:v>
                  </c:pt>
                  <c:pt idx="2">
                    <c:v>6.4065505423333429</c:v>
                  </c:pt>
                  <c:pt idx="3">
                    <c:v>1.742504932422634</c:v>
                  </c:pt>
                  <c:pt idx="4">
                    <c:v>5.478986993373403</c:v>
                  </c:pt>
                  <c:pt idx="5">
                    <c:v>4.6431123364061317</c:v>
                  </c:pt>
                  <c:pt idx="6">
                    <c:v>6.4470588831354876</c:v>
                  </c:pt>
                  <c:pt idx="7">
                    <c:v>14.486032459684001</c:v>
                  </c:pt>
                  <c:pt idx="8">
                    <c:v>14.72203375543913</c:v>
                  </c:pt>
                  <c:pt idx="11">
                    <c:v>9.8433483874678309</c:v>
                  </c:pt>
                </c:numCache>
              </c:numRef>
            </c:plus>
            <c:minus>
              <c:numRef>
                <c:f>(Col0!$I$29,Col0!$I$369,Col0!$I$397,Col0!$I$425,Col0!$I$453,Col0!$I$481,Col0!$I$509,Col0!$I$537,Col0!$I$565,Col0!$I$581,Col0!$I$597,Col0!$I$620)</c:f>
                <c:numCache>
                  <c:formatCode>General</c:formatCode>
                  <c:ptCount val="12"/>
                  <c:pt idx="0">
                    <c:v>5.109020964045988</c:v>
                  </c:pt>
                  <c:pt idx="1">
                    <c:v>3.8322187577105038</c:v>
                  </c:pt>
                  <c:pt idx="2">
                    <c:v>6.4065505423333429</c:v>
                  </c:pt>
                  <c:pt idx="3">
                    <c:v>1.742504932422634</c:v>
                  </c:pt>
                  <c:pt idx="4">
                    <c:v>5.478986993373403</c:v>
                  </c:pt>
                  <c:pt idx="5">
                    <c:v>4.6431123364061317</c:v>
                  </c:pt>
                  <c:pt idx="6">
                    <c:v>6.4470588831354876</c:v>
                  </c:pt>
                  <c:pt idx="7">
                    <c:v>14.486032459684001</c:v>
                  </c:pt>
                  <c:pt idx="8">
                    <c:v>14.72203375543913</c:v>
                  </c:pt>
                  <c:pt idx="11">
                    <c:v>9.8433483874678309</c:v>
                  </c:pt>
                </c:numCache>
              </c:numRef>
            </c:minus>
            <c:spPr>
              <a:ln w="6350"/>
            </c:spPr>
          </c:errBars>
          <c:xVal>
            <c:numRef>
              <c:f>(Col0!$C$2,Col0!$C$30,Col0!$C$58,Col0!$C$86,Col0!$C$114,Col0!$C$142,Col0!$C$170,Col0!$C$198,Col0!$C$226,Col0!$C$254,Col0!$C$270,Col0!$C$286)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(Col0!$I$28,Col0!$I$368,Col0!$I$396,Col0!$I$424,Col0!$I$452,Col0!$I$480,Col0!$I$508,Col0!$I$536,Col0!$I$564,Col0!$I$580,Col0!$I$596,Col0!$I$619)</c:f>
              <c:numCache>
                <c:formatCode>0.000</c:formatCode>
                <c:ptCount val="12"/>
                <c:pt idx="0">
                  <c:v>89.449744964271503</c:v>
                </c:pt>
                <c:pt idx="1">
                  <c:v>88.580544128213262</c:v>
                </c:pt>
                <c:pt idx="2">
                  <c:v>88.134954785638101</c:v>
                </c:pt>
                <c:pt idx="3">
                  <c:v>87.071855797361479</c:v>
                </c:pt>
                <c:pt idx="4">
                  <c:v>84.604506445949099</c:v>
                </c:pt>
                <c:pt idx="5">
                  <c:v>83.978923498600622</c:v>
                </c:pt>
                <c:pt idx="6">
                  <c:v>77.881509485272005</c:v>
                </c:pt>
                <c:pt idx="7">
                  <c:v>70.188868028227489</c:v>
                </c:pt>
                <c:pt idx="8">
                  <c:v>59.507155916839359</c:v>
                </c:pt>
                <c:pt idx="9">
                  <c:v>45.633292711996198</c:v>
                </c:pt>
                <c:pt idx="10">
                  <c:v>25.093375046772749</c:v>
                </c:pt>
                <c:pt idx="11">
                  <c:v>26.04431552068946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F4C-0640-8BB6-45DE0E3223E0}"/>
            </c:ext>
          </c:extLst>
        </c:ser>
        <c:ser>
          <c:idx val="1"/>
          <c:order val="1"/>
          <c:tx>
            <c:v>at1g08920</c:v>
          </c:tx>
          <c:spPr>
            <a:ln w="6350" cap="rnd">
              <a:solidFill>
                <a:schemeClr val="accent2"/>
              </a:solidFill>
              <a:round/>
            </a:ln>
            <a:effectLst/>
          </c:spPr>
          <c:marker>
            <c:symbol val="x"/>
            <c:size val="4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8920'!$H$29,'08920'!$H$383,'08920'!$H$411,'08920'!$H$439,'08920'!$H$467,'08920'!$H$495,'08920'!$H$523,'08920'!$H$551,'08920'!$H$579,'08920'!$H$602,'08920'!$H$625,'08920'!$H$648)</c:f>
                <c:numCache>
                  <c:formatCode>General</c:formatCode>
                  <c:ptCount val="12"/>
                  <c:pt idx="0">
                    <c:v>6.6838185088451834</c:v>
                  </c:pt>
                  <c:pt idx="1">
                    <c:v>4.1169375136716786</c:v>
                  </c:pt>
                  <c:pt idx="2">
                    <c:v>7.3556932171601321</c:v>
                  </c:pt>
                  <c:pt idx="3">
                    <c:v>2.100979438850207</c:v>
                  </c:pt>
                  <c:pt idx="4">
                    <c:v>3.0717040692959139</c:v>
                  </c:pt>
                  <c:pt idx="5">
                    <c:v>8.1002004322452255</c:v>
                  </c:pt>
                  <c:pt idx="6">
                    <c:v>7.4364238188190299</c:v>
                  </c:pt>
                  <c:pt idx="7">
                    <c:v>15.920314125485231</c:v>
                  </c:pt>
                  <c:pt idx="8">
                    <c:v>17.50129570305096</c:v>
                  </c:pt>
                  <c:pt idx="9">
                    <c:v>14.783159852746531</c:v>
                  </c:pt>
                  <c:pt idx="10">
                    <c:v>12.066371666122659</c:v>
                  </c:pt>
                  <c:pt idx="11">
                    <c:v>13.6237348866521</c:v>
                  </c:pt>
                </c:numCache>
              </c:numRef>
            </c:plus>
            <c:minus>
              <c:numRef>
                <c:f>('08920'!$H$29,'08920'!$H$383,'08920'!$H$411,'08920'!$H$439,'08920'!$H$467,'08920'!$H$495,'08920'!$H$523,'08920'!$H$551,'08920'!$H$579,'08920'!$H$602,'08920'!$H$625,'08920'!$H$648)</c:f>
                <c:numCache>
                  <c:formatCode>General</c:formatCode>
                  <c:ptCount val="12"/>
                  <c:pt idx="0">
                    <c:v>6.6838185088451834</c:v>
                  </c:pt>
                  <c:pt idx="1">
                    <c:v>4.1169375136716786</c:v>
                  </c:pt>
                  <c:pt idx="2">
                    <c:v>7.3556932171601321</c:v>
                  </c:pt>
                  <c:pt idx="3">
                    <c:v>2.100979438850207</c:v>
                  </c:pt>
                  <c:pt idx="4">
                    <c:v>3.0717040692959139</c:v>
                  </c:pt>
                  <c:pt idx="5">
                    <c:v>8.1002004322452255</c:v>
                  </c:pt>
                  <c:pt idx="6">
                    <c:v>7.4364238188190299</c:v>
                  </c:pt>
                  <c:pt idx="7">
                    <c:v>15.920314125485231</c:v>
                  </c:pt>
                  <c:pt idx="8">
                    <c:v>17.50129570305096</c:v>
                  </c:pt>
                  <c:pt idx="9">
                    <c:v>14.783159852746531</c:v>
                  </c:pt>
                  <c:pt idx="10">
                    <c:v>12.066371666122659</c:v>
                  </c:pt>
                  <c:pt idx="11">
                    <c:v>13.6237348866521</c:v>
                  </c:pt>
                </c:numCache>
              </c:numRef>
            </c:minus>
            <c:spPr>
              <a:ln w="6350"/>
            </c:spPr>
          </c:errBars>
          <c:xVal>
            <c:numRef>
              <c:f>(Col0!$C$2,Col0!$C$30,Col0!$C$58,Col0!$C$86,Col0!$C$114,Col0!$C$142,Col0!$C$170,Col0!$C$198,Col0!$C$226,Col0!$C$254,Col0!$C$270,Col0!$C$286)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('08920'!$H$28,'08920'!$H$382,'08920'!$H$410,'08920'!$H$438,'08920'!$H$466,'08920'!$H$494,'08920'!$H$522,'08920'!$H$550,'08920'!$H$578,'08920'!$H$601,'08920'!$H$624,'08920'!$H$647)</c:f>
              <c:numCache>
                <c:formatCode>0.000</c:formatCode>
                <c:ptCount val="12"/>
                <c:pt idx="0">
                  <c:v>94.859726339995476</c:v>
                </c:pt>
                <c:pt idx="1">
                  <c:v>87.372866400688935</c:v>
                </c:pt>
                <c:pt idx="2">
                  <c:v>86.546057711437044</c:v>
                </c:pt>
                <c:pt idx="3">
                  <c:v>86.043694192006882</c:v>
                </c:pt>
                <c:pt idx="4">
                  <c:v>84.713006836369289</c:v>
                </c:pt>
                <c:pt idx="5">
                  <c:v>77.725483114325527</c:v>
                </c:pt>
                <c:pt idx="6">
                  <c:v>73.64189793516384</c:v>
                </c:pt>
                <c:pt idx="7">
                  <c:v>61.263620787292993</c:v>
                </c:pt>
                <c:pt idx="8">
                  <c:v>50.728393887783049</c:v>
                </c:pt>
                <c:pt idx="9">
                  <c:v>34.915356503633589</c:v>
                </c:pt>
                <c:pt idx="10">
                  <c:v>30.71977541050914</c:v>
                </c:pt>
                <c:pt idx="11">
                  <c:v>23.78210070570645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7F4C-0640-8BB6-45DE0E3223E0}"/>
            </c:ext>
          </c:extLst>
        </c:ser>
        <c:ser>
          <c:idx val="2"/>
          <c:order val="2"/>
          <c:tx>
            <c:v>at1g75220</c:v>
          </c:tx>
          <c:spPr>
            <a:ln w="6350" cap="rnd">
              <a:solidFill>
                <a:schemeClr val="accent3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75220'!$H$29,'75220'!$H$383,'75220'!$H$411,'75220'!$H$439,'75220'!$H$467,'75220'!$H$495,'75220'!$H$523,'75220'!$H$551,'75220'!$H$579,'75220'!$H$602,'75220'!$H$625,'75220'!$H$648)</c:f>
                <c:numCache>
                  <c:formatCode>General</c:formatCode>
                  <c:ptCount val="12"/>
                  <c:pt idx="0">
                    <c:v>8.9496839254075997</c:v>
                  </c:pt>
                  <c:pt idx="1">
                    <c:v>2.6515550967719639</c:v>
                  </c:pt>
                  <c:pt idx="2">
                    <c:v>4.0127640392994959</c:v>
                  </c:pt>
                  <c:pt idx="3">
                    <c:v>2.1905164037290188</c:v>
                  </c:pt>
                  <c:pt idx="4">
                    <c:v>4.3005148410297771</c:v>
                  </c:pt>
                  <c:pt idx="5">
                    <c:v>6.6372217267170797</c:v>
                  </c:pt>
                  <c:pt idx="6">
                    <c:v>7.311378409093404</c:v>
                  </c:pt>
                  <c:pt idx="7">
                    <c:v>8.2869019088233618</c:v>
                  </c:pt>
                  <c:pt idx="8">
                    <c:v>16.106897573479269</c:v>
                  </c:pt>
                  <c:pt idx="9">
                    <c:v>15.25764716113812</c:v>
                  </c:pt>
                  <c:pt idx="10">
                    <c:v>18.6426735238351</c:v>
                  </c:pt>
                  <c:pt idx="11">
                    <c:v>19.919672389948509</c:v>
                  </c:pt>
                </c:numCache>
              </c:numRef>
            </c:plus>
            <c:minus>
              <c:numRef>
                <c:f>('75220'!$H$29,'75220'!$H$383,'75220'!$H$411,'75220'!$H$439,'75220'!$H$467,'75220'!$H$495,'75220'!$H$523,'75220'!$H$551,'75220'!$H$579,'75220'!$H$602,'75220'!$H$625,'75220'!$H$648)</c:f>
                <c:numCache>
                  <c:formatCode>General</c:formatCode>
                  <c:ptCount val="12"/>
                  <c:pt idx="0">
                    <c:v>8.9496839254075997</c:v>
                  </c:pt>
                  <c:pt idx="1">
                    <c:v>2.6515550967719639</c:v>
                  </c:pt>
                  <c:pt idx="2">
                    <c:v>4.0127640392994959</c:v>
                  </c:pt>
                  <c:pt idx="3">
                    <c:v>2.1905164037290188</c:v>
                  </c:pt>
                  <c:pt idx="4">
                    <c:v>4.3005148410297771</c:v>
                  </c:pt>
                  <c:pt idx="5">
                    <c:v>6.6372217267170797</c:v>
                  </c:pt>
                  <c:pt idx="6">
                    <c:v>7.311378409093404</c:v>
                  </c:pt>
                  <c:pt idx="7">
                    <c:v>8.2869019088233618</c:v>
                  </c:pt>
                  <c:pt idx="8">
                    <c:v>16.106897573479269</c:v>
                  </c:pt>
                  <c:pt idx="9">
                    <c:v>15.25764716113812</c:v>
                  </c:pt>
                  <c:pt idx="10">
                    <c:v>18.6426735238351</c:v>
                  </c:pt>
                  <c:pt idx="11">
                    <c:v>19.919672389948509</c:v>
                  </c:pt>
                </c:numCache>
              </c:numRef>
            </c:minus>
            <c:spPr>
              <a:ln w="6350"/>
            </c:spPr>
          </c:errBars>
          <c:xVal>
            <c:numRef>
              <c:f>('75220'!$C$2,'75220'!$C$30,'75220'!$C$58,'75220'!$C$86,'75220'!$C$114,'75220'!$C$142,'75220'!$C$170,'75220'!$C$198,'75220'!$C$226,'75220'!$C$254,'75220'!$C$277,'75220'!$C$300)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('75220'!$H$28,'75220'!$H$382,'75220'!$H$410,'75220'!$H$438,'75220'!$H$466,'75220'!$H$494,'75220'!$H$522,'75220'!$H$550,'75220'!$H$578,'75220'!$H$601,'75220'!$H$624,'75220'!$H$647)</c:f>
              <c:numCache>
                <c:formatCode>0.000</c:formatCode>
                <c:ptCount val="12"/>
                <c:pt idx="0">
                  <c:v>92.739850015747905</c:v>
                </c:pt>
                <c:pt idx="1">
                  <c:v>87.202418204870568</c:v>
                </c:pt>
                <c:pt idx="2">
                  <c:v>85.794582636101183</c:v>
                </c:pt>
                <c:pt idx="3">
                  <c:v>87.248769371927196</c:v>
                </c:pt>
                <c:pt idx="4">
                  <c:v>83.821125712475478</c:v>
                </c:pt>
                <c:pt idx="5">
                  <c:v>80.979119580737802</c:v>
                </c:pt>
                <c:pt idx="6">
                  <c:v>74.110130523264743</c:v>
                </c:pt>
                <c:pt idx="7">
                  <c:v>68.996936090777496</c:v>
                </c:pt>
                <c:pt idx="8">
                  <c:v>48.617855705007493</c:v>
                </c:pt>
                <c:pt idx="9">
                  <c:v>33.227296297130998</c:v>
                </c:pt>
                <c:pt idx="10">
                  <c:v>36.068631633318127</c:v>
                </c:pt>
                <c:pt idx="11">
                  <c:v>32.09760347048734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7F4C-0640-8BB6-45DE0E3223E0}"/>
            </c:ext>
          </c:extLst>
        </c:ser>
        <c:ser>
          <c:idx val="3"/>
          <c:order val="3"/>
          <c:tx>
            <c:v>at3g04760</c:v>
          </c:tx>
          <c:spPr>
            <a:ln w="6350" cap="rnd">
              <a:solidFill>
                <a:schemeClr val="accent4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4760'!$H$29,'04760'!$H$383,'04760'!$H$411,'04760'!$H$439,'04760'!$H$467,'04760'!$H$495,'04760'!$H$523,'04760'!$H$551,'04760'!$H$579,'04760'!$H$602,'04760'!$H$625,'04760'!$H$648)</c:f>
                <c:numCache>
                  <c:formatCode>General</c:formatCode>
                  <c:ptCount val="12"/>
                  <c:pt idx="0">
                    <c:v>6.7918101228019907</c:v>
                  </c:pt>
                  <c:pt idx="1">
                    <c:v>3.0949440111925561</c:v>
                  </c:pt>
                  <c:pt idx="2">
                    <c:v>2.1002766118340328</c:v>
                  </c:pt>
                  <c:pt idx="3">
                    <c:v>2.3618422372307051</c:v>
                  </c:pt>
                  <c:pt idx="4">
                    <c:v>2.2442736776960999</c:v>
                  </c:pt>
                  <c:pt idx="5">
                    <c:v>2.530056327169977</c:v>
                  </c:pt>
                  <c:pt idx="6">
                    <c:v>7.7105515463623746</c:v>
                  </c:pt>
                  <c:pt idx="7">
                    <c:v>14.53937890193483</c:v>
                  </c:pt>
                  <c:pt idx="8">
                    <c:v>15.20556188361658</c:v>
                  </c:pt>
                  <c:pt idx="9">
                    <c:v>13.918897656658039</c:v>
                  </c:pt>
                  <c:pt idx="10">
                    <c:v>4.4828016093365486</c:v>
                  </c:pt>
                  <c:pt idx="11">
                    <c:v>9.8366112117571731</c:v>
                  </c:pt>
                </c:numCache>
              </c:numRef>
            </c:plus>
            <c:minus>
              <c:numRef>
                <c:f>('04760'!$H$29,'04760'!$H$383,'04760'!$H$411,'04760'!$H$439,'04760'!$H$467,'04760'!$H$495,'04760'!$H$523,'04760'!$H$551,'04760'!$H$579,'04760'!$H$602,'04760'!$H$625,'04760'!$H$648)</c:f>
                <c:numCache>
                  <c:formatCode>General</c:formatCode>
                  <c:ptCount val="12"/>
                  <c:pt idx="0">
                    <c:v>6.7918101228019907</c:v>
                  </c:pt>
                  <c:pt idx="1">
                    <c:v>3.0949440111925561</c:v>
                  </c:pt>
                  <c:pt idx="2">
                    <c:v>2.1002766118340328</c:v>
                  </c:pt>
                  <c:pt idx="3">
                    <c:v>2.3618422372307051</c:v>
                  </c:pt>
                  <c:pt idx="4">
                    <c:v>2.2442736776960999</c:v>
                  </c:pt>
                  <c:pt idx="5">
                    <c:v>2.530056327169977</c:v>
                  </c:pt>
                  <c:pt idx="6">
                    <c:v>7.7105515463623746</c:v>
                  </c:pt>
                  <c:pt idx="7">
                    <c:v>14.53937890193483</c:v>
                  </c:pt>
                  <c:pt idx="8">
                    <c:v>15.20556188361658</c:v>
                  </c:pt>
                  <c:pt idx="9">
                    <c:v>13.918897656658039</c:v>
                  </c:pt>
                  <c:pt idx="10">
                    <c:v>4.4828016093365486</c:v>
                  </c:pt>
                  <c:pt idx="11">
                    <c:v>9.8366112117571731</c:v>
                  </c:pt>
                </c:numCache>
              </c:numRef>
            </c:minus>
            <c:spPr>
              <a:ln w="6350">
                <a:solidFill>
                  <a:schemeClr val="tx1"/>
                </a:solidFill>
              </a:ln>
            </c:spPr>
          </c:errBars>
          <c:xVal>
            <c:numRef>
              <c:f>('04760'!$C$2,'04760'!$C$30,'04760'!$C$58,'04760'!$C$86,'04760'!$C$114,'04760'!$C$142,'04760'!$C$170,'04760'!$C$198,'04760'!$C$226,'04760'!$C$254,'04760'!$C$277,'04760'!$C$300)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('04760'!$H$28,'04760'!$H$382,'04760'!$H$410,'04760'!$H$438,'04760'!$H$466,'04760'!$H$494,'04760'!$H$522,'04760'!$H$550,'04760'!$H$578,'04760'!$H$601,'04760'!$H$624,'04760'!$H$647)</c:f>
              <c:numCache>
                <c:formatCode>0.000</c:formatCode>
                <c:ptCount val="12"/>
                <c:pt idx="0">
                  <c:v>93.850644481950766</c:v>
                </c:pt>
                <c:pt idx="1">
                  <c:v>87.178001594377278</c:v>
                </c:pt>
                <c:pt idx="2">
                  <c:v>86.511147081722825</c:v>
                </c:pt>
                <c:pt idx="3">
                  <c:v>86.607661225774322</c:v>
                </c:pt>
                <c:pt idx="4">
                  <c:v>83.440005276772524</c:v>
                </c:pt>
                <c:pt idx="5">
                  <c:v>82.977368791544208</c:v>
                </c:pt>
                <c:pt idx="6">
                  <c:v>76.115328754722981</c:v>
                </c:pt>
                <c:pt idx="7">
                  <c:v>66.955992239280349</c:v>
                </c:pt>
                <c:pt idx="8">
                  <c:v>52.482106583128306</c:v>
                </c:pt>
                <c:pt idx="9">
                  <c:v>36.277593057316217</c:v>
                </c:pt>
                <c:pt idx="10">
                  <c:v>25.1330520476968</c:v>
                </c:pt>
                <c:pt idx="11">
                  <c:v>21.95397732133999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7F4C-0640-8BB6-45DE0E3223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14148184"/>
        <c:axId val="818423960"/>
      </c:scatterChart>
      <c:valAx>
        <c:axId val="814148184"/>
        <c:scaling>
          <c:orientation val="minMax"/>
          <c:max val="16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18423960"/>
        <c:crosses val="autoZero"/>
        <c:crossBetween val="midCat"/>
        <c:majorUnit val="1"/>
      </c:valAx>
      <c:valAx>
        <c:axId val="818423960"/>
        <c:scaling>
          <c:orientation val="minMax"/>
          <c:max val="120"/>
          <c:min val="0"/>
        </c:scaling>
        <c:delete val="0"/>
        <c:axPos val="l"/>
        <c:majorGridlines>
          <c:spPr>
            <a:ln w="6350">
              <a:solidFill>
                <a:schemeClr val="bg1">
                  <a:lumMod val="85000"/>
                </a:schemeClr>
              </a:solidFill>
            </a:ln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fr-FR" sz="1200" b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WC </a:t>
                </a:r>
                <a:r>
                  <a:rPr lang="fr-FR" sz="1200" b="0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%)</a:t>
                </a:r>
                <a:endParaRPr lang="fr-FR" sz="1200" b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4.4505456636592536E-3"/>
              <c:y val="0.1986316019142932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14148184"/>
        <c:crossesAt val="0"/>
        <c:crossBetween val="midCat"/>
        <c:majorUnit val="4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284726364323689"/>
          <c:y val="0.15255503760008812"/>
          <c:w val="0.72404123030895684"/>
          <c:h val="0.706736842105263"/>
        </c:manualLayout>
      </c:layout>
      <c:scatterChart>
        <c:scatterStyle val="lineMarker"/>
        <c:varyColors val="0"/>
        <c:ser>
          <c:idx val="0"/>
          <c:order val="0"/>
          <c:tx>
            <c:v>Col0</c:v>
          </c:tx>
          <c:spPr>
            <a:ln w="63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Col0!$I$29,Col0!$I$57,Col0!$I$85,Col0!$I$113,Col0!$I$141,Col0!$I$169,Col0!$I$197,Col0!$I$225,Col0!$I$253,Col0!$I$269,Col0!$I$285,Col0!$I$313)</c:f>
                <c:numCache>
                  <c:formatCode>General</c:formatCode>
                  <c:ptCount val="12"/>
                  <c:pt idx="0">
                    <c:v>5.109020964045988</c:v>
                  </c:pt>
                  <c:pt idx="1">
                    <c:v>4.6009090387474094</c:v>
                  </c:pt>
                  <c:pt idx="2">
                    <c:v>7.4334152520796941</c:v>
                  </c:pt>
                  <c:pt idx="3">
                    <c:v>3.7878170800269881</c:v>
                  </c:pt>
                  <c:pt idx="4">
                    <c:v>8.2723675953570144</c:v>
                  </c:pt>
                  <c:pt idx="5">
                    <c:v>8.3166412231282401</c:v>
                  </c:pt>
                  <c:pt idx="6">
                    <c:v>3.8857580796428821</c:v>
                  </c:pt>
                  <c:pt idx="7">
                    <c:v>3.1926537271709821</c:v>
                  </c:pt>
                  <c:pt idx="8">
                    <c:v>3.8643306192032241</c:v>
                  </c:pt>
                  <c:pt idx="11">
                    <c:v>3.4600181883604741</c:v>
                  </c:pt>
                </c:numCache>
              </c:numRef>
            </c:plus>
            <c:minus>
              <c:numRef>
                <c:f>(Col0!$I$29,Col0!$I$57,Col0!$I$85,Col0!$I$113,Col0!$I$141,Col0!$I$169,Col0!$I$197,Col0!$I$225,Col0!$I$253,Col0!$I$269,Col0!$I$285,Col0!$I$313)</c:f>
                <c:numCache>
                  <c:formatCode>General</c:formatCode>
                  <c:ptCount val="12"/>
                  <c:pt idx="0">
                    <c:v>5.109020964045988</c:v>
                  </c:pt>
                  <c:pt idx="1">
                    <c:v>4.6009090387474094</c:v>
                  </c:pt>
                  <c:pt idx="2">
                    <c:v>7.4334152520796941</c:v>
                  </c:pt>
                  <c:pt idx="3">
                    <c:v>3.7878170800269881</c:v>
                  </c:pt>
                  <c:pt idx="4">
                    <c:v>8.2723675953570144</c:v>
                  </c:pt>
                  <c:pt idx="5">
                    <c:v>8.3166412231282401</c:v>
                  </c:pt>
                  <c:pt idx="6">
                    <c:v>3.8857580796428821</c:v>
                  </c:pt>
                  <c:pt idx="7">
                    <c:v>3.1926537271709821</c:v>
                  </c:pt>
                  <c:pt idx="8">
                    <c:v>3.8643306192032241</c:v>
                  </c:pt>
                  <c:pt idx="11">
                    <c:v>3.4600181883604741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Col0!$C$3,Col0!$C$31,Col0!$C$59,Col0!$C$87,Col0!$C$115,Col0!$C$143,Col0!$C$171,Col0!$C$199,Col0!$C$227,Col0!$C$255,Col0!$C$271,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Col0!$I$28,Col0!$I$56,Col0!$I$84,Col0!$I$112,Col0!$I$140,Col0!$I$168,Col0!$I$196,Col0!$I$224,Col0!$I$252,Col0!$I$268,Col0!$I$284,Col0!$I$312)</c:f>
              <c:numCache>
                <c:formatCode>0.000</c:formatCode>
                <c:ptCount val="12"/>
                <c:pt idx="0">
                  <c:v>89.449744964271503</c:v>
                </c:pt>
                <c:pt idx="1">
                  <c:v>89.870540220170483</c:v>
                </c:pt>
                <c:pt idx="2">
                  <c:v>91.790137103133048</c:v>
                </c:pt>
                <c:pt idx="3">
                  <c:v>90.156311645853208</c:v>
                </c:pt>
                <c:pt idx="4">
                  <c:v>86.7986379523132</c:v>
                </c:pt>
                <c:pt idx="5">
                  <c:v>90.138396651690584</c:v>
                </c:pt>
                <c:pt idx="6">
                  <c:v>87.789399023789798</c:v>
                </c:pt>
                <c:pt idx="7">
                  <c:v>89.922507404163582</c:v>
                </c:pt>
                <c:pt idx="8">
                  <c:v>87.801594058728099</c:v>
                </c:pt>
                <c:pt idx="9">
                  <c:v>86.340514238886541</c:v>
                </c:pt>
                <c:pt idx="10">
                  <c:v>87.167044440207505</c:v>
                </c:pt>
                <c:pt idx="11">
                  <c:v>84.49613049484173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24B-474E-B7B0-B49F6962F435}"/>
            </c:ext>
          </c:extLst>
        </c:ser>
        <c:ser>
          <c:idx val="1"/>
          <c:order val="1"/>
          <c:tx>
            <c:v>at1g08920</c:v>
          </c:tx>
          <c:spPr>
            <a:ln w="6350" cap="rnd">
              <a:solidFill>
                <a:schemeClr val="accent2"/>
              </a:solidFill>
              <a:round/>
            </a:ln>
            <a:effectLst/>
          </c:spPr>
          <c:marker>
            <c:symbol val="x"/>
            <c:size val="4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8920'!$H$29,'08920'!$H$57,'08920'!$H$85,'08920'!$H$113,'08920'!$H$141,'08920'!$H$169,'08920'!$H$197,'08920'!$H$225,'08920'!$H$253,'08920'!$H$276,'08920'!$H$299,'08920'!$H$327)</c:f>
                <c:numCache>
                  <c:formatCode>General</c:formatCode>
                  <c:ptCount val="12"/>
                  <c:pt idx="0">
                    <c:v>6.6838185088451834</c:v>
                  </c:pt>
                  <c:pt idx="1">
                    <c:v>4.9856453909752796</c:v>
                  </c:pt>
                  <c:pt idx="2">
                    <c:v>19.107989679423941</c:v>
                  </c:pt>
                  <c:pt idx="3">
                    <c:v>2.3701149581613641</c:v>
                  </c:pt>
                  <c:pt idx="4">
                    <c:v>2.983713217435437</c:v>
                  </c:pt>
                  <c:pt idx="5">
                    <c:v>6.4676805543381066</c:v>
                  </c:pt>
                  <c:pt idx="6">
                    <c:v>4.8591572933756142</c:v>
                  </c:pt>
                  <c:pt idx="7">
                    <c:v>2.578686118196849</c:v>
                  </c:pt>
                  <c:pt idx="8">
                    <c:v>6.0282633104333501</c:v>
                  </c:pt>
                  <c:pt idx="9">
                    <c:v>15.420129859416781</c:v>
                  </c:pt>
                  <c:pt idx="10">
                    <c:v>2.7304555048287411</c:v>
                  </c:pt>
                  <c:pt idx="11">
                    <c:v>5.8562033700318841</c:v>
                  </c:pt>
                </c:numCache>
              </c:numRef>
            </c:plus>
            <c:minus>
              <c:numRef>
                <c:f>('08920'!$H$29,'08920'!$H$57,'08920'!$H$85,'08920'!$H$113,'08920'!$H$141,'08920'!$H$169,'08920'!$H$197,'08920'!$H$225,'08920'!$H$253,'08920'!$H$276,'08920'!$H$299,'08920'!$H$327)</c:f>
                <c:numCache>
                  <c:formatCode>General</c:formatCode>
                  <c:ptCount val="12"/>
                  <c:pt idx="0">
                    <c:v>6.6838185088451834</c:v>
                  </c:pt>
                  <c:pt idx="1">
                    <c:v>4.9856453909752796</c:v>
                  </c:pt>
                  <c:pt idx="2">
                    <c:v>19.107989679423941</c:v>
                  </c:pt>
                  <c:pt idx="3">
                    <c:v>2.3701149581613641</c:v>
                  </c:pt>
                  <c:pt idx="4">
                    <c:v>2.983713217435437</c:v>
                  </c:pt>
                  <c:pt idx="5">
                    <c:v>6.4676805543381066</c:v>
                  </c:pt>
                  <c:pt idx="6">
                    <c:v>4.8591572933756142</c:v>
                  </c:pt>
                  <c:pt idx="7">
                    <c:v>2.578686118196849</c:v>
                  </c:pt>
                  <c:pt idx="8">
                    <c:v>6.0282633104333501</c:v>
                  </c:pt>
                  <c:pt idx="9">
                    <c:v>15.420129859416781</c:v>
                  </c:pt>
                  <c:pt idx="10">
                    <c:v>2.7304555048287411</c:v>
                  </c:pt>
                  <c:pt idx="11">
                    <c:v>5.8562033700318841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Col0!$C$3,Col0!$C$31,Col0!$C$59,Col0!$C$87,Col0!$C$115,Col0!$C$143,Col0!$C$171,Col0!$C$199,Col0!$C$227,Col0!$C$255,Col0!$C$271,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'08920'!$H$28,'08920'!$H$56,'08920'!$H$84,'08920'!$H$112,'08920'!$H$140,'08920'!$H$168,'08920'!$H$196,'08920'!$H$224,'08920'!$H$252,'08920'!$H$275,'08920'!$H$298,'08920'!$H$326)</c:f>
              <c:numCache>
                <c:formatCode>0.000</c:formatCode>
                <c:ptCount val="12"/>
                <c:pt idx="0">
                  <c:v>94.859726339995476</c:v>
                </c:pt>
                <c:pt idx="1">
                  <c:v>89.808886523492276</c:v>
                </c:pt>
                <c:pt idx="2">
                  <c:v>95.434652599836596</c:v>
                </c:pt>
                <c:pt idx="3">
                  <c:v>90.475499741672621</c:v>
                </c:pt>
                <c:pt idx="4">
                  <c:v>91.016146879617395</c:v>
                </c:pt>
                <c:pt idx="5">
                  <c:v>91.7980989012854</c:v>
                </c:pt>
                <c:pt idx="6">
                  <c:v>87.230918150281354</c:v>
                </c:pt>
                <c:pt idx="7">
                  <c:v>85.342863027872653</c:v>
                </c:pt>
                <c:pt idx="8">
                  <c:v>89.186036584849646</c:v>
                </c:pt>
                <c:pt idx="9">
                  <c:v>87.711389720945206</c:v>
                </c:pt>
                <c:pt idx="10">
                  <c:v>87.297213232004523</c:v>
                </c:pt>
                <c:pt idx="11">
                  <c:v>88.0595134839222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A24B-474E-B7B0-B49F6962F435}"/>
            </c:ext>
          </c:extLst>
        </c:ser>
        <c:ser>
          <c:idx val="2"/>
          <c:order val="2"/>
          <c:tx>
            <c:v>at1g75220</c:v>
          </c:tx>
          <c:spPr>
            <a:ln w="6350" cap="rnd">
              <a:solidFill>
                <a:schemeClr val="accent3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75220'!$H$29,'75220'!$H$57,'75220'!$H$85,'75220'!$H$113,'75220'!$H$141,'75220'!$H$169,'75220'!$H$197,'75220'!$H$225,'75220'!$H$253,'75220'!$H$276,'75220'!$H$299,'75220'!$H$327)</c:f>
                <c:numCache>
                  <c:formatCode>General</c:formatCode>
                  <c:ptCount val="12"/>
                  <c:pt idx="0">
                    <c:v>8.9496839254075997</c:v>
                  </c:pt>
                  <c:pt idx="1">
                    <c:v>3.357068811514873</c:v>
                  </c:pt>
                  <c:pt idx="2">
                    <c:v>3.1272035185291509</c:v>
                  </c:pt>
                  <c:pt idx="3">
                    <c:v>3.1795146937724752</c:v>
                  </c:pt>
                  <c:pt idx="4">
                    <c:v>3.256662396235499</c:v>
                  </c:pt>
                  <c:pt idx="5">
                    <c:v>8.1079748032648187</c:v>
                  </c:pt>
                  <c:pt idx="6">
                    <c:v>4.3875771626780367</c:v>
                  </c:pt>
                  <c:pt idx="7">
                    <c:v>6.7707440442295201</c:v>
                  </c:pt>
                  <c:pt idx="8">
                    <c:v>4.7008822191431117</c:v>
                  </c:pt>
                  <c:pt idx="9">
                    <c:v>5.1049478133315001</c:v>
                  </c:pt>
                  <c:pt idx="10">
                    <c:v>3.8502440230005379</c:v>
                  </c:pt>
                  <c:pt idx="11">
                    <c:v>8.7244884571139636</c:v>
                  </c:pt>
                </c:numCache>
              </c:numRef>
            </c:plus>
            <c:minus>
              <c:numRef>
                <c:f>('75220'!$H$29,'75220'!$H$57,'75220'!$H$85,'75220'!$H$113,'75220'!$H$141,'75220'!$H$169,'75220'!$H$197,'75220'!$H$225,'75220'!$H$253,'75220'!$H$276,'75220'!$H$299,'75220'!$H$327)</c:f>
                <c:numCache>
                  <c:formatCode>General</c:formatCode>
                  <c:ptCount val="12"/>
                  <c:pt idx="0">
                    <c:v>8.9496839254075997</c:v>
                  </c:pt>
                  <c:pt idx="1">
                    <c:v>3.357068811514873</c:v>
                  </c:pt>
                  <c:pt idx="2">
                    <c:v>3.1272035185291509</c:v>
                  </c:pt>
                  <c:pt idx="3">
                    <c:v>3.1795146937724752</c:v>
                  </c:pt>
                  <c:pt idx="4">
                    <c:v>3.256662396235499</c:v>
                  </c:pt>
                  <c:pt idx="5">
                    <c:v>8.1079748032648187</c:v>
                  </c:pt>
                  <c:pt idx="6">
                    <c:v>4.3875771626780367</c:v>
                  </c:pt>
                  <c:pt idx="7">
                    <c:v>6.7707440442295201</c:v>
                  </c:pt>
                  <c:pt idx="8">
                    <c:v>4.7008822191431117</c:v>
                  </c:pt>
                  <c:pt idx="9">
                    <c:v>5.1049478133315001</c:v>
                  </c:pt>
                  <c:pt idx="10">
                    <c:v>3.8502440230005379</c:v>
                  </c:pt>
                  <c:pt idx="11">
                    <c:v>8.724488457113963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([1]Col0!$C$3,[1]Col0!$C$31,[1]Col0!$C$59,[1]Col0!$C$87,[1]Col0!$C$115,[1]Col0!$C$143,[1]Col0!$C$171,[1]Col0!$C$199,[1]Col0!$C$227,[1]Col0!$C$255,[1]Col0!$C$271,[1]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'75220'!$H$28,'75220'!$H$56,'75220'!$H$84,'75220'!$H$112,'75220'!$H$140,'75220'!$H$168,'75220'!$H$196,'75220'!$H$224,'75220'!$H$252,'75220'!$H$275,'75220'!$H$298)</c:f>
              <c:numCache>
                <c:formatCode>0.000</c:formatCode>
                <c:ptCount val="11"/>
                <c:pt idx="0">
                  <c:v>92.739850015747905</c:v>
                </c:pt>
                <c:pt idx="1">
                  <c:v>88.54887512901891</c:v>
                </c:pt>
                <c:pt idx="2">
                  <c:v>90.805343127615245</c:v>
                </c:pt>
                <c:pt idx="3">
                  <c:v>90.6104861840371</c:v>
                </c:pt>
                <c:pt idx="4">
                  <c:v>89.86812557975091</c:v>
                </c:pt>
                <c:pt idx="5">
                  <c:v>89.621995666014939</c:v>
                </c:pt>
                <c:pt idx="6">
                  <c:v>86.255022844145472</c:v>
                </c:pt>
                <c:pt idx="7">
                  <c:v>87.331344419474348</c:v>
                </c:pt>
                <c:pt idx="8">
                  <c:v>88.7496655879673</c:v>
                </c:pt>
                <c:pt idx="9">
                  <c:v>85.165225059967497</c:v>
                </c:pt>
                <c:pt idx="10">
                  <c:v>89.08542404783447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A24B-474E-B7B0-B49F6962F435}"/>
            </c:ext>
          </c:extLst>
        </c:ser>
        <c:ser>
          <c:idx val="3"/>
          <c:order val="3"/>
          <c:tx>
            <c:v>at3g04760</c:v>
          </c:tx>
          <c:spPr>
            <a:ln w="6350" cap="rnd">
              <a:solidFill>
                <a:schemeClr val="accent4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4760'!$H$29,'04760'!$H$57,'04760'!$H$85,'04760'!$H$113,'04760'!$H$141,'04760'!$H$169,'04760'!$H$197,'04760'!$H$225,'04760'!$H$253,'04760'!$H$276,'04760'!$H$299,'04760'!$H$327)</c:f>
                <c:numCache>
                  <c:formatCode>General</c:formatCode>
                  <c:ptCount val="12"/>
                  <c:pt idx="0">
                    <c:v>6.7918101228019907</c:v>
                  </c:pt>
                  <c:pt idx="1">
                    <c:v>2.9813491807619368</c:v>
                  </c:pt>
                  <c:pt idx="2">
                    <c:v>3.8470805935115711</c:v>
                  </c:pt>
                  <c:pt idx="3">
                    <c:v>3.5216544562491792</c:v>
                  </c:pt>
                  <c:pt idx="4">
                    <c:v>8.9114837890673204</c:v>
                  </c:pt>
                  <c:pt idx="5">
                    <c:v>8.8166618725235146</c:v>
                  </c:pt>
                  <c:pt idx="6">
                    <c:v>4.5470411122743499</c:v>
                  </c:pt>
                  <c:pt idx="7">
                    <c:v>7.9403278266999253</c:v>
                  </c:pt>
                  <c:pt idx="8">
                    <c:v>3.125810125309509</c:v>
                  </c:pt>
                  <c:pt idx="9">
                    <c:v>3.5620454355973381</c:v>
                  </c:pt>
                  <c:pt idx="10">
                    <c:v>4.6574274054988827</c:v>
                  </c:pt>
                  <c:pt idx="11">
                    <c:v>9.731145466705188</c:v>
                  </c:pt>
                </c:numCache>
              </c:numRef>
            </c:plus>
            <c:minus>
              <c:numRef>
                <c:f>('04760'!$H$29,'04760'!$H$57,'04760'!$H$85,'04760'!$H$113,'04760'!$H$141,'04760'!$H$169,'04760'!$H$197,'04760'!$H$225,'04760'!$H$253,'04760'!$H$276,'04760'!$H$299,'04760'!$H$327)</c:f>
                <c:numCache>
                  <c:formatCode>General</c:formatCode>
                  <c:ptCount val="12"/>
                  <c:pt idx="0">
                    <c:v>6.7918101228019907</c:v>
                  </c:pt>
                  <c:pt idx="1">
                    <c:v>2.9813491807619368</c:v>
                  </c:pt>
                  <c:pt idx="2">
                    <c:v>3.8470805935115711</c:v>
                  </c:pt>
                  <c:pt idx="3">
                    <c:v>3.5216544562491792</c:v>
                  </c:pt>
                  <c:pt idx="4">
                    <c:v>8.9114837890673204</c:v>
                  </c:pt>
                  <c:pt idx="5">
                    <c:v>8.8166618725235146</c:v>
                  </c:pt>
                  <c:pt idx="6">
                    <c:v>4.5470411122743499</c:v>
                  </c:pt>
                  <c:pt idx="7">
                    <c:v>7.9403278266999253</c:v>
                  </c:pt>
                  <c:pt idx="8">
                    <c:v>3.125810125309509</c:v>
                  </c:pt>
                  <c:pt idx="9">
                    <c:v>3.5620454355973381</c:v>
                  </c:pt>
                  <c:pt idx="10">
                    <c:v>4.6574274054988827</c:v>
                  </c:pt>
                  <c:pt idx="11">
                    <c:v>9.731145466705188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Col0!$C$3,Col0!$C$31,Col0!$C$59,Col0!$C$87,Col0!$C$115,Col0!$C$143,Col0!$C$171,Col0!$C$199,Col0!$C$227,Col0!$C$255,Col0!$C$271,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'04760'!$H$28,'04760'!$H$56,'04760'!$H$84,'04760'!$H$112,'04760'!$H$140,'04760'!$H$168,'04760'!$H$196,'04760'!$H$224,'04760'!$H$252,'04760'!$H$275,'04760'!$H$298,'04760'!$H$326)</c:f>
              <c:numCache>
                <c:formatCode>0.000</c:formatCode>
                <c:ptCount val="12"/>
                <c:pt idx="0">
                  <c:v>93.850644481950766</c:v>
                </c:pt>
                <c:pt idx="1">
                  <c:v>87.290440215435382</c:v>
                </c:pt>
                <c:pt idx="2">
                  <c:v>90.178810333599557</c:v>
                </c:pt>
                <c:pt idx="3">
                  <c:v>91.417123842078595</c:v>
                </c:pt>
                <c:pt idx="4">
                  <c:v>87.190297001897335</c:v>
                </c:pt>
                <c:pt idx="5">
                  <c:v>92.990629490376605</c:v>
                </c:pt>
                <c:pt idx="6">
                  <c:v>87.084987505960342</c:v>
                </c:pt>
                <c:pt idx="7">
                  <c:v>88.635041620740949</c:v>
                </c:pt>
                <c:pt idx="8">
                  <c:v>92.423006437979851</c:v>
                </c:pt>
                <c:pt idx="9">
                  <c:v>85.084066654030096</c:v>
                </c:pt>
                <c:pt idx="10">
                  <c:v>87.820051368867169</c:v>
                </c:pt>
                <c:pt idx="11">
                  <c:v>87.36425802795680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A24B-474E-B7B0-B49F6962F4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12733864"/>
        <c:axId val="812349256"/>
      </c:scatterChart>
      <c:valAx>
        <c:axId val="812733864"/>
        <c:scaling>
          <c:orientation val="minMax"/>
          <c:max val="51"/>
          <c:min val="35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12349256"/>
        <c:crosses val="autoZero"/>
        <c:crossBetween val="midCat"/>
        <c:majorUnit val="1"/>
      </c:valAx>
      <c:valAx>
        <c:axId val="812349256"/>
        <c:scaling>
          <c:orientation val="minMax"/>
          <c:max val="120"/>
          <c:min val="0"/>
        </c:scaling>
        <c:delete val="0"/>
        <c:axPos val="l"/>
        <c:majorGridlines>
          <c:spPr>
            <a:ln w="6350">
              <a:solidFill>
                <a:schemeClr val="bg1">
                  <a:lumMod val="85000"/>
                </a:schemeClr>
              </a:solidFill>
            </a:ln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fr-FR" sz="1200" b="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WC (%)</a:t>
                </a:r>
                <a:endParaRPr lang="fr-FR" sz="1200" b="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4.4181513987115867E-3"/>
              <c:y val="0.24268798594562624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12733864"/>
        <c:crossesAt val="0"/>
        <c:crossBetween val="midCat"/>
        <c:majorUnit val="4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141500623774727"/>
          <c:y val="9.3904107005824272E-2"/>
          <c:w val="0.76638060951702014"/>
          <c:h val="0.76538751357546342"/>
        </c:manualLayout>
      </c:layout>
      <c:scatterChart>
        <c:scatterStyle val="lineMarker"/>
        <c:varyColors val="0"/>
        <c:ser>
          <c:idx val="0"/>
          <c:order val="0"/>
          <c:tx>
            <c:v>Col0</c:v>
          </c:tx>
          <c:spPr>
            <a:ln w="63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Col0!$J$29,Col0!$J$57,Col0!$J$85,Col0!$J$113,Col0!$J$141,Col0!$J$169,Col0!$J$197,Col0!$J$225,Col0!$J$253,Col0!$J$269,Col0!$J$285,Col0!$J$313)</c:f>
                <c:numCache>
                  <c:formatCode>General</c:formatCode>
                  <c:ptCount val="12"/>
                  <c:pt idx="0">
                    <c:v>0.61779797179211404</c:v>
                  </c:pt>
                  <c:pt idx="1">
                    <c:v>2.357361887894192</c:v>
                  </c:pt>
                  <c:pt idx="2">
                    <c:v>0.65639943913927801</c:v>
                  </c:pt>
                  <c:pt idx="3">
                    <c:v>0.63452920214877595</c:v>
                  </c:pt>
                  <c:pt idx="4">
                    <c:v>0.81420961406015702</c:v>
                  </c:pt>
                  <c:pt idx="5">
                    <c:v>0.57738288696000295</c:v>
                  </c:pt>
                  <c:pt idx="6">
                    <c:v>0.41923725927376299</c:v>
                  </c:pt>
                  <c:pt idx="7">
                    <c:v>0.35259973701921699</c:v>
                  </c:pt>
                  <c:pt idx="8">
                    <c:v>0.43389192532582399</c:v>
                  </c:pt>
                  <c:pt idx="11">
                    <c:v>0.61088475466905101</c:v>
                  </c:pt>
                </c:numCache>
              </c:numRef>
            </c:plus>
            <c:minus>
              <c:numRef>
                <c:f>(Col0!$J$29,Col0!$J$57,Col0!$J$85,Col0!$J$113,Col0!$J$141,Col0!$J$169,Col0!$J$197,Col0!$J$225,Col0!$J$253,Col0!$J$269,Col0!$J$285,Col0!$J$313)</c:f>
                <c:numCache>
                  <c:formatCode>General</c:formatCode>
                  <c:ptCount val="12"/>
                  <c:pt idx="0">
                    <c:v>0.61779797179211404</c:v>
                  </c:pt>
                  <c:pt idx="1">
                    <c:v>2.357361887894192</c:v>
                  </c:pt>
                  <c:pt idx="2">
                    <c:v>0.65639943913927801</c:v>
                  </c:pt>
                  <c:pt idx="3">
                    <c:v>0.63452920214877595</c:v>
                  </c:pt>
                  <c:pt idx="4">
                    <c:v>0.81420961406015702</c:v>
                  </c:pt>
                  <c:pt idx="5">
                    <c:v>0.57738288696000295</c:v>
                  </c:pt>
                  <c:pt idx="6">
                    <c:v>0.41923725927376299</c:v>
                  </c:pt>
                  <c:pt idx="7">
                    <c:v>0.35259973701921699</c:v>
                  </c:pt>
                  <c:pt idx="8">
                    <c:v>0.43389192532582399</c:v>
                  </c:pt>
                  <c:pt idx="11">
                    <c:v>0.610884754669051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(Col0!$C$3,Col0!$C$31,Col0!$C$59,Col0!$C$87,Col0!$C$115,Col0!$C$143,Col0!$C$171,Col0!$C$199,Col0!$C$227,Col0!$C$255,Col0!$C$271,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Col0!$J$28,Col0!$J$56,Col0!$J$84,Col0!$J$112,Col0!$J$140,Col0!$J$168,Col0!$J$196,Col0!$J$224,Col0!$J$252,Col0!$J$268,Col0!$J$284,Col0!$J$312)</c:f>
              <c:numCache>
                <c:formatCode>0.000</c:formatCode>
                <c:ptCount val="12"/>
                <c:pt idx="0">
                  <c:v>93.325007052203958</c:v>
                </c:pt>
                <c:pt idx="1">
                  <c:v>93.940438713464403</c:v>
                </c:pt>
                <c:pt idx="2">
                  <c:v>93.522643628027495</c:v>
                </c:pt>
                <c:pt idx="3">
                  <c:v>93.517358462858439</c:v>
                </c:pt>
                <c:pt idx="4">
                  <c:v>92.903841996849351</c:v>
                </c:pt>
                <c:pt idx="5">
                  <c:v>93.218172976305112</c:v>
                </c:pt>
                <c:pt idx="6">
                  <c:v>93.307202206068212</c:v>
                </c:pt>
                <c:pt idx="7">
                  <c:v>93.211913718110296</c:v>
                </c:pt>
                <c:pt idx="8">
                  <c:v>93.394242745643822</c:v>
                </c:pt>
                <c:pt idx="9">
                  <c:v>93.185936818929576</c:v>
                </c:pt>
                <c:pt idx="10">
                  <c:v>94.761364248496562</c:v>
                </c:pt>
                <c:pt idx="11">
                  <c:v>92.56666972853601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05B-9042-AEDB-819DE3759125}"/>
            </c:ext>
          </c:extLst>
        </c:ser>
        <c:ser>
          <c:idx val="1"/>
          <c:order val="1"/>
          <c:tx>
            <c:v>at1g08920</c:v>
          </c:tx>
          <c:spPr>
            <a:ln w="6350" cap="rnd">
              <a:solidFill>
                <a:schemeClr val="accent2"/>
              </a:solidFill>
              <a:round/>
            </a:ln>
            <a:effectLst/>
          </c:spPr>
          <c:marker>
            <c:symbol val="x"/>
            <c:size val="4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8920'!$I$29,'08920'!$I$57,'08920'!$I$85,'08920'!$I$113,'08920'!$I$141,'08920'!$I$169,'08920'!$I$197,'08920'!$I$225,'08920'!$I$253,'08920'!$I$276,'08920'!$I$299,'08920'!$I$327)</c:f>
                <c:numCache>
                  <c:formatCode>General</c:formatCode>
                  <c:ptCount val="12"/>
                  <c:pt idx="0">
                    <c:v>0.450286064789294</c:v>
                  </c:pt>
                  <c:pt idx="1">
                    <c:v>1.706301122140454</c:v>
                  </c:pt>
                  <c:pt idx="2">
                    <c:v>1.03700010296666</c:v>
                  </c:pt>
                  <c:pt idx="3">
                    <c:v>0.35461251017532303</c:v>
                  </c:pt>
                  <c:pt idx="4">
                    <c:v>0.35342859793157599</c:v>
                  </c:pt>
                  <c:pt idx="5">
                    <c:v>0.44666692529478502</c:v>
                  </c:pt>
                  <c:pt idx="6">
                    <c:v>0.478755079298402</c:v>
                  </c:pt>
                  <c:pt idx="7">
                    <c:v>0.28579647162149202</c:v>
                  </c:pt>
                  <c:pt idx="8">
                    <c:v>0.464513295478374</c:v>
                  </c:pt>
                  <c:pt idx="9">
                    <c:v>1.965344808132742</c:v>
                  </c:pt>
                  <c:pt idx="10">
                    <c:v>0.57805498513917697</c:v>
                  </c:pt>
                  <c:pt idx="11">
                    <c:v>0.58439580559086501</c:v>
                  </c:pt>
                </c:numCache>
              </c:numRef>
            </c:plus>
            <c:minus>
              <c:numRef>
                <c:f>('08920'!$I$29,'08920'!$I$57,'08920'!$I$85,'08920'!$I$113,'08920'!$I$141,'08920'!$I$169,'08920'!$I$197,'08920'!$I$225,'08920'!$I$253,'08920'!$I$276,'08920'!$I$299,'08920'!$I$327)</c:f>
                <c:numCache>
                  <c:formatCode>General</c:formatCode>
                  <c:ptCount val="12"/>
                  <c:pt idx="0">
                    <c:v>0.450286064789294</c:v>
                  </c:pt>
                  <c:pt idx="1">
                    <c:v>1.706301122140454</c:v>
                  </c:pt>
                  <c:pt idx="2">
                    <c:v>1.03700010296666</c:v>
                  </c:pt>
                  <c:pt idx="3">
                    <c:v>0.35461251017532303</c:v>
                  </c:pt>
                  <c:pt idx="4">
                    <c:v>0.35342859793157599</c:v>
                  </c:pt>
                  <c:pt idx="5">
                    <c:v>0.44666692529478502</c:v>
                  </c:pt>
                  <c:pt idx="6">
                    <c:v>0.478755079298402</c:v>
                  </c:pt>
                  <c:pt idx="7">
                    <c:v>0.28579647162149202</c:v>
                  </c:pt>
                  <c:pt idx="8">
                    <c:v>0.464513295478374</c:v>
                  </c:pt>
                  <c:pt idx="9">
                    <c:v>1.965344808132742</c:v>
                  </c:pt>
                  <c:pt idx="10">
                    <c:v>0.57805498513917697</c:v>
                  </c:pt>
                  <c:pt idx="11">
                    <c:v>0.584395805590865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(Col0!$C$3,Col0!$C$31,Col0!$C$59,Col0!$C$87,Col0!$C$115,Col0!$C$143,Col0!$C$171,Col0!$C$199,Col0!$C$227,Col0!$C$255,Col0!$C$271,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'08920'!$I$28,'08920'!$I$56,'08920'!$I$84,'08920'!$I$112,'08920'!$I$140,'08920'!$I$168,'08920'!$I$196,'08920'!$I$224,'08920'!$I$252,'08920'!$I$275,'08920'!$I$298,'08920'!$I$326)</c:f>
              <c:numCache>
                <c:formatCode>0.000</c:formatCode>
                <c:ptCount val="12"/>
                <c:pt idx="0">
                  <c:v>93.728202809823784</c:v>
                </c:pt>
                <c:pt idx="1">
                  <c:v>94.171320644593379</c:v>
                </c:pt>
                <c:pt idx="2">
                  <c:v>93.807451472379839</c:v>
                </c:pt>
                <c:pt idx="3">
                  <c:v>93.437483592974132</c:v>
                </c:pt>
                <c:pt idx="4">
                  <c:v>92.952672420792041</c:v>
                </c:pt>
                <c:pt idx="5">
                  <c:v>93.276911534910084</c:v>
                </c:pt>
                <c:pt idx="6">
                  <c:v>93.147896010289116</c:v>
                </c:pt>
                <c:pt idx="7">
                  <c:v>93.089732919527293</c:v>
                </c:pt>
                <c:pt idx="8">
                  <c:v>93.263527397330122</c:v>
                </c:pt>
                <c:pt idx="9">
                  <c:v>93.233300228935803</c:v>
                </c:pt>
                <c:pt idx="10">
                  <c:v>92.497823050899854</c:v>
                </c:pt>
                <c:pt idx="11">
                  <c:v>92.56722702863483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005B-9042-AEDB-819DE3759125}"/>
            </c:ext>
          </c:extLst>
        </c:ser>
        <c:ser>
          <c:idx val="2"/>
          <c:order val="2"/>
          <c:tx>
            <c:v>at1g75220</c:v>
          </c:tx>
          <c:spPr>
            <a:ln w="6350" cap="rnd">
              <a:solidFill>
                <a:schemeClr val="accent3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75220'!$I$29,'75220'!$I$57,'75220'!$I$85,'75220'!$I$113,'75220'!$I$141,'75220'!$I$169,'75220'!$I$197,'75220'!$I$225,'75220'!$I$253,'75220'!$I$276,'75220'!$I$299,'75220'!$I$327)</c:f>
                <c:numCache>
                  <c:formatCode>General</c:formatCode>
                  <c:ptCount val="12"/>
                  <c:pt idx="0">
                    <c:v>1.0930259309910819</c:v>
                  </c:pt>
                  <c:pt idx="1">
                    <c:v>1.6885547282543141</c:v>
                  </c:pt>
                  <c:pt idx="2">
                    <c:v>0.58800715734926401</c:v>
                  </c:pt>
                  <c:pt idx="3">
                    <c:v>0.52060870003916304</c:v>
                  </c:pt>
                  <c:pt idx="4">
                    <c:v>0.292074359369351</c:v>
                  </c:pt>
                  <c:pt idx="5">
                    <c:v>0.35999063423661498</c:v>
                  </c:pt>
                  <c:pt idx="6">
                    <c:v>0.27263665266340997</c:v>
                  </c:pt>
                  <c:pt idx="7">
                    <c:v>0.60512168082389794</c:v>
                  </c:pt>
                  <c:pt idx="8">
                    <c:v>0.36436429741703402</c:v>
                  </c:pt>
                  <c:pt idx="9">
                    <c:v>0.33724918001349202</c:v>
                  </c:pt>
                  <c:pt idx="10">
                    <c:v>0.60008942357637696</c:v>
                  </c:pt>
                  <c:pt idx="11">
                    <c:v>1.0076315210134681</c:v>
                  </c:pt>
                </c:numCache>
              </c:numRef>
            </c:plus>
            <c:minus>
              <c:numRef>
                <c:f>('75220'!$I$29,'75220'!$I$57,'75220'!$I$85,'75220'!$I$113,'75220'!$I$141,'75220'!$I$169,'75220'!$I$197,'75220'!$I$225,'75220'!$I$253,'75220'!$I$276,'75220'!$I$299,'75220'!$I$327)</c:f>
                <c:numCache>
                  <c:formatCode>General</c:formatCode>
                  <c:ptCount val="12"/>
                  <c:pt idx="0">
                    <c:v>1.0930259309910819</c:v>
                  </c:pt>
                  <c:pt idx="1">
                    <c:v>1.6885547282543141</c:v>
                  </c:pt>
                  <c:pt idx="2">
                    <c:v>0.58800715734926401</c:v>
                  </c:pt>
                  <c:pt idx="3">
                    <c:v>0.52060870003916304</c:v>
                  </c:pt>
                  <c:pt idx="4">
                    <c:v>0.292074359369351</c:v>
                  </c:pt>
                  <c:pt idx="5">
                    <c:v>0.35999063423661498</c:v>
                  </c:pt>
                  <c:pt idx="6">
                    <c:v>0.27263665266340997</c:v>
                  </c:pt>
                  <c:pt idx="7">
                    <c:v>0.60512168082389794</c:v>
                  </c:pt>
                  <c:pt idx="8">
                    <c:v>0.36436429741703402</c:v>
                  </c:pt>
                  <c:pt idx="9">
                    <c:v>0.33724918001349202</c:v>
                  </c:pt>
                  <c:pt idx="10">
                    <c:v>0.60008942357637696</c:v>
                  </c:pt>
                  <c:pt idx="11">
                    <c:v>1.00763152101346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([2]Col0!$C$3,[2]Col0!$C$31,[2]Col0!$C$59,[2]Col0!$C$87,[2]Col0!$C$115,[2]Col0!$C$143,[2]Col0!$C$171,[2]Col0!$C$199,[2]Col0!$C$227,[2]Col0!$C$255,[2]Col0!$C$271,[2]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'75220'!$I$28,'75220'!$I$56,'75220'!$I$84,'75220'!$I$112,'75220'!$I$140,'75220'!$I$168,'75220'!$I$196,'75220'!$I$224,'75220'!$I$252,'75220'!$I$275,'75220'!$I$298,'75220'!$I$326)</c:f>
              <c:numCache>
                <c:formatCode>0.000</c:formatCode>
                <c:ptCount val="12"/>
                <c:pt idx="0">
                  <c:v>93.321931842752093</c:v>
                </c:pt>
                <c:pt idx="1">
                  <c:v>94.262210334834251</c:v>
                </c:pt>
                <c:pt idx="2">
                  <c:v>93.639225071322201</c:v>
                </c:pt>
                <c:pt idx="3">
                  <c:v>93.066939056353547</c:v>
                </c:pt>
                <c:pt idx="4">
                  <c:v>93.101960300264153</c:v>
                </c:pt>
                <c:pt idx="5">
                  <c:v>93.024352868152988</c:v>
                </c:pt>
                <c:pt idx="6">
                  <c:v>93.037614319932501</c:v>
                </c:pt>
                <c:pt idx="7">
                  <c:v>92.968486899061276</c:v>
                </c:pt>
                <c:pt idx="8">
                  <c:v>93.055039761402881</c:v>
                </c:pt>
                <c:pt idx="9">
                  <c:v>92.723987710483385</c:v>
                </c:pt>
                <c:pt idx="10">
                  <c:v>92.670579995385609</c:v>
                </c:pt>
                <c:pt idx="11">
                  <c:v>92.5201259639711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005B-9042-AEDB-819DE3759125}"/>
            </c:ext>
          </c:extLst>
        </c:ser>
        <c:ser>
          <c:idx val="3"/>
          <c:order val="3"/>
          <c:tx>
            <c:v>at3g04760</c:v>
          </c:tx>
          <c:spPr>
            <a:ln w="6350" cap="rnd">
              <a:solidFill>
                <a:schemeClr val="accent4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4760'!$I$29,'04760'!$I$57,'04760'!$I$85,'04760'!$I$113,'04760'!$I$141,'04760'!$I$169,'04760'!$I$197,'04760'!$I$225,'04760'!$I$253,'04760'!$I$276,'04760'!$I$299,'04760'!$I$327)</c:f>
                <c:numCache>
                  <c:formatCode>General</c:formatCode>
                  <c:ptCount val="12"/>
                  <c:pt idx="0">
                    <c:v>2.0595307286396598</c:v>
                  </c:pt>
                  <c:pt idx="1">
                    <c:v>3.2388669280486582</c:v>
                  </c:pt>
                  <c:pt idx="2">
                    <c:v>1.7088457879177641</c:v>
                  </c:pt>
                  <c:pt idx="3">
                    <c:v>1.4273399697771769</c:v>
                  </c:pt>
                  <c:pt idx="4">
                    <c:v>1.049882716492339</c:v>
                  </c:pt>
                  <c:pt idx="5">
                    <c:v>0.48200951688043497</c:v>
                  </c:pt>
                  <c:pt idx="6">
                    <c:v>0.39283004696512103</c:v>
                  </c:pt>
                  <c:pt idx="7">
                    <c:v>0.51892029511529103</c:v>
                  </c:pt>
                  <c:pt idx="8">
                    <c:v>0.22170296834446199</c:v>
                  </c:pt>
                  <c:pt idx="9">
                    <c:v>1.3971924677758061</c:v>
                  </c:pt>
                  <c:pt idx="10">
                    <c:v>0.745486269780961</c:v>
                  </c:pt>
                  <c:pt idx="11">
                    <c:v>0.54922428196302497</c:v>
                  </c:pt>
                </c:numCache>
              </c:numRef>
            </c:plus>
            <c:minus>
              <c:numRef>
                <c:f>('04760'!$I$29,'04760'!$I$57,'04760'!$I$85,'04760'!$I$113,'04760'!$I$141,'04760'!$I$169,'04760'!$I$197,'04760'!$I$225,'04760'!$I$253,'04760'!$I$276,'04760'!$I$299,'04760'!$I$327)</c:f>
                <c:numCache>
                  <c:formatCode>General</c:formatCode>
                  <c:ptCount val="12"/>
                  <c:pt idx="0">
                    <c:v>2.0595307286396598</c:v>
                  </c:pt>
                  <c:pt idx="1">
                    <c:v>3.2388669280486582</c:v>
                  </c:pt>
                  <c:pt idx="2">
                    <c:v>1.7088457879177641</c:v>
                  </c:pt>
                  <c:pt idx="3">
                    <c:v>1.4273399697771769</c:v>
                  </c:pt>
                  <c:pt idx="4">
                    <c:v>1.049882716492339</c:v>
                  </c:pt>
                  <c:pt idx="5">
                    <c:v>0.48200951688043497</c:v>
                  </c:pt>
                  <c:pt idx="6">
                    <c:v>0.39283004696512103</c:v>
                  </c:pt>
                  <c:pt idx="7">
                    <c:v>0.51892029511529103</c:v>
                  </c:pt>
                  <c:pt idx="8">
                    <c:v>0.22170296834446199</c:v>
                  </c:pt>
                  <c:pt idx="9">
                    <c:v>1.3971924677758061</c:v>
                  </c:pt>
                  <c:pt idx="10">
                    <c:v>0.745486269780961</c:v>
                  </c:pt>
                  <c:pt idx="11">
                    <c:v>0.54922428196302497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Col0!$C$3,Col0!$C$31,Col0!$C$59,Col0!$C$87,Col0!$C$115,Col0!$C$143,Col0!$C$171,Col0!$C$199,Col0!$C$227,Col0!$C$255,Col0!$C$271,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'04760'!$I$28,'04760'!$I$56,'04760'!$I$84,'04760'!$I$112,'04760'!$I$140,'04760'!$I$168,'04760'!$I$196,'04760'!$I$224,'04760'!$I$252,'04760'!$I$275,'04760'!$I$298,'04760'!$I$326)</c:f>
              <c:numCache>
                <c:formatCode>0.000</c:formatCode>
                <c:ptCount val="12"/>
                <c:pt idx="0">
                  <c:v>94.000042782962808</c:v>
                </c:pt>
                <c:pt idx="1">
                  <c:v>92.958775249131875</c:v>
                </c:pt>
                <c:pt idx="2">
                  <c:v>92.803374252655686</c:v>
                </c:pt>
                <c:pt idx="3">
                  <c:v>93.052414861516638</c:v>
                </c:pt>
                <c:pt idx="4">
                  <c:v>93.06704892129612</c:v>
                </c:pt>
                <c:pt idx="5">
                  <c:v>92.942045127934108</c:v>
                </c:pt>
                <c:pt idx="6">
                  <c:v>93.004693836318623</c:v>
                </c:pt>
                <c:pt idx="7">
                  <c:v>93.053644000733883</c:v>
                </c:pt>
                <c:pt idx="8">
                  <c:v>93.238387306767336</c:v>
                </c:pt>
                <c:pt idx="9">
                  <c:v>93.026394846923054</c:v>
                </c:pt>
                <c:pt idx="10">
                  <c:v>92.649245086784916</c:v>
                </c:pt>
                <c:pt idx="11">
                  <c:v>93.05175029722337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005B-9042-AEDB-819DE37591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01333192"/>
        <c:axId val="814556168"/>
      </c:scatterChart>
      <c:valAx>
        <c:axId val="801333192"/>
        <c:scaling>
          <c:orientation val="minMax"/>
          <c:max val="51"/>
          <c:min val="35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14556168"/>
        <c:crosses val="autoZero"/>
        <c:crossBetween val="midCat"/>
        <c:majorUnit val="1"/>
      </c:valAx>
      <c:valAx>
        <c:axId val="814556168"/>
        <c:scaling>
          <c:orientation val="minMax"/>
          <c:max val="100"/>
          <c:min val="0"/>
        </c:scaling>
        <c:delete val="0"/>
        <c:axPos val="l"/>
        <c:majorGridlines>
          <c:spPr>
            <a:ln w="6350">
              <a:solidFill>
                <a:schemeClr val="bg1">
                  <a:lumMod val="95000"/>
                </a:schemeClr>
              </a:solidFill>
            </a:ln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fr-FR" sz="1200" b="0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C (%)</a:t>
                </a:r>
                <a:endParaRPr lang="fr-FR" sz="1200" b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26230989540639416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01333192"/>
        <c:crossesAt val="0"/>
        <c:crossBetween val="midCat"/>
        <c:majorUnit val="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881855962747826"/>
          <c:y val="0.10367921035637562"/>
          <c:w val="0.73527825332426533"/>
          <c:h val="0.75561241022491199"/>
        </c:manualLayout>
      </c:layout>
      <c:scatterChart>
        <c:scatterStyle val="lineMarker"/>
        <c:varyColors val="0"/>
        <c:ser>
          <c:idx val="0"/>
          <c:order val="0"/>
          <c:tx>
            <c:v>Col0</c:v>
          </c:tx>
          <c:spPr>
            <a:ln w="63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Col0!$J$29,Col0!$J$369,Col0!$J$397,Col0!$J$425,Col0!$J$453,Col0!$J$481,Col0!$J$509,Col0!$J$537,Col0!$J$565,Col0!$J$581,Col0!$J$597,Col0!$J$620)</c:f>
                <c:numCache>
                  <c:formatCode>General</c:formatCode>
                  <c:ptCount val="12"/>
                  <c:pt idx="0">
                    <c:v>0.61779797179211404</c:v>
                  </c:pt>
                  <c:pt idx="1">
                    <c:v>5.850606822767122</c:v>
                  </c:pt>
                  <c:pt idx="2">
                    <c:v>0.78597415556256001</c:v>
                  </c:pt>
                  <c:pt idx="3">
                    <c:v>0.45007189740588199</c:v>
                  </c:pt>
                  <c:pt idx="4">
                    <c:v>0.697937346204763</c:v>
                  </c:pt>
                  <c:pt idx="5">
                    <c:v>0.92536076829819602</c:v>
                  </c:pt>
                  <c:pt idx="6">
                    <c:v>1.070930350599784</c:v>
                  </c:pt>
                  <c:pt idx="7">
                    <c:v>3.4929194469782741</c:v>
                  </c:pt>
                  <c:pt idx="8">
                    <c:v>4.2957817063065207</c:v>
                  </c:pt>
                  <c:pt idx="11">
                    <c:v>17.832995765055671</c:v>
                  </c:pt>
                </c:numCache>
              </c:numRef>
            </c:plus>
            <c:minus>
              <c:numRef>
                <c:f>(Col0!$J$29,Col0!$J$369,Col0!$J$397,Col0!$J$425,Col0!$J$453,Col0!$J$481,Col0!$J$509,Col0!$J$537,Col0!$J$565,Col0!$J$581,Col0!$J$597,Col0!$J$620)</c:f>
                <c:numCache>
                  <c:formatCode>General</c:formatCode>
                  <c:ptCount val="12"/>
                  <c:pt idx="0">
                    <c:v>0.61779797179211404</c:v>
                  </c:pt>
                  <c:pt idx="1">
                    <c:v>5.850606822767122</c:v>
                  </c:pt>
                  <c:pt idx="2">
                    <c:v>0.78597415556256001</c:v>
                  </c:pt>
                  <c:pt idx="3">
                    <c:v>0.45007189740588199</c:v>
                  </c:pt>
                  <c:pt idx="4">
                    <c:v>0.697937346204763</c:v>
                  </c:pt>
                  <c:pt idx="5">
                    <c:v>0.92536076829819602</c:v>
                  </c:pt>
                  <c:pt idx="6">
                    <c:v>1.070930350599784</c:v>
                  </c:pt>
                  <c:pt idx="7">
                    <c:v>3.4929194469782741</c:v>
                  </c:pt>
                  <c:pt idx="8">
                    <c:v>4.2957817063065207</c:v>
                  </c:pt>
                  <c:pt idx="11">
                    <c:v>17.832995765055671</c:v>
                  </c:pt>
                </c:numCache>
              </c:numRef>
            </c:minus>
            <c:spPr>
              <a:ln w="6350"/>
            </c:spPr>
          </c:errBars>
          <c:xVal>
            <c:numRef>
              <c:f>(Col0!$C$2,Col0!$C$30,Col0!$C$58,Col0!$C$86,Col0!$C$114,Col0!$C$142,Col0!$C$170,Col0!$C$198,Col0!$C$226,Col0!$C$254,Col0!$C$270,Col0!$C$286)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(Col0!$J$28,Col0!$J$368,Col0!$J$396,Col0!$J$424,Col0!$J$452,Col0!$J$480,Col0!$J$508,Col0!$J$536,Col0!$J$564,Col0!$J$580,Col0!$J$596,Col0!$J$619)</c:f>
              <c:numCache>
                <c:formatCode>0.000</c:formatCode>
                <c:ptCount val="12"/>
                <c:pt idx="0">
                  <c:v>93.325007052203958</c:v>
                </c:pt>
                <c:pt idx="1">
                  <c:v>93.539226897713746</c:v>
                </c:pt>
                <c:pt idx="2">
                  <c:v>93.057337751729122</c:v>
                </c:pt>
                <c:pt idx="3">
                  <c:v>92.8505164853689</c:v>
                </c:pt>
                <c:pt idx="4">
                  <c:v>92.524484040023552</c:v>
                </c:pt>
                <c:pt idx="5">
                  <c:v>92.146175023551464</c:v>
                </c:pt>
                <c:pt idx="6">
                  <c:v>91.015695144551046</c:v>
                </c:pt>
                <c:pt idx="7">
                  <c:v>88.261727599191801</c:v>
                </c:pt>
                <c:pt idx="8">
                  <c:v>86.153286255807032</c:v>
                </c:pt>
                <c:pt idx="9">
                  <c:v>76.715075192261835</c:v>
                </c:pt>
                <c:pt idx="10">
                  <c:v>59.205396340857661</c:v>
                </c:pt>
                <c:pt idx="11">
                  <c:v>60.4024202786071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91A-F847-AE71-912D20C97485}"/>
            </c:ext>
          </c:extLst>
        </c:ser>
        <c:ser>
          <c:idx val="1"/>
          <c:order val="1"/>
          <c:tx>
            <c:v>at1g08920</c:v>
          </c:tx>
          <c:spPr>
            <a:ln w="6350" cap="rnd">
              <a:solidFill>
                <a:schemeClr val="accent2"/>
              </a:solidFill>
              <a:round/>
            </a:ln>
            <a:effectLst/>
          </c:spPr>
          <c:marker>
            <c:symbol val="x"/>
            <c:size val="4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8920'!$I$29,'08920'!$I$383,'08920'!$I$411,'08920'!$I$439,'08920'!$I$467,'08920'!$I$495,'08920'!$I$523,'08920'!$I$551,'08920'!$I$579,'08920'!$I$602,'08920'!$I$625,'08920'!$I$648)</c:f>
                <c:numCache>
                  <c:formatCode>General</c:formatCode>
                  <c:ptCount val="12"/>
                  <c:pt idx="0">
                    <c:v>0.450286064789294</c:v>
                  </c:pt>
                  <c:pt idx="1">
                    <c:v>3.338673995337337</c:v>
                  </c:pt>
                  <c:pt idx="2">
                    <c:v>1.020843827857433</c:v>
                  </c:pt>
                  <c:pt idx="3">
                    <c:v>0.50172044949726502</c:v>
                  </c:pt>
                  <c:pt idx="4">
                    <c:v>0.582625904556209</c:v>
                  </c:pt>
                  <c:pt idx="5">
                    <c:v>1.577590085058123</c:v>
                  </c:pt>
                  <c:pt idx="6">
                    <c:v>1.683437949549941</c:v>
                  </c:pt>
                  <c:pt idx="7">
                    <c:v>5.0811041197438884</c:v>
                  </c:pt>
                  <c:pt idx="8">
                    <c:v>8.1302032644034128</c:v>
                  </c:pt>
                  <c:pt idx="9">
                    <c:v>13.81506058969477</c:v>
                  </c:pt>
                  <c:pt idx="10">
                    <c:v>11.21702555523242</c:v>
                  </c:pt>
                  <c:pt idx="11">
                    <c:v>18.718917112958231</c:v>
                  </c:pt>
                </c:numCache>
              </c:numRef>
            </c:plus>
            <c:minus>
              <c:numRef>
                <c:f>('08920'!$I$29,'08920'!$I$383,'08920'!$I$411,'08920'!$I$439,'08920'!$I$467,'08920'!$I$495,'08920'!$I$523,'08920'!$I$551,'08920'!$I$579,'08920'!$I$602,'08920'!$I$625,'08920'!$I$648)</c:f>
                <c:numCache>
                  <c:formatCode>General</c:formatCode>
                  <c:ptCount val="12"/>
                  <c:pt idx="0">
                    <c:v>0.450286064789294</c:v>
                  </c:pt>
                  <c:pt idx="1">
                    <c:v>3.338673995337337</c:v>
                  </c:pt>
                  <c:pt idx="2">
                    <c:v>1.020843827857433</c:v>
                  </c:pt>
                  <c:pt idx="3">
                    <c:v>0.50172044949726502</c:v>
                  </c:pt>
                  <c:pt idx="4">
                    <c:v>0.582625904556209</c:v>
                  </c:pt>
                  <c:pt idx="5">
                    <c:v>1.577590085058123</c:v>
                  </c:pt>
                  <c:pt idx="6">
                    <c:v>1.683437949549941</c:v>
                  </c:pt>
                  <c:pt idx="7">
                    <c:v>5.0811041197438884</c:v>
                  </c:pt>
                  <c:pt idx="8">
                    <c:v>8.1302032644034128</c:v>
                  </c:pt>
                  <c:pt idx="9">
                    <c:v>13.81506058969477</c:v>
                  </c:pt>
                  <c:pt idx="10">
                    <c:v>11.21702555523242</c:v>
                  </c:pt>
                  <c:pt idx="11">
                    <c:v>18.718917112958231</c:v>
                  </c:pt>
                </c:numCache>
              </c:numRef>
            </c:minus>
            <c:spPr>
              <a:ln w="6350"/>
            </c:spPr>
          </c:errBars>
          <c:xVal>
            <c:numRef>
              <c:f>(Col0!$C$2,Col0!$C$30,Col0!$C$58,Col0!$C$86,Col0!$C$114,Col0!$C$142,Col0!$C$170,Col0!$C$198,Col0!$C$226,Col0!$C$254,Col0!$C$270,Col0!$C$286)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('08920'!$I$28,'08920'!$I$382,'08920'!$I$410,'08920'!$I$438,'08920'!$I$466,'08920'!$I$494,'08920'!$I$522,'08920'!$I$550,'08920'!$I$578,'08920'!$I$601,'08920'!$I$624,'08920'!$I$647)</c:f>
              <c:numCache>
                <c:formatCode>0.000</c:formatCode>
                <c:ptCount val="12"/>
                <c:pt idx="0">
                  <c:v>93.728202809823784</c:v>
                </c:pt>
                <c:pt idx="1">
                  <c:v>94.2641124853821</c:v>
                </c:pt>
                <c:pt idx="2">
                  <c:v>92.716903367725124</c:v>
                </c:pt>
                <c:pt idx="3">
                  <c:v>92.603049522945483</c:v>
                </c:pt>
                <c:pt idx="4">
                  <c:v>91.891333523239169</c:v>
                </c:pt>
                <c:pt idx="5">
                  <c:v>90.811207264457863</c:v>
                </c:pt>
                <c:pt idx="6">
                  <c:v>89.969965964468699</c:v>
                </c:pt>
                <c:pt idx="7">
                  <c:v>86.613096671230593</c:v>
                </c:pt>
                <c:pt idx="8">
                  <c:v>81.387850669881999</c:v>
                </c:pt>
                <c:pt idx="9">
                  <c:v>70.587721974788849</c:v>
                </c:pt>
                <c:pt idx="10">
                  <c:v>60.982575160325467</c:v>
                </c:pt>
                <c:pt idx="11">
                  <c:v>53.65835116295404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B91A-F847-AE71-912D20C97485}"/>
            </c:ext>
          </c:extLst>
        </c:ser>
        <c:ser>
          <c:idx val="2"/>
          <c:order val="2"/>
          <c:tx>
            <c:v>at1g75220</c:v>
          </c:tx>
          <c:spPr>
            <a:ln w="6350" cap="rnd">
              <a:solidFill>
                <a:schemeClr val="accent3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75220'!$I$29,'75220'!$I$383,'75220'!$I$411,'75220'!$I$439,'75220'!$I$467,'75220'!$I$495,'75220'!$I$523,'75220'!$I$551,'75220'!$I$579,'75220'!$I$602,'75220'!$I$625,'75220'!$I$648)</c:f>
                <c:numCache>
                  <c:formatCode>General</c:formatCode>
                  <c:ptCount val="12"/>
                  <c:pt idx="0">
                    <c:v>1.0930259309910819</c:v>
                  </c:pt>
                  <c:pt idx="1">
                    <c:v>1.9372394662322849</c:v>
                  </c:pt>
                  <c:pt idx="2">
                    <c:v>1.0308038841760101</c:v>
                  </c:pt>
                  <c:pt idx="3">
                    <c:v>0.444967792634963</c:v>
                  </c:pt>
                  <c:pt idx="4">
                    <c:v>0.93772326507387305</c:v>
                  </c:pt>
                  <c:pt idx="5">
                    <c:v>0.87892785854272903</c:v>
                  </c:pt>
                  <c:pt idx="6">
                    <c:v>1.4677477264612699</c:v>
                  </c:pt>
                  <c:pt idx="7">
                    <c:v>2.7481149217135319</c:v>
                  </c:pt>
                  <c:pt idx="8">
                    <c:v>8.1769826404198458</c:v>
                  </c:pt>
                  <c:pt idx="9">
                    <c:v>12.45406082905216</c:v>
                  </c:pt>
                  <c:pt idx="10">
                    <c:v>16.796566040874339</c:v>
                  </c:pt>
                  <c:pt idx="11">
                    <c:v>22.303762776862179</c:v>
                  </c:pt>
                </c:numCache>
              </c:numRef>
            </c:plus>
            <c:minus>
              <c:numRef>
                <c:f>('75220'!$I$29,'75220'!$I$383,'75220'!$I$411,'75220'!$I$439,'75220'!$I$467,'75220'!$I$495,'75220'!$I$523,'75220'!$I$551,'75220'!$I$579,'75220'!$I$602,'75220'!$I$625,'75220'!$I$648)</c:f>
                <c:numCache>
                  <c:formatCode>General</c:formatCode>
                  <c:ptCount val="12"/>
                  <c:pt idx="0">
                    <c:v>1.0930259309910819</c:v>
                  </c:pt>
                  <c:pt idx="1">
                    <c:v>1.9372394662322849</c:v>
                  </c:pt>
                  <c:pt idx="2">
                    <c:v>1.0308038841760101</c:v>
                  </c:pt>
                  <c:pt idx="3">
                    <c:v>0.444967792634963</c:v>
                  </c:pt>
                  <c:pt idx="4">
                    <c:v>0.93772326507387305</c:v>
                  </c:pt>
                  <c:pt idx="5">
                    <c:v>0.87892785854272903</c:v>
                  </c:pt>
                  <c:pt idx="6">
                    <c:v>1.4677477264612699</c:v>
                  </c:pt>
                  <c:pt idx="7">
                    <c:v>2.7481149217135319</c:v>
                  </c:pt>
                  <c:pt idx="8">
                    <c:v>8.1769826404198458</c:v>
                  </c:pt>
                  <c:pt idx="9">
                    <c:v>12.45406082905216</c:v>
                  </c:pt>
                  <c:pt idx="10">
                    <c:v>16.796566040874339</c:v>
                  </c:pt>
                  <c:pt idx="11">
                    <c:v>22.303762776862179</c:v>
                  </c:pt>
                </c:numCache>
              </c:numRef>
            </c:minus>
            <c:spPr>
              <a:ln w="6350"/>
            </c:spPr>
          </c:errBars>
          <c:xVal>
            <c:numRef>
              <c:f>('75220'!$C$2,'75220'!$C$30,'75220'!$C$58,'75220'!$C$86,'75220'!$C$114,'75220'!$C$142,'75220'!$C$170,'75220'!$C$198,'75220'!$C$226,'75220'!$C$254,'75220'!$C$277,'75220'!$C$300)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('75220'!$I$28,'75220'!$I$382,'75220'!$I$410,'75220'!$I$438,'75220'!$I$466,'75220'!$I$494,'75220'!$I$522,'75220'!$I$550,'75220'!$I$578,'75220'!$I$601,'75220'!$I$624,'75220'!$I$647)</c:f>
              <c:numCache>
                <c:formatCode>0.000</c:formatCode>
                <c:ptCount val="12"/>
                <c:pt idx="0">
                  <c:v>93.321931842752093</c:v>
                </c:pt>
                <c:pt idx="1">
                  <c:v>94.034314975782493</c:v>
                </c:pt>
                <c:pt idx="2">
                  <c:v>92.768160959349103</c:v>
                </c:pt>
                <c:pt idx="3">
                  <c:v>92.527471689772696</c:v>
                </c:pt>
                <c:pt idx="4">
                  <c:v>92.3678019998937</c:v>
                </c:pt>
                <c:pt idx="5">
                  <c:v>91.607871844448226</c:v>
                </c:pt>
                <c:pt idx="6">
                  <c:v>90.482428950749082</c:v>
                </c:pt>
                <c:pt idx="7">
                  <c:v>88.645427115968758</c:v>
                </c:pt>
                <c:pt idx="8">
                  <c:v>81.015496476171549</c:v>
                </c:pt>
                <c:pt idx="9">
                  <c:v>69.976896414228179</c:v>
                </c:pt>
                <c:pt idx="10">
                  <c:v>63.070601816754241</c:v>
                </c:pt>
                <c:pt idx="11">
                  <c:v>61.53551498161983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B91A-F847-AE71-912D20C97485}"/>
            </c:ext>
          </c:extLst>
        </c:ser>
        <c:ser>
          <c:idx val="3"/>
          <c:order val="3"/>
          <c:tx>
            <c:v>at3g04760</c:v>
          </c:tx>
          <c:spPr>
            <a:ln w="6350" cap="rnd">
              <a:solidFill>
                <a:schemeClr val="accent4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4760'!$I$29,'04760'!$I$383,'04760'!$I$411,'04760'!$I$439,'04760'!$I$467,'04760'!$I$495,'04760'!$I$523,'04760'!$I$551,'04760'!$I$579,'04760'!$I$602,'04760'!$I$625,'04760'!$I$648)</c:f>
                <c:numCache>
                  <c:formatCode>General</c:formatCode>
                  <c:ptCount val="12"/>
                  <c:pt idx="0">
                    <c:v>2.0595307286396598</c:v>
                  </c:pt>
                  <c:pt idx="1">
                    <c:v>2.2074290539887831</c:v>
                  </c:pt>
                  <c:pt idx="2">
                    <c:v>0.73331796066300603</c:v>
                  </c:pt>
                  <c:pt idx="3">
                    <c:v>0.47606393141118503</c:v>
                  </c:pt>
                  <c:pt idx="4">
                    <c:v>0.55544639712360999</c:v>
                  </c:pt>
                  <c:pt idx="5">
                    <c:v>1.3645251475694029</c:v>
                  </c:pt>
                  <c:pt idx="6">
                    <c:v>1.33507576355233</c:v>
                  </c:pt>
                  <c:pt idx="7">
                    <c:v>3.5199986967565779</c:v>
                  </c:pt>
                  <c:pt idx="8">
                    <c:v>7.1972229828976939</c:v>
                  </c:pt>
                  <c:pt idx="9">
                    <c:v>8.8516440564937806</c:v>
                  </c:pt>
                  <c:pt idx="10">
                    <c:v>8.1764062113595202</c:v>
                  </c:pt>
                  <c:pt idx="11">
                    <c:v>20.050845037752531</c:v>
                  </c:pt>
                </c:numCache>
              </c:numRef>
            </c:plus>
            <c:minus>
              <c:numRef>
                <c:f>('04760'!$I$29,'04760'!$I$383,'04760'!$I$411,'04760'!$I$439,'04760'!$I$467,'04760'!$I$495,'04760'!$I$523,'04760'!$I$551,'04760'!$I$579,'04760'!$I$602,'04760'!$I$625,'04760'!$I$648)</c:f>
                <c:numCache>
                  <c:formatCode>General</c:formatCode>
                  <c:ptCount val="12"/>
                  <c:pt idx="0">
                    <c:v>2.0595307286396598</c:v>
                  </c:pt>
                  <c:pt idx="1">
                    <c:v>2.2074290539887831</c:v>
                  </c:pt>
                  <c:pt idx="2">
                    <c:v>0.73331796066300603</c:v>
                  </c:pt>
                  <c:pt idx="3">
                    <c:v>0.47606393141118503</c:v>
                  </c:pt>
                  <c:pt idx="4">
                    <c:v>0.55544639712360999</c:v>
                  </c:pt>
                  <c:pt idx="5">
                    <c:v>1.3645251475694029</c:v>
                  </c:pt>
                  <c:pt idx="6">
                    <c:v>1.33507576355233</c:v>
                  </c:pt>
                  <c:pt idx="7">
                    <c:v>3.5199986967565779</c:v>
                  </c:pt>
                  <c:pt idx="8">
                    <c:v>7.1972229828976939</c:v>
                  </c:pt>
                  <c:pt idx="9">
                    <c:v>8.8516440564937806</c:v>
                  </c:pt>
                  <c:pt idx="10">
                    <c:v>8.1764062113595202</c:v>
                  </c:pt>
                  <c:pt idx="11">
                    <c:v>20.050845037752531</c:v>
                  </c:pt>
                </c:numCache>
              </c:numRef>
            </c:minus>
            <c:spPr>
              <a:ln w="6350"/>
            </c:spPr>
          </c:errBars>
          <c:xVal>
            <c:numRef>
              <c:f>('04760'!$C$2,'04760'!$C$30,'04760'!$C$58,'04760'!$C$86,'04760'!$C$114,'04760'!$C$142,'04760'!$C$170,'04760'!$C$198,'04760'!$C$226,'04760'!$C$254,'04760'!$C$277,'04760'!$C$300)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('04760'!$I$28,'04760'!$I$382,'04760'!$I$410,'04760'!$I$438,'04760'!$I$466,'04760'!$I$494,'04760'!$I$522,'04760'!$I$550,'04760'!$I$578,'04760'!$I$601,'04760'!$I$624,'04760'!$I$647)</c:f>
              <c:numCache>
                <c:formatCode>0.000</c:formatCode>
                <c:ptCount val="12"/>
                <c:pt idx="0">
                  <c:v>94.000042782962808</c:v>
                </c:pt>
                <c:pt idx="1">
                  <c:v>93.376078325220533</c:v>
                </c:pt>
                <c:pt idx="2">
                  <c:v>93.435808805760914</c:v>
                </c:pt>
                <c:pt idx="3">
                  <c:v>92.845863005657066</c:v>
                </c:pt>
                <c:pt idx="4">
                  <c:v>92.323477573818153</c:v>
                </c:pt>
                <c:pt idx="5">
                  <c:v>91.661923787200493</c:v>
                </c:pt>
                <c:pt idx="6">
                  <c:v>90.488084956584558</c:v>
                </c:pt>
                <c:pt idx="7">
                  <c:v>87.855300944641797</c:v>
                </c:pt>
                <c:pt idx="8">
                  <c:v>82.973864559898161</c:v>
                </c:pt>
                <c:pt idx="9">
                  <c:v>74.876588999528266</c:v>
                </c:pt>
                <c:pt idx="10">
                  <c:v>61.779530971411901</c:v>
                </c:pt>
                <c:pt idx="11">
                  <c:v>55.32913720088207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B91A-F847-AE71-912D20C974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05705560"/>
        <c:axId val="820357080"/>
      </c:scatterChart>
      <c:valAx>
        <c:axId val="805705560"/>
        <c:scaling>
          <c:orientation val="minMax"/>
          <c:max val="16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20357080"/>
        <c:crosses val="autoZero"/>
        <c:crossBetween val="midCat"/>
        <c:majorUnit val="1"/>
      </c:valAx>
      <c:valAx>
        <c:axId val="820357080"/>
        <c:scaling>
          <c:orientation val="minMax"/>
          <c:max val="100"/>
          <c:min val="0"/>
        </c:scaling>
        <c:delete val="0"/>
        <c:axPos val="l"/>
        <c:majorGridlines>
          <c:spPr>
            <a:ln w="6350">
              <a:solidFill>
                <a:schemeClr val="bg1">
                  <a:lumMod val="85000"/>
                </a:schemeClr>
              </a:solidFill>
            </a:ln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fr-FR" sz="1200" b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C </a:t>
                </a:r>
                <a:r>
                  <a:rPr lang="fr-FR" sz="1200" b="0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%)</a:t>
                </a:r>
                <a:endParaRPr lang="fr-FR" sz="1200" b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7239338487216826E-2"/>
              <c:y val="0.26230989540639416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05705560"/>
        <c:crossesAt val="0"/>
        <c:crossBetween val="midCat"/>
        <c:majorUnit val="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931180555555599"/>
          <c:y val="8.7842775581906007E-2"/>
          <c:w val="0.826590972222222"/>
          <c:h val="0.76251207729468595"/>
        </c:manualLayout>
      </c:layout>
      <c:scatterChart>
        <c:scatterStyle val="lineMarker"/>
        <c:varyColors val="0"/>
        <c:ser>
          <c:idx val="0"/>
          <c:order val="0"/>
          <c:tx>
            <c:v>Col0</c:v>
          </c:tx>
          <c:spPr>
            <a:ln w="63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Col0!$J$425,Col0!$J$453,Col0!$J$481,Col0!$J$509)</c:f>
                <c:numCache>
                  <c:formatCode>General</c:formatCode>
                  <c:ptCount val="4"/>
                  <c:pt idx="0">
                    <c:v>0.45007189740588199</c:v>
                  </c:pt>
                  <c:pt idx="1">
                    <c:v>0.697937346204763</c:v>
                  </c:pt>
                  <c:pt idx="2">
                    <c:v>0.92536076829819602</c:v>
                  </c:pt>
                  <c:pt idx="3">
                    <c:v>1.070930350599784</c:v>
                  </c:pt>
                </c:numCache>
              </c:numRef>
            </c:plus>
            <c:minus>
              <c:numRef>
                <c:f>(Col0!$J$425,Col0!$J$453,Col0!$J$481,Col0!$J$509)</c:f>
                <c:numCache>
                  <c:formatCode>General</c:formatCode>
                  <c:ptCount val="4"/>
                  <c:pt idx="0">
                    <c:v>0.45007189740588199</c:v>
                  </c:pt>
                  <c:pt idx="1">
                    <c:v>0.697937346204763</c:v>
                  </c:pt>
                  <c:pt idx="2">
                    <c:v>0.92536076829819602</c:v>
                  </c:pt>
                  <c:pt idx="3">
                    <c:v>1.070930350599784</c:v>
                  </c:pt>
                </c:numCache>
              </c:numRef>
            </c:minus>
          </c:errBars>
          <c:xVal>
            <c:numRef>
              <c:f>(Col0!$C$86,Col0!$C$114,Col0!$C$142,Col0!$C$170)</c:f>
              <c:numCache>
                <c:formatCode>General</c:formatCode>
                <c:ptCount val="4"/>
                <c:pt idx="0">
                  <c:v>7</c:v>
                </c:pt>
                <c:pt idx="1">
                  <c:v>8</c:v>
                </c:pt>
                <c:pt idx="2">
                  <c:v>9</c:v>
                </c:pt>
                <c:pt idx="3">
                  <c:v>10</c:v>
                </c:pt>
              </c:numCache>
            </c:numRef>
          </c:xVal>
          <c:yVal>
            <c:numRef>
              <c:f>(Col0!$J$424,Col0!$J$452,Col0!$J$480,Col0!$J$508)</c:f>
              <c:numCache>
                <c:formatCode>0.000</c:formatCode>
                <c:ptCount val="4"/>
                <c:pt idx="0">
                  <c:v>92.8505164853689</c:v>
                </c:pt>
                <c:pt idx="1">
                  <c:v>92.524484040023552</c:v>
                </c:pt>
                <c:pt idx="2">
                  <c:v>92.146175023551521</c:v>
                </c:pt>
                <c:pt idx="3">
                  <c:v>91.015695144551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611-A54E-9FF7-F43C5055B8AC}"/>
            </c:ext>
          </c:extLst>
        </c:ser>
        <c:ser>
          <c:idx val="1"/>
          <c:order val="1"/>
          <c:tx>
            <c:v>at1g08920</c:v>
          </c:tx>
          <c:spPr>
            <a:ln w="6350" cap="rnd">
              <a:solidFill>
                <a:schemeClr val="accent2"/>
              </a:solidFill>
              <a:round/>
            </a:ln>
            <a:effectLst/>
          </c:spPr>
          <c:marker>
            <c:symbol val="x"/>
            <c:size val="4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8920'!$I$439,'08920'!$I$467,'08920'!$I$495,'08920'!$I$523)</c:f>
                <c:numCache>
                  <c:formatCode>General</c:formatCode>
                  <c:ptCount val="4"/>
                  <c:pt idx="0">
                    <c:v>0.50172044949726502</c:v>
                  </c:pt>
                  <c:pt idx="1">
                    <c:v>0.582625904556209</c:v>
                  </c:pt>
                  <c:pt idx="2">
                    <c:v>1.577590085058123</c:v>
                  </c:pt>
                  <c:pt idx="3">
                    <c:v>1.683437949549941</c:v>
                  </c:pt>
                </c:numCache>
              </c:numRef>
            </c:plus>
            <c:minus>
              <c:numRef>
                <c:f>('08920'!$I$439,'08920'!$I$467,'08920'!$I$495,'08920'!$I$523)</c:f>
                <c:numCache>
                  <c:formatCode>General</c:formatCode>
                  <c:ptCount val="4"/>
                  <c:pt idx="0">
                    <c:v>0.50172044949726502</c:v>
                  </c:pt>
                  <c:pt idx="1">
                    <c:v>0.582625904556209</c:v>
                  </c:pt>
                  <c:pt idx="2">
                    <c:v>1.577590085058123</c:v>
                  </c:pt>
                  <c:pt idx="3">
                    <c:v>1.683437949549941</c:v>
                  </c:pt>
                </c:numCache>
              </c:numRef>
            </c:minus>
          </c:errBars>
          <c:xVal>
            <c:numRef>
              <c:f>(Col0!$C$86,Col0!$C$114,Col0!$C$142,Col0!$C$170)</c:f>
              <c:numCache>
                <c:formatCode>General</c:formatCode>
                <c:ptCount val="4"/>
                <c:pt idx="0">
                  <c:v>7</c:v>
                </c:pt>
                <c:pt idx="1">
                  <c:v>8</c:v>
                </c:pt>
                <c:pt idx="2">
                  <c:v>9</c:v>
                </c:pt>
                <c:pt idx="3">
                  <c:v>10</c:v>
                </c:pt>
              </c:numCache>
            </c:numRef>
          </c:xVal>
          <c:yVal>
            <c:numRef>
              <c:f>('08920'!$I$438,'08920'!$I$466,'08920'!$I$494,'08920'!$I$522)</c:f>
              <c:numCache>
                <c:formatCode>0.000</c:formatCode>
                <c:ptCount val="4"/>
                <c:pt idx="0">
                  <c:v>92.603049522945483</c:v>
                </c:pt>
                <c:pt idx="1">
                  <c:v>91.891333523239169</c:v>
                </c:pt>
                <c:pt idx="2">
                  <c:v>90.811207264457863</c:v>
                </c:pt>
                <c:pt idx="3">
                  <c:v>89.96996596446868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A611-A54E-9FF7-F43C5055B8AC}"/>
            </c:ext>
          </c:extLst>
        </c:ser>
        <c:ser>
          <c:idx val="2"/>
          <c:order val="2"/>
          <c:tx>
            <c:v>at1g75220</c:v>
          </c:tx>
          <c:spPr>
            <a:ln w="6350" cap="rnd">
              <a:solidFill>
                <a:schemeClr val="accent3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75220'!$I$439,'75220'!$I$467,'75220'!$I$495,'75220'!$I$523)</c:f>
                <c:numCache>
                  <c:formatCode>General</c:formatCode>
                  <c:ptCount val="4"/>
                  <c:pt idx="0">
                    <c:v>0.444967792634963</c:v>
                  </c:pt>
                  <c:pt idx="1">
                    <c:v>0.93772326507387305</c:v>
                  </c:pt>
                  <c:pt idx="2">
                    <c:v>0.87892785854272903</c:v>
                  </c:pt>
                  <c:pt idx="3">
                    <c:v>1.4677477264612699</c:v>
                  </c:pt>
                </c:numCache>
              </c:numRef>
            </c:plus>
            <c:minus>
              <c:numRef>
                <c:f>('75220'!$I$439,'75220'!$I$467,'75220'!$I$495,'75220'!$I$523)</c:f>
                <c:numCache>
                  <c:formatCode>General</c:formatCode>
                  <c:ptCount val="4"/>
                  <c:pt idx="0">
                    <c:v>0.444967792634963</c:v>
                  </c:pt>
                  <c:pt idx="1">
                    <c:v>0.93772326507387305</c:v>
                  </c:pt>
                  <c:pt idx="2">
                    <c:v>0.87892785854272903</c:v>
                  </c:pt>
                  <c:pt idx="3">
                    <c:v>1.4677477264612699</c:v>
                  </c:pt>
                </c:numCache>
              </c:numRef>
            </c:minus>
          </c:errBars>
          <c:xVal>
            <c:numRef>
              <c:f>('75220'!$C$86,'75220'!$C$114,'75220'!$C$142,'75220'!$C$170)</c:f>
              <c:numCache>
                <c:formatCode>General</c:formatCode>
                <c:ptCount val="4"/>
                <c:pt idx="0">
                  <c:v>7</c:v>
                </c:pt>
                <c:pt idx="1">
                  <c:v>8</c:v>
                </c:pt>
                <c:pt idx="2">
                  <c:v>9</c:v>
                </c:pt>
                <c:pt idx="3">
                  <c:v>10</c:v>
                </c:pt>
              </c:numCache>
            </c:numRef>
          </c:xVal>
          <c:yVal>
            <c:numRef>
              <c:f>('75220'!$I$438,'75220'!$I$466,'75220'!$I$494,'75220'!$I$522)</c:f>
              <c:numCache>
                <c:formatCode>0.000</c:formatCode>
                <c:ptCount val="4"/>
                <c:pt idx="0">
                  <c:v>92.527471689772696</c:v>
                </c:pt>
                <c:pt idx="1">
                  <c:v>92.3678019998937</c:v>
                </c:pt>
                <c:pt idx="2">
                  <c:v>91.607871844448255</c:v>
                </c:pt>
                <c:pt idx="3">
                  <c:v>90.48242895074908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A611-A54E-9FF7-F43C5055B8AC}"/>
            </c:ext>
          </c:extLst>
        </c:ser>
        <c:ser>
          <c:idx val="3"/>
          <c:order val="3"/>
          <c:tx>
            <c:v>at3g04760</c:v>
          </c:tx>
          <c:spPr>
            <a:ln w="6350" cap="rnd">
              <a:solidFill>
                <a:schemeClr val="accent4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4760'!$I$439,'04760'!$I$467,'04760'!$I$495,'04760'!$I$523)</c:f>
                <c:numCache>
                  <c:formatCode>General</c:formatCode>
                  <c:ptCount val="4"/>
                  <c:pt idx="0">
                    <c:v>0.47606393141118503</c:v>
                  </c:pt>
                  <c:pt idx="1">
                    <c:v>0.55544639712360999</c:v>
                  </c:pt>
                  <c:pt idx="2">
                    <c:v>1.3645251475694029</c:v>
                  </c:pt>
                  <c:pt idx="3">
                    <c:v>1.33507576355233</c:v>
                  </c:pt>
                </c:numCache>
              </c:numRef>
            </c:plus>
            <c:minus>
              <c:numRef>
                <c:f>('04760'!$I$439,'04760'!$I$467,'04760'!$I$495,'04760'!$I$523)</c:f>
                <c:numCache>
                  <c:formatCode>General</c:formatCode>
                  <c:ptCount val="4"/>
                  <c:pt idx="0">
                    <c:v>0.47606393141118503</c:v>
                  </c:pt>
                  <c:pt idx="1">
                    <c:v>0.55544639712360999</c:v>
                  </c:pt>
                  <c:pt idx="2">
                    <c:v>1.3645251475694029</c:v>
                  </c:pt>
                  <c:pt idx="3">
                    <c:v>1.33507576355233</c:v>
                  </c:pt>
                </c:numCache>
              </c:numRef>
            </c:minus>
            <c:spPr>
              <a:ln w="6350"/>
            </c:spPr>
          </c:errBars>
          <c:xVal>
            <c:numRef>
              <c:f>('04760'!$C$86,'04760'!$C$114,'04760'!$C$142,'04760'!$C$170)</c:f>
              <c:numCache>
                <c:formatCode>General</c:formatCode>
                <c:ptCount val="4"/>
                <c:pt idx="0">
                  <c:v>7</c:v>
                </c:pt>
                <c:pt idx="1">
                  <c:v>8</c:v>
                </c:pt>
                <c:pt idx="2">
                  <c:v>9</c:v>
                </c:pt>
                <c:pt idx="3">
                  <c:v>10</c:v>
                </c:pt>
              </c:numCache>
            </c:numRef>
          </c:xVal>
          <c:yVal>
            <c:numRef>
              <c:f>('04760'!$I$438,'04760'!$I$466,'04760'!$I$494,'04760'!$I$522)</c:f>
              <c:numCache>
                <c:formatCode>0.000</c:formatCode>
                <c:ptCount val="4"/>
                <c:pt idx="0">
                  <c:v>92.845863005657066</c:v>
                </c:pt>
                <c:pt idx="1">
                  <c:v>92.323477573818181</c:v>
                </c:pt>
                <c:pt idx="2">
                  <c:v>91.661923787200493</c:v>
                </c:pt>
                <c:pt idx="3">
                  <c:v>90.48808495658461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A611-A54E-9FF7-F43C5055B8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11276760"/>
        <c:axId val="801647064"/>
      </c:scatterChart>
      <c:valAx>
        <c:axId val="811276760"/>
        <c:scaling>
          <c:orientation val="minMax"/>
          <c:max val="10"/>
          <c:min val="7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01647064"/>
        <c:crosses val="autoZero"/>
        <c:crossBetween val="midCat"/>
        <c:majorUnit val="1"/>
      </c:valAx>
      <c:valAx>
        <c:axId val="801647064"/>
        <c:scaling>
          <c:orientation val="minMax"/>
          <c:max val="94"/>
          <c:min val="88"/>
        </c:scaling>
        <c:delete val="0"/>
        <c:axPos val="l"/>
        <c:numFmt formatCode="#,##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11276760"/>
        <c:crossesAt val="0"/>
        <c:crossBetween val="midCat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solidFill>
        <a:schemeClr val="bg1">
          <a:lumMod val="85000"/>
        </a:schemeClr>
      </a:solidFill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006791843266506"/>
          <c:y val="0.16708328188290031"/>
          <c:w val="0.80170972222222237"/>
          <c:h val="0.61498432487605714"/>
        </c:manualLayout>
      </c:layout>
      <c:scatterChart>
        <c:scatterStyle val="lineMarker"/>
        <c:varyColors val="0"/>
        <c:ser>
          <c:idx val="0"/>
          <c:order val="0"/>
          <c:tx>
            <c:strRef>
              <c:f>'CS -SFP'!$Q$5</c:f>
              <c:strCache>
                <c:ptCount val="1"/>
                <c:pt idx="0">
                  <c:v>Col-0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S -SFP'!$S$7:$S$18</c:f>
                <c:numCache>
                  <c:formatCode>General</c:formatCode>
                  <c:ptCount val="12"/>
                  <c:pt idx="0">
                    <c:v>2.6178426232300533</c:v>
                  </c:pt>
                  <c:pt idx="1">
                    <c:v>3.5269320271036726</c:v>
                  </c:pt>
                  <c:pt idx="2">
                    <c:v>5.6503980475041136</c:v>
                  </c:pt>
                  <c:pt idx="3">
                    <c:v>7.1565582310413545</c:v>
                  </c:pt>
                  <c:pt idx="4">
                    <c:v>6.6069573719137757</c:v>
                  </c:pt>
                  <c:pt idx="5">
                    <c:v>7.9466985058486799</c:v>
                  </c:pt>
                  <c:pt idx="6">
                    <c:v>9.4248762528190468</c:v>
                  </c:pt>
                  <c:pt idx="7">
                    <c:v>8.5592580341544515</c:v>
                  </c:pt>
                  <c:pt idx="8">
                    <c:v>9.7601513454308062</c:v>
                  </c:pt>
                  <c:pt idx="9">
                    <c:v>9.4294378461940553</c:v>
                  </c:pt>
                  <c:pt idx="10">
                    <c:v>11.600331193958349</c:v>
                  </c:pt>
                  <c:pt idx="11">
                    <c:v>12.588033357499601</c:v>
                  </c:pt>
                </c:numCache>
              </c:numRef>
            </c:plus>
            <c:minus>
              <c:numRef>
                <c:f>'CS -SFP'!$S$7:$S$18</c:f>
                <c:numCache>
                  <c:formatCode>General</c:formatCode>
                  <c:ptCount val="12"/>
                  <c:pt idx="0">
                    <c:v>2.6178426232300533</c:v>
                  </c:pt>
                  <c:pt idx="1">
                    <c:v>3.5269320271036726</c:v>
                  </c:pt>
                  <c:pt idx="2">
                    <c:v>5.6503980475041136</c:v>
                  </c:pt>
                  <c:pt idx="3">
                    <c:v>7.1565582310413545</c:v>
                  </c:pt>
                  <c:pt idx="4">
                    <c:v>6.6069573719137757</c:v>
                  </c:pt>
                  <c:pt idx="5">
                    <c:v>7.9466985058486799</c:v>
                  </c:pt>
                  <c:pt idx="6">
                    <c:v>9.4248762528190468</c:v>
                  </c:pt>
                  <c:pt idx="7">
                    <c:v>8.5592580341544515</c:v>
                  </c:pt>
                  <c:pt idx="8">
                    <c:v>9.7601513454308062</c:v>
                  </c:pt>
                  <c:pt idx="9">
                    <c:v>9.4294378461940553</c:v>
                  </c:pt>
                  <c:pt idx="10">
                    <c:v>11.600331193958349</c:v>
                  </c:pt>
                  <c:pt idx="11">
                    <c:v>12.5880333574996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CS -SFP'!$P$7:$P$18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'CS -SFP'!$Q$7:$Q$18</c:f>
              <c:numCache>
                <c:formatCode>0.00</c:formatCode>
                <c:ptCount val="12"/>
                <c:pt idx="0">
                  <c:v>9.370000000000001</c:v>
                </c:pt>
                <c:pt idx="1">
                  <c:v>15.990666666666664</c:v>
                </c:pt>
                <c:pt idx="2">
                  <c:v>25.201333333333331</c:v>
                </c:pt>
                <c:pt idx="3">
                  <c:v>29.596</c:v>
                </c:pt>
                <c:pt idx="4">
                  <c:v>33.79</c:v>
                </c:pt>
                <c:pt idx="5">
                  <c:v>40.031999999999996</c:v>
                </c:pt>
                <c:pt idx="6">
                  <c:v>43.942666666666668</c:v>
                </c:pt>
                <c:pt idx="7">
                  <c:v>49.204666666666668</c:v>
                </c:pt>
                <c:pt idx="8">
                  <c:v>53.535999999999994</c:v>
                </c:pt>
                <c:pt idx="9">
                  <c:v>60.014666666666677</c:v>
                </c:pt>
                <c:pt idx="10">
                  <c:v>68.278666666666666</c:v>
                </c:pt>
                <c:pt idx="11">
                  <c:v>71.49466666666667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F93-6A44-93C5-85A94C7A5D52}"/>
            </c:ext>
          </c:extLst>
        </c:ser>
        <c:ser>
          <c:idx val="1"/>
          <c:order val="1"/>
          <c:tx>
            <c:strRef>
              <c:f>'CS -SFP'!$R$5</c:f>
              <c:strCache>
                <c:ptCount val="1"/>
                <c:pt idx="0">
                  <c:v>esl3</c:v>
                </c:pt>
              </c:strCache>
            </c:strRef>
          </c:tx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rgbClr val="FFC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S -SFP'!$T$7:$T$18</c:f>
                <c:numCache>
                  <c:formatCode>General</c:formatCode>
                  <c:ptCount val="12"/>
                  <c:pt idx="0">
                    <c:v>2.7398588771443433</c:v>
                  </c:pt>
                  <c:pt idx="1">
                    <c:v>4.223652222335331</c:v>
                  </c:pt>
                  <c:pt idx="2">
                    <c:v>7.4085198701674955</c:v>
                  </c:pt>
                  <c:pt idx="3">
                    <c:v>8.4152246949601288</c:v>
                  </c:pt>
                  <c:pt idx="4">
                    <c:v>8.5110856002767346</c:v>
                  </c:pt>
                  <c:pt idx="5">
                    <c:v>10.268648448183498</c:v>
                  </c:pt>
                  <c:pt idx="6">
                    <c:v>11.865236056086983</c:v>
                  </c:pt>
                  <c:pt idx="7">
                    <c:v>12.944901073763505</c:v>
                  </c:pt>
                  <c:pt idx="8">
                    <c:v>14.388533364486864</c:v>
                  </c:pt>
                  <c:pt idx="9">
                    <c:v>13.06717144311688</c:v>
                  </c:pt>
                  <c:pt idx="10">
                    <c:v>15.546609736071547</c:v>
                  </c:pt>
                  <c:pt idx="11">
                    <c:v>13.809798212380434</c:v>
                  </c:pt>
                </c:numCache>
              </c:numRef>
            </c:plus>
            <c:minus>
              <c:numRef>
                <c:f>'CS -SFP'!$T$7:$T$18</c:f>
                <c:numCache>
                  <c:formatCode>General</c:formatCode>
                  <c:ptCount val="12"/>
                  <c:pt idx="0">
                    <c:v>2.7398588771443433</c:v>
                  </c:pt>
                  <c:pt idx="1">
                    <c:v>4.223652222335331</c:v>
                  </c:pt>
                  <c:pt idx="2">
                    <c:v>7.4085198701674955</c:v>
                  </c:pt>
                  <c:pt idx="3">
                    <c:v>8.4152246949601288</c:v>
                  </c:pt>
                  <c:pt idx="4">
                    <c:v>8.5110856002767346</c:v>
                  </c:pt>
                  <c:pt idx="5">
                    <c:v>10.268648448183498</c:v>
                  </c:pt>
                  <c:pt idx="6">
                    <c:v>11.865236056086983</c:v>
                  </c:pt>
                  <c:pt idx="7">
                    <c:v>12.944901073763505</c:v>
                  </c:pt>
                  <c:pt idx="8">
                    <c:v>14.388533364486864</c:v>
                  </c:pt>
                  <c:pt idx="9">
                    <c:v>13.06717144311688</c:v>
                  </c:pt>
                  <c:pt idx="10">
                    <c:v>15.546609736071547</c:v>
                  </c:pt>
                  <c:pt idx="11">
                    <c:v>13.8097982123804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CS -SFP'!$P$7:$P$18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'CS -SFP'!$R$7:$R$18</c:f>
              <c:numCache>
                <c:formatCode>0.00</c:formatCode>
                <c:ptCount val="12"/>
                <c:pt idx="0">
                  <c:v>8.8313333333333333</c:v>
                </c:pt>
                <c:pt idx="1">
                  <c:v>15.283333333333331</c:v>
                </c:pt>
                <c:pt idx="2">
                  <c:v>24.123333333333335</c:v>
                </c:pt>
                <c:pt idx="3">
                  <c:v>27.997333333333334</c:v>
                </c:pt>
                <c:pt idx="4">
                  <c:v>31.457333333333334</c:v>
                </c:pt>
                <c:pt idx="5">
                  <c:v>37.661333333333332</c:v>
                </c:pt>
                <c:pt idx="6">
                  <c:v>41.464666666666666</c:v>
                </c:pt>
                <c:pt idx="7">
                  <c:v>46.777333333333338</c:v>
                </c:pt>
                <c:pt idx="8">
                  <c:v>50.217333333333343</c:v>
                </c:pt>
                <c:pt idx="9">
                  <c:v>55.98533333333333</c:v>
                </c:pt>
                <c:pt idx="10">
                  <c:v>62.682000000000002</c:v>
                </c:pt>
                <c:pt idx="11">
                  <c:v>63.34533333333333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F93-6A44-93C5-85A94C7A5D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09676127"/>
        <c:axId val="1109681951"/>
      </c:scatterChart>
      <c:valAx>
        <c:axId val="1109676127"/>
        <c:scaling>
          <c:orientation val="minMax"/>
          <c:max val="51"/>
          <c:min val="35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1109681951"/>
        <c:crosses val="autoZero"/>
        <c:crossBetween val="midCat"/>
        <c:majorUnit val="1"/>
      </c:valAx>
      <c:valAx>
        <c:axId val="1109681951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+mn-cs"/>
                  </a:defRPr>
                </a:pPr>
                <a:r>
                  <a:rPr lang="fr-FR" sz="1200" b="0" dirty="0">
                    <a:solidFill>
                      <a:schemeClr val="tx1"/>
                    </a:solidFill>
                  </a:rPr>
                  <a:t>PLA (cm</a:t>
                </a:r>
                <a:r>
                  <a:rPr lang="fr-FR" sz="1200" b="0" baseline="30000" dirty="0">
                    <a:solidFill>
                      <a:schemeClr val="tx1"/>
                    </a:solidFill>
                  </a:rPr>
                  <a:t>2</a:t>
                </a:r>
                <a:r>
                  <a:rPr lang="fr-FR" sz="1200" b="0" dirty="0">
                    <a:solidFill>
                      <a:schemeClr val="tx1"/>
                    </a:solidFill>
                  </a:rPr>
                  <a:t>)</a:t>
                </a:r>
              </a:p>
            </c:rich>
          </c:tx>
          <c:layout>
            <c:manualLayout>
              <c:xMode val="edge"/>
              <c:yMode val="edge"/>
              <c:x val="1.6574444444444447E-2"/>
              <c:y val="0.2262194444444444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+mn-cs"/>
                </a:defRPr>
              </a:pPr>
              <a:endParaRPr lang="fr-FR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1109676127"/>
        <c:crosses val="autoZero"/>
        <c:crossBetween val="midCat"/>
        <c:majorUnit val="25"/>
      </c:valAx>
      <c:spPr>
        <a:noFill/>
        <a:ln w="6350">
          <a:solidFill>
            <a:schemeClr val="tx1">
              <a:lumMod val="15000"/>
              <a:lumOff val="85000"/>
            </a:schemeClr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>
          <a:latin typeface="Times New Roman" panose="02020603050405020304" pitchFamily="18" charset="0"/>
        </a:defRPr>
      </a:pPr>
      <a:endParaRPr lang="fr-FR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005205669752922"/>
          <c:y val="0.18759767171743835"/>
          <c:w val="0.76060963578153373"/>
          <c:h val="0.61498432487605714"/>
        </c:manualLayout>
      </c:layout>
      <c:scatterChart>
        <c:scatterStyle val="lineMarker"/>
        <c:varyColors val="0"/>
        <c:ser>
          <c:idx val="0"/>
          <c:order val="0"/>
          <c:tx>
            <c:strRef>
              <c:f>'CS -SFP'!$R$23</c:f>
              <c:strCache>
                <c:ptCount val="1"/>
                <c:pt idx="0">
                  <c:v>Col-0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S -SFP'!$T$25:$T$36</c:f>
                <c:numCache>
                  <c:formatCode>General</c:formatCode>
                  <c:ptCount val="12"/>
                  <c:pt idx="0">
                    <c:v>3.0245199540391448</c:v>
                  </c:pt>
                  <c:pt idx="1">
                    <c:v>5.1391325931059564</c:v>
                  </c:pt>
                  <c:pt idx="2">
                    <c:v>7.541781209337997</c:v>
                  </c:pt>
                  <c:pt idx="3">
                    <c:v>7.4056953629975864</c:v>
                  </c:pt>
                  <c:pt idx="4">
                    <c:v>8.1359354541617535</c:v>
                  </c:pt>
                  <c:pt idx="5">
                    <c:v>7.5943332256924965</c:v>
                  </c:pt>
                  <c:pt idx="6">
                    <c:v>6.5370579519127965</c:v>
                  </c:pt>
                  <c:pt idx="7">
                    <c:v>5.8848056973223501</c:v>
                  </c:pt>
                  <c:pt idx="8">
                    <c:v>4.1159770002596527</c:v>
                  </c:pt>
                  <c:pt idx="9">
                    <c:v>6.2400078601904108</c:v>
                  </c:pt>
                  <c:pt idx="10">
                    <c:v>8.2614415898714277</c:v>
                  </c:pt>
                  <c:pt idx="11">
                    <c:v>6.2967786170692825</c:v>
                  </c:pt>
                </c:numCache>
              </c:numRef>
            </c:plus>
            <c:minus>
              <c:numRef>
                <c:f>'CS -SFP'!$T$25:$T$36</c:f>
                <c:numCache>
                  <c:formatCode>General</c:formatCode>
                  <c:ptCount val="12"/>
                  <c:pt idx="0">
                    <c:v>3.0245199540391448</c:v>
                  </c:pt>
                  <c:pt idx="1">
                    <c:v>5.1391325931059564</c:v>
                  </c:pt>
                  <c:pt idx="2">
                    <c:v>7.541781209337997</c:v>
                  </c:pt>
                  <c:pt idx="3">
                    <c:v>7.4056953629975864</c:v>
                  </c:pt>
                  <c:pt idx="4">
                    <c:v>8.1359354541617535</c:v>
                  </c:pt>
                  <c:pt idx="5">
                    <c:v>7.5943332256924965</c:v>
                  </c:pt>
                  <c:pt idx="6">
                    <c:v>6.5370579519127965</c:v>
                  </c:pt>
                  <c:pt idx="7">
                    <c:v>5.8848056973223501</c:v>
                  </c:pt>
                  <c:pt idx="8">
                    <c:v>4.1159770002596527</c:v>
                  </c:pt>
                  <c:pt idx="9">
                    <c:v>6.2400078601904108</c:v>
                  </c:pt>
                  <c:pt idx="10">
                    <c:v>8.2614415898714277</c:v>
                  </c:pt>
                  <c:pt idx="11">
                    <c:v>6.2967786170692825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CS -SFP'!$Q$25:$Q$36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'CS -SFP'!$R$25:$R$36</c:f>
              <c:numCache>
                <c:formatCode>0.00</c:formatCode>
                <c:ptCount val="12"/>
                <c:pt idx="0">
                  <c:v>10.660666666666666</c:v>
                </c:pt>
                <c:pt idx="1">
                  <c:v>18.018666666666665</c:v>
                </c:pt>
                <c:pt idx="2">
                  <c:v>26.462666666666667</c:v>
                </c:pt>
                <c:pt idx="3">
                  <c:v>29.333333333333332</c:v>
                </c:pt>
                <c:pt idx="4">
                  <c:v>32.181999999999995</c:v>
                </c:pt>
                <c:pt idx="5">
                  <c:v>35.216000000000001</c:v>
                </c:pt>
                <c:pt idx="6">
                  <c:v>35.838666666666668</c:v>
                </c:pt>
                <c:pt idx="7">
                  <c:v>35.873333333333342</c:v>
                </c:pt>
                <c:pt idx="8">
                  <c:v>33.216666666666669</c:v>
                </c:pt>
                <c:pt idx="9">
                  <c:v>28.874666666666666</c:v>
                </c:pt>
                <c:pt idx="10">
                  <c:v>19.701999999999998</c:v>
                </c:pt>
                <c:pt idx="11">
                  <c:v>14.0006666666666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489-8644-A06F-72998BFAF82A}"/>
            </c:ext>
          </c:extLst>
        </c:ser>
        <c:ser>
          <c:idx val="1"/>
          <c:order val="1"/>
          <c:tx>
            <c:strRef>
              <c:f>'CS -SFP'!$S$23</c:f>
              <c:strCache>
                <c:ptCount val="1"/>
                <c:pt idx="0">
                  <c:v>esl3</c:v>
                </c:pt>
              </c:strCache>
            </c:strRef>
          </c:tx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rgbClr val="FFC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S -SFP'!$U$25:$U$36</c:f>
                <c:numCache>
                  <c:formatCode>General</c:formatCode>
                  <c:ptCount val="12"/>
                  <c:pt idx="0">
                    <c:v>3.0499255260228462</c:v>
                  </c:pt>
                  <c:pt idx="1">
                    <c:v>5.4239466390126969</c:v>
                  </c:pt>
                  <c:pt idx="2">
                    <c:v>8.4352642999211138</c:v>
                  </c:pt>
                  <c:pt idx="3">
                    <c:v>8.2977909854427665</c:v>
                  </c:pt>
                  <c:pt idx="4">
                    <c:v>9.2063025513322536</c:v>
                  </c:pt>
                  <c:pt idx="5">
                    <c:v>9.2393336185184669</c:v>
                  </c:pt>
                  <c:pt idx="6">
                    <c:v>8.9726182408056463</c:v>
                  </c:pt>
                  <c:pt idx="7">
                    <c:v>8.6561078353462992</c:v>
                  </c:pt>
                  <c:pt idx="8">
                    <c:v>7.4062793820996484</c:v>
                  </c:pt>
                  <c:pt idx="9">
                    <c:v>6.1403739610020187</c:v>
                  </c:pt>
                  <c:pt idx="10">
                    <c:v>5.5934125632357876</c:v>
                  </c:pt>
                  <c:pt idx="11">
                    <c:v>4.8622591261186221</c:v>
                  </c:pt>
                </c:numCache>
              </c:numRef>
            </c:plus>
            <c:minus>
              <c:numRef>
                <c:f>'CS -SFP'!$U$25:$U$36</c:f>
                <c:numCache>
                  <c:formatCode>General</c:formatCode>
                  <c:ptCount val="12"/>
                  <c:pt idx="0">
                    <c:v>3.0499255260228462</c:v>
                  </c:pt>
                  <c:pt idx="1">
                    <c:v>5.4239466390126969</c:v>
                  </c:pt>
                  <c:pt idx="2">
                    <c:v>8.4352642999211138</c:v>
                  </c:pt>
                  <c:pt idx="3">
                    <c:v>8.2977909854427665</c:v>
                  </c:pt>
                  <c:pt idx="4">
                    <c:v>9.2063025513322536</c:v>
                  </c:pt>
                  <c:pt idx="5">
                    <c:v>9.2393336185184669</c:v>
                  </c:pt>
                  <c:pt idx="6">
                    <c:v>8.9726182408056463</c:v>
                  </c:pt>
                  <c:pt idx="7">
                    <c:v>8.6561078353462992</c:v>
                  </c:pt>
                  <c:pt idx="8">
                    <c:v>7.4062793820996484</c:v>
                  </c:pt>
                  <c:pt idx="9">
                    <c:v>6.1403739610020187</c:v>
                  </c:pt>
                  <c:pt idx="10">
                    <c:v>5.5934125632357876</c:v>
                  </c:pt>
                  <c:pt idx="11">
                    <c:v>4.8622591261186221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CS -SFP'!$Q$25:$Q$36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'CS -SFP'!$S$25:$S$36</c:f>
              <c:numCache>
                <c:formatCode>0.00</c:formatCode>
                <c:ptCount val="12"/>
                <c:pt idx="0">
                  <c:v>9.8979999999999997</c:v>
                </c:pt>
                <c:pt idx="1">
                  <c:v>16.085999999999999</c:v>
                </c:pt>
                <c:pt idx="2">
                  <c:v>24.315333333333335</c:v>
                </c:pt>
                <c:pt idx="3">
                  <c:v>27.229333333333336</c:v>
                </c:pt>
                <c:pt idx="4">
                  <c:v>29.149333333333335</c:v>
                </c:pt>
                <c:pt idx="5">
                  <c:v>32.08</c:v>
                </c:pt>
                <c:pt idx="6">
                  <c:v>33.31066666666667</c:v>
                </c:pt>
                <c:pt idx="7">
                  <c:v>33.397999999999996</c:v>
                </c:pt>
                <c:pt idx="8">
                  <c:v>32.297999999999995</c:v>
                </c:pt>
                <c:pt idx="9">
                  <c:v>29.20933333333334</c:v>
                </c:pt>
                <c:pt idx="10">
                  <c:v>22.391538461538463</c:v>
                </c:pt>
                <c:pt idx="11">
                  <c:v>16.92933333333333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489-8644-A06F-72998BFAF8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11911071"/>
        <c:axId val="1111917727"/>
      </c:scatterChart>
      <c:valAx>
        <c:axId val="1111911071"/>
        <c:scaling>
          <c:orientation val="minMax"/>
          <c:max val="16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1111917727"/>
        <c:crosses val="autoZero"/>
        <c:crossBetween val="midCat"/>
        <c:majorUnit val="1"/>
      </c:valAx>
      <c:valAx>
        <c:axId val="1111917727"/>
        <c:scaling>
          <c:orientation val="minMax"/>
          <c:max val="100"/>
        </c:scaling>
        <c:delete val="0"/>
        <c:axPos val="l"/>
        <c:majorGridlines>
          <c:spPr>
            <a:ln w="6350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+mn-cs"/>
                  </a:defRPr>
                </a:pPr>
                <a:r>
                  <a:rPr lang="fr-FR" sz="1200" b="0" dirty="0">
                    <a:solidFill>
                      <a:schemeClr val="tx1"/>
                    </a:solidFill>
                  </a:rPr>
                  <a:t>PLA (cm</a:t>
                </a:r>
                <a:r>
                  <a:rPr lang="fr-FR" sz="1200" b="0" baseline="30000" dirty="0">
                    <a:solidFill>
                      <a:schemeClr val="tx1"/>
                    </a:solidFill>
                  </a:rPr>
                  <a:t>2</a:t>
                </a:r>
                <a:r>
                  <a:rPr lang="fr-FR" sz="1200" b="0" dirty="0">
                    <a:solidFill>
                      <a:schemeClr val="tx1"/>
                    </a:solidFill>
                  </a:rPr>
                  <a:t>)</a:t>
                </a:r>
              </a:p>
            </c:rich>
          </c:tx>
          <c:layout>
            <c:manualLayout>
              <c:xMode val="edge"/>
              <c:yMode val="edge"/>
              <c:x val="2.7509061745079451E-2"/>
              <c:y val="0.2506909614064727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+mn-cs"/>
                </a:defRPr>
              </a:pPr>
              <a:endParaRPr lang="fr-FR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1111911071"/>
        <c:crosses val="autoZero"/>
        <c:crossBetween val="midCat"/>
        <c:majorUnit val="25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>
          <a:latin typeface="Times New Roman" panose="02020603050405020304" pitchFamily="18" charset="0"/>
        </a:defRPr>
      </a:pPr>
      <a:endParaRPr lang="fr-FR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625005331172432"/>
          <c:y val="0.1168034722222222"/>
          <c:w val="0.76605909071523004"/>
          <c:h val="0.67791041666666674"/>
        </c:manualLayout>
      </c:layout>
      <c:scatterChart>
        <c:scatterStyle val="lineMarker"/>
        <c:varyColors val="0"/>
        <c:ser>
          <c:idx val="0"/>
          <c:order val="0"/>
          <c:tx>
            <c:strRef>
              <c:f>'MF-MT-MS'!$B$3</c:f>
              <c:strCache>
                <c:ptCount val="1"/>
                <c:pt idx="0">
                  <c:v>Col-0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F-MT-MS'!$D$5:$D$16</c:f>
                <c:numCache>
                  <c:formatCode>General</c:formatCode>
                  <c:ptCount val="12"/>
                  <c:pt idx="0">
                    <c:v>8.345731729167799E-2</c:v>
                  </c:pt>
                  <c:pt idx="1">
                    <c:v>0.10017356366398697</c:v>
                  </c:pt>
                  <c:pt idx="2">
                    <c:v>0.15602554735866653</c:v>
                  </c:pt>
                  <c:pt idx="3">
                    <c:v>0.17501855683925416</c:v>
                  </c:pt>
                  <c:pt idx="4">
                    <c:v>0.14232802488149207</c:v>
                  </c:pt>
                  <c:pt idx="5">
                    <c:v>0.23871347638858589</c:v>
                  </c:pt>
                  <c:pt idx="6">
                    <c:v>0.23899097412723683</c:v>
                  </c:pt>
                  <c:pt idx="7">
                    <c:v>0.27111301456526748</c:v>
                  </c:pt>
                  <c:pt idx="8">
                    <c:v>0.39602677879634579</c:v>
                  </c:pt>
                  <c:pt idx="9">
                    <c:v>0.43365388876164301</c:v>
                  </c:pt>
                  <c:pt idx="10">
                    <c:v>0.67668778057605916</c:v>
                  </c:pt>
                  <c:pt idx="11">
                    <c:v>0.98333944146609797</c:v>
                  </c:pt>
                </c:numCache>
              </c:numRef>
            </c:plus>
            <c:minus>
              <c:numRef>
                <c:f>'MF-MT-MS'!$D$5:$D$16</c:f>
                <c:numCache>
                  <c:formatCode>General</c:formatCode>
                  <c:ptCount val="12"/>
                  <c:pt idx="0">
                    <c:v>8.345731729167799E-2</c:v>
                  </c:pt>
                  <c:pt idx="1">
                    <c:v>0.10017356366398697</c:v>
                  </c:pt>
                  <c:pt idx="2">
                    <c:v>0.15602554735866653</c:v>
                  </c:pt>
                  <c:pt idx="3">
                    <c:v>0.17501855683925416</c:v>
                  </c:pt>
                  <c:pt idx="4">
                    <c:v>0.14232802488149207</c:v>
                  </c:pt>
                  <c:pt idx="5">
                    <c:v>0.23871347638858589</c:v>
                  </c:pt>
                  <c:pt idx="6">
                    <c:v>0.23899097412723683</c:v>
                  </c:pt>
                  <c:pt idx="7">
                    <c:v>0.27111301456526748</c:v>
                  </c:pt>
                  <c:pt idx="8">
                    <c:v>0.39602677879634579</c:v>
                  </c:pt>
                  <c:pt idx="9">
                    <c:v>0.43365388876164301</c:v>
                  </c:pt>
                  <c:pt idx="10">
                    <c:v>0.67668778057605916</c:v>
                  </c:pt>
                  <c:pt idx="11">
                    <c:v>0.98333944146609797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MF-MT-MS'!$A$5:$A$16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'MF-MT-MS'!$B$5:$B$16</c:f>
              <c:numCache>
                <c:formatCode>0.00</c:formatCode>
                <c:ptCount val="12"/>
                <c:pt idx="0">
                  <c:v>0.17913333333333331</c:v>
                </c:pt>
                <c:pt idx="1">
                  <c:v>0.26619999999999999</c:v>
                </c:pt>
                <c:pt idx="2">
                  <c:v>0.47559999999999997</c:v>
                </c:pt>
                <c:pt idx="3">
                  <c:v>0.57106666666666661</c:v>
                </c:pt>
                <c:pt idx="4">
                  <c:v>0.6318666666666668</c:v>
                </c:pt>
                <c:pt idx="5">
                  <c:v>0.9008666666666667</c:v>
                </c:pt>
                <c:pt idx="6">
                  <c:v>0.99960000000000016</c:v>
                </c:pt>
                <c:pt idx="7">
                  <c:v>1.0498666666666667</c:v>
                </c:pt>
                <c:pt idx="8">
                  <c:v>1.3682666666666665</c:v>
                </c:pt>
                <c:pt idx="9">
                  <c:v>1.4304666666666668</c:v>
                </c:pt>
                <c:pt idx="10">
                  <c:v>1.4809333333333332</c:v>
                </c:pt>
                <c:pt idx="11">
                  <c:v>2.100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406-9245-BA90-34276F8A5A9B}"/>
            </c:ext>
          </c:extLst>
        </c:ser>
        <c:ser>
          <c:idx val="1"/>
          <c:order val="1"/>
          <c:tx>
            <c:strRef>
              <c:f>'MF-MT-MS'!$C$3</c:f>
              <c:strCache>
                <c:ptCount val="1"/>
                <c:pt idx="0">
                  <c:v>esl3</c:v>
                </c:pt>
              </c:strCache>
            </c:strRef>
          </c:tx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rgbClr val="FFC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F-MT-MS'!$E$5:$E$16</c:f>
                <c:numCache>
                  <c:formatCode>General</c:formatCode>
                  <c:ptCount val="12"/>
                  <c:pt idx="0">
                    <c:v>8.3213552009845371E-2</c:v>
                  </c:pt>
                  <c:pt idx="1">
                    <c:v>9.1933878930664625E-2</c:v>
                  </c:pt>
                  <c:pt idx="2">
                    <c:v>0.16691292283560227</c:v>
                  </c:pt>
                  <c:pt idx="3">
                    <c:v>0.25352717521289253</c:v>
                  </c:pt>
                  <c:pt idx="4">
                    <c:v>0.25174064507137589</c:v>
                  </c:pt>
                  <c:pt idx="5">
                    <c:v>0.28663886354651591</c:v>
                  </c:pt>
                  <c:pt idx="6">
                    <c:v>0.42691421018413411</c:v>
                  </c:pt>
                  <c:pt idx="7">
                    <c:v>0.58848297301095154</c:v>
                  </c:pt>
                  <c:pt idx="8">
                    <c:v>0.48989749170714514</c:v>
                  </c:pt>
                  <c:pt idx="9">
                    <c:v>0.59488272553744337</c:v>
                  </c:pt>
                  <c:pt idx="10">
                    <c:v>0.64830399248089365</c:v>
                  </c:pt>
                  <c:pt idx="11">
                    <c:v>0.64018004907845583</c:v>
                  </c:pt>
                </c:numCache>
              </c:numRef>
            </c:plus>
            <c:minus>
              <c:numRef>
                <c:f>'MF-MT-MS'!$E$5:$E$16</c:f>
                <c:numCache>
                  <c:formatCode>General</c:formatCode>
                  <c:ptCount val="12"/>
                  <c:pt idx="0">
                    <c:v>8.3213552009845371E-2</c:v>
                  </c:pt>
                  <c:pt idx="1">
                    <c:v>9.1933878930664625E-2</c:v>
                  </c:pt>
                  <c:pt idx="2">
                    <c:v>0.16691292283560227</c:v>
                  </c:pt>
                  <c:pt idx="3">
                    <c:v>0.25352717521289253</c:v>
                  </c:pt>
                  <c:pt idx="4">
                    <c:v>0.25174064507137589</c:v>
                  </c:pt>
                  <c:pt idx="5">
                    <c:v>0.28663886354651591</c:v>
                  </c:pt>
                  <c:pt idx="6">
                    <c:v>0.42691421018413411</c:v>
                  </c:pt>
                  <c:pt idx="7">
                    <c:v>0.58848297301095154</c:v>
                  </c:pt>
                  <c:pt idx="8">
                    <c:v>0.48989749170714514</c:v>
                  </c:pt>
                  <c:pt idx="9">
                    <c:v>0.59488272553744337</c:v>
                  </c:pt>
                  <c:pt idx="10">
                    <c:v>0.64830399248089365</c:v>
                  </c:pt>
                  <c:pt idx="11">
                    <c:v>0.64018004907845583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MF-MT-MS'!$A$5:$A$16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'MF-MT-MS'!$C$5:$C$16</c:f>
              <c:numCache>
                <c:formatCode>0.00</c:formatCode>
                <c:ptCount val="12"/>
                <c:pt idx="0">
                  <c:v>0.23126666666666668</c:v>
                </c:pt>
                <c:pt idx="1">
                  <c:v>0.35586666666666666</c:v>
                </c:pt>
                <c:pt idx="2">
                  <c:v>0.64473333333333338</c:v>
                </c:pt>
                <c:pt idx="3">
                  <c:v>0.79620000000000002</c:v>
                </c:pt>
                <c:pt idx="4">
                  <c:v>0.91506666666666669</c:v>
                </c:pt>
                <c:pt idx="5">
                  <c:v>1.0775333333333335</c:v>
                </c:pt>
                <c:pt idx="6">
                  <c:v>1.2291999999999998</c:v>
                </c:pt>
                <c:pt idx="7">
                  <c:v>1.4029333333333336</c:v>
                </c:pt>
                <c:pt idx="8">
                  <c:v>1.7705333333333333</c:v>
                </c:pt>
                <c:pt idx="9">
                  <c:v>2.0617999999999999</c:v>
                </c:pt>
                <c:pt idx="10">
                  <c:v>2.4302666666666668</c:v>
                </c:pt>
                <c:pt idx="11">
                  <c:v>2.378733333333333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406-9245-BA90-34276F8A5A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9981552"/>
        <c:axId val="459984464"/>
      </c:scatterChart>
      <c:valAx>
        <c:axId val="459981552"/>
        <c:scaling>
          <c:orientation val="minMax"/>
          <c:max val="51"/>
          <c:min val="35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459984464"/>
        <c:crosses val="autoZero"/>
        <c:crossBetween val="midCat"/>
        <c:majorUnit val="1"/>
      </c:valAx>
      <c:valAx>
        <c:axId val="459984464"/>
        <c:scaling>
          <c:orientation val="minMax"/>
          <c:max val="4"/>
          <c:min val="0"/>
        </c:scaling>
        <c:delete val="0"/>
        <c:axPos val="l"/>
        <c:majorGridlines>
          <c:spPr>
            <a:ln w="6350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+mn-cs"/>
                  </a:defRPr>
                </a:pPr>
                <a:r>
                  <a:rPr lang="en-US" sz="1200" b="0">
                    <a:solidFill>
                      <a:schemeClr val="tx1"/>
                    </a:solidFill>
                  </a:rPr>
                  <a:t>FW (g)</a:t>
                </a:r>
              </a:p>
            </c:rich>
          </c:tx>
          <c:layout>
            <c:manualLayout>
              <c:xMode val="edge"/>
              <c:yMode val="edge"/>
              <c:x val="4.3697222222222221E-2"/>
              <c:y val="0.2264972222222222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+mn-cs"/>
                </a:defRPr>
              </a:pPr>
              <a:endParaRPr lang="fr-FR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459981552"/>
        <c:crosses val="autoZero"/>
        <c:crossBetween val="midCat"/>
        <c:majorUnit val="1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>
          <a:latin typeface="Times New Roman" panose="02020603050405020304" pitchFamily="18" charset="0"/>
        </a:defRPr>
      </a:pPr>
      <a:endParaRPr lang="fr-FR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734440529675677"/>
          <c:y val="0.20389069033723548"/>
          <c:w val="0.74257971402345146"/>
          <c:h val="0.66134872299987513"/>
        </c:manualLayout>
      </c:layout>
      <c:scatterChart>
        <c:scatterStyle val="lineMarker"/>
        <c:varyColors val="0"/>
        <c:ser>
          <c:idx val="0"/>
          <c:order val="0"/>
          <c:tx>
            <c:strRef>
              <c:f>'MF-MT-MS'!$B$21</c:f>
              <c:strCache>
                <c:ptCount val="1"/>
                <c:pt idx="0">
                  <c:v>Col-0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F-MT-MS'!$D$23:$D$34</c:f>
                <c:numCache>
                  <c:formatCode>General</c:formatCode>
                  <c:ptCount val="12"/>
                  <c:pt idx="0">
                    <c:v>8.345731729167799E-2</c:v>
                  </c:pt>
                  <c:pt idx="1">
                    <c:v>0.18838322137398028</c:v>
                  </c:pt>
                  <c:pt idx="2">
                    <c:v>0.21521373650618247</c:v>
                  </c:pt>
                  <c:pt idx="3">
                    <c:v>0.19099419088647898</c:v>
                  </c:pt>
                  <c:pt idx="4">
                    <c:v>0.20559907818952133</c:v>
                  </c:pt>
                  <c:pt idx="5">
                    <c:v>0.20893589812143265</c:v>
                  </c:pt>
                  <c:pt idx="6">
                    <c:v>0.22318649045990563</c:v>
                  </c:pt>
                  <c:pt idx="7">
                    <c:v>0.1611772168704235</c:v>
                  </c:pt>
                  <c:pt idx="8">
                    <c:v>0.1571917845908534</c:v>
                  </c:pt>
                  <c:pt idx="9">
                    <c:v>0.13022848053654482</c:v>
                  </c:pt>
                  <c:pt idx="10">
                    <c:v>0.12062448618198</c:v>
                  </c:pt>
                  <c:pt idx="11">
                    <c:v>0.12831304725256171</c:v>
                  </c:pt>
                </c:numCache>
              </c:numRef>
            </c:plus>
            <c:minus>
              <c:numRef>
                <c:f>'MF-MT-MS'!$D$23:$D$34</c:f>
                <c:numCache>
                  <c:formatCode>General</c:formatCode>
                  <c:ptCount val="12"/>
                  <c:pt idx="0">
                    <c:v>8.345731729167799E-2</c:v>
                  </c:pt>
                  <c:pt idx="1">
                    <c:v>0.18838322137398028</c:v>
                  </c:pt>
                  <c:pt idx="2">
                    <c:v>0.21521373650618247</c:v>
                  </c:pt>
                  <c:pt idx="3">
                    <c:v>0.19099419088647898</c:v>
                  </c:pt>
                  <c:pt idx="4">
                    <c:v>0.20559907818952133</c:v>
                  </c:pt>
                  <c:pt idx="5">
                    <c:v>0.20893589812143265</c:v>
                  </c:pt>
                  <c:pt idx="6">
                    <c:v>0.22318649045990563</c:v>
                  </c:pt>
                  <c:pt idx="7">
                    <c:v>0.1611772168704235</c:v>
                  </c:pt>
                  <c:pt idx="8">
                    <c:v>0.1571917845908534</c:v>
                  </c:pt>
                  <c:pt idx="9">
                    <c:v>0.13022848053654482</c:v>
                  </c:pt>
                  <c:pt idx="10">
                    <c:v>0.12062448618198</c:v>
                  </c:pt>
                  <c:pt idx="11">
                    <c:v>0.128313047252561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F-MT-MS'!$A$23:$A$34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'MF-MT-MS'!$B$23:$B$34</c:f>
              <c:numCache>
                <c:formatCode>0.00</c:formatCode>
                <c:ptCount val="12"/>
                <c:pt idx="0">
                  <c:v>0.17913333333333331</c:v>
                </c:pt>
                <c:pt idx="1">
                  <c:v>0.40066666666666673</c:v>
                </c:pt>
                <c:pt idx="2">
                  <c:v>0.68733333333333324</c:v>
                </c:pt>
                <c:pt idx="3">
                  <c:v>0.76493333333333335</c:v>
                </c:pt>
                <c:pt idx="4">
                  <c:v>0.78246666666666664</c:v>
                </c:pt>
                <c:pt idx="5">
                  <c:v>0.95873333333333333</c:v>
                </c:pt>
                <c:pt idx="6">
                  <c:v>1.0017333333333334</c:v>
                </c:pt>
                <c:pt idx="7">
                  <c:v>1.0233333333333332</c:v>
                </c:pt>
                <c:pt idx="8">
                  <c:v>0.9396000000000001</c:v>
                </c:pt>
                <c:pt idx="9">
                  <c:v>0.80819999999999992</c:v>
                </c:pt>
                <c:pt idx="10">
                  <c:v>0.70046666666666668</c:v>
                </c:pt>
                <c:pt idx="11">
                  <c:v>0.4893333333333333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81C-F946-8B64-E6922E1502AD}"/>
            </c:ext>
          </c:extLst>
        </c:ser>
        <c:ser>
          <c:idx val="1"/>
          <c:order val="1"/>
          <c:tx>
            <c:strRef>
              <c:f>'MF-MT-MS'!$C$21</c:f>
              <c:strCache>
                <c:ptCount val="1"/>
                <c:pt idx="0">
                  <c:v>esl3</c:v>
                </c:pt>
              </c:strCache>
            </c:strRef>
          </c:tx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rgbClr val="FFC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F-MT-MS'!$E$23:$E$34</c:f>
                <c:numCache>
                  <c:formatCode>General</c:formatCode>
                  <c:ptCount val="12"/>
                  <c:pt idx="0">
                    <c:v>8.3213552009845371E-2</c:v>
                  </c:pt>
                  <c:pt idx="1">
                    <c:v>9.9973901356208705E-2</c:v>
                  </c:pt>
                  <c:pt idx="2">
                    <c:v>0.17265443052801302</c:v>
                  </c:pt>
                  <c:pt idx="3">
                    <c:v>0.1872388339858515</c:v>
                  </c:pt>
                  <c:pt idx="4">
                    <c:v>0.10025244326674861</c:v>
                  </c:pt>
                  <c:pt idx="5">
                    <c:v>0.16645299636834382</c:v>
                  </c:pt>
                  <c:pt idx="6">
                    <c:v>0.19942555598757311</c:v>
                  </c:pt>
                  <c:pt idx="7">
                    <c:v>0.20008729047474147</c:v>
                  </c:pt>
                  <c:pt idx="8">
                    <c:v>0.1677198628098428</c:v>
                  </c:pt>
                  <c:pt idx="9">
                    <c:v>0.11175675115433371</c:v>
                  </c:pt>
                  <c:pt idx="10">
                    <c:v>8.7839518170245753E-2</c:v>
                  </c:pt>
                  <c:pt idx="11">
                    <c:v>0.14369007653710145</c:v>
                  </c:pt>
                </c:numCache>
              </c:numRef>
            </c:plus>
            <c:minus>
              <c:numRef>
                <c:f>'MF-MT-MS'!$E$23:$E$34</c:f>
                <c:numCache>
                  <c:formatCode>General</c:formatCode>
                  <c:ptCount val="12"/>
                  <c:pt idx="0">
                    <c:v>8.3213552009845371E-2</c:v>
                  </c:pt>
                  <c:pt idx="1">
                    <c:v>9.9973901356208705E-2</c:v>
                  </c:pt>
                  <c:pt idx="2">
                    <c:v>0.17265443052801302</c:v>
                  </c:pt>
                  <c:pt idx="3">
                    <c:v>0.1872388339858515</c:v>
                  </c:pt>
                  <c:pt idx="4">
                    <c:v>0.10025244326674861</c:v>
                  </c:pt>
                  <c:pt idx="5">
                    <c:v>0.16645299636834382</c:v>
                  </c:pt>
                  <c:pt idx="6">
                    <c:v>0.19942555598757311</c:v>
                  </c:pt>
                  <c:pt idx="7">
                    <c:v>0.20008729047474147</c:v>
                  </c:pt>
                  <c:pt idx="8">
                    <c:v>0.1677198628098428</c:v>
                  </c:pt>
                  <c:pt idx="9">
                    <c:v>0.11175675115433371</c:v>
                  </c:pt>
                  <c:pt idx="10">
                    <c:v>8.7839518170245753E-2</c:v>
                  </c:pt>
                  <c:pt idx="11">
                    <c:v>0.143690076537101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MF-MT-MS'!$A$23:$A$34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'MF-MT-MS'!$C$23:$C$34</c:f>
              <c:numCache>
                <c:formatCode>0.00</c:formatCode>
                <c:ptCount val="12"/>
                <c:pt idx="0">
                  <c:v>0.23126666666666668</c:v>
                </c:pt>
                <c:pt idx="1">
                  <c:v>0.30426666666666669</c:v>
                </c:pt>
                <c:pt idx="2">
                  <c:v>0.49213333333333331</c:v>
                </c:pt>
                <c:pt idx="3">
                  <c:v>0.62433333333333318</c:v>
                </c:pt>
                <c:pt idx="4">
                  <c:v>0.69213333333333316</c:v>
                </c:pt>
                <c:pt idx="5">
                  <c:v>0.84880000000000011</c:v>
                </c:pt>
                <c:pt idx="6">
                  <c:v>0.85146666666666659</c:v>
                </c:pt>
                <c:pt idx="7">
                  <c:v>0.83306666666666684</c:v>
                </c:pt>
                <c:pt idx="8">
                  <c:v>0.83733333333333337</c:v>
                </c:pt>
                <c:pt idx="9">
                  <c:v>0.77499999999999991</c:v>
                </c:pt>
                <c:pt idx="10">
                  <c:v>0.64826666666666666</c:v>
                </c:pt>
                <c:pt idx="11">
                  <c:v>0.5131333333333333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81C-F946-8B64-E6922E1502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9980720"/>
        <c:axId val="459964496"/>
      </c:scatterChart>
      <c:valAx>
        <c:axId val="459980720"/>
        <c:scaling>
          <c:orientation val="minMax"/>
          <c:max val="16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459964496"/>
        <c:crosses val="autoZero"/>
        <c:crossBetween val="midCat"/>
        <c:majorUnit val="1"/>
      </c:valAx>
      <c:valAx>
        <c:axId val="459964496"/>
        <c:scaling>
          <c:orientation val="minMax"/>
          <c:max val="4"/>
        </c:scaling>
        <c:delete val="0"/>
        <c:axPos val="l"/>
        <c:majorGridlines>
          <c:spPr>
            <a:ln w="6350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+mn-cs"/>
                  </a:defRPr>
                </a:pPr>
                <a:r>
                  <a:rPr lang="fr-FR" sz="1200" b="0">
                    <a:solidFill>
                      <a:schemeClr val="tx1"/>
                    </a:solidFill>
                  </a:rPr>
                  <a:t>FW (g)</a:t>
                </a:r>
              </a:p>
            </c:rich>
          </c:tx>
          <c:layout>
            <c:manualLayout>
              <c:xMode val="edge"/>
              <c:yMode val="edge"/>
              <c:x val="4.2686136494629157E-2"/>
              <c:y val="0.3027876490332416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+mn-cs"/>
                </a:defRPr>
              </a:pPr>
              <a:endParaRPr lang="fr-FR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459980720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>
          <a:latin typeface="Times New Roman" panose="02020603050405020304" pitchFamily="18" charset="0"/>
        </a:defRPr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425007505253677"/>
          <c:y val="0.15814035721966621"/>
          <c:w val="0.7566276964516816"/>
          <c:h val="0.706736842105263"/>
        </c:manualLayout>
      </c:layout>
      <c:scatterChart>
        <c:scatterStyle val="lineMarker"/>
        <c:varyColors val="0"/>
        <c:ser>
          <c:idx val="0"/>
          <c:order val="0"/>
          <c:tx>
            <c:v>Col0</c:v>
          </c:tx>
          <c:spPr>
            <a:ln w="63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Col0!$K$29,Col0!$K$57,Col0!$K$85,Col0!$K$113,Col0!$K$141,Col0!$K$169,Col0!$K$197,Col0!$K$225,Col0!$K$253,Col0!$K$269,Col0!$K$285,Col0!$K$313)</c:f>
                <c:numCache>
                  <c:formatCode>General</c:formatCode>
                  <c:ptCount val="12"/>
                  <c:pt idx="0">
                    <c:v>3.2118202741878652</c:v>
                  </c:pt>
                  <c:pt idx="1">
                    <c:v>5.5295854988844884</c:v>
                  </c:pt>
                  <c:pt idx="2">
                    <c:v>8.9846360087944745</c:v>
                  </c:pt>
                  <c:pt idx="3">
                    <c:v>10.388083591392331</c:v>
                  </c:pt>
                  <c:pt idx="4">
                    <c:v>9.9387598506262904</c:v>
                  </c:pt>
                  <c:pt idx="5">
                    <c:v>10.2412992596797</c:v>
                  </c:pt>
                  <c:pt idx="6">
                    <c:v>11.344370270848231</c:v>
                  </c:pt>
                  <c:pt idx="7">
                    <c:v>11.93579314058085</c:v>
                  </c:pt>
                  <c:pt idx="8">
                    <c:v>12.58351051344995</c:v>
                  </c:pt>
                  <c:pt idx="11">
                    <c:v>14.10962717251482</c:v>
                  </c:pt>
                </c:numCache>
              </c:numRef>
            </c:plus>
            <c:minus>
              <c:numRef>
                <c:f>(Col0!$K$29,Col0!$K$57,Col0!$K$85,Col0!$K$113,Col0!$K$141,Col0!$K$169,Col0!$K$197,Col0!$K$225,Col0!$K$253,Col0!$K$269,Col0!$K$285,Col0!$K$313)</c:f>
                <c:numCache>
                  <c:formatCode>General</c:formatCode>
                  <c:ptCount val="12"/>
                  <c:pt idx="0">
                    <c:v>3.2118202741878652</c:v>
                  </c:pt>
                  <c:pt idx="1">
                    <c:v>5.5295854988844884</c:v>
                  </c:pt>
                  <c:pt idx="2">
                    <c:v>8.9846360087944745</c:v>
                  </c:pt>
                  <c:pt idx="3">
                    <c:v>10.388083591392331</c:v>
                  </c:pt>
                  <c:pt idx="4">
                    <c:v>9.9387598506262904</c:v>
                  </c:pt>
                  <c:pt idx="5">
                    <c:v>10.2412992596797</c:v>
                  </c:pt>
                  <c:pt idx="6">
                    <c:v>11.344370270848231</c:v>
                  </c:pt>
                  <c:pt idx="7">
                    <c:v>11.93579314058085</c:v>
                  </c:pt>
                  <c:pt idx="8">
                    <c:v>12.58351051344995</c:v>
                  </c:pt>
                  <c:pt idx="11">
                    <c:v>14.1096271725148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Col0!$C$2,Col0!$C$30,Col0!$C$58,Col0!$C$86,Col0!$C$114,Col0!$C$142,Col0!$C$170)</c:f>
              <c:numCache>
                <c:formatCode>General</c:formatCode>
                <c:ptCount val="7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</c:numCache>
            </c:numRef>
          </c:xVal>
          <c:yVal>
            <c:numRef>
              <c:f>(Col0!$K$340,Col0!$K$368,Col0!$K$396,Col0!$K$424,Col0!$K$452,Col0!$K$480,Col0!$K$508)</c:f>
              <c:numCache>
                <c:formatCode>General</c:formatCode>
                <c:ptCount val="7"/>
                <c:pt idx="0">
                  <c:v>10.25</c:v>
                </c:pt>
                <c:pt idx="1">
                  <c:v>16</c:v>
                </c:pt>
                <c:pt idx="2">
                  <c:v>27.05</c:v>
                </c:pt>
                <c:pt idx="3">
                  <c:v>28.1</c:v>
                </c:pt>
                <c:pt idx="4">
                  <c:v>31.5</c:v>
                </c:pt>
                <c:pt idx="5">
                  <c:v>33.526315789473699</c:v>
                </c:pt>
                <c:pt idx="6">
                  <c:v>34.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BA4-2D4F-B7B2-D06F4A93B061}"/>
            </c:ext>
          </c:extLst>
        </c:ser>
        <c:ser>
          <c:idx val="1"/>
          <c:order val="1"/>
          <c:tx>
            <c:v>at1g08920</c:v>
          </c:tx>
          <c:spPr>
            <a:ln w="6350" cap="rnd">
              <a:solidFill>
                <a:schemeClr val="accent2"/>
              </a:solidFill>
              <a:round/>
            </a:ln>
            <a:effectLst/>
          </c:spPr>
          <c:marker>
            <c:symbol val="x"/>
            <c:size val="4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8920'!$J$29,'08920'!$J$57,'08920'!$J$85,'08920'!$J$113,'08920'!$J$141,'08920'!$J$169,'08920'!$J$197,'08920'!$J$225,'08920'!$J$253,'08920'!$J$276,'08920'!$J$299,'08920'!$J$327)</c:f>
                <c:numCache>
                  <c:formatCode>General</c:formatCode>
                  <c:ptCount val="12"/>
                  <c:pt idx="0">
                    <c:v>2.8999178970315338</c:v>
                  </c:pt>
                  <c:pt idx="1">
                    <c:v>6.2449979983983974</c:v>
                  </c:pt>
                  <c:pt idx="2">
                    <c:v>8.6475980700395798</c:v>
                  </c:pt>
                  <c:pt idx="3">
                    <c:v>9.9847502770594208</c:v>
                  </c:pt>
                  <c:pt idx="4">
                    <c:v>8.4953768940188095</c:v>
                  </c:pt>
                  <c:pt idx="5">
                    <c:v>12.299825782738321</c:v>
                  </c:pt>
                  <c:pt idx="6">
                    <c:v>11.88155833935215</c:v>
                  </c:pt>
                  <c:pt idx="7">
                    <c:v>12.82185633985968</c:v>
                  </c:pt>
                  <c:pt idx="8">
                    <c:v>10.86584863996673</c:v>
                  </c:pt>
                  <c:pt idx="9">
                    <c:v>12.959785644679631</c:v>
                  </c:pt>
                  <c:pt idx="10">
                    <c:v>16.383208593237281</c:v>
                  </c:pt>
                  <c:pt idx="11">
                    <c:v>15.88627163224986</c:v>
                  </c:pt>
                </c:numCache>
              </c:numRef>
            </c:plus>
            <c:minus>
              <c:numRef>
                <c:f>('08920'!$J$29,'08920'!$J$57,'08920'!$J$85,'08920'!$J$113,'08920'!$J$141,'08920'!$J$169,'08920'!$J$197,'08920'!$J$225,'08920'!$J$253,'08920'!$J$276,'08920'!$J$299,'08920'!$J$327)</c:f>
                <c:numCache>
                  <c:formatCode>General</c:formatCode>
                  <c:ptCount val="12"/>
                  <c:pt idx="0">
                    <c:v>2.8999178970315338</c:v>
                  </c:pt>
                  <c:pt idx="1">
                    <c:v>6.2449979983983974</c:v>
                  </c:pt>
                  <c:pt idx="2">
                    <c:v>8.6475980700395798</c:v>
                  </c:pt>
                  <c:pt idx="3">
                    <c:v>9.9847502770594208</c:v>
                  </c:pt>
                  <c:pt idx="4">
                    <c:v>8.4953768940188095</c:v>
                  </c:pt>
                  <c:pt idx="5">
                    <c:v>12.299825782738321</c:v>
                  </c:pt>
                  <c:pt idx="6">
                    <c:v>11.88155833935215</c:v>
                  </c:pt>
                  <c:pt idx="7">
                    <c:v>12.82185633985968</c:v>
                  </c:pt>
                  <c:pt idx="8">
                    <c:v>10.86584863996673</c:v>
                  </c:pt>
                  <c:pt idx="9">
                    <c:v>12.959785644679631</c:v>
                  </c:pt>
                  <c:pt idx="10">
                    <c:v>16.383208593237281</c:v>
                  </c:pt>
                  <c:pt idx="11">
                    <c:v>15.88627163224986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(Col0!$C$2,Col0!$C$30,Col0!$C$58,Col0!$C$86,Col0!$C$114,Col0!$C$142,Col0!$C$170)</c:f>
              <c:numCache>
                <c:formatCode>General</c:formatCode>
                <c:ptCount val="7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</c:numCache>
            </c:numRef>
          </c:xVal>
          <c:yVal>
            <c:numRef>
              <c:f>('08920'!$J$354,'08920'!$J$382,'08920'!$J$410,'08920'!$J$438,'08920'!$J$466,'08920'!$J$494,'08920'!$J$522)</c:f>
              <c:numCache>
                <c:formatCode>General</c:formatCode>
                <c:ptCount val="7"/>
                <c:pt idx="0">
                  <c:v>10.266666666666669</c:v>
                </c:pt>
                <c:pt idx="1">
                  <c:v>16.133333333333319</c:v>
                </c:pt>
                <c:pt idx="2">
                  <c:v>24.8</c:v>
                </c:pt>
                <c:pt idx="3">
                  <c:v>28.666666666666671</c:v>
                </c:pt>
                <c:pt idx="4">
                  <c:v>32.066666666666578</c:v>
                </c:pt>
                <c:pt idx="5">
                  <c:v>36.357142857142797</c:v>
                </c:pt>
                <c:pt idx="6">
                  <c:v>34.53333333333333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FBA4-2D4F-B7B2-D06F4A93B061}"/>
            </c:ext>
          </c:extLst>
        </c:ser>
        <c:ser>
          <c:idx val="2"/>
          <c:order val="2"/>
          <c:tx>
            <c:v>at1g75220</c:v>
          </c:tx>
          <c:spPr>
            <a:ln w="6350" cap="rnd">
              <a:solidFill>
                <a:schemeClr val="accent3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75220'!$J$29,'75220'!$J$57,'75220'!$J$85,'75220'!$J$113,'75220'!$J$141,'75220'!$J$169,'75220'!$J$197,'75220'!$J$225,'75220'!$J$253,'75220'!$J$276,'75220'!$J$299,'75220'!$J$327)</c:f>
                <c:numCache>
                  <c:formatCode>General</c:formatCode>
                  <c:ptCount val="12"/>
                  <c:pt idx="0">
                    <c:v>4.2054386555642784</c:v>
                  </c:pt>
                  <c:pt idx="1">
                    <c:v>8.5821818993683792</c:v>
                  </c:pt>
                  <c:pt idx="2">
                    <c:v>9.7575367695706827</c:v>
                  </c:pt>
                  <c:pt idx="3">
                    <c:v>11.94909839196885</c:v>
                  </c:pt>
                  <c:pt idx="4">
                    <c:v>11.308656608356021</c:v>
                  </c:pt>
                  <c:pt idx="5">
                    <c:v>13.48967859407438</c:v>
                  </c:pt>
                  <c:pt idx="6">
                    <c:v>14.316158037419861</c:v>
                  </c:pt>
                  <c:pt idx="7">
                    <c:v>16.272091211056811</c:v>
                  </c:pt>
                  <c:pt idx="8">
                    <c:v>17.212398631993921</c:v>
                  </c:pt>
                  <c:pt idx="9">
                    <c:v>15.154878081671569</c:v>
                  </c:pt>
                  <c:pt idx="10">
                    <c:v>15.93229723668547</c:v>
                  </c:pt>
                  <c:pt idx="11">
                    <c:v>17.773174007073521</c:v>
                  </c:pt>
                </c:numCache>
              </c:numRef>
            </c:plus>
            <c:minus>
              <c:numRef>
                <c:f>('75220'!$J$29,'75220'!$J$57,'75220'!$J$85,'75220'!$J$113,'75220'!$J$141,'75220'!$J$169,'75220'!$J$197,'75220'!$J$225,'75220'!$J$253,'75220'!$J$276,'75220'!$J$299,'75220'!$J$327)</c:f>
                <c:numCache>
                  <c:formatCode>General</c:formatCode>
                  <c:ptCount val="12"/>
                  <c:pt idx="0">
                    <c:v>4.2054386555642784</c:v>
                  </c:pt>
                  <c:pt idx="1">
                    <c:v>8.5821818993683792</c:v>
                  </c:pt>
                  <c:pt idx="2">
                    <c:v>9.7575367695706827</c:v>
                  </c:pt>
                  <c:pt idx="3">
                    <c:v>11.94909839196885</c:v>
                  </c:pt>
                  <c:pt idx="4">
                    <c:v>11.308656608356021</c:v>
                  </c:pt>
                  <c:pt idx="5">
                    <c:v>13.48967859407438</c:v>
                  </c:pt>
                  <c:pt idx="6">
                    <c:v>14.316158037419861</c:v>
                  </c:pt>
                  <c:pt idx="7">
                    <c:v>16.272091211056811</c:v>
                  </c:pt>
                  <c:pt idx="8">
                    <c:v>17.212398631993921</c:v>
                  </c:pt>
                  <c:pt idx="9">
                    <c:v>15.154878081671569</c:v>
                  </c:pt>
                  <c:pt idx="10">
                    <c:v>15.93229723668547</c:v>
                  </c:pt>
                  <c:pt idx="11">
                    <c:v>17.773174007073521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'75220'!$C$2,'75220'!$C$30,'75220'!$C$58,'75220'!$C$86,'75220'!$C$114,'75220'!$C$142,'75220'!$C$170)</c:f>
              <c:numCache>
                <c:formatCode>General</c:formatCode>
                <c:ptCount val="7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</c:numCache>
            </c:numRef>
          </c:xVal>
          <c:yVal>
            <c:numRef>
              <c:f>('75220'!$J$354,'75220'!$J$382,'75220'!$J$410,'75220'!$J$438,'75220'!$J$466,'75220'!$J$494,'75220'!$J$522)</c:f>
              <c:numCache>
                <c:formatCode>General</c:formatCode>
                <c:ptCount val="7"/>
                <c:pt idx="0">
                  <c:v>11.33333333333333</c:v>
                </c:pt>
                <c:pt idx="1">
                  <c:v>17.533333333333271</c:v>
                </c:pt>
                <c:pt idx="2">
                  <c:v>27.06666666666667</c:v>
                </c:pt>
                <c:pt idx="3">
                  <c:v>30.133333333333319</c:v>
                </c:pt>
                <c:pt idx="4">
                  <c:v>34.533333333333331</c:v>
                </c:pt>
                <c:pt idx="5">
                  <c:v>34.6</c:v>
                </c:pt>
                <c:pt idx="6">
                  <c:v>3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FBA4-2D4F-B7B2-D06F4A93B061}"/>
            </c:ext>
          </c:extLst>
        </c:ser>
        <c:ser>
          <c:idx val="3"/>
          <c:order val="3"/>
          <c:tx>
            <c:v>at3g04760</c:v>
          </c:tx>
          <c:spPr>
            <a:ln w="6350" cap="rnd">
              <a:solidFill>
                <a:schemeClr val="accent4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4760'!$J$29,'04760'!$J$57,'04760'!$J$85,'04760'!$J$113,'04760'!$J$141,'04760'!$J$169,'04760'!$J$197,'04760'!$J$225,'04760'!$J$253,'04760'!$J$276,'04760'!$J$299,'04760'!$J$327)</c:f>
                <c:numCache>
                  <c:formatCode>General</c:formatCode>
                  <c:ptCount val="12"/>
                  <c:pt idx="0">
                    <c:v>3.8631346758571001</c:v>
                  </c:pt>
                  <c:pt idx="1">
                    <c:v>8.2968726179263026</c:v>
                  </c:pt>
                  <c:pt idx="2">
                    <c:v>11.66476174924574</c:v>
                  </c:pt>
                  <c:pt idx="3">
                    <c:v>12.788759945842321</c:v>
                  </c:pt>
                  <c:pt idx="4">
                    <c:v>12.073978316236641</c:v>
                  </c:pt>
                  <c:pt idx="5">
                    <c:v>15.991962266803201</c:v>
                  </c:pt>
                  <c:pt idx="6">
                    <c:v>15.68615808780326</c:v>
                  </c:pt>
                  <c:pt idx="7">
                    <c:v>18.162537757091599</c:v>
                  </c:pt>
                  <c:pt idx="8">
                    <c:v>18.182714624365339</c:v>
                  </c:pt>
                  <c:pt idx="9">
                    <c:v>21.30727575266252</c:v>
                  </c:pt>
                  <c:pt idx="10">
                    <c:v>21.24173041706138</c:v>
                  </c:pt>
                  <c:pt idx="11">
                    <c:v>21.649736975564132</c:v>
                  </c:pt>
                </c:numCache>
              </c:numRef>
            </c:plus>
            <c:minus>
              <c:numRef>
                <c:f>('04760'!$J$29,'04760'!$J$57,'04760'!$J$85,'04760'!$J$113,'04760'!$J$141,'04760'!$J$169,'04760'!$J$197,'04760'!$J$225,'04760'!$J$253,'04760'!$J$276,'04760'!$J$299,'04760'!$J$327)</c:f>
                <c:numCache>
                  <c:formatCode>General</c:formatCode>
                  <c:ptCount val="12"/>
                  <c:pt idx="0">
                    <c:v>3.8631346758571001</c:v>
                  </c:pt>
                  <c:pt idx="1">
                    <c:v>8.2968726179263026</c:v>
                  </c:pt>
                  <c:pt idx="2">
                    <c:v>11.66476174924574</c:v>
                  </c:pt>
                  <c:pt idx="3">
                    <c:v>12.788759945842321</c:v>
                  </c:pt>
                  <c:pt idx="4">
                    <c:v>12.073978316236641</c:v>
                  </c:pt>
                  <c:pt idx="5">
                    <c:v>15.991962266803201</c:v>
                  </c:pt>
                  <c:pt idx="6">
                    <c:v>15.68615808780326</c:v>
                  </c:pt>
                  <c:pt idx="7">
                    <c:v>18.162537757091599</c:v>
                  </c:pt>
                  <c:pt idx="8">
                    <c:v>18.182714624365339</c:v>
                  </c:pt>
                  <c:pt idx="9">
                    <c:v>21.30727575266252</c:v>
                  </c:pt>
                  <c:pt idx="10">
                    <c:v>21.24173041706138</c:v>
                  </c:pt>
                  <c:pt idx="11">
                    <c:v>21.64973697556413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'04760'!$C$2,'04760'!$C$30,'04760'!$C$58,'04760'!$C$86,'04760'!$C$114,'04760'!$C$142,'04760'!$C$170)</c:f>
              <c:numCache>
                <c:formatCode>General</c:formatCode>
                <c:ptCount val="7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</c:numCache>
            </c:numRef>
          </c:xVal>
          <c:yVal>
            <c:numRef>
              <c:f>('04760'!$J$354,'04760'!$J$382,'04760'!$J$410,'04760'!$J$438,'04760'!$J$466,'04760'!$J$494,'04760'!$J$522)</c:f>
              <c:numCache>
                <c:formatCode>General</c:formatCode>
                <c:ptCount val="7"/>
                <c:pt idx="0">
                  <c:v>10.199999999999999</c:v>
                </c:pt>
                <c:pt idx="1">
                  <c:v>16.333333333333279</c:v>
                </c:pt>
                <c:pt idx="2">
                  <c:v>24.4</c:v>
                </c:pt>
                <c:pt idx="3">
                  <c:v>27.06666666666667</c:v>
                </c:pt>
                <c:pt idx="4">
                  <c:v>30.266666666666669</c:v>
                </c:pt>
                <c:pt idx="5">
                  <c:v>33</c:v>
                </c:pt>
                <c:pt idx="6">
                  <c:v>29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FBA4-2D4F-B7B2-D06F4A93B061}"/>
            </c:ext>
          </c:extLst>
        </c:ser>
        <c:ser>
          <c:idx val="4"/>
          <c:order val="4"/>
          <c:tx>
            <c:v>Col0 J10 J15</c:v>
          </c:tx>
          <c:spPr>
            <a:ln w="63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Col0!$D$483,Col0!$K$537,Col0!$K$565,Col0!$K$581,Col0!$K$597,Col0!$K$620)</c:f>
                <c:numCache>
                  <c:formatCode>General</c:formatCode>
                  <c:ptCount val="6"/>
                  <c:pt idx="1">
                    <c:v>7.5552352013268456</c:v>
                  </c:pt>
                  <c:pt idx="2">
                    <c:v>5.3101194356673966</c:v>
                  </c:pt>
                  <c:pt idx="5">
                    <c:v>4.9980948751451653</c:v>
                  </c:pt>
                </c:numCache>
              </c:numRef>
            </c:plus>
            <c:minus>
              <c:numRef>
                <c:f>(Col0!$D$483,Col0!$K$537,Col0!$K$565,Col0!$K$581,Col0!$K$597,Col0!$K$620)</c:f>
                <c:numCache>
                  <c:formatCode>General</c:formatCode>
                  <c:ptCount val="6"/>
                  <c:pt idx="1">
                    <c:v>7.5552352013268456</c:v>
                  </c:pt>
                  <c:pt idx="2">
                    <c:v>5.3101194356673966</c:v>
                  </c:pt>
                  <c:pt idx="5">
                    <c:v>4.9980948751451653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Col0!$C$170,Col0!$C$198,Col0!$C$226,Col0!$C$254,Col0!$C$270,Col0!$C$286)</c:f>
              <c:numCache>
                <c:formatCode>General</c:formatCode>
                <c:ptCount val="6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  <c:pt idx="4">
                  <c:v>14</c:v>
                </c:pt>
                <c:pt idx="5">
                  <c:v>15</c:v>
                </c:pt>
              </c:numCache>
            </c:numRef>
          </c:xVal>
          <c:yVal>
            <c:numRef>
              <c:f>(Col0!$K$508,Col0!$K$536,Col0!$K$564,Col0!$K$580,Col0!$K$596,Col0!$K$619)</c:f>
              <c:numCache>
                <c:formatCode>General</c:formatCode>
                <c:ptCount val="6"/>
                <c:pt idx="0">
                  <c:v>34.35</c:v>
                </c:pt>
                <c:pt idx="1">
                  <c:v>31.35</c:v>
                </c:pt>
                <c:pt idx="2">
                  <c:v>25.75</c:v>
                </c:pt>
                <c:pt idx="3">
                  <c:v>23.2</c:v>
                </c:pt>
                <c:pt idx="4">
                  <c:v>16.8</c:v>
                </c:pt>
                <c:pt idx="5">
                  <c:v>13.1333333333333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FBA4-2D4F-B7B2-D06F4A93B061}"/>
            </c:ext>
          </c:extLst>
        </c:ser>
        <c:ser>
          <c:idx val="5"/>
          <c:order val="5"/>
          <c:tx>
            <c:v>08920 J10 J15</c:v>
          </c:tx>
          <c:spPr>
            <a:ln w="6350" cap="rnd">
              <a:solidFill>
                <a:schemeClr val="accent2"/>
              </a:solidFill>
              <a:round/>
            </a:ln>
            <a:effectLst/>
          </c:spPr>
          <c:marker>
            <c:symbol val="square"/>
            <c:size val="4"/>
            <c:spPr>
              <a:solidFill>
                <a:schemeClr val="accent2"/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8920'!$C$497,'08920'!$J$551,'08920'!$J$579,'08920'!$J$602,'08920'!$J$625,'08920'!$J$648)</c:f>
                <c:numCache>
                  <c:formatCode>General</c:formatCode>
                  <c:ptCount val="6"/>
                  <c:pt idx="1">
                    <c:v>5.5634864026418613</c:v>
                  </c:pt>
                  <c:pt idx="2">
                    <c:v>6.7598253006448408</c:v>
                  </c:pt>
                  <c:pt idx="3">
                    <c:v>6.3635868891088432</c:v>
                  </c:pt>
                  <c:pt idx="4">
                    <c:v>6.7577116442377561</c:v>
                  </c:pt>
                  <c:pt idx="5">
                    <c:v>4.8824271871780356</c:v>
                  </c:pt>
                </c:numCache>
              </c:numRef>
            </c:plus>
            <c:minus>
              <c:numRef>
                <c:f>('08920'!$C$497,'08920'!$J$551,'08920'!$J$579,'08920'!$J$602,'08920'!$J$625,'08920'!$J$648)</c:f>
                <c:numCache>
                  <c:formatCode>General</c:formatCode>
                  <c:ptCount val="6"/>
                  <c:pt idx="1">
                    <c:v>5.5634864026418613</c:v>
                  </c:pt>
                  <c:pt idx="2">
                    <c:v>6.7598253006448408</c:v>
                  </c:pt>
                  <c:pt idx="3">
                    <c:v>6.3635868891088432</c:v>
                  </c:pt>
                  <c:pt idx="4">
                    <c:v>6.7577116442377561</c:v>
                  </c:pt>
                  <c:pt idx="5">
                    <c:v>4.8824271871780356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'08920'!$C$170,'08920'!$C$198,'08920'!$C$226,'08920'!$C$254,'08920'!$C$277,'08920'!$C$300)</c:f>
              <c:numCache>
                <c:formatCode>General</c:formatCode>
                <c:ptCount val="6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  <c:pt idx="4">
                  <c:v>14</c:v>
                </c:pt>
                <c:pt idx="5">
                  <c:v>15</c:v>
                </c:pt>
              </c:numCache>
            </c:numRef>
          </c:xVal>
          <c:yVal>
            <c:numRef>
              <c:f>('08920'!$J$522,'08920'!$J$550,'08920'!$J$578,'08920'!$J$601,'08920'!$J$624,'08920'!$J$647)</c:f>
              <c:numCache>
                <c:formatCode>General</c:formatCode>
                <c:ptCount val="6"/>
                <c:pt idx="0">
                  <c:v>34.533333333333331</c:v>
                </c:pt>
                <c:pt idx="1">
                  <c:v>34.333333333333343</c:v>
                </c:pt>
                <c:pt idx="2">
                  <c:v>30.533333333333271</c:v>
                </c:pt>
                <c:pt idx="3" formatCode="0.000">
                  <c:v>24.73333333333327</c:v>
                </c:pt>
                <c:pt idx="4" formatCode="0.000">
                  <c:v>18.666666666666671</c:v>
                </c:pt>
                <c:pt idx="5">
                  <c:v>13.4666666666666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FBA4-2D4F-B7B2-D06F4A93B061}"/>
            </c:ext>
          </c:extLst>
        </c:ser>
        <c:ser>
          <c:idx val="6"/>
          <c:order val="6"/>
          <c:tx>
            <c:v>75220 J10 J15</c:v>
          </c:tx>
          <c:spPr>
            <a:ln w="6350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75220'!$C$497,'75220'!$J$551,'75220'!$J$579,'75220'!$J$602,'75220'!$J$625,'75220'!$J$648)</c:f>
                <c:numCache>
                  <c:formatCode>General</c:formatCode>
                  <c:ptCount val="6"/>
                  <c:pt idx="1">
                    <c:v>4.0083246708153144</c:v>
                  </c:pt>
                  <c:pt idx="2">
                    <c:v>3.3636714634883251</c:v>
                  </c:pt>
                  <c:pt idx="3">
                    <c:v>4.3698098465766266</c:v>
                  </c:pt>
                  <c:pt idx="4">
                    <c:v>4.2736092783192374</c:v>
                  </c:pt>
                  <c:pt idx="5">
                    <c:v>3.0110906108363249</c:v>
                  </c:pt>
                </c:numCache>
              </c:numRef>
            </c:plus>
            <c:minus>
              <c:numRef>
                <c:f>('75220'!$C$497,'75220'!$J$551,'75220'!$J$579,'75220'!$J$602,'75220'!$J$625,'75220'!$J$648)</c:f>
                <c:numCache>
                  <c:formatCode>General</c:formatCode>
                  <c:ptCount val="6"/>
                  <c:pt idx="1">
                    <c:v>4.0083246708153144</c:v>
                  </c:pt>
                  <c:pt idx="2">
                    <c:v>3.3636714634883251</c:v>
                  </c:pt>
                  <c:pt idx="3">
                    <c:v>4.3698098465766266</c:v>
                  </c:pt>
                  <c:pt idx="4">
                    <c:v>4.2736092783192374</c:v>
                  </c:pt>
                  <c:pt idx="5">
                    <c:v>3.0110906108363249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('75220'!$C$496,'75220'!$C$524,'75220'!$C$552,'75220'!$C$580,'75220'!$C$603,'75220'!$C$626)</c:f>
              <c:numCache>
                <c:formatCode>General</c:formatCode>
                <c:ptCount val="6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  <c:pt idx="4">
                  <c:v>14</c:v>
                </c:pt>
                <c:pt idx="5">
                  <c:v>15</c:v>
                </c:pt>
              </c:numCache>
            </c:numRef>
          </c:xVal>
          <c:yVal>
            <c:numRef>
              <c:f>('75220'!$J$522,'75220'!$J$550,'75220'!$J$578,'75220'!$J$601,'75220'!$J$624)</c:f>
              <c:numCache>
                <c:formatCode>General</c:formatCode>
                <c:ptCount val="5"/>
                <c:pt idx="0">
                  <c:v>36</c:v>
                </c:pt>
                <c:pt idx="1">
                  <c:v>34.733333333333341</c:v>
                </c:pt>
                <c:pt idx="2">
                  <c:v>30.2</c:v>
                </c:pt>
                <c:pt idx="3" formatCode="0.000">
                  <c:v>23.333333333333279</c:v>
                </c:pt>
                <c:pt idx="4" formatCode="0.000">
                  <c:v>14.42857142857143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FBA4-2D4F-B7B2-D06F4A93B061}"/>
            </c:ext>
          </c:extLst>
        </c:ser>
        <c:ser>
          <c:idx val="7"/>
          <c:order val="7"/>
          <c:tx>
            <c:v>4760 J10 J15</c:v>
          </c:tx>
          <c:spPr>
            <a:ln w="6350" cap="rnd">
              <a:solidFill>
                <a:schemeClr val="accent4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4760'!$C$497,'04760'!$J$551,'04760'!$J$579,'04760'!$J$602,'04760'!$J$625,'04760'!$J$648)</c:f>
                <c:numCache>
                  <c:formatCode>General</c:formatCode>
                  <c:ptCount val="6"/>
                  <c:pt idx="1">
                    <c:v>7.6710132606093486</c:v>
                  </c:pt>
                  <c:pt idx="2">
                    <c:v>5.6134758493388937</c:v>
                  </c:pt>
                  <c:pt idx="3">
                    <c:v>2.9514591494904781</c:v>
                  </c:pt>
                  <c:pt idx="4">
                    <c:v>4.2687494916219002</c:v>
                  </c:pt>
                  <c:pt idx="5">
                    <c:v>4.8177911028926026</c:v>
                  </c:pt>
                </c:numCache>
              </c:numRef>
            </c:plus>
            <c:minus>
              <c:numRef>
                <c:f>('04760'!$C$497,'04760'!$J$551,'04760'!$J$579,'04760'!$J$602,'04760'!$J$625,'04760'!$J$648)</c:f>
                <c:numCache>
                  <c:formatCode>General</c:formatCode>
                  <c:ptCount val="6"/>
                  <c:pt idx="1">
                    <c:v>7.6710132606093486</c:v>
                  </c:pt>
                  <c:pt idx="2">
                    <c:v>5.6134758493388937</c:v>
                  </c:pt>
                  <c:pt idx="3">
                    <c:v>2.9514591494904781</c:v>
                  </c:pt>
                  <c:pt idx="4">
                    <c:v>4.2687494916219002</c:v>
                  </c:pt>
                  <c:pt idx="5">
                    <c:v>4.8177911028926026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'04760'!$C$496,'04760'!$C$524,'04760'!$C$552,'04760'!$C$580,'04760'!$C$603,'04760'!$C$626)</c:f>
              <c:numCache>
                <c:formatCode>General</c:formatCode>
                <c:ptCount val="6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  <c:pt idx="4">
                  <c:v>14</c:v>
                </c:pt>
                <c:pt idx="5">
                  <c:v>15</c:v>
                </c:pt>
              </c:numCache>
            </c:numRef>
          </c:xVal>
          <c:yVal>
            <c:numRef>
              <c:f>('04760'!$J$522,'04760'!$J$550,'04760'!$J$578,'04760'!$J$601,'04760'!$J$624,'04760'!$J$647)</c:f>
              <c:numCache>
                <c:formatCode>General</c:formatCode>
                <c:ptCount val="6"/>
                <c:pt idx="0">
                  <c:v>29.8</c:v>
                </c:pt>
                <c:pt idx="1">
                  <c:v>30.2</c:v>
                </c:pt>
                <c:pt idx="2">
                  <c:v>28.2</c:v>
                </c:pt>
                <c:pt idx="3" formatCode="0.000">
                  <c:v>23.6</c:v>
                </c:pt>
                <c:pt idx="4" formatCode="0.000">
                  <c:v>18</c:v>
                </c:pt>
                <c:pt idx="5">
                  <c:v>14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FBA4-2D4F-B7B2-D06F4A93B0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94065080"/>
        <c:axId val="762425912"/>
      </c:scatterChart>
      <c:valAx>
        <c:axId val="694065080"/>
        <c:scaling>
          <c:orientation val="minMax"/>
          <c:max val="16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762425912"/>
        <c:crosses val="autoZero"/>
        <c:crossBetween val="midCat"/>
        <c:majorUnit val="1"/>
      </c:valAx>
      <c:valAx>
        <c:axId val="762425912"/>
        <c:scaling>
          <c:orientation val="minMax"/>
          <c:max val="100"/>
          <c:min val="0"/>
        </c:scaling>
        <c:delete val="0"/>
        <c:axPos val="l"/>
        <c:majorGridlines>
          <c:spPr>
            <a:ln w="6350">
              <a:solidFill>
                <a:schemeClr val="bg1">
                  <a:lumMod val="85000"/>
                </a:schemeClr>
              </a:solidFill>
            </a:ln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fr-FR" sz="1200" b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LA </a:t>
                </a:r>
                <a:r>
                  <a:rPr lang="fr-FR" sz="1200" b="0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cm</a:t>
                </a:r>
                <a:r>
                  <a:rPr lang="fr-FR" sz="1200" b="0" baseline="3000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fr-FR" sz="1200" b="0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fr-FR" sz="1200" b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2.2726808766136294E-2"/>
              <c:y val="0.2837476406850751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694065080"/>
        <c:crossesAt val="0"/>
        <c:crossBetween val="midCat"/>
        <c:majorUnit val="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728015697153573"/>
          <c:y val="0.12034166666666667"/>
          <c:w val="0.7800279120372241"/>
          <c:h val="0.79459444444444449"/>
        </c:manualLayout>
      </c:layout>
      <c:scatterChart>
        <c:scatterStyle val="lineMarker"/>
        <c:varyColors val="0"/>
        <c:ser>
          <c:idx val="0"/>
          <c:order val="0"/>
          <c:tx>
            <c:strRef>
              <c:f>'MF-MT-MS'!$B$39</c:f>
              <c:strCache>
                <c:ptCount val="1"/>
                <c:pt idx="0">
                  <c:v>Col-0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F-MT-MS'!$D$41:$D$52</c:f>
                <c:numCache>
                  <c:formatCode>General</c:formatCode>
                  <c:ptCount val="12"/>
                  <c:pt idx="0">
                    <c:v>6.543281273211572E-3</c:v>
                  </c:pt>
                  <c:pt idx="1">
                    <c:v>6.9596652544000681E-3</c:v>
                  </c:pt>
                  <c:pt idx="2">
                    <c:v>1.4836444362829592E-2</c:v>
                  </c:pt>
                  <c:pt idx="3">
                    <c:v>1.490882763910859E-2</c:v>
                  </c:pt>
                  <c:pt idx="4">
                    <c:v>1.2527661905152039E-2</c:v>
                  </c:pt>
                  <c:pt idx="5">
                    <c:v>1.9181645262638523E-2</c:v>
                  </c:pt>
                  <c:pt idx="6">
                    <c:v>1.5801861646456892E-2</c:v>
                  </c:pt>
                  <c:pt idx="7">
                    <c:v>2.1076856914691921E-2</c:v>
                  </c:pt>
                  <c:pt idx="8">
                    <c:v>2.7258531887993827E-2</c:v>
                  </c:pt>
                  <c:pt idx="9">
                    <c:v>3.0313845681489843E-2</c:v>
                  </c:pt>
                  <c:pt idx="10">
                    <c:v>4.9031551470608073E-2</c:v>
                  </c:pt>
                  <c:pt idx="11">
                    <c:v>6.831523003288123E-2</c:v>
                  </c:pt>
                </c:numCache>
              </c:numRef>
            </c:plus>
            <c:minus>
              <c:numRef>
                <c:f>'MF-MT-MS'!$D$41:$D$52</c:f>
                <c:numCache>
                  <c:formatCode>General</c:formatCode>
                  <c:ptCount val="12"/>
                  <c:pt idx="0">
                    <c:v>6.543281273211572E-3</c:v>
                  </c:pt>
                  <c:pt idx="1">
                    <c:v>6.9596652544000681E-3</c:v>
                  </c:pt>
                  <c:pt idx="2">
                    <c:v>1.4836444362829592E-2</c:v>
                  </c:pt>
                  <c:pt idx="3">
                    <c:v>1.490882763910859E-2</c:v>
                  </c:pt>
                  <c:pt idx="4">
                    <c:v>1.2527661905152039E-2</c:v>
                  </c:pt>
                  <c:pt idx="5">
                    <c:v>1.9181645262638523E-2</c:v>
                  </c:pt>
                  <c:pt idx="6">
                    <c:v>1.5801861646456892E-2</c:v>
                  </c:pt>
                  <c:pt idx="7">
                    <c:v>2.1076856914691921E-2</c:v>
                  </c:pt>
                  <c:pt idx="8">
                    <c:v>2.7258531887993827E-2</c:v>
                  </c:pt>
                  <c:pt idx="9">
                    <c:v>3.0313845681489843E-2</c:v>
                  </c:pt>
                  <c:pt idx="10">
                    <c:v>4.9031551470608073E-2</c:v>
                  </c:pt>
                  <c:pt idx="11">
                    <c:v>6.831523003288123E-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MF-MT-MS'!$A$41:$A$52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'MF-MT-MS'!$B$41:$B$52</c:f>
              <c:numCache>
                <c:formatCode>0.00</c:formatCode>
                <c:ptCount val="12"/>
                <c:pt idx="0">
                  <c:v>1.2758879195832266E-2</c:v>
                </c:pt>
                <c:pt idx="1">
                  <c:v>1.9518601218301998E-2</c:v>
                </c:pt>
                <c:pt idx="2">
                  <c:v>3.6049116033722024E-2</c:v>
                </c:pt>
                <c:pt idx="3">
                  <c:v>4.2874814914964962E-2</c:v>
                </c:pt>
                <c:pt idx="4">
                  <c:v>4.7610941463588796E-2</c:v>
                </c:pt>
                <c:pt idx="5">
                  <c:v>6.8152972255587613E-2</c:v>
                </c:pt>
                <c:pt idx="6">
                  <c:v>7.8168167836479938E-2</c:v>
                </c:pt>
                <c:pt idx="7">
                  <c:v>8.2101098437590433E-2</c:v>
                </c:pt>
                <c:pt idx="8">
                  <c:v>0.10175976878911892</c:v>
                </c:pt>
                <c:pt idx="9">
                  <c:v>0.10472758738490109</c:v>
                </c:pt>
                <c:pt idx="10">
                  <c:v>0.10977091158120483</c:v>
                </c:pt>
                <c:pt idx="11">
                  <c:v>0.1515022562720024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F28-EC4B-BE97-D1FA1BD7A565}"/>
            </c:ext>
          </c:extLst>
        </c:ser>
        <c:ser>
          <c:idx val="1"/>
          <c:order val="1"/>
          <c:tx>
            <c:strRef>
              <c:f>'MF-MT-MS'!$C$39</c:f>
              <c:strCache>
                <c:ptCount val="1"/>
                <c:pt idx="0">
                  <c:v>esl3</c:v>
                </c:pt>
              </c:strCache>
            </c:strRef>
          </c:tx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rgbClr val="FFC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F-MT-MS'!$E$41:$E$52</c:f>
                <c:numCache>
                  <c:formatCode>General</c:formatCode>
                  <c:ptCount val="12"/>
                  <c:pt idx="0">
                    <c:v>6.1085002976905391E-3</c:v>
                  </c:pt>
                  <c:pt idx="1">
                    <c:v>5.562190347883157E-3</c:v>
                  </c:pt>
                  <c:pt idx="2">
                    <c:v>1.0227615537963782E-2</c:v>
                  </c:pt>
                  <c:pt idx="3">
                    <c:v>1.7920846897150237E-2</c:v>
                  </c:pt>
                  <c:pt idx="4">
                    <c:v>1.7274886128255951E-2</c:v>
                  </c:pt>
                  <c:pt idx="5">
                    <c:v>1.8379358653142382E-2</c:v>
                  </c:pt>
                  <c:pt idx="6">
                    <c:v>3.0006063737078328E-2</c:v>
                  </c:pt>
                  <c:pt idx="7">
                    <c:v>4.1427855123626671E-2</c:v>
                  </c:pt>
                  <c:pt idx="8">
                    <c:v>3.3606537187453656E-2</c:v>
                  </c:pt>
                  <c:pt idx="9">
                    <c:v>4.1742012587775608E-2</c:v>
                  </c:pt>
                  <c:pt idx="10">
                    <c:v>4.6155440645783967E-2</c:v>
                  </c:pt>
                  <c:pt idx="11">
                    <c:v>4.4652026559775661E-2</c:v>
                  </c:pt>
                </c:numCache>
              </c:numRef>
            </c:plus>
            <c:minus>
              <c:numRef>
                <c:f>'MF-MT-MS'!$E$41:$E$52</c:f>
                <c:numCache>
                  <c:formatCode>General</c:formatCode>
                  <c:ptCount val="12"/>
                  <c:pt idx="0">
                    <c:v>6.1085002976905391E-3</c:v>
                  </c:pt>
                  <c:pt idx="1">
                    <c:v>5.562190347883157E-3</c:v>
                  </c:pt>
                  <c:pt idx="2">
                    <c:v>1.0227615537963782E-2</c:v>
                  </c:pt>
                  <c:pt idx="3">
                    <c:v>1.7920846897150237E-2</c:v>
                  </c:pt>
                  <c:pt idx="4">
                    <c:v>1.7274886128255951E-2</c:v>
                  </c:pt>
                  <c:pt idx="5">
                    <c:v>1.8379358653142382E-2</c:v>
                  </c:pt>
                  <c:pt idx="6">
                    <c:v>3.0006063737078328E-2</c:v>
                  </c:pt>
                  <c:pt idx="7">
                    <c:v>4.1427855123626671E-2</c:v>
                  </c:pt>
                  <c:pt idx="8">
                    <c:v>3.3606537187453656E-2</c:v>
                  </c:pt>
                  <c:pt idx="9">
                    <c:v>4.1742012587775608E-2</c:v>
                  </c:pt>
                  <c:pt idx="10">
                    <c:v>4.6155440645783967E-2</c:v>
                  </c:pt>
                  <c:pt idx="11">
                    <c:v>4.4652026559775661E-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MF-MT-MS'!$A$41:$A$52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'MF-MT-MS'!$C$41:$C$52</c:f>
              <c:numCache>
                <c:formatCode>0.00</c:formatCode>
                <c:ptCount val="12"/>
                <c:pt idx="0">
                  <c:v>1.5357819693275076E-2</c:v>
                </c:pt>
                <c:pt idx="1">
                  <c:v>2.5634863463589966E-2</c:v>
                </c:pt>
                <c:pt idx="2">
                  <c:v>4.5664967778606187E-2</c:v>
                </c:pt>
                <c:pt idx="3">
                  <c:v>5.634004857724282E-2</c:v>
                </c:pt>
                <c:pt idx="4">
                  <c:v>6.5675171867880924E-2</c:v>
                </c:pt>
                <c:pt idx="5">
                  <c:v>7.7962355045418874E-2</c:v>
                </c:pt>
                <c:pt idx="6">
                  <c:v>9.228070621210753E-2</c:v>
                </c:pt>
                <c:pt idx="7">
                  <c:v>0.10353127237796775</c:v>
                </c:pt>
                <c:pt idx="8">
                  <c:v>0.12936263474604587</c:v>
                </c:pt>
                <c:pt idx="9">
                  <c:v>0.14389017130898876</c:v>
                </c:pt>
                <c:pt idx="10">
                  <c:v>0.17382318800325536</c:v>
                </c:pt>
                <c:pt idx="11">
                  <c:v>0.1726231875756327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F28-EC4B-BE97-D1FA1BD7A56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9785392"/>
        <c:axId val="79771248"/>
      </c:scatterChart>
      <c:valAx>
        <c:axId val="79785392"/>
        <c:scaling>
          <c:orientation val="minMax"/>
          <c:max val="51"/>
          <c:min val="35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79771248"/>
        <c:crosses val="autoZero"/>
        <c:crossBetween val="midCat"/>
        <c:majorUnit val="1"/>
      </c:valAx>
      <c:valAx>
        <c:axId val="79771248"/>
        <c:scaling>
          <c:orientation val="minMax"/>
        </c:scaling>
        <c:delete val="0"/>
        <c:axPos val="l"/>
        <c:majorGridlines>
          <c:spPr>
            <a:ln w="6350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+mn-cs"/>
                  </a:defRPr>
                </a:pPr>
                <a:r>
                  <a:rPr lang="fr-FR" sz="1200" b="0">
                    <a:solidFill>
                      <a:schemeClr val="tx1"/>
                    </a:solidFill>
                  </a:rPr>
                  <a:t>DW (g)</a:t>
                </a:r>
              </a:p>
            </c:rich>
          </c:tx>
          <c:layout>
            <c:manualLayout>
              <c:xMode val="edge"/>
              <c:yMode val="edge"/>
              <c:x val="2.8679247150176602E-2"/>
              <c:y val="0.2928312499999999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+mn-cs"/>
                </a:defRPr>
              </a:pPr>
              <a:endParaRPr lang="fr-FR"/>
            </a:p>
          </c:txPr>
        </c:title>
        <c:numFmt formatCode="0.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797853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>
          <a:latin typeface="Times New Roman" panose="02020603050405020304" pitchFamily="18" charset="0"/>
        </a:defRPr>
      </a:pPr>
      <a:endParaRPr lang="fr-FR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312561537834617"/>
          <c:y val="0.12916111111111112"/>
          <c:w val="0.75402652209129784"/>
          <c:h val="0.79459444444444449"/>
        </c:manualLayout>
      </c:layout>
      <c:scatterChart>
        <c:scatterStyle val="lineMarker"/>
        <c:varyColors val="0"/>
        <c:ser>
          <c:idx val="0"/>
          <c:order val="0"/>
          <c:tx>
            <c:strRef>
              <c:f>'MF-MT-MS'!$P$22</c:f>
              <c:strCache>
                <c:ptCount val="1"/>
                <c:pt idx="0">
                  <c:v>Col-0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F-MT-MS'!$R$24:$R$35</c:f>
                <c:numCache>
                  <c:formatCode>General</c:formatCode>
                  <c:ptCount val="12"/>
                  <c:pt idx="0">
                    <c:v>9.5244745739834435E-2</c:v>
                  </c:pt>
                  <c:pt idx="1">
                    <c:v>0.20414139833590828</c:v>
                  </c:pt>
                  <c:pt idx="2">
                    <c:v>0.24827106765675483</c:v>
                  </c:pt>
                  <c:pt idx="3">
                    <c:v>0.22112053635085668</c:v>
                  </c:pt>
                  <c:pt idx="4">
                    <c:v>0.25752988646757741</c:v>
                  </c:pt>
                  <c:pt idx="5">
                    <c:v>0.27000347982285172</c:v>
                  </c:pt>
                  <c:pt idx="6">
                    <c:v>0.32404108375812102</c:v>
                  </c:pt>
                  <c:pt idx="7">
                    <c:v>0.2349142842571034</c:v>
                  </c:pt>
                  <c:pt idx="8">
                    <c:v>0.25162570790396843</c:v>
                  </c:pt>
                  <c:pt idx="9">
                    <c:v>0.21349834747931837</c:v>
                  </c:pt>
                  <c:pt idx="10">
                    <c:v>0.14897058680060379</c:v>
                  </c:pt>
                  <c:pt idx="11">
                    <c:v>0.17023847848874096</c:v>
                  </c:pt>
                </c:numCache>
              </c:numRef>
            </c:plus>
            <c:minus>
              <c:numRef>
                <c:f>'MF-MT-MS'!$R$24:$R$35</c:f>
                <c:numCache>
                  <c:formatCode>General</c:formatCode>
                  <c:ptCount val="12"/>
                  <c:pt idx="0">
                    <c:v>9.5244745739834435E-2</c:v>
                  </c:pt>
                  <c:pt idx="1">
                    <c:v>0.20414139833590828</c:v>
                  </c:pt>
                  <c:pt idx="2">
                    <c:v>0.24827106765675483</c:v>
                  </c:pt>
                  <c:pt idx="3">
                    <c:v>0.22112053635085668</c:v>
                  </c:pt>
                  <c:pt idx="4">
                    <c:v>0.25752988646757741</c:v>
                  </c:pt>
                  <c:pt idx="5">
                    <c:v>0.27000347982285172</c:v>
                  </c:pt>
                  <c:pt idx="6">
                    <c:v>0.32404108375812102</c:v>
                  </c:pt>
                  <c:pt idx="7">
                    <c:v>0.2349142842571034</c:v>
                  </c:pt>
                  <c:pt idx="8">
                    <c:v>0.25162570790396843</c:v>
                  </c:pt>
                  <c:pt idx="9">
                    <c:v>0.21349834747931837</c:v>
                  </c:pt>
                  <c:pt idx="10">
                    <c:v>0.14897058680060379</c:v>
                  </c:pt>
                  <c:pt idx="11">
                    <c:v>0.17023847848874096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MF-MT-MS'!$O$24:$O$35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'MF-MT-MS'!$P$24:$P$35</c:f>
              <c:numCache>
                <c:formatCode>0.00</c:formatCode>
                <c:ptCount val="12"/>
                <c:pt idx="0">
                  <c:v>0.20115054580820521</c:v>
                </c:pt>
                <c:pt idx="1">
                  <c:v>0.44987022906850116</c:v>
                </c:pt>
                <c:pt idx="2">
                  <c:v>0.78283302345409456</c:v>
                </c:pt>
                <c:pt idx="3">
                  <c:v>0.868818325784252</c:v>
                </c:pt>
                <c:pt idx="4">
                  <c:v>0.9184474150785642</c:v>
                </c:pt>
                <c:pt idx="5">
                  <c:v>1.1297476598206742</c:v>
                </c:pt>
                <c:pt idx="6">
                  <c:v>1.2498125815414034</c:v>
                </c:pt>
                <c:pt idx="7">
                  <c:v>1.2949594517641663</c:v>
                </c:pt>
                <c:pt idx="8">
                  <c:v>1.2378666953339883</c:v>
                </c:pt>
                <c:pt idx="9">
                  <c:v>1.214180280539686</c:v>
                </c:pt>
                <c:pt idx="10">
                  <c:v>1.179459612944245</c:v>
                </c:pt>
                <c:pt idx="11">
                  <c:v>1.021025923563056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D98-6049-8553-DD65A37D547D}"/>
            </c:ext>
          </c:extLst>
        </c:ser>
        <c:ser>
          <c:idx val="1"/>
          <c:order val="1"/>
          <c:tx>
            <c:strRef>
              <c:f>'MF-MT-MS'!$Q$22</c:f>
              <c:strCache>
                <c:ptCount val="1"/>
                <c:pt idx="0">
                  <c:v>esl3</c:v>
                </c:pt>
              </c:strCache>
            </c:strRef>
          </c:tx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rgbClr val="FFC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F-MT-MS'!$S$24:$S$35</c:f>
                <c:numCache>
                  <c:formatCode>General</c:formatCode>
                  <c:ptCount val="12"/>
                  <c:pt idx="0">
                    <c:v>0.11454613053258429</c:v>
                  </c:pt>
                  <c:pt idx="1">
                    <c:v>0.11175171739552303</c:v>
                  </c:pt>
                  <c:pt idx="2">
                    <c:v>0.19749719056898915</c:v>
                  </c:pt>
                  <c:pt idx="3">
                    <c:v>0.21789165818956399</c:v>
                  </c:pt>
                  <c:pt idx="4">
                    <c:v>0.12103506056074119</c:v>
                  </c:pt>
                  <c:pt idx="5">
                    <c:v>0.20323027879344724</c:v>
                  </c:pt>
                  <c:pt idx="6">
                    <c:v>0.26156290773661123</c:v>
                  </c:pt>
                  <c:pt idx="7">
                    <c:v>0.25961364368601353</c:v>
                  </c:pt>
                  <c:pt idx="8">
                    <c:v>0.26491884784244052</c:v>
                  </c:pt>
                  <c:pt idx="9">
                    <c:v>0.19574442083458618</c:v>
                  </c:pt>
                  <c:pt idx="10">
                    <c:v>0.23931991691515084</c:v>
                  </c:pt>
                  <c:pt idx="11">
                    <c:v>0.23286380877164256</c:v>
                  </c:pt>
                </c:numCache>
              </c:numRef>
            </c:plus>
            <c:minus>
              <c:numRef>
                <c:f>'MF-MT-MS'!$S$24:$S$35</c:f>
                <c:numCache>
                  <c:formatCode>General</c:formatCode>
                  <c:ptCount val="12"/>
                  <c:pt idx="0">
                    <c:v>0.11454613053258429</c:v>
                  </c:pt>
                  <c:pt idx="1">
                    <c:v>0.11175171739552303</c:v>
                  </c:pt>
                  <c:pt idx="2">
                    <c:v>0.19749719056898915</c:v>
                  </c:pt>
                  <c:pt idx="3">
                    <c:v>0.21789165818956399</c:v>
                  </c:pt>
                  <c:pt idx="4">
                    <c:v>0.12103506056074119</c:v>
                  </c:pt>
                  <c:pt idx="5">
                    <c:v>0.20323027879344724</c:v>
                  </c:pt>
                  <c:pt idx="6">
                    <c:v>0.26156290773661123</c:v>
                  </c:pt>
                  <c:pt idx="7">
                    <c:v>0.25961364368601353</c:v>
                  </c:pt>
                  <c:pt idx="8">
                    <c:v>0.26491884784244052</c:v>
                  </c:pt>
                  <c:pt idx="9">
                    <c:v>0.19574442083458618</c:v>
                  </c:pt>
                  <c:pt idx="10">
                    <c:v>0.23931991691515084</c:v>
                  </c:pt>
                  <c:pt idx="11">
                    <c:v>0.23286380877164256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MF-MT-MS'!$O$24:$O$35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'MF-MT-MS'!$Q$24:$Q$35</c:f>
              <c:numCache>
                <c:formatCode>0.00</c:formatCode>
                <c:ptCount val="12"/>
                <c:pt idx="0">
                  <c:v>0.23812808380010203</c:v>
                </c:pt>
                <c:pt idx="1">
                  <c:v>0.34569171554871569</c:v>
                </c:pt>
                <c:pt idx="2">
                  <c:v>0.55343787589515803</c:v>
                </c:pt>
                <c:pt idx="3">
                  <c:v>0.71457062994116483</c:v>
                </c:pt>
                <c:pt idx="4">
                  <c:v>0.80703511894680735</c:v>
                </c:pt>
                <c:pt idx="5">
                  <c:v>0.98423803847892244</c:v>
                </c:pt>
                <c:pt idx="6">
                  <c:v>1.0288650941615238</c:v>
                </c:pt>
                <c:pt idx="7">
                  <c:v>1.0123742306362056</c:v>
                </c:pt>
                <c:pt idx="8">
                  <c:v>1.0775708171597951</c:v>
                </c:pt>
                <c:pt idx="9">
                  <c:v>1.0700051777843258</c:v>
                </c:pt>
                <c:pt idx="10">
                  <c:v>1.0281733441071697</c:v>
                </c:pt>
                <c:pt idx="11">
                  <c:v>0.981970824434916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D98-6049-8553-DD65A37D54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9979888"/>
        <c:axId val="459985712"/>
      </c:scatterChart>
      <c:valAx>
        <c:axId val="459979888"/>
        <c:scaling>
          <c:orientation val="minMax"/>
          <c:max val="16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459985712"/>
        <c:crosses val="autoZero"/>
        <c:crossBetween val="midCat"/>
        <c:majorUnit val="1"/>
      </c:valAx>
      <c:valAx>
        <c:axId val="459985712"/>
        <c:scaling>
          <c:orientation val="minMax"/>
          <c:max val="4"/>
        </c:scaling>
        <c:delete val="0"/>
        <c:axPos val="l"/>
        <c:majorGridlines>
          <c:spPr>
            <a:ln w="6350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+mn-cs"/>
                  </a:defRPr>
                </a:pPr>
                <a:r>
                  <a:rPr lang="fr-FR" sz="1200" b="0">
                    <a:solidFill>
                      <a:schemeClr val="tx1"/>
                    </a:solidFill>
                  </a:rPr>
                  <a:t>TW (g)</a:t>
                </a:r>
              </a:p>
            </c:rich>
          </c:tx>
          <c:layout>
            <c:manualLayout>
              <c:xMode val="edge"/>
              <c:yMode val="edge"/>
              <c:x val="3.4891498986142154E-2"/>
              <c:y val="0.351634722222222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+mn-cs"/>
                </a:defRPr>
              </a:pPr>
              <a:endParaRPr lang="fr-FR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459979888"/>
        <c:crosses val="autoZero"/>
        <c:crossBetween val="midCat"/>
        <c:majorUnit val="1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>
          <a:latin typeface="Times New Roman" panose="02020603050405020304" pitchFamily="18" charset="0"/>
        </a:defRPr>
      </a:pPr>
      <a:endParaRPr lang="fr-FR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739844651267334"/>
          <c:y val="0.17120468291557631"/>
          <c:w val="0.75520297379532675"/>
          <c:h val="0.74373164228048638"/>
        </c:manualLayout>
      </c:layout>
      <c:scatterChart>
        <c:scatterStyle val="lineMarker"/>
        <c:varyColors val="0"/>
        <c:ser>
          <c:idx val="0"/>
          <c:order val="0"/>
          <c:tx>
            <c:strRef>
              <c:f>'MF-MT-MS'!$P$40</c:f>
              <c:strCache>
                <c:ptCount val="1"/>
                <c:pt idx="0">
                  <c:v>Col-0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F-MT-MS'!$R$42:$R$53</c:f>
                <c:numCache>
                  <c:formatCode>General</c:formatCode>
                  <c:ptCount val="12"/>
                  <c:pt idx="0">
                    <c:v>6.543281273211572E-3</c:v>
                  </c:pt>
                  <c:pt idx="1">
                    <c:v>1.249744021870604E-2</c:v>
                  </c:pt>
                  <c:pt idx="2">
                    <c:v>1.7534737464293272E-2</c:v>
                  </c:pt>
                  <c:pt idx="3">
                    <c:v>1.6409763847896306E-2</c:v>
                  </c:pt>
                  <c:pt idx="4">
                    <c:v>1.840866112682233E-2</c:v>
                  </c:pt>
                  <c:pt idx="5">
                    <c:v>2.2757132064684563E-2</c:v>
                  </c:pt>
                  <c:pt idx="6">
                    <c:v>2.9402549787063425E-2</c:v>
                  </c:pt>
                  <c:pt idx="7">
                    <c:v>2.2774396498436194E-2</c:v>
                  </c:pt>
                  <c:pt idx="8">
                    <c:v>2.6023775165336698E-2</c:v>
                  </c:pt>
                  <c:pt idx="9">
                    <c:v>2.5110673775233478E-2</c:v>
                  </c:pt>
                  <c:pt idx="10">
                    <c:v>2.2367510073282783E-2</c:v>
                  </c:pt>
                  <c:pt idx="11">
                    <c:v>1.922554171470349E-2</c:v>
                  </c:pt>
                </c:numCache>
              </c:numRef>
            </c:plus>
            <c:minus>
              <c:numRef>
                <c:f>'MF-MT-MS'!$R$42:$R$53</c:f>
                <c:numCache>
                  <c:formatCode>General</c:formatCode>
                  <c:ptCount val="12"/>
                  <c:pt idx="0">
                    <c:v>6.543281273211572E-3</c:v>
                  </c:pt>
                  <c:pt idx="1">
                    <c:v>1.249744021870604E-2</c:v>
                  </c:pt>
                  <c:pt idx="2">
                    <c:v>1.7534737464293272E-2</c:v>
                  </c:pt>
                  <c:pt idx="3">
                    <c:v>1.6409763847896306E-2</c:v>
                  </c:pt>
                  <c:pt idx="4">
                    <c:v>1.840866112682233E-2</c:v>
                  </c:pt>
                  <c:pt idx="5">
                    <c:v>2.2757132064684563E-2</c:v>
                  </c:pt>
                  <c:pt idx="6">
                    <c:v>2.9402549787063425E-2</c:v>
                  </c:pt>
                  <c:pt idx="7">
                    <c:v>2.2774396498436194E-2</c:v>
                  </c:pt>
                  <c:pt idx="8">
                    <c:v>2.6023775165336698E-2</c:v>
                  </c:pt>
                  <c:pt idx="9">
                    <c:v>2.5110673775233478E-2</c:v>
                  </c:pt>
                  <c:pt idx="10">
                    <c:v>2.2367510073282783E-2</c:v>
                  </c:pt>
                  <c:pt idx="11">
                    <c:v>1.922554171470349E-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MF-MT-MS'!$O$42:$O$53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'MF-MT-MS'!$P$42:$P$53</c:f>
              <c:numCache>
                <c:formatCode>0.00</c:formatCode>
                <c:ptCount val="12"/>
                <c:pt idx="0">
                  <c:v>1.2758879195832266E-2</c:v>
                </c:pt>
                <c:pt idx="1">
                  <c:v>2.833034197497275E-2</c:v>
                </c:pt>
                <c:pt idx="2">
                  <c:v>4.9748042447612703E-2</c:v>
                </c:pt>
                <c:pt idx="3">
                  <c:v>5.6808870004632507E-2</c:v>
                </c:pt>
                <c:pt idx="4">
                  <c:v>6.0305110488613194E-2</c:v>
                </c:pt>
                <c:pt idx="5">
                  <c:v>7.9704883947787589E-2</c:v>
                </c:pt>
                <c:pt idx="6">
                  <c:v>9.1910481315282816E-2</c:v>
                </c:pt>
                <c:pt idx="7">
                  <c:v>0.10083508648101258</c:v>
                </c:pt>
                <c:pt idx="8">
                  <c:v>0.10157139427489277</c:v>
                </c:pt>
                <c:pt idx="9">
                  <c:v>0.10897060156766183</c:v>
                </c:pt>
                <c:pt idx="10">
                  <c:v>0.11967887560344179</c:v>
                </c:pt>
                <c:pt idx="11">
                  <c:v>0.11081607059902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AE2-AB4E-BB52-86589813E260}"/>
            </c:ext>
          </c:extLst>
        </c:ser>
        <c:ser>
          <c:idx val="1"/>
          <c:order val="1"/>
          <c:tx>
            <c:strRef>
              <c:f>'MF-MT-MS'!$Q$40</c:f>
              <c:strCache>
                <c:ptCount val="1"/>
                <c:pt idx="0">
                  <c:v>esl3</c:v>
                </c:pt>
              </c:strCache>
            </c:strRef>
          </c:tx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rgbClr val="FFC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F-MT-MS'!$S$42:$S$53</c:f>
                <c:numCache>
                  <c:formatCode>General</c:formatCode>
                  <c:ptCount val="12"/>
                  <c:pt idx="0">
                    <c:v>6.1085002976905391E-3</c:v>
                  </c:pt>
                  <c:pt idx="1">
                    <c:v>6.8962382103170327E-3</c:v>
                  </c:pt>
                  <c:pt idx="2">
                    <c:v>1.2913259630235272E-2</c:v>
                  </c:pt>
                  <c:pt idx="3">
                    <c:v>1.4778613724483955E-2</c:v>
                  </c:pt>
                  <c:pt idx="4">
                    <c:v>9.0071103496903917E-3</c:v>
                  </c:pt>
                  <c:pt idx="5">
                    <c:v>1.5448049745143631E-2</c:v>
                  </c:pt>
                  <c:pt idx="6">
                    <c:v>2.3661362076569912E-2</c:v>
                  </c:pt>
                  <c:pt idx="7">
                    <c:v>2.1759576572215122E-2</c:v>
                  </c:pt>
                  <c:pt idx="8">
                    <c:v>2.5846027834767124E-2</c:v>
                  </c:pt>
                  <c:pt idx="9">
                    <c:v>1.9913474583352572E-2</c:v>
                  </c:pt>
                  <c:pt idx="10">
                    <c:v>2.9824261204265665E-2</c:v>
                  </c:pt>
                  <c:pt idx="11">
                    <c:v>2.9471925054170248E-2</c:v>
                  </c:pt>
                </c:numCache>
              </c:numRef>
            </c:plus>
            <c:minus>
              <c:numRef>
                <c:f>'MF-MT-MS'!$S$42:$S$53</c:f>
                <c:numCache>
                  <c:formatCode>General</c:formatCode>
                  <c:ptCount val="12"/>
                  <c:pt idx="0">
                    <c:v>6.1085002976905391E-3</c:v>
                  </c:pt>
                  <c:pt idx="1">
                    <c:v>6.8962382103170327E-3</c:v>
                  </c:pt>
                  <c:pt idx="2">
                    <c:v>1.2913259630235272E-2</c:v>
                  </c:pt>
                  <c:pt idx="3">
                    <c:v>1.4778613724483955E-2</c:v>
                  </c:pt>
                  <c:pt idx="4">
                    <c:v>9.0071103496903917E-3</c:v>
                  </c:pt>
                  <c:pt idx="5">
                    <c:v>1.5448049745143631E-2</c:v>
                  </c:pt>
                  <c:pt idx="6">
                    <c:v>2.3661362076569912E-2</c:v>
                  </c:pt>
                  <c:pt idx="7">
                    <c:v>2.1759576572215122E-2</c:v>
                  </c:pt>
                  <c:pt idx="8">
                    <c:v>2.5846027834767124E-2</c:v>
                  </c:pt>
                  <c:pt idx="9">
                    <c:v>1.9913474583352572E-2</c:v>
                  </c:pt>
                  <c:pt idx="10">
                    <c:v>2.9824261204265665E-2</c:v>
                  </c:pt>
                  <c:pt idx="11">
                    <c:v>2.9471925054170248E-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MF-MT-MS'!$O$42:$O$53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'MF-MT-MS'!$Q$42:$Q$53</c:f>
              <c:numCache>
                <c:formatCode>0.00</c:formatCode>
                <c:ptCount val="12"/>
                <c:pt idx="0">
                  <c:v>1.5357819693275076E-2</c:v>
                </c:pt>
                <c:pt idx="1">
                  <c:v>2.1612605504442377E-2</c:v>
                </c:pt>
                <c:pt idx="2">
                  <c:v>3.4802993881328216E-2</c:v>
                </c:pt>
                <c:pt idx="3">
                  <c:v>4.9666097853481896E-2</c:v>
                </c:pt>
                <c:pt idx="4">
                  <c:v>5.3547380238614974E-2</c:v>
                </c:pt>
                <c:pt idx="5">
                  <c:v>6.728212083301012E-2</c:v>
                </c:pt>
                <c:pt idx="6">
                  <c:v>7.4658973201282425E-2</c:v>
                </c:pt>
                <c:pt idx="7">
                  <c:v>7.6995005632664704E-2</c:v>
                </c:pt>
                <c:pt idx="8">
                  <c:v>8.4462251083030668E-2</c:v>
                </c:pt>
                <c:pt idx="9">
                  <c:v>9.3293099806832702E-2</c:v>
                </c:pt>
                <c:pt idx="10">
                  <c:v>9.6061833450661938E-2</c:v>
                </c:pt>
                <c:pt idx="11">
                  <c:v>0.1020339841320954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AE2-AB4E-BB52-86589813E2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9779984"/>
        <c:axId val="79783312"/>
      </c:scatterChart>
      <c:valAx>
        <c:axId val="79779984"/>
        <c:scaling>
          <c:orientation val="minMax"/>
          <c:max val="16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79783312"/>
        <c:crosses val="autoZero"/>
        <c:crossBetween val="midCat"/>
        <c:majorUnit val="1"/>
      </c:valAx>
      <c:valAx>
        <c:axId val="79783312"/>
        <c:scaling>
          <c:orientation val="minMax"/>
          <c:max val="0.30000000000000004"/>
          <c:min val="0"/>
        </c:scaling>
        <c:delete val="0"/>
        <c:axPos val="l"/>
        <c:majorGridlines>
          <c:spPr>
            <a:ln w="6350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+mn-cs"/>
                  </a:defRPr>
                </a:pPr>
                <a:r>
                  <a:rPr lang="fr-FR"/>
                  <a:t>DW (g)</a:t>
                </a:r>
              </a:p>
            </c:rich>
          </c:tx>
          <c:layout>
            <c:manualLayout>
              <c:xMode val="edge"/>
              <c:yMode val="edge"/>
              <c:x val="2.3518496713075307E-2"/>
              <c:y val="0.3189587433407585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+mn-cs"/>
                </a:defRPr>
              </a:pPr>
              <a:endParaRPr lang="fr-FR"/>
            </a:p>
          </c:txPr>
        </c:title>
        <c:numFmt formatCode="0.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79779984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b="0">
          <a:solidFill>
            <a:schemeClr val="tx1"/>
          </a:solidFill>
          <a:latin typeface="Times New Roman" panose="02020603050405020304" pitchFamily="18" charset="0"/>
        </a:defRPr>
      </a:pPr>
      <a:endParaRPr lang="fr-FR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347978527235762"/>
          <c:y val="7.9446949465739727E-2"/>
          <c:w val="0.73715571886827591"/>
          <c:h val="0.57916120045744768"/>
        </c:manualLayout>
      </c:layout>
      <c:scatterChart>
        <c:scatterStyle val="lineMarker"/>
        <c:varyColors val="0"/>
        <c:ser>
          <c:idx val="0"/>
          <c:order val="0"/>
          <c:tx>
            <c:strRef>
              <c:f>'CS -SFP'!$B$3</c:f>
              <c:strCache>
                <c:ptCount val="1"/>
                <c:pt idx="0">
                  <c:v>Col-0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S -SFP'!$D$5:$D$16</c:f>
                <c:numCache>
                  <c:formatCode>General</c:formatCode>
                  <c:ptCount val="12"/>
                  <c:pt idx="0">
                    <c:v>25.332433241065608</c:v>
                  </c:pt>
                  <c:pt idx="1">
                    <c:v>28.32134993373311</c:v>
                  </c:pt>
                  <c:pt idx="2">
                    <c:v>42.296650230126431</c:v>
                  </c:pt>
                  <c:pt idx="3">
                    <c:v>30.428932843972508</c:v>
                  </c:pt>
                  <c:pt idx="4">
                    <c:v>31.178825153155373</c:v>
                  </c:pt>
                  <c:pt idx="5">
                    <c:v>39.669119406444644</c:v>
                  </c:pt>
                  <c:pt idx="6">
                    <c:v>29.542714838010422</c:v>
                  </c:pt>
                  <c:pt idx="7">
                    <c:v>35.71593481906929</c:v>
                  </c:pt>
                  <c:pt idx="8">
                    <c:v>38.479124658478945</c:v>
                  </c:pt>
                  <c:pt idx="9">
                    <c:v>46.917136662883394</c:v>
                  </c:pt>
                  <c:pt idx="10">
                    <c:v>37.748045698062199</c:v>
                  </c:pt>
                  <c:pt idx="11">
                    <c:v>31.842709878617342</c:v>
                  </c:pt>
                </c:numCache>
              </c:numRef>
            </c:plus>
            <c:minus>
              <c:numRef>
                <c:f>'CS -SFP'!$D$5:$D$15</c:f>
                <c:numCache>
                  <c:formatCode>General</c:formatCode>
                  <c:ptCount val="11"/>
                  <c:pt idx="0">
                    <c:v>25.332433241065608</c:v>
                  </c:pt>
                  <c:pt idx="1">
                    <c:v>28.32134993373311</c:v>
                  </c:pt>
                  <c:pt idx="2">
                    <c:v>42.296650230126431</c:v>
                  </c:pt>
                  <c:pt idx="3">
                    <c:v>30.428932843972508</c:v>
                  </c:pt>
                  <c:pt idx="4">
                    <c:v>31.178825153155373</c:v>
                  </c:pt>
                  <c:pt idx="5">
                    <c:v>39.669119406444644</c:v>
                  </c:pt>
                  <c:pt idx="6">
                    <c:v>29.542714838010422</c:v>
                  </c:pt>
                  <c:pt idx="7">
                    <c:v>35.71593481906929</c:v>
                  </c:pt>
                  <c:pt idx="8">
                    <c:v>38.479124658478945</c:v>
                  </c:pt>
                  <c:pt idx="9">
                    <c:v>46.917136662883394</c:v>
                  </c:pt>
                  <c:pt idx="10">
                    <c:v>37.748045698062199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CS -SFP'!$A$5:$A$16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'CS -SFP'!$B$5:$B$16</c:f>
              <c:numCache>
                <c:formatCode>0.00</c:formatCode>
                <c:ptCount val="12"/>
                <c:pt idx="0">
                  <c:v>83.049999999999983</c:v>
                </c:pt>
                <c:pt idx="1">
                  <c:v>106.29</c:v>
                </c:pt>
                <c:pt idx="2">
                  <c:v>98.839999999999989</c:v>
                </c:pt>
                <c:pt idx="3">
                  <c:v>92.026666666666657</c:v>
                </c:pt>
                <c:pt idx="4">
                  <c:v>81.849999999999994</c:v>
                </c:pt>
                <c:pt idx="5">
                  <c:v>99.659999999999982</c:v>
                </c:pt>
                <c:pt idx="6">
                  <c:v>97.779999999999987</c:v>
                </c:pt>
                <c:pt idx="7">
                  <c:v>100.05999999999997</c:v>
                </c:pt>
                <c:pt idx="8">
                  <c:v>83.32</c:v>
                </c:pt>
                <c:pt idx="9">
                  <c:v>95.276666666666671</c:v>
                </c:pt>
                <c:pt idx="10">
                  <c:v>88.543333333333322</c:v>
                </c:pt>
                <c:pt idx="11">
                  <c:v>85.30999999999998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D21-6A4C-9D7C-4096F28A2242}"/>
            </c:ext>
          </c:extLst>
        </c:ser>
        <c:ser>
          <c:idx val="1"/>
          <c:order val="1"/>
          <c:tx>
            <c:strRef>
              <c:f>'CS -SFP'!$C$3</c:f>
              <c:strCache>
                <c:ptCount val="1"/>
                <c:pt idx="0">
                  <c:v>esl3</c:v>
                </c:pt>
              </c:strCache>
            </c:strRef>
          </c:tx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rgbClr val="FFC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S -SFP'!$E$5:$E$16</c:f>
                <c:numCache>
                  <c:formatCode>General</c:formatCode>
                  <c:ptCount val="12"/>
                  <c:pt idx="0">
                    <c:v>30.632106250359787</c:v>
                  </c:pt>
                  <c:pt idx="1">
                    <c:v>27.443229594468548</c:v>
                  </c:pt>
                  <c:pt idx="2">
                    <c:v>35.707206684301184</c:v>
                  </c:pt>
                  <c:pt idx="3">
                    <c:v>34.870732713838912</c:v>
                  </c:pt>
                  <c:pt idx="4">
                    <c:v>38.112055141732256</c:v>
                  </c:pt>
                  <c:pt idx="5">
                    <c:v>34.877296241300705</c:v>
                  </c:pt>
                  <c:pt idx="6">
                    <c:v>50.272560555710577</c:v>
                  </c:pt>
                  <c:pt idx="7">
                    <c:v>29.676516703921941</c:v>
                  </c:pt>
                  <c:pt idx="8">
                    <c:v>37.18459945705488</c:v>
                  </c:pt>
                  <c:pt idx="9">
                    <c:v>45.521782205581715</c:v>
                  </c:pt>
                  <c:pt idx="10">
                    <c:v>23.892206202889245</c:v>
                  </c:pt>
                  <c:pt idx="11">
                    <c:v>49.3060351625263</c:v>
                  </c:pt>
                </c:numCache>
              </c:numRef>
            </c:plus>
            <c:minus>
              <c:numRef>
                <c:f>'CS -SFP'!$E$5:$E$16</c:f>
                <c:numCache>
                  <c:formatCode>General</c:formatCode>
                  <c:ptCount val="12"/>
                  <c:pt idx="0">
                    <c:v>30.632106250359787</c:v>
                  </c:pt>
                  <c:pt idx="1">
                    <c:v>27.443229594468548</c:v>
                  </c:pt>
                  <c:pt idx="2">
                    <c:v>35.707206684301184</c:v>
                  </c:pt>
                  <c:pt idx="3">
                    <c:v>34.870732713838912</c:v>
                  </c:pt>
                  <c:pt idx="4">
                    <c:v>38.112055141732256</c:v>
                  </c:pt>
                  <c:pt idx="5">
                    <c:v>34.877296241300705</c:v>
                  </c:pt>
                  <c:pt idx="6">
                    <c:v>50.272560555710577</c:v>
                  </c:pt>
                  <c:pt idx="7">
                    <c:v>29.676516703921941</c:v>
                  </c:pt>
                  <c:pt idx="8">
                    <c:v>37.18459945705488</c:v>
                  </c:pt>
                  <c:pt idx="9">
                    <c:v>45.521782205581715</c:v>
                  </c:pt>
                  <c:pt idx="10">
                    <c:v>23.892206202889245</c:v>
                  </c:pt>
                  <c:pt idx="11">
                    <c:v>49.3060351625263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CS -SFP'!$A$5:$A$16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'CS -SFP'!$C$5:$C$16</c:f>
              <c:numCache>
                <c:formatCode>0.00</c:formatCode>
                <c:ptCount val="12"/>
                <c:pt idx="0">
                  <c:v>88.448000000000008</c:v>
                </c:pt>
                <c:pt idx="1">
                  <c:v>99.713333333333338</c:v>
                </c:pt>
                <c:pt idx="2">
                  <c:v>101.87666666666668</c:v>
                </c:pt>
                <c:pt idx="3">
                  <c:v>103.26000000000002</c:v>
                </c:pt>
                <c:pt idx="4">
                  <c:v>107.54333333333332</c:v>
                </c:pt>
                <c:pt idx="5">
                  <c:v>119.67999999999999</c:v>
                </c:pt>
                <c:pt idx="6">
                  <c:v>98.4</c:v>
                </c:pt>
                <c:pt idx="7">
                  <c:v>86.476666666666688</c:v>
                </c:pt>
                <c:pt idx="8">
                  <c:v>94.793333333333337</c:v>
                </c:pt>
                <c:pt idx="9">
                  <c:v>86.489999999999981</c:v>
                </c:pt>
                <c:pt idx="10">
                  <c:v>75.08</c:v>
                </c:pt>
                <c:pt idx="11">
                  <c:v>93.87999999999998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D21-6A4C-9D7C-4096F28A22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32486703"/>
        <c:axId val="1032492111"/>
      </c:scatterChart>
      <c:valAx>
        <c:axId val="1032486703"/>
        <c:scaling>
          <c:orientation val="minMax"/>
          <c:max val="51"/>
          <c:min val="35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+mn-cs"/>
                  </a:defRPr>
                </a:pPr>
                <a:r>
                  <a:rPr lang="fr-FR" sz="1200" b="0" dirty="0" err="1">
                    <a:solidFill>
                      <a:schemeClr val="tx1"/>
                    </a:solidFill>
                  </a:rPr>
                  <a:t>Days</a:t>
                </a:r>
                <a:r>
                  <a:rPr lang="fr-FR" sz="1200" b="0" dirty="0">
                    <a:solidFill>
                      <a:schemeClr val="tx1"/>
                    </a:solidFill>
                  </a:rPr>
                  <a:t> </a:t>
                </a:r>
                <a:r>
                  <a:rPr lang="fr-FR" sz="1200" b="0" i="0" u="none" strike="noStrike" baseline="0" dirty="0">
                    <a:solidFill>
                      <a:schemeClr val="tx1"/>
                    </a:solidFill>
                    <a:effectLst/>
                  </a:rPr>
                  <a:t>post</a:t>
                </a:r>
                <a:r>
                  <a:rPr lang="fr-FR" sz="1200" b="0" dirty="0">
                    <a:solidFill>
                      <a:schemeClr val="tx1"/>
                    </a:solidFill>
                  </a:rPr>
                  <a:t> </a:t>
                </a:r>
                <a:r>
                  <a:rPr lang="fr-FR" sz="1200" b="0" dirty="0" err="1">
                    <a:solidFill>
                      <a:schemeClr val="tx1"/>
                    </a:solidFill>
                  </a:rPr>
                  <a:t>sowing</a:t>
                </a:r>
                <a:endParaRPr lang="fr-FR" sz="1200" b="0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0.43881055164794913"/>
              <c:y val="0.8670285530879278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1032492111"/>
        <c:crosses val="autoZero"/>
        <c:crossBetween val="midCat"/>
        <c:majorUnit val="1"/>
      </c:valAx>
      <c:valAx>
        <c:axId val="1032492111"/>
        <c:scaling>
          <c:orientation val="minMax"/>
          <c:max val="200"/>
        </c:scaling>
        <c:delete val="0"/>
        <c:axPos val="l"/>
        <c:majorGridlines>
          <c:spPr>
            <a:ln w="6350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+mn-cs"/>
                  </a:defRPr>
                </a:pPr>
                <a:r>
                  <a:rPr lang="fr-FR" sz="1200" b="0" dirty="0">
                    <a:solidFill>
                      <a:schemeClr val="tx1"/>
                    </a:solidFill>
                  </a:rPr>
                  <a:t>SC (</a:t>
                </a:r>
                <a:r>
                  <a:rPr lang="fr-FR" sz="1200" b="0" dirty="0" err="1">
                    <a:solidFill>
                      <a:schemeClr val="tx1"/>
                    </a:solidFill>
                  </a:rPr>
                  <a:t>mmole</a:t>
                </a:r>
                <a:r>
                  <a:rPr lang="fr-FR" sz="1200" b="0" dirty="0">
                    <a:solidFill>
                      <a:schemeClr val="tx1"/>
                    </a:solidFill>
                  </a:rPr>
                  <a:t>/m</a:t>
                </a:r>
                <a:r>
                  <a:rPr lang="fr-FR" sz="1200" b="0" baseline="30000" dirty="0">
                    <a:solidFill>
                      <a:schemeClr val="tx1"/>
                    </a:solidFill>
                  </a:rPr>
                  <a:t>2</a:t>
                </a:r>
                <a:r>
                  <a:rPr lang="fr-FR" sz="1200" b="0" dirty="0">
                    <a:solidFill>
                      <a:schemeClr val="tx1"/>
                    </a:solidFill>
                  </a:rPr>
                  <a:t>/s)</a:t>
                </a:r>
              </a:p>
            </c:rich>
          </c:tx>
          <c:layout>
            <c:manualLayout>
              <c:xMode val="edge"/>
              <c:yMode val="edge"/>
              <c:x val="7.5448617063785722E-2"/>
              <c:y val="1.1537778387154071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+mn-cs"/>
                </a:defRPr>
              </a:pPr>
              <a:endParaRPr lang="fr-FR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1032486703"/>
        <c:crosses val="autoZero"/>
        <c:crossBetween val="midCat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>
          <a:latin typeface="Times New Roman" panose="02020603050405020304" pitchFamily="18" charset="0"/>
        </a:defRPr>
      </a:pPr>
      <a:endParaRPr lang="fr-FR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535564479269604"/>
          <c:y val="0.13797930990900775"/>
          <c:w val="0.78494116265775105"/>
          <c:h val="0.65192467012450594"/>
        </c:manualLayout>
      </c:layout>
      <c:scatterChart>
        <c:scatterStyle val="lineMarker"/>
        <c:varyColors val="0"/>
        <c:ser>
          <c:idx val="0"/>
          <c:order val="0"/>
          <c:tx>
            <c:strRef>
              <c:f>'CS -SFP'!$B$22</c:f>
              <c:strCache>
                <c:ptCount val="1"/>
                <c:pt idx="0">
                  <c:v>Col-0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S -SFP'!$D$24:$D$35</c:f>
                <c:numCache>
                  <c:formatCode>General</c:formatCode>
                  <c:ptCount val="12"/>
                  <c:pt idx="0">
                    <c:v>35.352582178204059</c:v>
                  </c:pt>
                  <c:pt idx="1">
                    <c:v>39.708342590246204</c:v>
                  </c:pt>
                  <c:pt idx="2">
                    <c:v>45.932872559956358</c:v>
                  </c:pt>
                  <c:pt idx="3">
                    <c:v>26.898546087273868</c:v>
                  </c:pt>
                  <c:pt idx="4">
                    <c:v>28.588335375467928</c:v>
                  </c:pt>
                  <c:pt idx="5">
                    <c:v>24.441244583318781</c:v>
                  </c:pt>
                  <c:pt idx="6">
                    <c:v>26.127591440520465</c:v>
                  </c:pt>
                  <c:pt idx="7">
                    <c:v>29.4250969978577</c:v>
                  </c:pt>
                  <c:pt idx="8">
                    <c:v>18.67104085654216</c:v>
                  </c:pt>
                  <c:pt idx="9">
                    <c:v>16.384129825685815</c:v>
                  </c:pt>
                  <c:pt idx="10">
                    <c:v>19.466246090145503</c:v>
                  </c:pt>
                  <c:pt idx="11">
                    <c:v>15.879496876558512</c:v>
                  </c:pt>
                </c:numCache>
              </c:numRef>
            </c:plus>
            <c:minus>
              <c:numRef>
                <c:f>'CS -SFP'!$D$24:$D$35</c:f>
                <c:numCache>
                  <c:formatCode>General</c:formatCode>
                  <c:ptCount val="12"/>
                  <c:pt idx="0">
                    <c:v>35.352582178204059</c:v>
                  </c:pt>
                  <c:pt idx="1">
                    <c:v>39.708342590246204</c:v>
                  </c:pt>
                  <c:pt idx="2">
                    <c:v>45.932872559956358</c:v>
                  </c:pt>
                  <c:pt idx="3">
                    <c:v>26.898546087273868</c:v>
                  </c:pt>
                  <c:pt idx="4">
                    <c:v>28.588335375467928</c:v>
                  </c:pt>
                  <c:pt idx="5">
                    <c:v>24.441244583318781</c:v>
                  </c:pt>
                  <c:pt idx="6">
                    <c:v>26.127591440520465</c:v>
                  </c:pt>
                  <c:pt idx="7">
                    <c:v>29.4250969978577</c:v>
                  </c:pt>
                  <c:pt idx="8">
                    <c:v>18.67104085654216</c:v>
                  </c:pt>
                  <c:pt idx="9">
                    <c:v>16.384129825685815</c:v>
                  </c:pt>
                  <c:pt idx="10">
                    <c:v>19.466246090145503</c:v>
                  </c:pt>
                  <c:pt idx="11">
                    <c:v>15.87949687655851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CS -SFP'!$A$24:$A$35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'CS -SFP'!$B$24:$B$35</c:f>
              <c:numCache>
                <c:formatCode>0.00</c:formatCode>
                <c:ptCount val="12"/>
                <c:pt idx="0">
                  <c:v>96.555999999999983</c:v>
                </c:pt>
                <c:pt idx="1">
                  <c:v>80.983333333333363</c:v>
                </c:pt>
                <c:pt idx="2">
                  <c:v>71.746666666666684</c:v>
                </c:pt>
                <c:pt idx="3">
                  <c:v>62.68333333333333</c:v>
                </c:pt>
                <c:pt idx="4">
                  <c:v>65.846666666666664</c:v>
                </c:pt>
                <c:pt idx="5">
                  <c:v>58.473333333333336</c:v>
                </c:pt>
                <c:pt idx="6">
                  <c:v>47.1</c:v>
                </c:pt>
                <c:pt idx="7">
                  <c:v>44.523333333333326</c:v>
                </c:pt>
                <c:pt idx="8">
                  <c:v>32.988</c:v>
                </c:pt>
                <c:pt idx="9">
                  <c:v>25.116666666666671</c:v>
                </c:pt>
                <c:pt idx="10">
                  <c:v>19.300000000000004</c:v>
                </c:pt>
                <c:pt idx="11">
                  <c:v>11.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C9A-2941-93C4-365DD4C75938}"/>
            </c:ext>
          </c:extLst>
        </c:ser>
        <c:ser>
          <c:idx val="1"/>
          <c:order val="1"/>
          <c:tx>
            <c:strRef>
              <c:f>'CS -SFP'!$C$22</c:f>
              <c:strCache>
                <c:ptCount val="1"/>
                <c:pt idx="0">
                  <c:v>esl3</c:v>
                </c:pt>
              </c:strCache>
            </c:strRef>
          </c:tx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rgbClr val="FFC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S -SFP'!$E$24:$E$35</c:f>
                <c:numCache>
                  <c:formatCode>General</c:formatCode>
                  <c:ptCount val="12"/>
                  <c:pt idx="0">
                    <c:v>34.325409927146765</c:v>
                  </c:pt>
                  <c:pt idx="1">
                    <c:v>31.235177818180134</c:v>
                  </c:pt>
                  <c:pt idx="2">
                    <c:v>34.064256555994923</c:v>
                  </c:pt>
                  <c:pt idx="3">
                    <c:v>88.300414664287118</c:v>
                  </c:pt>
                  <c:pt idx="4">
                    <c:v>28.605312785219319</c:v>
                  </c:pt>
                  <c:pt idx="5">
                    <c:v>35.683354566288337</c:v>
                  </c:pt>
                  <c:pt idx="6">
                    <c:v>31.554860091629273</c:v>
                  </c:pt>
                  <c:pt idx="7">
                    <c:v>29.743347367834694</c:v>
                  </c:pt>
                  <c:pt idx="8">
                    <c:v>17.113976388632992</c:v>
                  </c:pt>
                  <c:pt idx="9">
                    <c:v>22.258635174395568</c:v>
                  </c:pt>
                  <c:pt idx="10">
                    <c:v>20.262941933230572</c:v>
                  </c:pt>
                  <c:pt idx="11">
                    <c:v>18.378656814788982</c:v>
                  </c:pt>
                </c:numCache>
              </c:numRef>
            </c:plus>
            <c:minus>
              <c:numRef>
                <c:f>'CS -SFP'!$E$24:$E$35</c:f>
                <c:numCache>
                  <c:formatCode>General</c:formatCode>
                  <c:ptCount val="12"/>
                  <c:pt idx="0">
                    <c:v>34.325409927146765</c:v>
                  </c:pt>
                  <c:pt idx="1">
                    <c:v>31.235177818180134</c:v>
                  </c:pt>
                  <c:pt idx="2">
                    <c:v>34.064256555994923</c:v>
                  </c:pt>
                  <c:pt idx="3">
                    <c:v>88.300414664287118</c:v>
                  </c:pt>
                  <c:pt idx="4">
                    <c:v>28.605312785219319</c:v>
                  </c:pt>
                  <c:pt idx="5">
                    <c:v>35.683354566288337</c:v>
                  </c:pt>
                  <c:pt idx="6">
                    <c:v>31.554860091629273</c:v>
                  </c:pt>
                  <c:pt idx="7">
                    <c:v>29.743347367834694</c:v>
                  </c:pt>
                  <c:pt idx="8">
                    <c:v>17.113976388632992</c:v>
                  </c:pt>
                  <c:pt idx="9">
                    <c:v>22.258635174395568</c:v>
                  </c:pt>
                  <c:pt idx="10">
                    <c:v>20.262941933230572</c:v>
                  </c:pt>
                  <c:pt idx="11">
                    <c:v>18.37865681478898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CS -SFP'!$A$24:$A$35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'CS -SFP'!$C$24:$C$35</c:f>
              <c:numCache>
                <c:formatCode>0.00</c:formatCode>
                <c:ptCount val="12"/>
                <c:pt idx="0">
                  <c:v>73.272000000000006</c:v>
                </c:pt>
                <c:pt idx="1">
                  <c:v>94.076666666666668</c:v>
                </c:pt>
                <c:pt idx="2">
                  <c:v>90.623333333333321</c:v>
                </c:pt>
                <c:pt idx="3">
                  <c:v>92.523333333333369</c:v>
                </c:pt>
                <c:pt idx="4">
                  <c:v>62.556666666666651</c:v>
                </c:pt>
                <c:pt idx="5">
                  <c:v>78.559999999999988</c:v>
                </c:pt>
                <c:pt idx="6">
                  <c:v>49.733333333333334</c:v>
                </c:pt>
                <c:pt idx="7">
                  <c:v>43.253333333333337</c:v>
                </c:pt>
                <c:pt idx="8">
                  <c:v>29.11785714285714</c:v>
                </c:pt>
                <c:pt idx="9">
                  <c:v>32.27272727272728</c:v>
                </c:pt>
                <c:pt idx="10">
                  <c:v>17.444999999999997</c:v>
                </c:pt>
                <c:pt idx="11">
                  <c:v>13.484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C9A-2941-93C4-365DD4C759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11913983"/>
        <c:axId val="1111921471"/>
      </c:scatterChart>
      <c:valAx>
        <c:axId val="1111913983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1111921471"/>
        <c:crosses val="autoZero"/>
        <c:crossBetween val="midCat"/>
        <c:majorUnit val="1"/>
      </c:valAx>
      <c:valAx>
        <c:axId val="1111921471"/>
        <c:scaling>
          <c:orientation val="minMax"/>
          <c:min val="0"/>
        </c:scaling>
        <c:delete val="0"/>
        <c:axPos val="l"/>
        <c:majorGridlines>
          <c:spPr>
            <a:ln w="6350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+mn-cs"/>
                  </a:defRPr>
                </a:pPr>
                <a:r>
                  <a:rPr lang="fr-FR" sz="1200" b="0" dirty="0">
                    <a:solidFill>
                      <a:schemeClr val="tx1"/>
                    </a:solidFill>
                  </a:rPr>
                  <a:t>SC (</a:t>
                </a:r>
                <a:r>
                  <a:rPr lang="fr-FR" sz="1200" b="0" dirty="0" err="1">
                    <a:solidFill>
                      <a:schemeClr val="tx1"/>
                    </a:solidFill>
                  </a:rPr>
                  <a:t>mmol</a:t>
                </a:r>
                <a:r>
                  <a:rPr lang="fr-FR" sz="1200" b="0" dirty="0">
                    <a:solidFill>
                      <a:schemeClr val="tx1"/>
                    </a:solidFill>
                  </a:rPr>
                  <a:t>/m</a:t>
                </a:r>
                <a:r>
                  <a:rPr lang="fr-FR" sz="1200" b="0" baseline="30000" dirty="0">
                    <a:solidFill>
                      <a:schemeClr val="tx1"/>
                    </a:solidFill>
                  </a:rPr>
                  <a:t>2</a:t>
                </a:r>
                <a:r>
                  <a:rPr lang="fr-FR" sz="1200" b="0" dirty="0">
                    <a:solidFill>
                      <a:schemeClr val="tx1"/>
                    </a:solidFill>
                  </a:rPr>
                  <a:t>/s)</a:t>
                </a:r>
              </a:p>
            </c:rich>
          </c:tx>
          <c:layout>
            <c:manualLayout>
              <c:xMode val="edge"/>
              <c:yMode val="edge"/>
              <c:x val="0"/>
              <c:y val="0.1063170957484411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+mn-cs"/>
                </a:defRPr>
              </a:pPr>
              <a:endParaRPr lang="fr-FR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1111913983"/>
        <c:crosses val="autoZero"/>
        <c:crossBetween val="midCat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>
          <a:latin typeface="Times New Roman" panose="02020603050405020304" pitchFamily="18" charset="0"/>
        </a:defRPr>
      </a:pPr>
      <a:endParaRPr lang="fr-FR"/>
    </a:p>
  </c:txPr>
  <c:externalData r:id="rId3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542499999999999"/>
          <c:y val="0.13567550608141704"/>
          <c:w val="0.75213903794184878"/>
          <c:h val="0.78690362389706081"/>
        </c:manualLayout>
      </c:layout>
      <c:scatterChart>
        <c:scatterStyle val="lineMarker"/>
        <c:varyColors val="0"/>
        <c:ser>
          <c:idx val="0"/>
          <c:order val="0"/>
          <c:tx>
            <c:strRef>
              <c:f>'RWC-WC'!$B$2</c:f>
              <c:strCache>
                <c:ptCount val="1"/>
                <c:pt idx="0">
                  <c:v>Col-0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rgbClr val="4282BB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WC-WC'!$D$4:$D$15</c:f>
                <c:numCache>
                  <c:formatCode>General</c:formatCode>
                  <c:ptCount val="12"/>
                  <c:pt idx="0">
                    <c:v>4.4994361725231746</c:v>
                  </c:pt>
                  <c:pt idx="1">
                    <c:v>3.6276403278465899</c:v>
                  </c:pt>
                  <c:pt idx="2">
                    <c:v>2.4232264701414419</c:v>
                  </c:pt>
                  <c:pt idx="3">
                    <c:v>1.0691592713344071</c:v>
                  </c:pt>
                  <c:pt idx="4">
                    <c:v>3.4948002792287518</c:v>
                  </c:pt>
                  <c:pt idx="5">
                    <c:v>3.5902967498020768</c:v>
                  </c:pt>
                  <c:pt idx="6">
                    <c:v>1.535219503319972</c:v>
                  </c:pt>
                  <c:pt idx="7">
                    <c:v>1.1104656258845871</c:v>
                  </c:pt>
                  <c:pt idx="8">
                    <c:v>1.1441254068347573</c:v>
                  </c:pt>
                  <c:pt idx="9">
                    <c:v>5.4808341543906529</c:v>
                  </c:pt>
                  <c:pt idx="10">
                    <c:v>1.509867127622373</c:v>
                  </c:pt>
                  <c:pt idx="11">
                    <c:v>3.589230574774553</c:v>
                  </c:pt>
                </c:numCache>
              </c:numRef>
            </c:plus>
            <c:minus>
              <c:numRef>
                <c:f>'RWC-WC'!$D$4:$D$15</c:f>
                <c:numCache>
                  <c:formatCode>General</c:formatCode>
                  <c:ptCount val="12"/>
                  <c:pt idx="0">
                    <c:v>4.4994361725231746</c:v>
                  </c:pt>
                  <c:pt idx="1">
                    <c:v>3.6276403278465899</c:v>
                  </c:pt>
                  <c:pt idx="2">
                    <c:v>2.4232264701414419</c:v>
                  </c:pt>
                  <c:pt idx="3">
                    <c:v>1.0691592713344071</c:v>
                  </c:pt>
                  <c:pt idx="4">
                    <c:v>3.4948002792287518</c:v>
                  </c:pt>
                  <c:pt idx="5">
                    <c:v>3.5902967498020768</c:v>
                  </c:pt>
                  <c:pt idx="6">
                    <c:v>1.535219503319972</c:v>
                  </c:pt>
                  <c:pt idx="7">
                    <c:v>1.1104656258845871</c:v>
                  </c:pt>
                  <c:pt idx="8">
                    <c:v>1.1441254068347573</c:v>
                  </c:pt>
                  <c:pt idx="9">
                    <c:v>5.4808341543906529</c:v>
                  </c:pt>
                  <c:pt idx="10">
                    <c:v>1.509867127622373</c:v>
                  </c:pt>
                  <c:pt idx="11">
                    <c:v>3.589230574774553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RWC-WC'!$A$4:$A$15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'RWC-WC'!$B$4:$B$15</c:f>
              <c:numCache>
                <c:formatCode>0.00</c:formatCode>
                <c:ptCount val="12"/>
                <c:pt idx="0">
                  <c:v>88.530259596803177</c:v>
                </c:pt>
                <c:pt idx="1">
                  <c:v>88.419242337401172</c:v>
                </c:pt>
                <c:pt idx="2">
                  <c:v>90.33305720894667</c:v>
                </c:pt>
                <c:pt idx="3">
                  <c:v>88.037248015905874</c:v>
                </c:pt>
                <c:pt idx="4">
                  <c:v>88.340295628818751</c:v>
                </c:pt>
                <c:pt idx="5">
                  <c:v>89.195086381564451</c:v>
                </c:pt>
                <c:pt idx="6">
                  <c:v>86.954947770361912</c:v>
                </c:pt>
                <c:pt idx="7">
                  <c:v>87.636115936859042</c:v>
                </c:pt>
                <c:pt idx="8">
                  <c:v>88.697964485958408</c:v>
                </c:pt>
                <c:pt idx="9">
                  <c:v>87.657868026637971</c:v>
                </c:pt>
                <c:pt idx="10">
                  <c:v>87.774358035367541</c:v>
                </c:pt>
                <c:pt idx="11">
                  <c:v>89.2513130913165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0A3-D846-A034-BE743335BC85}"/>
            </c:ext>
          </c:extLst>
        </c:ser>
        <c:ser>
          <c:idx val="1"/>
          <c:order val="1"/>
          <c:tx>
            <c:strRef>
              <c:f>'RWC-WC'!$C$2</c:f>
              <c:strCache>
                <c:ptCount val="1"/>
                <c:pt idx="0">
                  <c:v>esl3</c:v>
                </c:pt>
              </c:strCache>
            </c:strRef>
          </c:tx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rgbClr val="FFC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WC-WC'!$E$4:$E$15</c:f>
                <c:numCache>
                  <c:formatCode>General</c:formatCode>
                  <c:ptCount val="12"/>
                  <c:pt idx="0">
                    <c:v>7.1199867321688313</c:v>
                  </c:pt>
                  <c:pt idx="1">
                    <c:v>3.2144325801353548</c:v>
                  </c:pt>
                  <c:pt idx="2">
                    <c:v>2.9118792875656325</c:v>
                  </c:pt>
                  <c:pt idx="3">
                    <c:v>1.6340471502182583</c:v>
                  </c:pt>
                  <c:pt idx="4">
                    <c:v>1.6421868290394561</c:v>
                  </c:pt>
                  <c:pt idx="5">
                    <c:v>2.6316666067718928</c:v>
                  </c:pt>
                  <c:pt idx="6">
                    <c:v>1.7926934111605624</c:v>
                  </c:pt>
                  <c:pt idx="7">
                    <c:v>1.131006421933616</c:v>
                  </c:pt>
                  <c:pt idx="8">
                    <c:v>1.0343129555442565</c:v>
                  </c:pt>
                  <c:pt idx="9">
                    <c:v>2.7435453667699905</c:v>
                  </c:pt>
                  <c:pt idx="10">
                    <c:v>1.2320093772355036</c:v>
                  </c:pt>
                  <c:pt idx="11">
                    <c:v>0.99954787343181761</c:v>
                  </c:pt>
                </c:numCache>
              </c:numRef>
            </c:plus>
            <c:minus>
              <c:numRef>
                <c:f>'RWC-WC'!$E$4:$E$15</c:f>
                <c:numCache>
                  <c:formatCode>General</c:formatCode>
                  <c:ptCount val="12"/>
                  <c:pt idx="0">
                    <c:v>7.1199867321688313</c:v>
                  </c:pt>
                  <c:pt idx="1">
                    <c:v>3.2144325801353548</c:v>
                  </c:pt>
                  <c:pt idx="2">
                    <c:v>2.9118792875656325</c:v>
                  </c:pt>
                  <c:pt idx="3">
                    <c:v>1.6340471502182583</c:v>
                  </c:pt>
                  <c:pt idx="4">
                    <c:v>1.6421868290394561</c:v>
                  </c:pt>
                  <c:pt idx="5">
                    <c:v>2.6316666067718928</c:v>
                  </c:pt>
                  <c:pt idx="6">
                    <c:v>1.7926934111605624</c:v>
                  </c:pt>
                  <c:pt idx="7">
                    <c:v>1.131006421933616</c:v>
                  </c:pt>
                  <c:pt idx="8">
                    <c:v>1.0343129555442565</c:v>
                  </c:pt>
                  <c:pt idx="9">
                    <c:v>2.7435453667699905</c:v>
                  </c:pt>
                  <c:pt idx="10">
                    <c:v>1.2320093772355036</c:v>
                  </c:pt>
                  <c:pt idx="11">
                    <c:v>0.9995478734318176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RWC-WC'!$A$4:$A$15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'RWC-WC'!$C$4:$C$15</c:f>
              <c:numCache>
                <c:formatCode>0.00</c:formatCode>
                <c:ptCount val="12"/>
                <c:pt idx="0">
                  <c:v>94.151316287354774</c:v>
                </c:pt>
                <c:pt idx="1">
                  <c:v>90.472720430812629</c:v>
                </c:pt>
                <c:pt idx="2">
                  <c:v>90.656743171079455</c:v>
                </c:pt>
                <c:pt idx="3">
                  <c:v>89.533641267239219</c:v>
                </c:pt>
                <c:pt idx="4">
                  <c:v>87.412678345279431</c:v>
                </c:pt>
                <c:pt idx="5">
                  <c:v>90.229264414406899</c:v>
                </c:pt>
                <c:pt idx="6">
                  <c:v>87.710046876263689</c:v>
                </c:pt>
                <c:pt idx="7">
                  <c:v>88.377061712193139</c:v>
                </c:pt>
                <c:pt idx="8">
                  <c:v>89.153178614289587</c:v>
                </c:pt>
                <c:pt idx="9">
                  <c:v>88.531811604752903</c:v>
                </c:pt>
                <c:pt idx="10">
                  <c:v>88.099049758529375</c:v>
                </c:pt>
                <c:pt idx="11">
                  <c:v>89.05746863250138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0A3-D846-A034-BE743335BC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6640432"/>
        <c:axId val="276650416"/>
      </c:scatterChart>
      <c:valAx>
        <c:axId val="276640432"/>
        <c:scaling>
          <c:orientation val="minMax"/>
          <c:max val="51"/>
          <c:min val="35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276650416"/>
        <c:crosses val="autoZero"/>
        <c:crossBetween val="midCat"/>
        <c:majorUnit val="1"/>
      </c:valAx>
      <c:valAx>
        <c:axId val="276650416"/>
        <c:scaling>
          <c:orientation val="minMax"/>
          <c:max val="100"/>
          <c:min val="0"/>
        </c:scaling>
        <c:delete val="0"/>
        <c:axPos val="l"/>
        <c:majorGridlines>
          <c:spPr>
            <a:ln w="6350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+mn-cs"/>
                  </a:defRPr>
                </a:pPr>
                <a:r>
                  <a:rPr lang="en-US" sz="1200" b="0" dirty="0">
                    <a:solidFill>
                      <a:schemeClr val="tx1"/>
                    </a:solidFill>
                  </a:rPr>
                  <a:t>RWC (%)</a:t>
                </a:r>
              </a:p>
            </c:rich>
          </c:tx>
          <c:layout>
            <c:manualLayout>
              <c:xMode val="edge"/>
              <c:yMode val="edge"/>
              <c:x val="8.2847182190303542E-2"/>
              <c:y val="0.243657007537351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+mn-cs"/>
                </a:defRPr>
              </a:pPr>
              <a:endParaRPr lang="fr-FR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276640432"/>
        <c:crosses val="autoZero"/>
        <c:crossBetween val="midCat"/>
        <c:majorUnit val="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="1">
          <a:latin typeface="Times New Roman" panose="02020603050405020304" pitchFamily="18" charset="0"/>
        </a:defRPr>
      </a:pPr>
      <a:endParaRPr lang="fr-FR"/>
    </a:p>
  </c:txPr>
  <c:externalData r:id="rId3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12330042438247"/>
          <c:y val="0.11152222222222222"/>
          <c:w val="0.77602287251526303"/>
          <c:h val="0.79459444444444449"/>
        </c:manualLayout>
      </c:layout>
      <c:scatterChart>
        <c:scatterStyle val="lineMarker"/>
        <c:varyColors val="0"/>
        <c:ser>
          <c:idx val="0"/>
          <c:order val="0"/>
          <c:tx>
            <c:strRef>
              <c:f>'RWC-WC'!$B$20</c:f>
              <c:strCache>
                <c:ptCount val="1"/>
                <c:pt idx="0">
                  <c:v>Col-0</c:v>
                </c:pt>
              </c:strCache>
            </c:strRef>
          </c:tx>
          <c:spPr>
            <a:ln w="19050" cap="rnd">
              <a:solidFill>
                <a:srgbClr val="4282BB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WC-WC'!$D$22:$D$33</c:f>
                <c:numCache>
                  <c:formatCode>General</c:formatCode>
                  <c:ptCount val="12"/>
                  <c:pt idx="0">
                    <c:v>4.4994361725231746</c:v>
                  </c:pt>
                  <c:pt idx="1">
                    <c:v>3.0779385336298208</c:v>
                  </c:pt>
                  <c:pt idx="2">
                    <c:v>2.6922570331587359</c:v>
                  </c:pt>
                  <c:pt idx="3">
                    <c:v>1.7486541737529206</c:v>
                  </c:pt>
                  <c:pt idx="4">
                    <c:v>2.3799535095822848</c:v>
                  </c:pt>
                  <c:pt idx="5">
                    <c:v>3.214398480047747</c:v>
                  </c:pt>
                  <c:pt idx="6">
                    <c:v>4.5008842265852618</c:v>
                  </c:pt>
                  <c:pt idx="7">
                    <c:v>3.4709385050131307</c:v>
                  </c:pt>
                  <c:pt idx="8">
                    <c:v>6.1854515324121193</c:v>
                  </c:pt>
                  <c:pt idx="9">
                    <c:v>10.214588501029672</c:v>
                  </c:pt>
                  <c:pt idx="10">
                    <c:v>13.000467716845254</c:v>
                  </c:pt>
                  <c:pt idx="11">
                    <c:v>10.131925522251311</c:v>
                  </c:pt>
                </c:numCache>
              </c:numRef>
            </c:plus>
            <c:minus>
              <c:numRef>
                <c:f>'RWC-WC'!$D$22:$D$33</c:f>
                <c:numCache>
                  <c:formatCode>General</c:formatCode>
                  <c:ptCount val="12"/>
                  <c:pt idx="0">
                    <c:v>4.4994361725231746</c:v>
                  </c:pt>
                  <c:pt idx="1">
                    <c:v>3.0779385336298208</c:v>
                  </c:pt>
                  <c:pt idx="2">
                    <c:v>2.6922570331587359</c:v>
                  </c:pt>
                  <c:pt idx="3">
                    <c:v>1.7486541737529206</c:v>
                  </c:pt>
                  <c:pt idx="4">
                    <c:v>2.3799535095822848</c:v>
                  </c:pt>
                  <c:pt idx="5">
                    <c:v>3.214398480047747</c:v>
                  </c:pt>
                  <c:pt idx="6">
                    <c:v>4.5008842265852618</c:v>
                  </c:pt>
                  <c:pt idx="7">
                    <c:v>3.4709385050131307</c:v>
                  </c:pt>
                  <c:pt idx="8">
                    <c:v>6.1854515324121193</c:v>
                  </c:pt>
                  <c:pt idx="9">
                    <c:v>10.214588501029672</c:v>
                  </c:pt>
                  <c:pt idx="10">
                    <c:v>13.000467716845254</c:v>
                  </c:pt>
                  <c:pt idx="11">
                    <c:v>10.131925522251311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RWC-WC'!$A$22:$A$33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'RWC-WC'!$B$22:$B$33</c:f>
              <c:numCache>
                <c:formatCode>0.00</c:formatCode>
                <c:ptCount val="12"/>
                <c:pt idx="0">
                  <c:v>88.530259596803177</c:v>
                </c:pt>
                <c:pt idx="1">
                  <c:v>87.984780385082914</c:v>
                </c:pt>
                <c:pt idx="2">
                  <c:v>87.182318224659099</c:v>
                </c:pt>
                <c:pt idx="3">
                  <c:v>87.305746976107713</c:v>
                </c:pt>
                <c:pt idx="4">
                  <c:v>84.608896379484719</c:v>
                </c:pt>
                <c:pt idx="5">
                  <c:v>84.206688459956098</c:v>
                </c:pt>
                <c:pt idx="6">
                  <c:v>79.39071215825372</c:v>
                </c:pt>
                <c:pt idx="7">
                  <c:v>77.6961773904236</c:v>
                </c:pt>
                <c:pt idx="8">
                  <c:v>74.53161897261235</c:v>
                </c:pt>
                <c:pt idx="9">
                  <c:v>64.098793848782947</c:v>
                </c:pt>
                <c:pt idx="10">
                  <c:v>55.33210255695812</c:v>
                </c:pt>
                <c:pt idx="11">
                  <c:v>41.1015592373114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DB0-8943-8260-6CE625D78A44}"/>
            </c:ext>
          </c:extLst>
        </c:ser>
        <c:ser>
          <c:idx val="1"/>
          <c:order val="1"/>
          <c:tx>
            <c:strRef>
              <c:f>'RWC-WC'!$C$20</c:f>
              <c:strCache>
                <c:ptCount val="1"/>
                <c:pt idx="0">
                  <c:v>esl3</c:v>
                </c:pt>
              </c:strCache>
            </c:strRef>
          </c:tx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rgbClr val="FFC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WC-WC'!$E$22:$E$33</c:f>
                <c:numCache>
                  <c:formatCode>General</c:formatCode>
                  <c:ptCount val="12"/>
                  <c:pt idx="0">
                    <c:v>7.1199867321688313</c:v>
                  </c:pt>
                  <c:pt idx="1">
                    <c:v>2.723205865151614</c:v>
                  </c:pt>
                  <c:pt idx="2">
                    <c:v>1.4411157960422059</c:v>
                  </c:pt>
                  <c:pt idx="3">
                    <c:v>1.3473633790916448</c:v>
                  </c:pt>
                  <c:pt idx="4">
                    <c:v>1.5000209251194965</c:v>
                  </c:pt>
                  <c:pt idx="5">
                    <c:v>1.7958348772257688</c:v>
                  </c:pt>
                  <c:pt idx="6">
                    <c:v>3.0913643378100297</c:v>
                  </c:pt>
                  <c:pt idx="7">
                    <c:v>3.2821502562718199</c:v>
                  </c:pt>
                  <c:pt idx="8">
                    <c:v>5.5633501402569774</c:v>
                  </c:pt>
                  <c:pt idx="9">
                    <c:v>6.2875593419534095</c:v>
                  </c:pt>
                  <c:pt idx="10">
                    <c:v>10.580350836225538</c:v>
                  </c:pt>
                  <c:pt idx="11">
                    <c:v>12.664280253927481</c:v>
                  </c:pt>
                </c:numCache>
              </c:numRef>
            </c:plus>
            <c:minus>
              <c:numRef>
                <c:f>'RWC-WC'!$E$22:$E$33</c:f>
                <c:numCache>
                  <c:formatCode>General</c:formatCode>
                  <c:ptCount val="12"/>
                  <c:pt idx="0">
                    <c:v>7.1199867321688313</c:v>
                  </c:pt>
                  <c:pt idx="1">
                    <c:v>2.723205865151614</c:v>
                  </c:pt>
                  <c:pt idx="2">
                    <c:v>1.4411157960422059</c:v>
                  </c:pt>
                  <c:pt idx="3">
                    <c:v>1.3473633790916448</c:v>
                  </c:pt>
                  <c:pt idx="4">
                    <c:v>1.5000209251194965</c:v>
                  </c:pt>
                  <c:pt idx="5">
                    <c:v>1.7958348772257688</c:v>
                  </c:pt>
                  <c:pt idx="6">
                    <c:v>3.0913643378100297</c:v>
                  </c:pt>
                  <c:pt idx="7">
                    <c:v>3.2821502562718199</c:v>
                  </c:pt>
                  <c:pt idx="8">
                    <c:v>5.5633501402569774</c:v>
                  </c:pt>
                  <c:pt idx="9">
                    <c:v>6.2875593419534095</c:v>
                  </c:pt>
                  <c:pt idx="10">
                    <c:v>10.580350836225538</c:v>
                  </c:pt>
                  <c:pt idx="11">
                    <c:v>12.664280253927481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RWC-WC'!$A$22:$A$33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'RWC-WC'!$C$22:$C$33</c:f>
              <c:numCache>
                <c:formatCode>0.00</c:formatCode>
                <c:ptCount val="12"/>
                <c:pt idx="0">
                  <c:v>94.151316287354774</c:v>
                </c:pt>
                <c:pt idx="1">
                  <c:v>87.145451315097915</c:v>
                </c:pt>
                <c:pt idx="2">
                  <c:v>88.417898210767632</c:v>
                </c:pt>
                <c:pt idx="3">
                  <c:v>86.558469743926693</c:v>
                </c:pt>
                <c:pt idx="4">
                  <c:v>84.833112100792448</c:v>
                </c:pt>
                <c:pt idx="5">
                  <c:v>85.447092716230898</c:v>
                </c:pt>
                <c:pt idx="6">
                  <c:v>81.867759498957312</c:v>
                </c:pt>
                <c:pt idx="7">
                  <c:v>81.219131466328761</c:v>
                </c:pt>
                <c:pt idx="8">
                  <c:v>76.715542966461527</c:v>
                </c:pt>
                <c:pt idx="9">
                  <c:v>70.568731975111376</c:v>
                </c:pt>
                <c:pt idx="10">
                  <c:v>61.234629522528444</c:v>
                </c:pt>
                <c:pt idx="11">
                  <c:v>47.05070995201562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DB0-8943-8260-6CE625D78A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6659152"/>
        <c:axId val="276662480"/>
      </c:scatterChart>
      <c:valAx>
        <c:axId val="276659152"/>
        <c:scaling>
          <c:orientation val="minMax"/>
          <c:max val="16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276662480"/>
        <c:crosses val="autoZero"/>
        <c:crossBetween val="midCat"/>
        <c:majorUnit val="1"/>
      </c:valAx>
      <c:valAx>
        <c:axId val="276662480"/>
        <c:scaling>
          <c:orientation val="minMax"/>
          <c:max val="100"/>
        </c:scaling>
        <c:delete val="0"/>
        <c:axPos val="l"/>
        <c:majorGridlines>
          <c:spPr>
            <a:ln w="6350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+mn-cs"/>
                  </a:defRPr>
                </a:pPr>
                <a:r>
                  <a:rPr lang="en-US" sz="1200" b="0" dirty="0">
                    <a:solidFill>
                      <a:schemeClr val="tx1"/>
                    </a:solidFill>
                  </a:rPr>
                  <a:t>RWC (%)</a:t>
                </a:r>
              </a:p>
            </c:rich>
          </c:tx>
          <c:layout>
            <c:manualLayout>
              <c:xMode val="edge"/>
              <c:yMode val="edge"/>
              <c:x val="5.5985534131476188E-2"/>
              <c:y val="0.2692833333333333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+mn-cs"/>
                </a:defRPr>
              </a:pPr>
              <a:endParaRPr lang="fr-FR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276659152"/>
        <c:crosses val="autoZero"/>
        <c:crossBetween val="midCat"/>
        <c:majorUnit val="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="1">
          <a:latin typeface="Times New Roman" panose="02020603050405020304" pitchFamily="18" charset="0"/>
        </a:defRPr>
      </a:pPr>
      <a:endParaRPr lang="fr-FR"/>
    </a:p>
  </c:txPr>
  <c:externalData r:id="rId3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116729253143716"/>
          <c:y val="0.12739737915473401"/>
          <c:w val="0.77039155538004489"/>
          <c:h val="0.52324577897345415"/>
        </c:manualLayout>
      </c:layout>
      <c:scatterChart>
        <c:scatterStyle val="lineMarker"/>
        <c:varyColors val="0"/>
        <c:ser>
          <c:idx val="0"/>
          <c:order val="0"/>
          <c:tx>
            <c:strRef>
              <c:f>'RWC-WC'!$P$3</c:f>
              <c:strCache>
                <c:ptCount val="1"/>
                <c:pt idx="0">
                  <c:v>Col-0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WC-WC'!$R$5:$R$16</c:f>
                <c:numCache>
                  <c:formatCode>General</c:formatCode>
                  <c:ptCount val="12"/>
                  <c:pt idx="0">
                    <c:v>1.3119242872124612</c:v>
                  </c:pt>
                  <c:pt idx="1">
                    <c:v>0.98199717793320951</c:v>
                  </c:pt>
                  <c:pt idx="2">
                    <c:v>1.1097140867269744</c:v>
                  </c:pt>
                  <c:pt idx="3">
                    <c:v>0.47864323154945809</c:v>
                  </c:pt>
                  <c:pt idx="4">
                    <c:v>0.59095918951917603</c:v>
                  </c:pt>
                  <c:pt idx="5">
                    <c:v>0.57989257202160038</c:v>
                  </c:pt>
                  <c:pt idx="6">
                    <c:v>0.64446714227925739</c:v>
                  </c:pt>
                  <c:pt idx="7">
                    <c:v>0.34324135292781816</c:v>
                  </c:pt>
                  <c:pt idx="8">
                    <c:v>0.34023395779455223</c:v>
                  </c:pt>
                  <c:pt idx="9">
                    <c:v>0.84358083568722697</c:v>
                  </c:pt>
                  <c:pt idx="10">
                    <c:v>1.7111655506401313</c:v>
                  </c:pt>
                  <c:pt idx="11">
                    <c:v>0.3791843876120416</c:v>
                  </c:pt>
                </c:numCache>
              </c:numRef>
            </c:plus>
            <c:minus>
              <c:numRef>
                <c:f>'RWC-WC'!$R$5:$R$16</c:f>
                <c:numCache>
                  <c:formatCode>General</c:formatCode>
                  <c:ptCount val="12"/>
                  <c:pt idx="0">
                    <c:v>1.3119242872124612</c:v>
                  </c:pt>
                  <c:pt idx="1">
                    <c:v>0.98199717793320951</c:v>
                  </c:pt>
                  <c:pt idx="2">
                    <c:v>1.1097140867269744</c:v>
                  </c:pt>
                  <c:pt idx="3">
                    <c:v>0.47864323154945809</c:v>
                  </c:pt>
                  <c:pt idx="4">
                    <c:v>0.59095918951917603</c:v>
                  </c:pt>
                  <c:pt idx="5">
                    <c:v>0.57989257202160038</c:v>
                  </c:pt>
                  <c:pt idx="6">
                    <c:v>0.64446714227925739</c:v>
                  </c:pt>
                  <c:pt idx="7">
                    <c:v>0.34324135292781816</c:v>
                  </c:pt>
                  <c:pt idx="8">
                    <c:v>0.34023395779455223</c:v>
                  </c:pt>
                  <c:pt idx="9">
                    <c:v>0.84358083568722697</c:v>
                  </c:pt>
                  <c:pt idx="10">
                    <c:v>1.7111655506401313</c:v>
                  </c:pt>
                  <c:pt idx="11">
                    <c:v>0.37918438761204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RWC-WC'!$O$5:$O$16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'RWC-WC'!$P$5:$P$16</c:f>
              <c:numCache>
                <c:formatCode>0.00</c:formatCode>
                <c:ptCount val="12"/>
                <c:pt idx="0">
                  <c:v>92.740655279579698</c:v>
                </c:pt>
                <c:pt idx="1">
                  <c:v>92.557395219488583</c:v>
                </c:pt>
                <c:pt idx="2">
                  <c:v>92.63077199508426</c:v>
                </c:pt>
                <c:pt idx="3">
                  <c:v>92.56993812112411</c:v>
                </c:pt>
                <c:pt idx="4">
                  <c:v>92.520144190140556</c:v>
                </c:pt>
                <c:pt idx="5">
                  <c:v>92.448158051894083</c:v>
                </c:pt>
                <c:pt idx="6">
                  <c:v>92.086069076665098</c:v>
                </c:pt>
                <c:pt idx="7">
                  <c:v>92.163873720722805</c:v>
                </c:pt>
                <c:pt idx="8">
                  <c:v>92.530124683096588</c:v>
                </c:pt>
                <c:pt idx="9">
                  <c:v>92.636879390660255</c:v>
                </c:pt>
                <c:pt idx="10">
                  <c:v>93.158214233967456</c:v>
                </c:pt>
                <c:pt idx="11">
                  <c:v>92.71167551977505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78F-A44C-BF9C-D8A9C56DBC72}"/>
            </c:ext>
          </c:extLst>
        </c:ser>
        <c:ser>
          <c:idx val="1"/>
          <c:order val="1"/>
          <c:tx>
            <c:strRef>
              <c:f>'RWC-WC'!$Q$3</c:f>
              <c:strCache>
                <c:ptCount val="1"/>
                <c:pt idx="0">
                  <c:v>esl3</c:v>
                </c:pt>
              </c:strCache>
            </c:strRef>
          </c:tx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rgbClr val="FFC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WC-WC'!$S$5:$S$16</c:f>
                <c:numCache>
                  <c:formatCode>General</c:formatCode>
                  <c:ptCount val="12"/>
                  <c:pt idx="0">
                    <c:v>0.47297033271143402</c:v>
                  </c:pt>
                  <c:pt idx="1">
                    <c:v>0.81011614756308958</c:v>
                  </c:pt>
                  <c:pt idx="2">
                    <c:v>1.0346080329333447</c:v>
                  </c:pt>
                  <c:pt idx="3">
                    <c:v>0.52281662510619342</c:v>
                  </c:pt>
                  <c:pt idx="4">
                    <c:v>0.5179521679758089</c:v>
                  </c:pt>
                  <c:pt idx="5">
                    <c:v>0.51366990586068151</c:v>
                  </c:pt>
                  <c:pt idx="6">
                    <c:v>0.44873795958341384</c:v>
                  </c:pt>
                  <c:pt idx="7">
                    <c:v>0.28052643672236344</c:v>
                  </c:pt>
                  <c:pt idx="8">
                    <c:v>0.2377375813642009</c:v>
                  </c:pt>
                  <c:pt idx="9">
                    <c:v>0.42001925235200532</c:v>
                  </c:pt>
                  <c:pt idx="10">
                    <c:v>0.31971695074749257</c:v>
                  </c:pt>
                  <c:pt idx="11">
                    <c:v>0.21229199616368935</c:v>
                  </c:pt>
                </c:numCache>
              </c:numRef>
            </c:plus>
            <c:minus>
              <c:numRef>
                <c:f>'RWC-WC'!$S$5:$S$16</c:f>
                <c:numCache>
                  <c:formatCode>General</c:formatCode>
                  <c:ptCount val="12"/>
                  <c:pt idx="0">
                    <c:v>0.47297033271143402</c:v>
                  </c:pt>
                  <c:pt idx="1">
                    <c:v>0.81011614756308958</c:v>
                  </c:pt>
                  <c:pt idx="2">
                    <c:v>1.0346080329333447</c:v>
                  </c:pt>
                  <c:pt idx="3">
                    <c:v>0.52281662510619342</c:v>
                  </c:pt>
                  <c:pt idx="4">
                    <c:v>0.5179521679758089</c:v>
                  </c:pt>
                  <c:pt idx="5">
                    <c:v>0.51366990586068151</c:v>
                  </c:pt>
                  <c:pt idx="6">
                    <c:v>0.44873795958341384</c:v>
                  </c:pt>
                  <c:pt idx="7">
                    <c:v>0.28052643672236344</c:v>
                  </c:pt>
                  <c:pt idx="8">
                    <c:v>0.2377375813642009</c:v>
                  </c:pt>
                  <c:pt idx="9">
                    <c:v>0.42001925235200532</c:v>
                  </c:pt>
                  <c:pt idx="10">
                    <c:v>0.31971695074749257</c:v>
                  </c:pt>
                  <c:pt idx="11">
                    <c:v>0.212291996163689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RWC-WC'!$O$5:$O$16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'RWC-WC'!$Q$5:$Q$16</c:f>
              <c:numCache>
                <c:formatCode>0.00</c:formatCode>
                <c:ptCount val="12"/>
                <c:pt idx="0">
                  <c:v>93.4293613220552</c:v>
                </c:pt>
                <c:pt idx="1">
                  <c:v>92.661074603419195</c:v>
                </c:pt>
                <c:pt idx="2">
                  <c:v>92.788315622942335</c:v>
                </c:pt>
                <c:pt idx="3">
                  <c:v>92.883852553446459</c:v>
                </c:pt>
                <c:pt idx="4">
                  <c:v>92.776535482281176</c:v>
                </c:pt>
                <c:pt idx="5">
                  <c:v>92.672257339311912</c:v>
                </c:pt>
                <c:pt idx="6">
                  <c:v>92.244492362238262</c:v>
                </c:pt>
                <c:pt idx="7">
                  <c:v>92.557639288154988</c:v>
                </c:pt>
                <c:pt idx="8">
                  <c:v>92.657873028273031</c:v>
                </c:pt>
                <c:pt idx="9">
                  <c:v>93.006868725956608</c:v>
                </c:pt>
                <c:pt idx="10">
                  <c:v>92.851009677980585</c:v>
                </c:pt>
                <c:pt idx="11">
                  <c:v>92.72403313373267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78F-A44C-BF9C-D8A9C56DBC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9983632"/>
        <c:axId val="459961584"/>
      </c:scatterChart>
      <c:valAx>
        <c:axId val="459983632"/>
        <c:scaling>
          <c:orientation val="minMax"/>
          <c:max val="51"/>
          <c:min val="35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459961584"/>
        <c:crosses val="autoZero"/>
        <c:crossBetween val="midCat"/>
        <c:majorUnit val="1"/>
      </c:valAx>
      <c:valAx>
        <c:axId val="459961584"/>
        <c:scaling>
          <c:orientation val="minMax"/>
          <c:max val="100"/>
          <c:min val="0"/>
        </c:scaling>
        <c:delete val="0"/>
        <c:axPos val="l"/>
        <c:majorGridlines>
          <c:spPr>
            <a:ln w="6350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459983632"/>
        <c:crosses val="autoZero"/>
        <c:crossBetween val="midCat"/>
        <c:majorUnit val="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>
          <a:latin typeface="Times New Roman" panose="02020603050405020304" pitchFamily="18" charset="0"/>
        </a:defRPr>
      </a:pPr>
      <a:endParaRPr lang="fr-FR"/>
    </a:p>
  </c:txPr>
  <c:externalData r:id="rId3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729965445637759"/>
          <c:y val="0.10612847222222223"/>
          <c:w val="0.79729047065625569"/>
          <c:h val="0.68896875000000013"/>
        </c:manualLayout>
      </c:layout>
      <c:scatterChart>
        <c:scatterStyle val="lineMarker"/>
        <c:varyColors val="0"/>
        <c:ser>
          <c:idx val="0"/>
          <c:order val="0"/>
          <c:tx>
            <c:strRef>
              <c:f>'RWC-WC'!$P$20</c:f>
              <c:strCache>
                <c:ptCount val="1"/>
                <c:pt idx="0">
                  <c:v>Col-0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WC-WC'!$R$22:$R$33</c:f>
                <c:numCache>
                  <c:formatCode>General</c:formatCode>
                  <c:ptCount val="12"/>
                  <c:pt idx="0">
                    <c:v>1.3119242872124612</c:v>
                  </c:pt>
                  <c:pt idx="1">
                    <c:v>0.9136933527590182</c:v>
                  </c:pt>
                  <c:pt idx="2">
                    <c:v>0.55959605611247032</c:v>
                  </c:pt>
                  <c:pt idx="3">
                    <c:v>0.68846102014048616</c:v>
                  </c:pt>
                  <c:pt idx="4">
                    <c:v>0.53522288545933272</c:v>
                  </c:pt>
                  <c:pt idx="5">
                    <c:v>0.71627189953464931</c:v>
                  </c:pt>
                  <c:pt idx="6">
                    <c:v>1.0752434010557457</c:v>
                  </c:pt>
                  <c:pt idx="7">
                    <c:v>0.9707749759817812</c:v>
                  </c:pt>
                  <c:pt idx="8">
                    <c:v>1.5951611226428333</c:v>
                  </c:pt>
                  <c:pt idx="9">
                    <c:v>3.221831888581538</c:v>
                  </c:pt>
                  <c:pt idx="10">
                    <c:v>5.7173874438850545</c:v>
                  </c:pt>
                  <c:pt idx="11">
                    <c:v>7.9108683302298894</c:v>
                  </c:pt>
                </c:numCache>
              </c:numRef>
            </c:plus>
            <c:minus>
              <c:numRef>
                <c:f>'RWC-WC'!$R$22:$R$33</c:f>
                <c:numCache>
                  <c:formatCode>General</c:formatCode>
                  <c:ptCount val="12"/>
                  <c:pt idx="0">
                    <c:v>1.3119242872124612</c:v>
                  </c:pt>
                  <c:pt idx="1">
                    <c:v>0.9136933527590182</c:v>
                  </c:pt>
                  <c:pt idx="2">
                    <c:v>0.55959605611247032</c:v>
                  </c:pt>
                  <c:pt idx="3">
                    <c:v>0.68846102014048616</c:v>
                  </c:pt>
                  <c:pt idx="4">
                    <c:v>0.53522288545933272</c:v>
                  </c:pt>
                  <c:pt idx="5">
                    <c:v>0.71627189953464931</c:v>
                  </c:pt>
                  <c:pt idx="6">
                    <c:v>1.0752434010557457</c:v>
                  </c:pt>
                  <c:pt idx="7">
                    <c:v>0.9707749759817812</c:v>
                  </c:pt>
                  <c:pt idx="8">
                    <c:v>1.5951611226428333</c:v>
                  </c:pt>
                  <c:pt idx="9">
                    <c:v>3.221831888581538</c:v>
                  </c:pt>
                  <c:pt idx="10">
                    <c:v>5.7173874438850545</c:v>
                  </c:pt>
                  <c:pt idx="11">
                    <c:v>7.9108683302298894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RWC-WC'!$O$22:$O$33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'RWC-WC'!$P$22:$P$33</c:f>
              <c:numCache>
                <c:formatCode>0.00</c:formatCode>
                <c:ptCount val="12"/>
                <c:pt idx="0">
                  <c:v>92.740655279579698</c:v>
                </c:pt>
                <c:pt idx="1">
                  <c:v>92.82384979243011</c:v>
                </c:pt>
                <c:pt idx="2">
                  <c:v>92.854770643126599</c:v>
                </c:pt>
                <c:pt idx="3">
                  <c:v>92.601630933485794</c:v>
                </c:pt>
                <c:pt idx="4">
                  <c:v>92.37947740801927</c:v>
                </c:pt>
                <c:pt idx="5">
                  <c:v>91.795132163461986</c:v>
                </c:pt>
                <c:pt idx="6">
                  <c:v>90.976481252864446</c:v>
                </c:pt>
                <c:pt idx="7">
                  <c:v>90.245927148417252</c:v>
                </c:pt>
                <c:pt idx="8">
                  <c:v>89.274089143682986</c:v>
                </c:pt>
                <c:pt idx="9">
                  <c:v>86.387083288024726</c:v>
                </c:pt>
                <c:pt idx="10">
                  <c:v>82.168357506578573</c:v>
                </c:pt>
                <c:pt idx="11">
                  <c:v>75.87606322489018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1B8-DB40-A0F3-D3CEB2715607}"/>
            </c:ext>
          </c:extLst>
        </c:ser>
        <c:ser>
          <c:idx val="1"/>
          <c:order val="1"/>
          <c:tx>
            <c:strRef>
              <c:f>'RWC-WC'!$Q$20</c:f>
              <c:strCache>
                <c:ptCount val="1"/>
                <c:pt idx="0">
                  <c:v>esl3</c:v>
                </c:pt>
              </c:strCache>
            </c:strRef>
          </c:tx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rgbClr val="FFC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RWC-WC'!$S$22:$S$33</c:f>
                <c:numCache>
                  <c:formatCode>General</c:formatCode>
                  <c:ptCount val="12"/>
                  <c:pt idx="0">
                    <c:v>0.47297033271143402</c:v>
                  </c:pt>
                  <c:pt idx="1">
                    <c:v>0.90293579941072621</c:v>
                  </c:pt>
                  <c:pt idx="2">
                    <c:v>0.48380925379195844</c:v>
                  </c:pt>
                  <c:pt idx="3">
                    <c:v>0.55460676002039178</c:v>
                  </c:pt>
                  <c:pt idx="4">
                    <c:v>0.53595540551199294</c:v>
                  </c:pt>
                  <c:pt idx="5">
                    <c:v>0.4674950917115025</c:v>
                  </c:pt>
                  <c:pt idx="6">
                    <c:v>0.79386006961698097</c:v>
                  </c:pt>
                  <c:pt idx="7">
                    <c:v>0.81591987498824781</c:v>
                  </c:pt>
                  <c:pt idx="8">
                    <c:v>1.462925326908707</c:v>
                  </c:pt>
                  <c:pt idx="9">
                    <c:v>1.4820816267697987</c:v>
                  </c:pt>
                  <c:pt idx="10">
                    <c:v>3.2381329402396015</c:v>
                  </c:pt>
                  <c:pt idx="11">
                    <c:v>7.7785960461283015</c:v>
                  </c:pt>
                </c:numCache>
              </c:numRef>
            </c:plus>
            <c:minus>
              <c:numRef>
                <c:f>'RWC-WC'!$S$22:$S$33</c:f>
                <c:numCache>
                  <c:formatCode>General</c:formatCode>
                  <c:ptCount val="12"/>
                  <c:pt idx="0">
                    <c:v>0.47297033271143402</c:v>
                  </c:pt>
                  <c:pt idx="1">
                    <c:v>0.90293579941072621</c:v>
                  </c:pt>
                  <c:pt idx="2">
                    <c:v>0.48380925379195844</c:v>
                  </c:pt>
                  <c:pt idx="3">
                    <c:v>0.55460676002039178</c:v>
                  </c:pt>
                  <c:pt idx="4">
                    <c:v>0.53595540551199294</c:v>
                  </c:pt>
                  <c:pt idx="5">
                    <c:v>0.4674950917115025</c:v>
                  </c:pt>
                  <c:pt idx="6">
                    <c:v>0.79386006961698097</c:v>
                  </c:pt>
                  <c:pt idx="7">
                    <c:v>0.81591987498824781</c:v>
                  </c:pt>
                  <c:pt idx="8">
                    <c:v>1.462925326908707</c:v>
                  </c:pt>
                  <c:pt idx="9">
                    <c:v>1.4820816267697987</c:v>
                  </c:pt>
                  <c:pt idx="10">
                    <c:v>3.2381329402396015</c:v>
                  </c:pt>
                  <c:pt idx="11">
                    <c:v>7.7785960461283015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RWC-WC'!$O$22:$O$33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'RWC-WC'!$Q$22:$Q$33</c:f>
              <c:numCache>
                <c:formatCode>0.00</c:formatCode>
                <c:ptCount val="12"/>
                <c:pt idx="0">
                  <c:v>93.4293613220552</c:v>
                </c:pt>
                <c:pt idx="1">
                  <c:v>92.821846575517455</c:v>
                </c:pt>
                <c:pt idx="2">
                  <c:v>92.953737026445637</c:v>
                </c:pt>
                <c:pt idx="3">
                  <c:v>92.020570106561166</c:v>
                </c:pt>
                <c:pt idx="4">
                  <c:v>92.276229840728391</c:v>
                </c:pt>
                <c:pt idx="5">
                  <c:v>92.106401816600993</c:v>
                </c:pt>
                <c:pt idx="6">
                  <c:v>91.374093461217413</c:v>
                </c:pt>
                <c:pt idx="7">
                  <c:v>90.817760735922803</c:v>
                </c:pt>
                <c:pt idx="8">
                  <c:v>90.056616820629429</c:v>
                </c:pt>
                <c:pt idx="9">
                  <c:v>88.033604456202525</c:v>
                </c:pt>
                <c:pt idx="10">
                  <c:v>85.448936398522818</c:v>
                </c:pt>
                <c:pt idx="11">
                  <c:v>79.0361949018669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1B8-DB40-A0F3-D3CEB27156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9782480"/>
        <c:axId val="79782896"/>
      </c:scatterChart>
      <c:valAx>
        <c:axId val="79782480"/>
        <c:scaling>
          <c:orientation val="minMax"/>
          <c:max val="16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79782896"/>
        <c:crosses val="autoZero"/>
        <c:crossBetween val="midCat"/>
        <c:majorUnit val="1"/>
      </c:valAx>
      <c:valAx>
        <c:axId val="79782896"/>
        <c:scaling>
          <c:orientation val="minMax"/>
          <c:max val="100"/>
        </c:scaling>
        <c:delete val="0"/>
        <c:axPos val="l"/>
        <c:majorGridlines>
          <c:spPr>
            <a:ln w="6350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+mn-cs"/>
                  </a:defRPr>
                </a:pPr>
                <a:r>
                  <a:rPr lang="en-US" sz="1200" b="0" dirty="0">
                    <a:solidFill>
                      <a:schemeClr val="tx1"/>
                    </a:solidFill>
                  </a:rPr>
                  <a:t>WC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+mn-cs"/>
                </a:defRPr>
              </a:pPr>
              <a:endParaRPr lang="fr-FR"/>
            </a:p>
          </c:txPr>
        </c:title>
        <c:numFmt formatCode="#,##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79782480"/>
        <c:crosses val="autoZero"/>
        <c:crossBetween val="midCat"/>
        <c:majorUnit val="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>
          <a:latin typeface="Times New Roman" panose="02020603050405020304" pitchFamily="18" charset="0"/>
        </a:defRPr>
      </a:pPr>
      <a:endParaRPr lang="fr-FR"/>
    </a:p>
  </c:txPr>
  <c:externalData r:id="rId3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809574035379295"/>
          <c:y val="0.10424267371899335"/>
          <c:w val="0.77416383035816139"/>
          <c:h val="0.79151465256201325"/>
        </c:manualLayout>
      </c:layout>
      <c:scatterChart>
        <c:scatterStyle val="lineMarker"/>
        <c:varyColors val="0"/>
        <c:ser>
          <c:idx val="0"/>
          <c:order val="0"/>
          <c:tx>
            <c:strRef>
              <c:f>'MF-MT-MS'!$P$4</c:f>
              <c:strCache>
                <c:ptCount val="1"/>
                <c:pt idx="0">
                  <c:v>Col-0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F-MT-MS'!$R$6:$R$17</c:f>
                <c:numCache>
                  <c:formatCode>General</c:formatCode>
                  <c:ptCount val="12"/>
                  <c:pt idx="0">
                    <c:v>9.5244745739834435E-2</c:v>
                  </c:pt>
                  <c:pt idx="1">
                    <c:v>0.11361139690051704</c:v>
                  </c:pt>
                  <c:pt idx="2">
                    <c:v>0.17555569149130923</c:v>
                  </c:pt>
                  <c:pt idx="3">
                    <c:v>0.19995754379687708</c:v>
                  </c:pt>
                  <c:pt idx="4">
                    <c:v>0.17604664707407666</c:v>
                  </c:pt>
                  <c:pt idx="5">
                    <c:v>0.2805373178343824</c:v>
                  </c:pt>
                  <c:pt idx="6">
                    <c:v>0.27211091788568942</c:v>
                  </c:pt>
                  <c:pt idx="7">
                    <c:v>0.3106819141205211</c:v>
                  </c:pt>
                  <c:pt idx="8">
                    <c:v>0.4337132308150447</c:v>
                  </c:pt>
                  <c:pt idx="9">
                    <c:v>0.47856141157149373</c:v>
                  </c:pt>
                  <c:pt idx="10">
                    <c:v>0.76750436973789293</c:v>
                  </c:pt>
                  <c:pt idx="11">
                    <c:v>1.0900658729194252</c:v>
                  </c:pt>
                </c:numCache>
              </c:numRef>
            </c:plus>
            <c:minus>
              <c:numRef>
                <c:f>'MF-MT-MS'!$R$6:$R$17</c:f>
                <c:numCache>
                  <c:formatCode>General</c:formatCode>
                  <c:ptCount val="12"/>
                  <c:pt idx="0">
                    <c:v>9.5244745739834435E-2</c:v>
                  </c:pt>
                  <c:pt idx="1">
                    <c:v>0.11361139690051704</c:v>
                  </c:pt>
                  <c:pt idx="2">
                    <c:v>0.17555569149130923</c:v>
                  </c:pt>
                  <c:pt idx="3">
                    <c:v>0.19995754379687708</c:v>
                  </c:pt>
                  <c:pt idx="4">
                    <c:v>0.17604664707407666</c:v>
                  </c:pt>
                  <c:pt idx="5">
                    <c:v>0.2805373178343824</c:v>
                  </c:pt>
                  <c:pt idx="6">
                    <c:v>0.27211091788568942</c:v>
                  </c:pt>
                  <c:pt idx="7">
                    <c:v>0.3106819141205211</c:v>
                  </c:pt>
                  <c:pt idx="8">
                    <c:v>0.4337132308150447</c:v>
                  </c:pt>
                  <c:pt idx="9">
                    <c:v>0.47856141157149373</c:v>
                  </c:pt>
                  <c:pt idx="10">
                    <c:v>0.76750436973789293</c:v>
                  </c:pt>
                  <c:pt idx="11">
                    <c:v>1.090065872919425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MF-MT-MS'!$O$6:$O$17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'MF-MT-MS'!$P$6:$P$17</c:f>
              <c:numCache>
                <c:formatCode>0.00</c:formatCode>
                <c:ptCount val="12"/>
                <c:pt idx="0">
                  <c:v>0.20115054580820521</c:v>
                </c:pt>
                <c:pt idx="1">
                  <c:v>0.29884830508442478</c:v>
                </c:pt>
                <c:pt idx="2">
                  <c:v>0.52377917473045355</c:v>
                </c:pt>
                <c:pt idx="3">
                  <c:v>0.64382033920074488</c:v>
                </c:pt>
                <c:pt idx="4">
                  <c:v>0.71272275856963319</c:v>
                </c:pt>
                <c:pt idx="5">
                  <c:v>1.0063080612444497</c:v>
                </c:pt>
                <c:pt idx="6">
                  <c:v>1.1381909322590653</c:v>
                </c:pt>
                <c:pt idx="7">
                  <c:v>1.1874544390402082</c:v>
                </c:pt>
                <c:pt idx="8">
                  <c:v>1.5279007254154748</c:v>
                </c:pt>
                <c:pt idx="9">
                  <c:v>1.6193721460094512</c:v>
                </c:pt>
                <c:pt idx="10">
                  <c:v>1.6769470427123336</c:v>
                </c:pt>
                <c:pt idx="11">
                  <c:v>2.331483514183878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AF3-E74E-B59D-BED3D34FB40D}"/>
            </c:ext>
          </c:extLst>
        </c:ser>
        <c:ser>
          <c:idx val="1"/>
          <c:order val="1"/>
          <c:tx>
            <c:strRef>
              <c:f>'MF-MT-MS'!$Q$4</c:f>
              <c:strCache>
                <c:ptCount val="1"/>
                <c:pt idx="0">
                  <c:v>esl3</c:v>
                </c:pt>
              </c:strCache>
            </c:strRef>
          </c:tx>
          <c:spPr>
            <a:ln w="19050" cap="rnd">
              <a:solidFill>
                <a:srgbClr val="FFC000"/>
              </a:solidFill>
              <a:round/>
            </a:ln>
            <a:effectLst/>
          </c:spPr>
          <c:marker>
            <c:symbol val="x"/>
            <c:size val="7"/>
            <c:spPr>
              <a:noFill/>
              <a:ln w="9525">
                <a:solidFill>
                  <a:srgbClr val="FFC000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MF-MT-MS'!$S$6:$S$17</c:f>
                <c:numCache>
                  <c:formatCode>General</c:formatCode>
                  <c:ptCount val="12"/>
                  <c:pt idx="0">
                    <c:v>0.11454613053258429</c:v>
                  </c:pt>
                  <c:pt idx="1">
                    <c:v>0.10614365038255781</c:v>
                  </c:pt>
                  <c:pt idx="2">
                    <c:v>0.18276856486533447</c:v>
                  </c:pt>
                  <c:pt idx="3">
                    <c:v>0.2819501974518106</c:v>
                  </c:pt>
                  <c:pt idx="4">
                    <c:v>0.27945380969433103</c:v>
                  </c:pt>
                  <c:pt idx="5">
                    <c:v>0.30742185828133151</c:v>
                  </c:pt>
                  <c:pt idx="6">
                    <c:v>0.48503643501825588</c:v>
                  </c:pt>
                  <c:pt idx="7">
                    <c:v>0.6491468738841879</c:v>
                  </c:pt>
                  <c:pt idx="8">
                    <c:v>0.53068929955346666</c:v>
                  </c:pt>
                  <c:pt idx="9">
                    <c:v>0.69870256552737386</c:v>
                  </c:pt>
                  <c:pt idx="10">
                    <c:v>0.74125828237386471</c:v>
                  </c:pt>
                  <c:pt idx="11">
                    <c:v>0.71196558517681507</c:v>
                  </c:pt>
                </c:numCache>
              </c:numRef>
            </c:plus>
            <c:minus>
              <c:numRef>
                <c:f>'MF-MT-MS'!$S$6:$S$17</c:f>
                <c:numCache>
                  <c:formatCode>General</c:formatCode>
                  <c:ptCount val="12"/>
                  <c:pt idx="0">
                    <c:v>0.11454613053258429</c:v>
                  </c:pt>
                  <c:pt idx="1">
                    <c:v>0.10614365038255781</c:v>
                  </c:pt>
                  <c:pt idx="2">
                    <c:v>0.18276856486533447</c:v>
                  </c:pt>
                  <c:pt idx="3">
                    <c:v>0.2819501974518106</c:v>
                  </c:pt>
                  <c:pt idx="4">
                    <c:v>0.27945380969433103</c:v>
                  </c:pt>
                  <c:pt idx="5">
                    <c:v>0.30742185828133151</c:v>
                  </c:pt>
                  <c:pt idx="6">
                    <c:v>0.48503643501825588</c:v>
                  </c:pt>
                  <c:pt idx="7">
                    <c:v>0.6491468738841879</c:v>
                  </c:pt>
                  <c:pt idx="8">
                    <c:v>0.53068929955346666</c:v>
                  </c:pt>
                  <c:pt idx="9">
                    <c:v>0.69870256552737386</c:v>
                  </c:pt>
                  <c:pt idx="10">
                    <c:v>0.74125828237386471</c:v>
                  </c:pt>
                  <c:pt idx="11">
                    <c:v>0.71196558517681507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'MF-MT-MS'!$O$6:$O$17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'MF-MT-MS'!$Q$6:$Q$17</c:f>
              <c:numCache>
                <c:formatCode>0.00</c:formatCode>
                <c:ptCount val="12"/>
                <c:pt idx="0">
                  <c:v>0.23812808380010203</c:v>
                </c:pt>
                <c:pt idx="1">
                  <c:v>0.39236998109475818</c:v>
                </c:pt>
                <c:pt idx="2">
                  <c:v>0.706342737800146</c:v>
                </c:pt>
                <c:pt idx="3">
                  <c:v>0.88300665892615038</c:v>
                </c:pt>
                <c:pt idx="4">
                  <c:v>1.035322124994581</c:v>
                </c:pt>
                <c:pt idx="5">
                  <c:v>1.1826584244549507</c:v>
                </c:pt>
                <c:pt idx="6">
                  <c:v>1.390000634872177</c:v>
                </c:pt>
                <c:pt idx="7">
                  <c:v>1.5701827764742609</c:v>
                </c:pt>
                <c:pt idx="8">
                  <c:v>1.967495469646932</c:v>
                </c:pt>
                <c:pt idx="9">
                  <c:v>2.3190776961434616</c:v>
                </c:pt>
                <c:pt idx="10">
                  <c:v>2.7393547478249318</c:v>
                </c:pt>
                <c:pt idx="11">
                  <c:v>2.650386516551141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AF3-E74E-B59D-BED3D34FB4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59970736"/>
        <c:axId val="459984880"/>
      </c:scatterChart>
      <c:valAx>
        <c:axId val="459970736"/>
        <c:scaling>
          <c:orientation val="minMax"/>
          <c:max val="51"/>
          <c:min val="35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459984880"/>
        <c:crosses val="autoZero"/>
        <c:crossBetween val="midCat"/>
        <c:majorUnit val="1"/>
      </c:valAx>
      <c:valAx>
        <c:axId val="459984880"/>
        <c:scaling>
          <c:orientation val="minMax"/>
        </c:scaling>
        <c:delete val="0"/>
        <c:axPos val="l"/>
        <c:majorGridlines>
          <c:spPr>
            <a:ln w="6350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+mn-cs"/>
                  </a:defRPr>
                </a:pPr>
                <a:r>
                  <a:rPr lang="fr-FR" sz="1200" b="0">
                    <a:solidFill>
                      <a:schemeClr val="tx1"/>
                    </a:solidFill>
                  </a:rPr>
                  <a:t>TW (g)</a:t>
                </a:r>
              </a:p>
            </c:rich>
          </c:tx>
          <c:layout>
            <c:manualLayout>
              <c:xMode val="edge"/>
              <c:yMode val="edge"/>
              <c:x val="7.53385712425555E-3"/>
              <c:y val="0.3136034532341647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+mn-cs"/>
                </a:defRPr>
              </a:pPr>
              <a:endParaRPr lang="fr-FR"/>
            </a:p>
          </c:txPr>
        </c:title>
        <c:numFmt formatCode="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fr-FR"/>
          </a:p>
        </c:txPr>
        <c:crossAx val="459970736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>
          <a:latin typeface="Times New Roman" panose="02020603050405020304" pitchFamily="18" charset="0"/>
        </a:defRPr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078133995992112"/>
          <c:y val="0.12693268061275911"/>
          <c:w val="0.73494213715423795"/>
          <c:h val="0.77939597533020843"/>
        </c:manualLayout>
      </c:layout>
      <c:scatterChart>
        <c:scatterStyle val="lineMarker"/>
        <c:varyColors val="0"/>
        <c:ser>
          <c:idx val="0"/>
          <c:order val="0"/>
          <c:tx>
            <c:v>Col0</c:v>
          </c:tx>
          <c:spPr>
            <a:ln w="63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Col0!$E$29,Col0!$E$369,Col0!$E$397,Col0!$E$425,Col0!$E$453,Col0!$E$481,Col0!$E$509,Col0!$E$537,Col0!$E$565,Col0!$E$581,Col0!$E$597,Col0!$E$620)</c:f>
                <c:numCache>
                  <c:formatCode>General</c:formatCode>
                  <c:ptCount val="12"/>
                  <c:pt idx="0">
                    <c:v>6.5679597469910894E-2</c:v>
                  </c:pt>
                  <c:pt idx="1">
                    <c:v>0.14426110586941501</c:v>
                  </c:pt>
                  <c:pt idx="2">
                    <c:v>0.25872198721149797</c:v>
                  </c:pt>
                  <c:pt idx="3">
                    <c:v>0.162186782386706</c:v>
                  </c:pt>
                  <c:pt idx="4">
                    <c:v>0.281456382478876</c:v>
                  </c:pt>
                  <c:pt idx="5">
                    <c:v>0.191478905962436</c:v>
                  </c:pt>
                  <c:pt idx="6">
                    <c:v>0.232248942793227</c:v>
                  </c:pt>
                  <c:pt idx="7">
                    <c:v>0.154404601461164</c:v>
                  </c:pt>
                  <c:pt idx="8">
                    <c:v>0.18602181131715201</c:v>
                  </c:pt>
                  <c:pt idx="11">
                    <c:v>0.136107232975997</c:v>
                  </c:pt>
                </c:numCache>
              </c:numRef>
            </c:plus>
            <c:minus>
              <c:numRef>
                <c:f>(Col0!$E$29,Col0!$E$369,Col0!$E$397,Col0!$E$425,Col0!$E$453,Col0!$E$481,Col0!$E$509,Col0!$E$537,Col0!$E$565,Col0!$E$581,Col0!$E$597,Col0!$E$620)</c:f>
                <c:numCache>
                  <c:formatCode>General</c:formatCode>
                  <c:ptCount val="12"/>
                  <c:pt idx="0">
                    <c:v>6.5679597469910894E-2</c:v>
                  </c:pt>
                  <c:pt idx="1">
                    <c:v>0.14426110586941501</c:v>
                  </c:pt>
                  <c:pt idx="2">
                    <c:v>0.25872198721149797</c:v>
                  </c:pt>
                  <c:pt idx="3">
                    <c:v>0.162186782386706</c:v>
                  </c:pt>
                  <c:pt idx="4">
                    <c:v>0.281456382478876</c:v>
                  </c:pt>
                  <c:pt idx="5">
                    <c:v>0.191478905962436</c:v>
                  </c:pt>
                  <c:pt idx="6">
                    <c:v>0.232248942793227</c:v>
                  </c:pt>
                  <c:pt idx="7">
                    <c:v>0.154404601461164</c:v>
                  </c:pt>
                  <c:pt idx="8">
                    <c:v>0.18602181131715201</c:v>
                  </c:pt>
                  <c:pt idx="11">
                    <c:v>0.136107232975997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(Col0!$C$2,Col0!$C$30,Col0!$C$58,Col0!$C$86)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</c:numCache>
            </c:numRef>
          </c:xVal>
          <c:yVal>
            <c:numRef>
              <c:f>(Col0!$E$28,Col0!$E$368,Col0!$E$396,Col0!$E$424)</c:f>
              <c:numCache>
                <c:formatCode>0.000</c:formatCode>
                <c:ptCount val="4"/>
                <c:pt idx="0">
                  <c:v>0.230333333333333</c:v>
                </c:pt>
                <c:pt idx="1">
                  <c:v>0.381533333333333</c:v>
                </c:pt>
                <c:pt idx="2">
                  <c:v>0.61326666666666696</c:v>
                </c:pt>
                <c:pt idx="3">
                  <c:v>0.859533333333333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E17-2A47-AB98-0E01BA3E541A}"/>
            </c:ext>
          </c:extLst>
        </c:ser>
        <c:ser>
          <c:idx val="1"/>
          <c:order val="1"/>
          <c:tx>
            <c:v>at1g08920</c:v>
          </c:tx>
          <c:spPr>
            <a:ln w="6350" cap="rnd">
              <a:solidFill>
                <a:schemeClr val="accent2"/>
              </a:solidFill>
              <a:round/>
            </a:ln>
            <a:effectLst/>
          </c:spPr>
          <c:marker>
            <c:symbol val="x"/>
            <c:size val="4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8920'!$E$29,'08920'!$E$383,'08920'!$E$411,'08920'!$E$439,'08920'!$E$467,'08920'!$E$495,'08920'!$E$523,'08920'!$E$551,'08920'!$E$579,'08920'!$E$602,'08920'!$E$625,'08920'!$E$648)</c:f>
                <c:numCache>
                  <c:formatCode>General</c:formatCode>
                  <c:ptCount val="12"/>
                  <c:pt idx="0">
                    <c:v>3.8201470926554397E-2</c:v>
                  </c:pt>
                  <c:pt idx="1">
                    <c:v>0.180637442725161</c:v>
                  </c:pt>
                  <c:pt idx="2">
                    <c:v>0.16452723034139199</c:v>
                  </c:pt>
                  <c:pt idx="3">
                    <c:v>0.20632410934071199</c:v>
                  </c:pt>
                  <c:pt idx="4">
                    <c:v>0.25154081369109998</c:v>
                  </c:pt>
                  <c:pt idx="5">
                    <c:v>0.167352436777115</c:v>
                  </c:pt>
                  <c:pt idx="6">
                    <c:v>0.18277495921018699</c:v>
                  </c:pt>
                  <c:pt idx="7">
                    <c:v>0.20622140205775599</c:v>
                  </c:pt>
                  <c:pt idx="8">
                    <c:v>0.20443890692983699</c:v>
                  </c:pt>
                  <c:pt idx="9">
                    <c:v>0.22328696035968301</c:v>
                  </c:pt>
                  <c:pt idx="10">
                    <c:v>0.165003665182957</c:v>
                  </c:pt>
                  <c:pt idx="11">
                    <c:v>0.136927989380595</c:v>
                  </c:pt>
                </c:numCache>
              </c:numRef>
            </c:plus>
            <c:minus>
              <c:numRef>
                <c:f>('08920'!$E$29,'08920'!$E$383,'08920'!$E$411,'08920'!$E$439,'08920'!$E$467,'08920'!$E$495,'08920'!$E$523,'08920'!$E$551,'08920'!$E$579,'08920'!$E$602,'08920'!$E$625,'08920'!$E$648)</c:f>
                <c:numCache>
                  <c:formatCode>General</c:formatCode>
                  <c:ptCount val="12"/>
                  <c:pt idx="0">
                    <c:v>3.8201470926554397E-2</c:v>
                  </c:pt>
                  <c:pt idx="1">
                    <c:v>0.180637442725161</c:v>
                  </c:pt>
                  <c:pt idx="2">
                    <c:v>0.16452723034139199</c:v>
                  </c:pt>
                  <c:pt idx="3">
                    <c:v>0.20632410934071199</c:v>
                  </c:pt>
                  <c:pt idx="4">
                    <c:v>0.25154081369109998</c:v>
                  </c:pt>
                  <c:pt idx="5">
                    <c:v>0.167352436777115</c:v>
                  </c:pt>
                  <c:pt idx="6">
                    <c:v>0.18277495921018699</c:v>
                  </c:pt>
                  <c:pt idx="7">
                    <c:v>0.20622140205775599</c:v>
                  </c:pt>
                  <c:pt idx="8">
                    <c:v>0.20443890692983699</c:v>
                  </c:pt>
                  <c:pt idx="9">
                    <c:v>0.22328696035968301</c:v>
                  </c:pt>
                  <c:pt idx="10">
                    <c:v>0.165003665182957</c:v>
                  </c:pt>
                  <c:pt idx="11">
                    <c:v>0.136927989380595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Col0!$C$2,Col0!$C$30,Col0!$C$58,Col0!$C$86)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</c:numCache>
            </c:numRef>
          </c:xVal>
          <c:yVal>
            <c:numRef>
              <c:f>('08920'!$E$28,'08920'!$E$382,'08920'!$E$410,'08920'!$E$438,'08920'!$E$466)</c:f>
              <c:numCache>
                <c:formatCode>0.000</c:formatCode>
                <c:ptCount val="5"/>
                <c:pt idx="0">
                  <c:v>0.227066666666667</c:v>
                </c:pt>
                <c:pt idx="1">
                  <c:v>0.41620000000000001</c:v>
                </c:pt>
                <c:pt idx="2">
                  <c:v>0.77006666666666601</c:v>
                </c:pt>
                <c:pt idx="3">
                  <c:v>0.84206666666666596</c:v>
                </c:pt>
                <c:pt idx="4">
                  <c:v>0.88306666666666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1E17-2A47-AB98-0E01BA3E541A}"/>
            </c:ext>
          </c:extLst>
        </c:ser>
        <c:ser>
          <c:idx val="2"/>
          <c:order val="2"/>
          <c:tx>
            <c:v>at1g75220</c:v>
          </c:tx>
          <c:spPr>
            <a:ln w="6350" cap="rnd">
              <a:solidFill>
                <a:schemeClr val="accent3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75220'!$E$29,'75220'!$E$383,'75220'!$E$411,'75220'!$E$439,'75220'!$E$467,'75220'!$E$495,'75220'!$E$523,'75220'!$E$551,'75220'!$E$579,'75220'!$E$602,'75220'!$E$625,'75220'!$E$648)</c:f>
                <c:numCache>
                  <c:formatCode>General</c:formatCode>
                  <c:ptCount val="12"/>
                  <c:pt idx="0">
                    <c:v>8.9996719516933096E-2</c:v>
                  </c:pt>
                  <c:pt idx="1">
                    <c:v>9.8760798083527501E-2</c:v>
                  </c:pt>
                  <c:pt idx="2">
                    <c:v>0.20134677501644699</c:v>
                  </c:pt>
                  <c:pt idx="3">
                    <c:v>0.22612480750998701</c:v>
                  </c:pt>
                  <c:pt idx="4">
                    <c:v>0.26180772661303398</c:v>
                  </c:pt>
                  <c:pt idx="5">
                    <c:v>0.17068118427836901</c:v>
                  </c:pt>
                  <c:pt idx="6">
                    <c:v>0.16151903912542401</c:v>
                  </c:pt>
                  <c:pt idx="7">
                    <c:v>0.11144484008222399</c:v>
                  </c:pt>
                  <c:pt idx="8">
                    <c:v>0.19241208258269399</c:v>
                  </c:pt>
                  <c:pt idx="9">
                    <c:v>0.180894523331771</c:v>
                  </c:pt>
                  <c:pt idx="10">
                    <c:v>0.16923139976572499</c:v>
                  </c:pt>
                  <c:pt idx="11">
                    <c:v>0.15082282497347599</c:v>
                  </c:pt>
                </c:numCache>
              </c:numRef>
            </c:plus>
            <c:minus>
              <c:numRef>
                <c:f>('75220'!$E$29,'75220'!$E$383,'75220'!$E$411,'75220'!$E$439,'75220'!$E$467,'75220'!$E$495,'75220'!$E$523,'75220'!$E$551,'75220'!$E$579,'75220'!$E$602,'75220'!$E$625,'75220'!$E$648)</c:f>
                <c:numCache>
                  <c:formatCode>General</c:formatCode>
                  <c:ptCount val="12"/>
                  <c:pt idx="0">
                    <c:v>8.9996719516933096E-2</c:v>
                  </c:pt>
                  <c:pt idx="1">
                    <c:v>9.8760798083527501E-2</c:v>
                  </c:pt>
                  <c:pt idx="2">
                    <c:v>0.20134677501644699</c:v>
                  </c:pt>
                  <c:pt idx="3">
                    <c:v>0.22612480750998701</c:v>
                  </c:pt>
                  <c:pt idx="4">
                    <c:v>0.26180772661303398</c:v>
                  </c:pt>
                  <c:pt idx="5">
                    <c:v>0.17068118427836901</c:v>
                  </c:pt>
                  <c:pt idx="6">
                    <c:v>0.16151903912542401</c:v>
                  </c:pt>
                  <c:pt idx="7">
                    <c:v>0.11144484008222399</c:v>
                  </c:pt>
                  <c:pt idx="8">
                    <c:v>0.19241208258269399</c:v>
                  </c:pt>
                  <c:pt idx="9">
                    <c:v>0.180894523331771</c:v>
                  </c:pt>
                  <c:pt idx="10">
                    <c:v>0.16923139976572499</c:v>
                  </c:pt>
                  <c:pt idx="11">
                    <c:v>0.15082282497347599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'75220'!$C$2,'75220'!$C$30,'75220'!$C$58,'75220'!$C$86)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</c:numCache>
            </c:numRef>
          </c:xVal>
          <c:yVal>
            <c:numRef>
              <c:f>('75220'!$E$28,'75220'!$E$382,'75220'!$E$410,'75220'!$E$438)</c:f>
              <c:numCache>
                <c:formatCode>0.000</c:formatCode>
                <c:ptCount val="4"/>
                <c:pt idx="0">
                  <c:v>0.205866666666667</c:v>
                </c:pt>
                <c:pt idx="1">
                  <c:v>0.37786666666666702</c:v>
                </c:pt>
                <c:pt idx="2">
                  <c:v>0.62233333333333296</c:v>
                </c:pt>
                <c:pt idx="3">
                  <c:v>0.7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1E17-2A47-AB98-0E01BA3E541A}"/>
            </c:ext>
          </c:extLst>
        </c:ser>
        <c:ser>
          <c:idx val="3"/>
          <c:order val="3"/>
          <c:tx>
            <c:v>at3g04760</c:v>
          </c:tx>
          <c:spPr>
            <a:ln w="6350" cap="rnd">
              <a:solidFill>
                <a:schemeClr val="accent4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4760'!$E$29,'04760'!$E$383,'04760'!$E$411,'04760'!$E$439,'04760'!$E$467,'04760'!$E$495,'04760'!$E$523,'04760'!$E$551,'04760'!$E$579,'04760'!$E$602,'04760'!$E$625,'04760'!$E$648)</c:f>
                <c:numCache>
                  <c:formatCode>General</c:formatCode>
                  <c:ptCount val="12"/>
                  <c:pt idx="0">
                    <c:v>5.58741783789597E-2</c:v>
                  </c:pt>
                  <c:pt idx="1">
                    <c:v>0.119936292612846</c:v>
                  </c:pt>
                  <c:pt idx="2">
                    <c:v>0.18855975432838501</c:v>
                  </c:pt>
                  <c:pt idx="3">
                    <c:v>0.17698837734237199</c:v>
                  </c:pt>
                  <c:pt idx="4">
                    <c:v>0.19275380300120801</c:v>
                  </c:pt>
                  <c:pt idx="5">
                    <c:v>0.14851070187507801</c:v>
                  </c:pt>
                  <c:pt idx="6">
                    <c:v>0.13063825006847199</c:v>
                  </c:pt>
                  <c:pt idx="7">
                    <c:v>0.126776894394763</c:v>
                  </c:pt>
                  <c:pt idx="8">
                    <c:v>0.19194599935051199</c:v>
                  </c:pt>
                  <c:pt idx="9">
                    <c:v>0.14315486120182699</c:v>
                  </c:pt>
                  <c:pt idx="10">
                    <c:v>6.1482464220242797E-2</c:v>
                  </c:pt>
                  <c:pt idx="11">
                    <c:v>9.1423918957757894E-2</c:v>
                  </c:pt>
                </c:numCache>
              </c:numRef>
            </c:plus>
            <c:minus>
              <c:numRef>
                <c:f>('04760'!$E$29,'04760'!$E$383,'04760'!$E$411,'04760'!$E$439,'04760'!$E$467,'04760'!$E$495,'04760'!$E$523,'04760'!$E$551,'04760'!$E$579,'04760'!$E$602,'04760'!$E$625,'04760'!$E$648)</c:f>
                <c:numCache>
                  <c:formatCode>General</c:formatCode>
                  <c:ptCount val="12"/>
                  <c:pt idx="0">
                    <c:v>5.58741783789597E-2</c:v>
                  </c:pt>
                  <c:pt idx="1">
                    <c:v>0.119936292612846</c:v>
                  </c:pt>
                  <c:pt idx="2">
                    <c:v>0.18855975432838501</c:v>
                  </c:pt>
                  <c:pt idx="3">
                    <c:v>0.17698837734237199</c:v>
                  </c:pt>
                  <c:pt idx="4">
                    <c:v>0.19275380300120801</c:v>
                  </c:pt>
                  <c:pt idx="5">
                    <c:v>0.14851070187507801</c:v>
                  </c:pt>
                  <c:pt idx="6">
                    <c:v>0.13063825006847199</c:v>
                  </c:pt>
                  <c:pt idx="7">
                    <c:v>0.126776894394763</c:v>
                  </c:pt>
                  <c:pt idx="8">
                    <c:v>0.19194599935051199</c:v>
                  </c:pt>
                  <c:pt idx="9">
                    <c:v>0.14315486120182699</c:v>
                  </c:pt>
                  <c:pt idx="10">
                    <c:v>6.1482464220242797E-2</c:v>
                  </c:pt>
                  <c:pt idx="11">
                    <c:v>9.1423918957757894E-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('04760'!$C$2,'04760'!$C$30,'04760'!$C$58,'04760'!$C$86)</c:f>
              <c:numCache>
                <c:formatCode>General</c:formatCode>
                <c:ptCount val="4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</c:numCache>
            </c:numRef>
          </c:xVal>
          <c:yVal>
            <c:numRef>
              <c:f>('04760'!$E$28,'04760'!$E$382,'04760'!$E$410,'04760'!$E$438)</c:f>
              <c:numCache>
                <c:formatCode>0.000</c:formatCode>
                <c:ptCount val="4"/>
                <c:pt idx="0">
                  <c:v>0.16873333333333301</c:v>
                </c:pt>
                <c:pt idx="1">
                  <c:v>0.40500000000000003</c:v>
                </c:pt>
                <c:pt idx="2">
                  <c:v>0.68293333333333395</c:v>
                </c:pt>
                <c:pt idx="3">
                  <c:v>0.812200000000000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1E17-2A47-AB98-0E01BA3E541A}"/>
            </c:ext>
          </c:extLst>
        </c:ser>
        <c:ser>
          <c:idx val="4"/>
          <c:order val="4"/>
          <c:tx>
            <c:v>Col0 J7 J10</c:v>
          </c:tx>
          <c:spPr>
            <a:ln w="63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accent2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Col0!$E$403,Col0!$E$453,Col0!$E$481,Col0!$E$509)</c:f>
                <c:numCache>
                  <c:formatCode>General</c:formatCode>
                  <c:ptCount val="4"/>
                  <c:pt idx="1">
                    <c:v>0.281456382478876</c:v>
                  </c:pt>
                  <c:pt idx="2">
                    <c:v>0.191478905962436</c:v>
                  </c:pt>
                  <c:pt idx="3">
                    <c:v>0.232248942793227</c:v>
                  </c:pt>
                </c:numCache>
              </c:numRef>
            </c:plus>
            <c:minus>
              <c:numRef>
                <c:f>(Col0!$E$403,Col0!$E$453,Col0!$E$481,Col0!$E$509)</c:f>
                <c:numCache>
                  <c:formatCode>General</c:formatCode>
                  <c:ptCount val="4"/>
                  <c:pt idx="1">
                    <c:v>0.281456382478876</c:v>
                  </c:pt>
                  <c:pt idx="2">
                    <c:v>0.191478905962436</c:v>
                  </c:pt>
                  <c:pt idx="3">
                    <c:v>0.232248942793227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(Col0!$C$86,Col0!$C$114,Col0!$C$142,Col0!$C$170)</c:f>
              <c:numCache>
                <c:formatCode>General</c:formatCode>
                <c:ptCount val="4"/>
                <c:pt idx="0">
                  <c:v>7</c:v>
                </c:pt>
                <c:pt idx="1">
                  <c:v>8</c:v>
                </c:pt>
                <c:pt idx="2">
                  <c:v>9</c:v>
                </c:pt>
                <c:pt idx="3">
                  <c:v>10</c:v>
                </c:pt>
              </c:numCache>
            </c:numRef>
          </c:xVal>
          <c:yVal>
            <c:numRef>
              <c:f>(Col0!$E$424,Col0!$E$452,Col0!$E$480,Col0!$E$508)</c:f>
              <c:numCache>
                <c:formatCode>0.000</c:formatCode>
                <c:ptCount val="4"/>
                <c:pt idx="0">
                  <c:v>0.85953333333333304</c:v>
                </c:pt>
                <c:pt idx="1">
                  <c:v>0.88253333333333295</c:v>
                </c:pt>
                <c:pt idx="2">
                  <c:v>0.92779999999999996</c:v>
                </c:pt>
                <c:pt idx="3">
                  <c:v>0.933000000000000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1E17-2A47-AB98-0E01BA3E541A}"/>
            </c:ext>
          </c:extLst>
        </c:ser>
        <c:ser>
          <c:idx val="5"/>
          <c:order val="5"/>
          <c:tx>
            <c:v>08 J7 J10</c:v>
          </c:tx>
          <c:spPr>
            <a:ln w="6350" cap="rnd">
              <a:solidFill>
                <a:schemeClr val="accent2"/>
              </a:solidFill>
              <a:round/>
            </a:ln>
            <a:effectLst/>
          </c:spPr>
          <c:marker>
            <c:symbol val="square"/>
            <c:size val="4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08920'!$D$413,'08920'!$E$467,'08920'!$E$495,'08920'!$E$523)</c:f>
                <c:numCache>
                  <c:formatCode>General</c:formatCode>
                  <c:ptCount val="4"/>
                  <c:pt idx="1">
                    <c:v>0.25154081369109998</c:v>
                  </c:pt>
                  <c:pt idx="2">
                    <c:v>0.167352436777115</c:v>
                  </c:pt>
                  <c:pt idx="3">
                    <c:v>0.18277495921018699</c:v>
                  </c:pt>
                </c:numCache>
              </c:numRef>
            </c:plus>
            <c:minus>
              <c:numRef>
                <c:f>('08920'!$D$413,'08920'!$E$467,'08920'!$E$495,'08920'!$E$523)</c:f>
                <c:numCache>
                  <c:formatCode>General</c:formatCode>
                  <c:ptCount val="4"/>
                  <c:pt idx="1">
                    <c:v>0.25154081369109998</c:v>
                  </c:pt>
                  <c:pt idx="2">
                    <c:v>0.167352436777115</c:v>
                  </c:pt>
                  <c:pt idx="3">
                    <c:v>0.18277495921018699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('08920'!$C$86,'08920'!$C$114,'08920'!$C$142,'08920'!$C$170)</c:f>
              <c:numCache>
                <c:formatCode>General</c:formatCode>
                <c:ptCount val="4"/>
                <c:pt idx="0">
                  <c:v>7</c:v>
                </c:pt>
                <c:pt idx="1">
                  <c:v>8</c:v>
                </c:pt>
                <c:pt idx="2">
                  <c:v>9</c:v>
                </c:pt>
                <c:pt idx="3">
                  <c:v>10</c:v>
                </c:pt>
              </c:numCache>
            </c:numRef>
          </c:xVal>
          <c:yVal>
            <c:numRef>
              <c:f>('08920'!$E$438,'08920'!$E$466,'08920'!$E$494,'08920'!$E$522)</c:f>
              <c:numCache>
                <c:formatCode>0.000</c:formatCode>
                <c:ptCount val="4"/>
                <c:pt idx="0">
                  <c:v>0.84206666666666596</c:v>
                </c:pt>
                <c:pt idx="1">
                  <c:v>0.883066666666667</c:v>
                </c:pt>
                <c:pt idx="2">
                  <c:v>0.94586666666666597</c:v>
                </c:pt>
                <c:pt idx="3">
                  <c:v>0.926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1E17-2A47-AB98-0E01BA3E541A}"/>
            </c:ext>
          </c:extLst>
        </c:ser>
        <c:ser>
          <c:idx val="6"/>
          <c:order val="6"/>
          <c:tx>
            <c:v>75 J7 J10</c:v>
          </c:tx>
          <c:spPr>
            <a:ln w="6350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bg1">
                    <a:lumMod val="65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75220'!$E$417,'75220'!$E$467,'75220'!$E$495,'75220'!$E$523)</c:f>
                <c:numCache>
                  <c:formatCode>General</c:formatCode>
                  <c:ptCount val="4"/>
                  <c:pt idx="1">
                    <c:v>0.26180772661303398</c:v>
                  </c:pt>
                  <c:pt idx="2">
                    <c:v>0.17068118427836901</c:v>
                  </c:pt>
                  <c:pt idx="3">
                    <c:v>0.16151903912542401</c:v>
                  </c:pt>
                </c:numCache>
              </c:numRef>
            </c:plus>
            <c:minus>
              <c:numRef>
                <c:f>('75220'!$E$417,'75220'!$E$467,'75220'!$E$495,'75220'!$E$523)</c:f>
                <c:numCache>
                  <c:formatCode>General</c:formatCode>
                  <c:ptCount val="4"/>
                  <c:pt idx="1">
                    <c:v>0.26180772661303398</c:v>
                  </c:pt>
                  <c:pt idx="2">
                    <c:v>0.17068118427836901</c:v>
                  </c:pt>
                  <c:pt idx="3">
                    <c:v>0.16151903912542401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('75220'!$C$412,'75220'!$C$440,'75220'!$C$468,'75220'!$C$496)</c:f>
              <c:numCache>
                <c:formatCode>General</c:formatCode>
                <c:ptCount val="4"/>
                <c:pt idx="0">
                  <c:v>7</c:v>
                </c:pt>
                <c:pt idx="1">
                  <c:v>8</c:v>
                </c:pt>
                <c:pt idx="2">
                  <c:v>9</c:v>
                </c:pt>
                <c:pt idx="3">
                  <c:v>10</c:v>
                </c:pt>
              </c:numCache>
            </c:numRef>
          </c:xVal>
          <c:yVal>
            <c:numRef>
              <c:f>('75220'!$E$438,'75220'!$E$466,'75220'!$E$494,'75220'!$E$522)</c:f>
              <c:numCache>
                <c:formatCode>0.000</c:formatCode>
                <c:ptCount val="4"/>
                <c:pt idx="0">
                  <c:v>0.78</c:v>
                </c:pt>
                <c:pt idx="1">
                  <c:v>0.82199999999999995</c:v>
                </c:pt>
                <c:pt idx="2">
                  <c:v>0.79026666666666701</c:v>
                </c:pt>
                <c:pt idx="3">
                  <c:v>0.947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1E17-2A47-AB98-0E01BA3E541A}"/>
            </c:ext>
          </c:extLst>
        </c:ser>
        <c:ser>
          <c:idx val="7"/>
          <c:order val="7"/>
          <c:tx>
            <c:v>47 J7 J10</c:v>
          </c:tx>
          <c:spPr>
            <a:ln w="6350" cap="rnd">
              <a:solidFill>
                <a:schemeClr val="accent4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04760'!$E$445,'04760'!$E$467,'04760'!$E$495,'04760'!$E$523)</c:f>
                <c:numCache>
                  <c:formatCode>General</c:formatCode>
                  <c:ptCount val="4"/>
                  <c:pt idx="1">
                    <c:v>0.19275380300120801</c:v>
                  </c:pt>
                  <c:pt idx="2">
                    <c:v>0.14851070187507801</c:v>
                  </c:pt>
                  <c:pt idx="3">
                    <c:v>0.13063825006847199</c:v>
                  </c:pt>
                </c:numCache>
              </c:numRef>
            </c:plus>
            <c:minus>
              <c:numRef>
                <c:f>('04760'!$E$445,'04760'!$E$467,'04760'!$E$495,'04760'!$E$523)</c:f>
                <c:numCache>
                  <c:formatCode>General</c:formatCode>
                  <c:ptCount val="4"/>
                  <c:pt idx="1">
                    <c:v>0.19275380300120801</c:v>
                  </c:pt>
                  <c:pt idx="2">
                    <c:v>0.14851070187507801</c:v>
                  </c:pt>
                  <c:pt idx="3">
                    <c:v>0.13063825006847199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'04760'!$C$412,'04760'!$C$440,'04760'!$C$468,'04760'!$C$496)</c:f>
              <c:numCache>
                <c:formatCode>General</c:formatCode>
                <c:ptCount val="4"/>
                <c:pt idx="0">
                  <c:v>7</c:v>
                </c:pt>
                <c:pt idx="1">
                  <c:v>8</c:v>
                </c:pt>
                <c:pt idx="2">
                  <c:v>9</c:v>
                </c:pt>
                <c:pt idx="3">
                  <c:v>10</c:v>
                </c:pt>
              </c:numCache>
            </c:numRef>
          </c:xVal>
          <c:yVal>
            <c:numRef>
              <c:f>('04760'!$E$438,'04760'!$E$466,'04760'!$E$494,'04760'!$E$522)</c:f>
              <c:numCache>
                <c:formatCode>0.000</c:formatCode>
                <c:ptCount val="4"/>
                <c:pt idx="0">
                  <c:v>0.81220000000000003</c:v>
                </c:pt>
                <c:pt idx="1">
                  <c:v>0.8972</c:v>
                </c:pt>
                <c:pt idx="2">
                  <c:v>0.93400000000000005</c:v>
                </c:pt>
                <c:pt idx="3">
                  <c:v>0.921266666666667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1E17-2A47-AB98-0E01BA3E541A}"/>
            </c:ext>
          </c:extLst>
        </c:ser>
        <c:ser>
          <c:idx val="8"/>
          <c:order val="8"/>
          <c:tx>
            <c:v>Col0 J10 J15</c:v>
          </c:tx>
          <c:spPr>
            <a:ln w="63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bg1">
                  <a:lumMod val="50000"/>
                </a:schemeClr>
              </a:solidFill>
              <a:ln w="9525">
                <a:solidFill>
                  <a:schemeClr val="bg1">
                    <a:lumMod val="50000"/>
                  </a:schemeClr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Col0!$E$515,Col0!$E$537,Col0!$E$565,Col0!$E$581,Col0!$E$597,Col0!$E$620)</c:f>
                <c:numCache>
                  <c:formatCode>General</c:formatCode>
                  <c:ptCount val="6"/>
                  <c:pt idx="1">
                    <c:v>0.154404601461164</c:v>
                  </c:pt>
                  <c:pt idx="2">
                    <c:v>0.18602181131715201</c:v>
                  </c:pt>
                  <c:pt idx="5">
                    <c:v>0.136107232975997</c:v>
                  </c:pt>
                </c:numCache>
              </c:numRef>
            </c:plus>
            <c:minus>
              <c:numRef>
                <c:f>(Col0!$E$515,Col0!$E$537,Col0!$E$565,Col0!$E$581,Col0!$E$597,Col0!$E$620)</c:f>
                <c:numCache>
                  <c:formatCode>General</c:formatCode>
                  <c:ptCount val="6"/>
                  <c:pt idx="1">
                    <c:v>0.154404601461164</c:v>
                  </c:pt>
                  <c:pt idx="2">
                    <c:v>0.18602181131715201</c:v>
                  </c:pt>
                  <c:pt idx="5">
                    <c:v>0.136107232975997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Col0!$C$482,Col0!$C$510,Col0!$C$538,Col0!$C$566,Col0!$C$582,Col0!$C$598)</c:f>
              <c:numCache>
                <c:formatCode>General</c:formatCode>
                <c:ptCount val="6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  <c:pt idx="4">
                  <c:v>14</c:v>
                </c:pt>
                <c:pt idx="5">
                  <c:v>15</c:v>
                </c:pt>
              </c:numCache>
            </c:numRef>
          </c:xVal>
          <c:yVal>
            <c:numRef>
              <c:f>(Col0!$E$508,Col0!$E$536,Col0!$E$564,Col0!$E$580,Col0!$E$596,Col0!$E$619)</c:f>
              <c:numCache>
                <c:formatCode>0.000</c:formatCode>
                <c:ptCount val="6"/>
                <c:pt idx="0">
                  <c:v>0.93300000000000005</c:v>
                </c:pt>
                <c:pt idx="1">
                  <c:v>0.81793333333333296</c:v>
                </c:pt>
                <c:pt idx="2">
                  <c:v>0.74939999999999996</c:v>
                </c:pt>
                <c:pt idx="3">
                  <c:v>0.5121</c:v>
                </c:pt>
                <c:pt idx="4">
                  <c:v>0.33779999999999999</c:v>
                </c:pt>
                <c:pt idx="5">
                  <c:v>0.263212441997364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1E17-2A47-AB98-0E01BA3E541A}"/>
            </c:ext>
          </c:extLst>
        </c:ser>
        <c:ser>
          <c:idx val="9"/>
          <c:order val="9"/>
          <c:tx>
            <c:v>08 J10 J15</c:v>
          </c:tx>
          <c:spPr>
            <a:ln w="6350" cap="rnd">
              <a:solidFill>
                <a:schemeClr val="accent2"/>
              </a:solidFill>
              <a:round/>
            </a:ln>
            <a:effectLst/>
          </c:spPr>
          <c:marker>
            <c:symbol val="square"/>
            <c:size val="4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8920'!$E$529,'08920'!$E$551,'08920'!$E$579,'08920'!$E$602,'08920'!$E$625,'08920'!$E$648)</c:f>
                <c:numCache>
                  <c:formatCode>General</c:formatCode>
                  <c:ptCount val="6"/>
                  <c:pt idx="1">
                    <c:v>0.20622140205775599</c:v>
                  </c:pt>
                  <c:pt idx="2">
                    <c:v>0.20443890692983699</c:v>
                  </c:pt>
                  <c:pt idx="3">
                    <c:v>0.22328696035968301</c:v>
                  </c:pt>
                  <c:pt idx="4">
                    <c:v>0.165003665182957</c:v>
                  </c:pt>
                  <c:pt idx="5">
                    <c:v>0.136927989380595</c:v>
                  </c:pt>
                </c:numCache>
              </c:numRef>
            </c:plus>
            <c:minus>
              <c:numRef>
                <c:f>('08920'!$E$529,'08920'!$E$551,'08920'!$E$579,'08920'!$E$602,'08920'!$E$625,'08920'!$E$648)</c:f>
                <c:numCache>
                  <c:formatCode>General</c:formatCode>
                  <c:ptCount val="6"/>
                  <c:pt idx="1">
                    <c:v>0.20622140205775599</c:v>
                  </c:pt>
                  <c:pt idx="2">
                    <c:v>0.20443890692983699</c:v>
                  </c:pt>
                  <c:pt idx="3">
                    <c:v>0.22328696035968301</c:v>
                  </c:pt>
                  <c:pt idx="4">
                    <c:v>0.165003665182957</c:v>
                  </c:pt>
                  <c:pt idx="5">
                    <c:v>0.136927989380595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('08920'!$C$496,'08920'!$C$524,'08920'!$C$552,'08920'!$C$580,'08920'!$C$603,'08920'!$C$626)</c:f>
              <c:numCache>
                <c:formatCode>General</c:formatCode>
                <c:ptCount val="6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  <c:pt idx="4">
                  <c:v>14</c:v>
                </c:pt>
                <c:pt idx="5">
                  <c:v>15</c:v>
                </c:pt>
              </c:numCache>
            </c:numRef>
          </c:xVal>
          <c:yVal>
            <c:numRef>
              <c:f>('08920'!$E$522,'08920'!$E$550,'08920'!$E$578,'08920'!$E$601,'08920'!$E$624,'08920'!$E$647)</c:f>
              <c:numCache>
                <c:formatCode>0.000</c:formatCode>
                <c:ptCount val="6"/>
                <c:pt idx="0">
                  <c:v>0.9264</c:v>
                </c:pt>
                <c:pt idx="1">
                  <c:v>0.74453333333333305</c:v>
                </c:pt>
                <c:pt idx="2">
                  <c:v>0.65113333333333301</c:v>
                </c:pt>
                <c:pt idx="3">
                  <c:v>0.441066666666667</c:v>
                </c:pt>
                <c:pt idx="4">
                  <c:v>0.26693333333333302</c:v>
                </c:pt>
                <c:pt idx="5">
                  <c:v>0.263348909823136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1E17-2A47-AB98-0E01BA3E541A}"/>
            </c:ext>
          </c:extLst>
        </c:ser>
        <c:ser>
          <c:idx val="10"/>
          <c:order val="10"/>
          <c:tx>
            <c:v>75 J10 J15</c:v>
          </c:tx>
          <c:spPr>
            <a:ln w="6350" cap="rnd">
              <a:solidFill>
                <a:schemeClr val="bg1">
                  <a:lumMod val="65000"/>
                </a:schemeClr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bg1">
                  <a:lumMod val="65000"/>
                </a:schemeClr>
              </a:solidFill>
              <a:ln w="9525">
                <a:solidFill>
                  <a:schemeClr val="bg1">
                    <a:lumMod val="65000"/>
                  </a:schemeClr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75220'!$E$531,'75220'!$E$551,'75220'!$E$579,'75220'!$E$602,'75220'!$E$625,'75220'!$E$648)</c:f>
                <c:numCache>
                  <c:formatCode>General</c:formatCode>
                  <c:ptCount val="6"/>
                  <c:pt idx="1">
                    <c:v>0.11144484008222399</c:v>
                  </c:pt>
                  <c:pt idx="2">
                    <c:v>0.19241208258269399</c:v>
                  </c:pt>
                  <c:pt idx="3">
                    <c:v>0.180894523331771</c:v>
                  </c:pt>
                  <c:pt idx="4">
                    <c:v>0.16923139976572499</c:v>
                  </c:pt>
                  <c:pt idx="5">
                    <c:v>0.15082282497347599</c:v>
                  </c:pt>
                </c:numCache>
              </c:numRef>
            </c:plus>
            <c:minus>
              <c:numRef>
                <c:f>('75220'!$E$531,'75220'!$E$551,'75220'!$E$579,'75220'!$E$602,'75220'!$E$625,'75220'!$E$648)</c:f>
                <c:numCache>
                  <c:formatCode>General</c:formatCode>
                  <c:ptCount val="6"/>
                  <c:pt idx="1">
                    <c:v>0.11144484008222399</c:v>
                  </c:pt>
                  <c:pt idx="2">
                    <c:v>0.19241208258269399</c:v>
                  </c:pt>
                  <c:pt idx="3">
                    <c:v>0.180894523331771</c:v>
                  </c:pt>
                  <c:pt idx="4">
                    <c:v>0.16923139976572499</c:v>
                  </c:pt>
                  <c:pt idx="5">
                    <c:v>0.150822824973475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('75220'!$C$496,'75220'!$C$524,'75220'!$C$552,'75220'!$C$580,'75220'!$C$603,'75220'!$C$626)</c:f>
              <c:numCache>
                <c:formatCode>General</c:formatCode>
                <c:ptCount val="6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  <c:pt idx="4">
                  <c:v>14</c:v>
                </c:pt>
                <c:pt idx="5">
                  <c:v>15</c:v>
                </c:pt>
              </c:numCache>
            </c:numRef>
          </c:xVal>
          <c:yVal>
            <c:numRef>
              <c:f>('75220'!$E$522,'75220'!$E$550,'75220'!$E$578,'75220'!$E$601,'75220'!$E$624,'75220'!$E$647)</c:f>
              <c:numCache>
                <c:formatCode>0.000</c:formatCode>
                <c:ptCount val="6"/>
                <c:pt idx="0">
                  <c:v>0.9476</c:v>
                </c:pt>
                <c:pt idx="1">
                  <c:v>0.76566666666666705</c:v>
                </c:pt>
                <c:pt idx="2">
                  <c:v>0.59653333333333303</c:v>
                </c:pt>
                <c:pt idx="3">
                  <c:v>0.41660000000000003</c:v>
                </c:pt>
                <c:pt idx="4">
                  <c:v>0.30886666666666701</c:v>
                </c:pt>
                <c:pt idx="5">
                  <c:v>0.308451234417068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1E17-2A47-AB98-0E01BA3E541A}"/>
            </c:ext>
          </c:extLst>
        </c:ser>
        <c:ser>
          <c:idx val="11"/>
          <c:order val="11"/>
          <c:tx>
            <c:v>47 J10 J15</c:v>
          </c:tx>
          <c:spPr>
            <a:ln w="6350" cap="rnd">
              <a:solidFill>
                <a:schemeClr val="accent4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4760'!$E$529,'04760'!$E$551,'04760'!$E$579,'04760'!$E$602,'04760'!$E$625,'04760'!$E$648)</c:f>
                <c:numCache>
                  <c:formatCode>General</c:formatCode>
                  <c:ptCount val="6"/>
                  <c:pt idx="1">
                    <c:v>0.126776894394763</c:v>
                  </c:pt>
                  <c:pt idx="2">
                    <c:v>0.19194599935051199</c:v>
                  </c:pt>
                  <c:pt idx="3">
                    <c:v>0.14315486120182699</c:v>
                  </c:pt>
                  <c:pt idx="4">
                    <c:v>6.1482464220242797E-2</c:v>
                  </c:pt>
                  <c:pt idx="5">
                    <c:v>9.1423918957757894E-2</c:v>
                  </c:pt>
                </c:numCache>
              </c:numRef>
            </c:plus>
            <c:minus>
              <c:numRef>
                <c:f>('04760'!$E$529,'04760'!$E$551,'04760'!$E$579,'04760'!$E$602,'04760'!$E$625,'04760'!$E$648)</c:f>
                <c:numCache>
                  <c:formatCode>General</c:formatCode>
                  <c:ptCount val="6"/>
                  <c:pt idx="1">
                    <c:v>0.126776894394763</c:v>
                  </c:pt>
                  <c:pt idx="2">
                    <c:v>0.19194599935051199</c:v>
                  </c:pt>
                  <c:pt idx="3">
                    <c:v>0.14315486120182699</c:v>
                  </c:pt>
                  <c:pt idx="4">
                    <c:v>6.1482464220242797E-2</c:v>
                  </c:pt>
                  <c:pt idx="5">
                    <c:v>9.142391895775789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('04760'!$C$496,'04760'!$C$524,'04760'!$C$552,'04760'!$C$580,'04760'!$C$603,'04760'!$C$626)</c:f>
              <c:numCache>
                <c:formatCode>General</c:formatCode>
                <c:ptCount val="6"/>
                <c:pt idx="0">
                  <c:v>10</c:v>
                </c:pt>
                <c:pt idx="1">
                  <c:v>11</c:v>
                </c:pt>
                <c:pt idx="2">
                  <c:v>12</c:v>
                </c:pt>
                <c:pt idx="3">
                  <c:v>13</c:v>
                </c:pt>
                <c:pt idx="4">
                  <c:v>14</c:v>
                </c:pt>
                <c:pt idx="5">
                  <c:v>15</c:v>
                </c:pt>
              </c:numCache>
            </c:numRef>
          </c:xVal>
          <c:yVal>
            <c:numRef>
              <c:f>('04760'!$E$522,'04760'!$E$550,'04760'!$E$578,'04760'!$E$601,'04760'!$E$624,'04760'!$E$647)</c:f>
              <c:numCache>
                <c:formatCode>0.000</c:formatCode>
                <c:ptCount val="6"/>
                <c:pt idx="0">
                  <c:v>0.92126666666666701</c:v>
                </c:pt>
                <c:pt idx="1">
                  <c:v>0.76766666666666705</c:v>
                </c:pt>
                <c:pt idx="2">
                  <c:v>0.65486666666666704</c:v>
                </c:pt>
                <c:pt idx="3">
                  <c:v>0.44979999999999998</c:v>
                </c:pt>
                <c:pt idx="4">
                  <c:v>0.23864285714285699</c:v>
                </c:pt>
                <c:pt idx="5">
                  <c:v>0.210502765051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1E17-2A47-AB98-0E01BA3E54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10921832"/>
        <c:axId val="810928520"/>
      </c:scatterChart>
      <c:valAx>
        <c:axId val="810921832"/>
        <c:scaling>
          <c:orientation val="minMax"/>
          <c:max val="16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10928520"/>
        <c:crosses val="autoZero"/>
        <c:crossBetween val="midCat"/>
        <c:majorUnit val="1"/>
      </c:valAx>
      <c:valAx>
        <c:axId val="810928520"/>
        <c:scaling>
          <c:orientation val="minMax"/>
          <c:max val="4"/>
          <c:min val="0"/>
        </c:scaling>
        <c:delete val="0"/>
        <c:axPos val="l"/>
        <c:majorGridlines>
          <c:spPr>
            <a:ln w="6350">
              <a:solidFill>
                <a:schemeClr val="bg1">
                  <a:lumMod val="85000"/>
                </a:schemeClr>
              </a:solidFill>
            </a:ln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fr-FR" sz="1200" b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W </a:t>
                </a:r>
                <a:r>
                  <a:rPr lang="fr-FR" sz="1200" b="0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g)</a:t>
                </a:r>
                <a:endParaRPr lang="fr-FR" sz="1200" b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1288986041815541E-2"/>
              <c:y val="0.331793226003235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10921832"/>
        <c:crossesAt val="0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925681080466642"/>
          <c:y val="0.14076141585030871"/>
          <c:w val="0.69915446454508334"/>
          <c:h val="0.73032409879436844"/>
        </c:manualLayout>
      </c:layout>
      <c:scatterChart>
        <c:scatterStyle val="lineMarker"/>
        <c:varyColors val="0"/>
        <c:ser>
          <c:idx val="0"/>
          <c:order val="0"/>
          <c:tx>
            <c:v>Col0</c:v>
          </c:tx>
          <c:spPr>
            <a:ln w="63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bg1">
                  <a:lumMod val="50000"/>
                </a:schemeClr>
              </a:solidFill>
              <a:ln w="9525">
                <a:solidFill>
                  <a:schemeClr val="bg1">
                    <a:lumMod val="50000"/>
                  </a:schemeClr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Col0!$G$29,Col0!$G$369,Col0!$G$397,Col0!$G$425,Col0!$G$453,Col0!$G$481,Col0!$G$509,Col0!$G$537,Col0!$G$565,Col0!$G$581,Col0!$G$597,Col0!$G$620)</c:f>
                <c:numCache>
                  <c:formatCode>General</c:formatCode>
                  <c:ptCount val="12"/>
                  <c:pt idx="0">
                    <c:v>4.4264163272596602E-3</c:v>
                  </c:pt>
                  <c:pt idx="1">
                    <c:v>7.8875159083715302E-3</c:v>
                  </c:pt>
                  <c:pt idx="2">
                    <c:v>2.01711134103837E-2</c:v>
                  </c:pt>
                  <c:pt idx="3">
                    <c:v>1.0325196119530001E-2</c:v>
                  </c:pt>
                  <c:pt idx="4">
                    <c:v>2.4607229225969598E-2</c:v>
                  </c:pt>
                  <c:pt idx="5">
                    <c:v>2.0604850521062201E-2</c:v>
                  </c:pt>
                  <c:pt idx="6">
                    <c:v>2.8262994717865999E-2</c:v>
                  </c:pt>
                  <c:pt idx="7">
                    <c:v>2.0231055154258701E-2</c:v>
                  </c:pt>
                  <c:pt idx="8">
                    <c:v>2.0075456082510199E-2</c:v>
                  </c:pt>
                  <c:pt idx="11">
                    <c:v>2.2135185794002699E-2</c:v>
                  </c:pt>
                </c:numCache>
              </c:numRef>
            </c:plus>
            <c:minus>
              <c:numRef>
                <c:f>(Col0!$G$29,Col0!$G$369,Col0!$G$397,Col0!$G$425,Col0!$G$453,Col0!$G$481,Col0!$G$509,Col0!$G$537,Col0!$G$565,Col0!$G$581,Col0!$G$597,Col0!$G$620)</c:f>
                <c:numCache>
                  <c:formatCode>General</c:formatCode>
                  <c:ptCount val="12"/>
                  <c:pt idx="0">
                    <c:v>4.4264163272596602E-3</c:v>
                  </c:pt>
                  <c:pt idx="1">
                    <c:v>7.8875159083715302E-3</c:v>
                  </c:pt>
                  <c:pt idx="2">
                    <c:v>2.01711134103837E-2</c:v>
                  </c:pt>
                  <c:pt idx="3">
                    <c:v>1.0325196119530001E-2</c:v>
                  </c:pt>
                  <c:pt idx="4">
                    <c:v>2.4607229225969598E-2</c:v>
                  </c:pt>
                  <c:pt idx="5">
                    <c:v>2.0604850521062201E-2</c:v>
                  </c:pt>
                  <c:pt idx="6">
                    <c:v>2.8262994717865999E-2</c:v>
                  </c:pt>
                  <c:pt idx="7">
                    <c:v>2.0231055154258701E-2</c:v>
                  </c:pt>
                  <c:pt idx="8">
                    <c:v>2.0075456082510199E-2</c:v>
                  </c:pt>
                  <c:pt idx="11">
                    <c:v>2.2135185794002699E-2</c:v>
                  </c:pt>
                </c:numCache>
              </c:numRef>
            </c:minus>
            <c:spPr>
              <a:ln w="6350"/>
            </c:spPr>
          </c:errBars>
          <c:xVal>
            <c:numRef>
              <c:f>(Col0!$C$2,Col0!$C$30,Col0!$C$58,Col0!$C$86,Col0!$C$114,Col0!$C$142,Col0!$C$170,Col0!$C$198,Col0!$C$226)</c:f>
              <c:numCache>
                <c:formatCode>General</c:formatCode>
                <c:ptCount val="9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</c:numCache>
            </c:numRef>
          </c:xVal>
          <c:yVal>
            <c:numRef>
              <c:f>(Col0!$G$28,Col0!$G$368,Col0!$G$396,Col0!$G$424,Col0!$G$452,Col0!$G$480,Col0!$G$508,Col0!$G$536,Col0!$G$564)</c:f>
              <c:numCache>
                <c:formatCode>0.000</c:formatCode>
                <c:ptCount val="9"/>
                <c:pt idx="0">
                  <c:v>1.53172581246333E-2</c:v>
                </c:pt>
                <c:pt idx="1">
                  <c:v>2.8208851649500499E-2</c:v>
                </c:pt>
                <c:pt idx="2">
                  <c:v>4.3184951477317698E-2</c:v>
                </c:pt>
                <c:pt idx="3">
                  <c:v>6.11555165139539E-2</c:v>
                </c:pt>
                <c:pt idx="4">
                  <c:v>6.6725323321820407E-2</c:v>
                </c:pt>
                <c:pt idx="5">
                  <c:v>7.3690639979004102E-2</c:v>
                </c:pt>
                <c:pt idx="6">
                  <c:v>8.5385576125393298E-2</c:v>
                </c:pt>
                <c:pt idx="7">
                  <c:v>9.3282856846961901E-2</c:v>
                </c:pt>
                <c:pt idx="8">
                  <c:v>9.8823485755891699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E7D-C349-B00F-F3CC6D47FEA9}"/>
            </c:ext>
          </c:extLst>
        </c:ser>
        <c:ser>
          <c:idx val="1"/>
          <c:order val="1"/>
          <c:tx>
            <c:v>at1g08920</c:v>
          </c:tx>
          <c:spPr>
            <a:ln w="6350" cap="rnd">
              <a:solidFill>
                <a:schemeClr val="accent2"/>
              </a:solidFill>
              <a:round/>
            </a:ln>
            <a:effectLst/>
          </c:spPr>
          <c:marker>
            <c:symbol val="x"/>
            <c:size val="4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8920'!$G$29,'08920'!$G$383,'08920'!$G$411,'08920'!$G$439,'08920'!$G$467,'08920'!$G$495,'08920'!$G$523,'08920'!$G$551,'08920'!$G$579,'08920'!$G$602,'08920'!$G$625,'08920'!$G$648)</c:f>
                <c:numCache>
                  <c:formatCode>General</c:formatCode>
                  <c:ptCount val="12"/>
                  <c:pt idx="0">
                    <c:v>3.9686518723274101E-3</c:v>
                  </c:pt>
                  <c:pt idx="1">
                    <c:v>1.6651951578917301E-2</c:v>
                  </c:pt>
                  <c:pt idx="2">
                    <c:v>1.20591735378203E-2</c:v>
                  </c:pt>
                  <c:pt idx="3">
                    <c:v>1.4727284361474E-2</c:v>
                  </c:pt>
                  <c:pt idx="4">
                    <c:v>2.21839002802625E-2</c:v>
                  </c:pt>
                  <c:pt idx="5">
                    <c:v>2.2769704986429801E-2</c:v>
                  </c:pt>
                  <c:pt idx="6">
                    <c:v>2.3351588482659499E-2</c:v>
                  </c:pt>
                  <c:pt idx="7">
                    <c:v>2.7172806835667199E-2</c:v>
                  </c:pt>
                  <c:pt idx="8">
                    <c:v>1.9654945799783E-2</c:v>
                  </c:pt>
                  <c:pt idx="9">
                    <c:v>1.8295035506391999E-2</c:v>
                  </c:pt>
                  <c:pt idx="10">
                    <c:v>1.8349513052893899E-2</c:v>
                  </c:pt>
                  <c:pt idx="11">
                    <c:v>3.1607726061887498E-2</c:v>
                  </c:pt>
                </c:numCache>
              </c:numRef>
            </c:plus>
            <c:minus>
              <c:numRef>
                <c:f>('08920'!$G$29,'08920'!$G$383,'08920'!$G$411,'08920'!$G$439,'08920'!$G$467,'08920'!$G$495,'08920'!$G$523,'08920'!$G$551,'08920'!$G$579,'08920'!$G$602,'08920'!$G$625,'08920'!$G$648)</c:f>
                <c:numCache>
                  <c:formatCode>General</c:formatCode>
                  <c:ptCount val="12"/>
                  <c:pt idx="0">
                    <c:v>3.9686518723274101E-3</c:v>
                  </c:pt>
                  <c:pt idx="1">
                    <c:v>1.6651951578917301E-2</c:v>
                  </c:pt>
                  <c:pt idx="2">
                    <c:v>1.20591735378203E-2</c:v>
                  </c:pt>
                  <c:pt idx="3">
                    <c:v>1.4727284361474E-2</c:v>
                  </c:pt>
                  <c:pt idx="4">
                    <c:v>2.21839002802625E-2</c:v>
                  </c:pt>
                  <c:pt idx="5">
                    <c:v>2.2769704986429801E-2</c:v>
                  </c:pt>
                  <c:pt idx="6">
                    <c:v>2.3351588482659499E-2</c:v>
                  </c:pt>
                  <c:pt idx="7">
                    <c:v>2.7172806835667199E-2</c:v>
                  </c:pt>
                  <c:pt idx="8">
                    <c:v>1.9654945799783E-2</c:v>
                  </c:pt>
                  <c:pt idx="9">
                    <c:v>1.8295035506391999E-2</c:v>
                  </c:pt>
                  <c:pt idx="10">
                    <c:v>1.8349513052893899E-2</c:v>
                  </c:pt>
                  <c:pt idx="11">
                    <c:v>3.1607726061887498E-2</c:v>
                  </c:pt>
                </c:numCache>
              </c:numRef>
            </c:minus>
          </c:errBars>
          <c:xVal>
            <c:numRef>
              <c:f>(Col0!$C$2,Col0!$C$30,Col0!$C$58,Col0!$C$86,Col0!$C$114,Col0!$C$142,Col0!$C$170,Col0!$C$198,Col0!$C$226)</c:f>
              <c:numCache>
                <c:formatCode>General</c:formatCode>
                <c:ptCount val="9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</c:numCache>
            </c:numRef>
          </c:xVal>
          <c:yVal>
            <c:numRef>
              <c:f>('08920'!$G$28,'08920'!$G$382,'08920'!$G$410,'08920'!$G$438,'08920'!$G$466,'08920'!$G$494,'08920'!$G$522,'08920'!$G$550,'08920'!$G$578)</c:f>
              <c:numCache>
                <c:formatCode>0.000</c:formatCode>
                <c:ptCount val="9"/>
                <c:pt idx="0">
                  <c:v>1.2069622764293899E-2</c:v>
                </c:pt>
                <c:pt idx="1">
                  <c:v>2.49041581020297E-2</c:v>
                </c:pt>
                <c:pt idx="2">
                  <c:v>5.5484057579965197E-2</c:v>
                </c:pt>
                <c:pt idx="3">
                  <c:v>6.1998161837692099E-2</c:v>
                </c:pt>
                <c:pt idx="4">
                  <c:v>7.1930493687584404E-2</c:v>
                </c:pt>
                <c:pt idx="5">
                  <c:v>8.7194263816737297E-2</c:v>
                </c:pt>
                <c:pt idx="6">
                  <c:v>9.3157203451484094E-2</c:v>
                </c:pt>
                <c:pt idx="7">
                  <c:v>9.5123514126952094E-2</c:v>
                </c:pt>
                <c:pt idx="8">
                  <c:v>0.10737249615632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3E7D-C349-B00F-F3CC6D47FEA9}"/>
            </c:ext>
          </c:extLst>
        </c:ser>
        <c:ser>
          <c:idx val="2"/>
          <c:order val="2"/>
          <c:tx>
            <c:v>at1g75220</c:v>
          </c:tx>
          <c:spPr>
            <a:ln w="6350" cap="rnd">
              <a:solidFill>
                <a:schemeClr val="accent3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75220'!$G$29,'75220'!$G$383,'75220'!$G$411,'75220'!$G$439,'75220'!$G$467,'75220'!$G$495,'75220'!$G$523,'75220'!$G$551,'75220'!$G$579,'75220'!$G$602,'75220'!$G$625,'75220'!$G$648)</c:f>
                <c:numCache>
                  <c:formatCode>General</c:formatCode>
                  <c:ptCount val="12"/>
                  <c:pt idx="0">
                    <c:v>7.0867635286332303E-3</c:v>
                  </c:pt>
                  <c:pt idx="1">
                    <c:v>7.7633293625772098E-3</c:v>
                  </c:pt>
                  <c:pt idx="2">
                    <c:v>1.7160902618085502E-2</c:v>
                  </c:pt>
                  <c:pt idx="3">
                    <c:v>1.7398535085294198E-2</c:v>
                  </c:pt>
                  <c:pt idx="4">
                    <c:v>2.4811824415091201E-2</c:v>
                  </c:pt>
                  <c:pt idx="5">
                    <c:v>1.8833192650673399E-2</c:v>
                  </c:pt>
                  <c:pt idx="6">
                    <c:v>1.7621768167956402E-2</c:v>
                  </c:pt>
                  <c:pt idx="7">
                    <c:v>2.09793182165985E-2</c:v>
                  </c:pt>
                  <c:pt idx="8">
                    <c:v>1.9080618718544599E-2</c:v>
                  </c:pt>
                  <c:pt idx="9">
                    <c:v>1.56122143526579E-2</c:v>
                  </c:pt>
                  <c:pt idx="10">
                    <c:v>1.72097936102177E-2</c:v>
                  </c:pt>
                  <c:pt idx="11">
                    <c:v>2.8515780835146599E-2</c:v>
                  </c:pt>
                </c:numCache>
              </c:numRef>
            </c:plus>
            <c:minus>
              <c:numRef>
                <c:f>('75220'!$G$29,'75220'!$G$383,'75220'!$G$411,'75220'!$G$439,'75220'!$G$467,'75220'!$G$495,'75220'!$G$523,'75220'!$G$551,'75220'!$G$579,'75220'!$G$602,'75220'!$G$625,'75220'!$G$648)</c:f>
                <c:numCache>
                  <c:formatCode>General</c:formatCode>
                  <c:ptCount val="12"/>
                  <c:pt idx="0">
                    <c:v>7.0867635286332303E-3</c:v>
                  </c:pt>
                  <c:pt idx="1">
                    <c:v>7.7633293625772098E-3</c:v>
                  </c:pt>
                  <c:pt idx="2">
                    <c:v>1.7160902618085502E-2</c:v>
                  </c:pt>
                  <c:pt idx="3">
                    <c:v>1.7398535085294198E-2</c:v>
                  </c:pt>
                  <c:pt idx="4">
                    <c:v>2.4811824415091201E-2</c:v>
                  </c:pt>
                  <c:pt idx="5">
                    <c:v>1.8833192650673399E-2</c:v>
                  </c:pt>
                  <c:pt idx="6">
                    <c:v>1.7621768167956402E-2</c:v>
                  </c:pt>
                  <c:pt idx="7">
                    <c:v>2.09793182165985E-2</c:v>
                  </c:pt>
                  <c:pt idx="8">
                    <c:v>1.9080618718544599E-2</c:v>
                  </c:pt>
                  <c:pt idx="9">
                    <c:v>1.56122143526579E-2</c:v>
                  </c:pt>
                  <c:pt idx="10">
                    <c:v>1.72097936102177E-2</c:v>
                  </c:pt>
                  <c:pt idx="11">
                    <c:v>2.8515780835146599E-2</c:v>
                  </c:pt>
                </c:numCache>
              </c:numRef>
            </c:minus>
          </c:errBars>
          <c:xVal>
            <c:numRef>
              <c:f>('75220'!$C$2,'75220'!$C$30,'75220'!$C$58,'75220'!$C$86,'75220'!$C$114,'75220'!$C$142,'75220'!$C$170,'75220'!$C$198,'75220'!$C$226)</c:f>
              <c:numCache>
                <c:formatCode>General</c:formatCode>
                <c:ptCount val="9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</c:numCache>
            </c:numRef>
          </c:xVal>
          <c:yVal>
            <c:numRef>
              <c:f>('75220'!$G$28,'75220'!$G$382,'75220'!$G$410,'75220'!$G$438,'75220'!$G$466,'75220'!$G$494,'75220'!$G$522,'75220'!$G$550,'75220'!$G$578)</c:f>
              <c:numCache>
                <c:formatCode>0.000</c:formatCode>
                <c:ptCount val="9"/>
                <c:pt idx="0">
                  <c:v>1.3958631274406001E-2</c:v>
                </c:pt>
                <c:pt idx="1">
                  <c:v>2.1935923851070099E-2</c:v>
                </c:pt>
                <c:pt idx="2">
                  <c:v>4.5247633785613799E-2</c:v>
                </c:pt>
                <c:pt idx="3">
                  <c:v>5.8392479375364799E-2</c:v>
                </c:pt>
                <c:pt idx="4">
                  <c:v>6.3996355549131495E-2</c:v>
                </c:pt>
                <c:pt idx="5">
                  <c:v>6.7087243528339793E-2</c:v>
                </c:pt>
                <c:pt idx="6">
                  <c:v>8.9783559675469901E-2</c:v>
                </c:pt>
                <c:pt idx="7">
                  <c:v>8.6579537209730606E-2</c:v>
                </c:pt>
                <c:pt idx="8">
                  <c:v>0.10094943621544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3E7D-C349-B00F-F3CC6D47FEA9}"/>
            </c:ext>
          </c:extLst>
        </c:ser>
        <c:ser>
          <c:idx val="3"/>
          <c:order val="3"/>
          <c:tx>
            <c:v>at3g04760</c:v>
          </c:tx>
          <c:spPr>
            <a:ln w="6350" cap="rnd">
              <a:solidFill>
                <a:schemeClr val="accent4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4760'!$G$29,'04760'!$G$383,'04760'!$G$411,'04760'!$G$439,'04760'!$G$467,'04760'!$G$495,'04760'!$G$523,'04760'!$G$551,'04760'!$G$579,'04760'!$G$602,'04760'!$G$625,'04760'!$G$648)</c:f>
                <c:numCache>
                  <c:formatCode>General</c:formatCode>
                  <c:ptCount val="12"/>
                  <c:pt idx="0">
                    <c:v>3.94521541984933E-3</c:v>
                  </c:pt>
                  <c:pt idx="1">
                    <c:v>9.1263008609325999E-3</c:v>
                  </c:pt>
                  <c:pt idx="2">
                    <c:v>1.55337190550552E-2</c:v>
                  </c:pt>
                  <c:pt idx="3">
                    <c:v>1.39411618224512E-2</c:v>
                  </c:pt>
                  <c:pt idx="4">
                    <c:v>1.6053365156027101E-2</c:v>
                  </c:pt>
                  <c:pt idx="5">
                    <c:v>1.61118000502408E-2</c:v>
                  </c:pt>
                  <c:pt idx="6">
                    <c:v>1.8080182035986301E-2</c:v>
                  </c:pt>
                  <c:pt idx="7">
                    <c:v>2.1720290196530399E-2</c:v>
                  </c:pt>
                  <c:pt idx="8">
                    <c:v>2.0057582403833901E-2</c:v>
                  </c:pt>
                  <c:pt idx="9">
                    <c:v>1.3991155237119E-2</c:v>
                  </c:pt>
                  <c:pt idx="10">
                    <c:v>2.01057265719062E-2</c:v>
                  </c:pt>
                  <c:pt idx="11">
                    <c:v>2.40962909524048E-2</c:v>
                  </c:pt>
                </c:numCache>
              </c:numRef>
            </c:plus>
            <c:minus>
              <c:numRef>
                <c:f>('04760'!$G$29,'04760'!$G$383,'04760'!$G$411,'04760'!$G$439,'04760'!$G$467,'04760'!$G$495,'04760'!$G$523,'04760'!$G$551,'04760'!$G$579,'04760'!$G$602,'04760'!$G$625,'04760'!$G$648)</c:f>
                <c:numCache>
                  <c:formatCode>General</c:formatCode>
                  <c:ptCount val="12"/>
                  <c:pt idx="0">
                    <c:v>3.94521541984933E-3</c:v>
                  </c:pt>
                  <c:pt idx="1">
                    <c:v>9.1263008609325999E-3</c:v>
                  </c:pt>
                  <c:pt idx="2">
                    <c:v>1.55337190550552E-2</c:v>
                  </c:pt>
                  <c:pt idx="3">
                    <c:v>1.39411618224512E-2</c:v>
                  </c:pt>
                  <c:pt idx="4">
                    <c:v>1.6053365156027101E-2</c:v>
                  </c:pt>
                  <c:pt idx="5">
                    <c:v>1.61118000502408E-2</c:v>
                  </c:pt>
                  <c:pt idx="6">
                    <c:v>1.8080182035986301E-2</c:v>
                  </c:pt>
                  <c:pt idx="7">
                    <c:v>2.1720290196530399E-2</c:v>
                  </c:pt>
                  <c:pt idx="8">
                    <c:v>2.0057582403833901E-2</c:v>
                  </c:pt>
                  <c:pt idx="9">
                    <c:v>1.3991155237119E-2</c:v>
                  </c:pt>
                  <c:pt idx="10">
                    <c:v>2.01057265719062E-2</c:v>
                  </c:pt>
                  <c:pt idx="11">
                    <c:v>2.40962909524048E-2</c:v>
                  </c:pt>
                </c:numCache>
              </c:numRef>
            </c:minus>
          </c:errBars>
          <c:xVal>
            <c:numRef>
              <c:f>('04760'!$C$2,'04760'!$C$30,'04760'!$C$58,'04760'!$C$86,'04760'!$C$114,'04760'!$C$142,'04760'!$C$170,'04760'!$C$198,'04760'!$C$226)</c:f>
              <c:numCache>
                <c:formatCode>General</c:formatCode>
                <c:ptCount val="9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</c:numCache>
            </c:numRef>
          </c:xVal>
          <c:yVal>
            <c:numRef>
              <c:f>('04760'!$G$28,'04760'!$G$382,'04760'!$G$410,'04760'!$G$438,'04760'!$G$466,'04760'!$G$494,'04760'!$G$522,'04760'!$G$550,'04760'!$G$578)</c:f>
              <c:numCache>
                <c:formatCode>0.000</c:formatCode>
                <c:ptCount val="9"/>
                <c:pt idx="0">
                  <c:v>9.9575797310491806E-3</c:v>
                </c:pt>
                <c:pt idx="1">
                  <c:v>2.6079773236901999E-2</c:v>
                </c:pt>
                <c:pt idx="2">
                  <c:v>4.5277729634201298E-2</c:v>
                </c:pt>
                <c:pt idx="3">
                  <c:v>5.8306968132055603E-2</c:v>
                </c:pt>
                <c:pt idx="4">
                  <c:v>6.8985797269270899E-2</c:v>
                </c:pt>
                <c:pt idx="5">
                  <c:v>7.7511457759482996E-2</c:v>
                </c:pt>
                <c:pt idx="6">
                  <c:v>8.7966757912404894E-2</c:v>
                </c:pt>
                <c:pt idx="7">
                  <c:v>9.1436582357969406E-2</c:v>
                </c:pt>
                <c:pt idx="8">
                  <c:v>0.101225315830196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3E7D-C349-B00F-F3CC6D47FEA9}"/>
            </c:ext>
          </c:extLst>
        </c:ser>
        <c:ser>
          <c:idx val="4"/>
          <c:order val="4"/>
          <c:tx>
            <c:v>Col0 J12 J13</c:v>
          </c:tx>
          <c:spPr>
            <a:ln w="6350">
              <a:solidFill>
                <a:schemeClr val="bg1">
                  <a:lumMod val="50000"/>
                </a:schemeClr>
              </a:solidFill>
            </a:ln>
          </c:spPr>
          <c:marker>
            <c:symbol val="circle"/>
            <c:size val="4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Col0!$D$567,Col0!$G$581)</c:f>
                <c:numCache>
                  <c:formatCode>General</c:formatCode>
                  <c:ptCount val="2"/>
                </c:numCache>
              </c:numRef>
            </c:plus>
            <c:minus>
              <c:numRef>
                <c:f>(Col0!$D$567,Col0!$G$581)</c:f>
                <c:numCache>
                  <c:formatCode>General</c:formatCode>
                  <c:ptCount val="2"/>
                </c:numCache>
              </c:numRef>
            </c:minus>
          </c:errBars>
          <c:xVal>
            <c:numRef>
              <c:f>(Col0!$C$226,Col0!$C$254)</c:f>
              <c:numCache>
                <c:formatCode>General</c:formatCode>
                <c:ptCount val="2"/>
                <c:pt idx="0">
                  <c:v>12</c:v>
                </c:pt>
                <c:pt idx="1">
                  <c:v>13</c:v>
                </c:pt>
              </c:numCache>
            </c:numRef>
          </c:xVal>
          <c:yVal>
            <c:numRef>
              <c:f>(Col0!$G$564,Col0!$G$580)</c:f>
              <c:numCache>
                <c:formatCode>0.000</c:formatCode>
                <c:ptCount val="2"/>
                <c:pt idx="0">
                  <c:v>9.8823485755891699E-2</c:v>
                </c:pt>
                <c:pt idx="1">
                  <c:v>9.9898144891929302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3E7D-C349-B00F-F3CC6D47FEA9}"/>
            </c:ext>
          </c:extLst>
        </c:ser>
        <c:ser>
          <c:idx val="5"/>
          <c:order val="5"/>
          <c:tx>
            <c:v>08 J12 J13</c:v>
          </c:tx>
          <c:spPr>
            <a:ln w="6350">
              <a:solidFill>
                <a:schemeClr val="accent2"/>
              </a:solidFill>
            </a:ln>
          </c:spPr>
          <c:marker>
            <c:symbol val="square"/>
            <c:size val="4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08920'!$G$579,'08920'!$G$602)</c:f>
                <c:numCache>
                  <c:formatCode>General</c:formatCode>
                  <c:ptCount val="2"/>
                  <c:pt idx="0">
                    <c:v>1.9654945799783E-2</c:v>
                  </c:pt>
                  <c:pt idx="1">
                    <c:v>1.8295035506391999E-2</c:v>
                  </c:pt>
                </c:numCache>
              </c:numRef>
            </c:plus>
            <c:minus>
              <c:numRef>
                <c:f>('08920'!$G$579,'08920'!$G$602)</c:f>
                <c:numCache>
                  <c:formatCode>General</c:formatCode>
                  <c:ptCount val="2"/>
                  <c:pt idx="0">
                    <c:v>1.9654945799783E-2</c:v>
                  </c:pt>
                  <c:pt idx="1">
                    <c:v>1.8295035506391999E-2</c:v>
                  </c:pt>
                </c:numCache>
              </c:numRef>
            </c:minus>
          </c:errBars>
          <c:xVal>
            <c:numRef>
              <c:f>('08920'!$C$552,'08920'!$C$580)</c:f>
              <c:numCache>
                <c:formatCode>General</c:formatCode>
                <c:ptCount val="2"/>
                <c:pt idx="0">
                  <c:v>12</c:v>
                </c:pt>
                <c:pt idx="1">
                  <c:v>13</c:v>
                </c:pt>
              </c:numCache>
            </c:numRef>
          </c:xVal>
          <c:yVal>
            <c:numRef>
              <c:f>('08920'!$G$578,'08920'!$G$601)</c:f>
              <c:numCache>
                <c:formatCode>0.000</c:formatCode>
                <c:ptCount val="2"/>
                <c:pt idx="0">
                  <c:v>0.107372496156329</c:v>
                </c:pt>
                <c:pt idx="1">
                  <c:v>0.10499881259887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3E7D-C349-B00F-F3CC6D47FEA9}"/>
            </c:ext>
          </c:extLst>
        </c:ser>
        <c:ser>
          <c:idx val="6"/>
          <c:order val="6"/>
          <c:tx>
            <c:v>75 J12 J13</c:v>
          </c:tx>
          <c:spPr>
            <a:ln w="6350">
              <a:solidFill>
                <a:schemeClr val="bg1">
                  <a:lumMod val="65000"/>
                </a:schemeClr>
              </a:solidFill>
            </a:ln>
          </c:spPr>
          <c:marker>
            <c:symbol val="triangle"/>
            <c:size val="4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75220'!$D$605,'75220'!$G$625,'75220'!$G$648)</c:f>
                <c:numCache>
                  <c:formatCode>General</c:formatCode>
                  <c:ptCount val="3"/>
                  <c:pt idx="1">
                    <c:v>1.72097936102177E-2</c:v>
                  </c:pt>
                  <c:pt idx="2">
                    <c:v>2.8515780835146599E-2</c:v>
                  </c:pt>
                </c:numCache>
              </c:numRef>
            </c:plus>
            <c:minus>
              <c:numRef>
                <c:f>('75220'!$D$605,'75220'!$G$625,'75220'!$G$648)</c:f>
                <c:numCache>
                  <c:formatCode>General</c:formatCode>
                  <c:ptCount val="3"/>
                  <c:pt idx="1">
                    <c:v>1.72097936102177E-2</c:v>
                  </c:pt>
                  <c:pt idx="2">
                    <c:v>2.8515780835146599E-2</c:v>
                  </c:pt>
                </c:numCache>
              </c:numRef>
            </c:minus>
          </c:errBars>
          <c:xVal>
            <c:numRef>
              <c:f>('75220'!$C$552,'75220'!$C$580)</c:f>
              <c:numCache>
                <c:formatCode>General</c:formatCode>
                <c:ptCount val="2"/>
                <c:pt idx="0">
                  <c:v>12</c:v>
                </c:pt>
                <c:pt idx="1">
                  <c:v>13</c:v>
                </c:pt>
              </c:numCache>
            </c:numRef>
          </c:xVal>
          <c:yVal>
            <c:numRef>
              <c:f>('75220'!$G$578,'75220'!$G$601)</c:f>
              <c:numCache>
                <c:formatCode>0.000</c:formatCode>
                <c:ptCount val="2"/>
                <c:pt idx="0">
                  <c:v>0.100949436215448</c:v>
                </c:pt>
                <c:pt idx="1">
                  <c:v>0.105690492306443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3E7D-C349-B00F-F3CC6D47FEA9}"/>
            </c:ext>
          </c:extLst>
        </c:ser>
        <c:ser>
          <c:idx val="7"/>
          <c:order val="7"/>
          <c:tx>
            <c:v>47 J12 J13</c:v>
          </c:tx>
          <c:spPr>
            <a:ln w="6350">
              <a:solidFill>
                <a:schemeClr val="accent4"/>
              </a:solidFill>
            </a:ln>
          </c:spPr>
          <c:marker>
            <c:symbol val="diamond"/>
            <c:size val="4"/>
            <c:spPr>
              <a:solidFill>
                <a:schemeClr val="accent4"/>
              </a:solidFill>
              <a:ln>
                <a:solidFill>
                  <a:schemeClr val="accent4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04760'!$G$579,'04760'!$G$602)</c:f>
                <c:numCache>
                  <c:formatCode>General</c:formatCode>
                  <c:ptCount val="2"/>
                  <c:pt idx="0">
                    <c:v>2.0057582403833901E-2</c:v>
                  </c:pt>
                  <c:pt idx="1">
                    <c:v>1.3991155237119E-2</c:v>
                  </c:pt>
                </c:numCache>
              </c:numRef>
            </c:plus>
            <c:minus>
              <c:numRef>
                <c:f>('04760'!$G$579,'04760'!$G$602)</c:f>
                <c:numCache>
                  <c:formatCode>General</c:formatCode>
                  <c:ptCount val="2"/>
                  <c:pt idx="0">
                    <c:v>2.0057582403833901E-2</c:v>
                  </c:pt>
                  <c:pt idx="1">
                    <c:v>1.3991155237119E-2</c:v>
                  </c:pt>
                </c:numCache>
              </c:numRef>
            </c:minus>
          </c:errBars>
          <c:xVal>
            <c:numRef>
              <c:f>('04760'!$C$552,'04760'!$C$580)</c:f>
              <c:numCache>
                <c:formatCode>General</c:formatCode>
                <c:ptCount val="2"/>
                <c:pt idx="0">
                  <c:v>12</c:v>
                </c:pt>
                <c:pt idx="1">
                  <c:v>13</c:v>
                </c:pt>
              </c:numCache>
            </c:numRef>
          </c:xVal>
          <c:yVal>
            <c:numRef>
              <c:f>('04760'!$G$578,'04760'!$G$601)</c:f>
              <c:numCache>
                <c:formatCode>0.000</c:formatCode>
                <c:ptCount val="2"/>
                <c:pt idx="0">
                  <c:v>0.10122531583019601</c:v>
                </c:pt>
                <c:pt idx="1">
                  <c:v>0.102548421200444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3E7D-C349-B00F-F3CC6D47FEA9}"/>
            </c:ext>
          </c:extLst>
        </c:ser>
        <c:ser>
          <c:idx val="8"/>
          <c:order val="8"/>
          <c:tx>
            <c:v>Col0 J13 J15</c:v>
          </c:tx>
          <c:spPr>
            <a:ln w="6350">
              <a:solidFill>
                <a:schemeClr val="accent1"/>
              </a:solidFill>
            </a:ln>
          </c:spPr>
          <c:marker>
            <c:symbol val="circle"/>
            <c:size val="4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</c:spPr>
          </c:marker>
          <c:trendline>
            <c:spPr>
              <a:ln>
                <a:noFill/>
              </a:ln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Col0!$G$581,Col0!$G$597,Col0!$G$620)</c:f>
                <c:numCache>
                  <c:formatCode>General</c:formatCode>
                  <c:ptCount val="3"/>
                  <c:pt idx="2">
                    <c:v>2.2135185794002699E-2</c:v>
                  </c:pt>
                </c:numCache>
              </c:numRef>
            </c:plus>
            <c:minus>
              <c:numRef>
                <c:f>(Col0!$G$581,Col0!$G$597,Col0!$G$620)</c:f>
                <c:numCache>
                  <c:formatCode>General</c:formatCode>
                  <c:ptCount val="3"/>
                  <c:pt idx="2">
                    <c:v>2.2135185794002699E-2</c:v>
                  </c:pt>
                </c:numCache>
              </c:numRef>
            </c:minus>
          </c:errBars>
          <c:xVal>
            <c:numRef>
              <c:f>(Col0!$C$566,Col0!$C$582,Col0!$C$598)</c:f>
              <c:numCache>
                <c:formatCode>General</c:formatCode>
                <c:ptCount val="3"/>
                <c:pt idx="0">
                  <c:v>13</c:v>
                </c:pt>
                <c:pt idx="1">
                  <c:v>14</c:v>
                </c:pt>
                <c:pt idx="2">
                  <c:v>15</c:v>
                </c:pt>
              </c:numCache>
            </c:numRef>
          </c:xVal>
          <c:yVal>
            <c:numRef>
              <c:f>(Col0!$G$580,Col0!$G$596,Col0!$G$619)</c:f>
              <c:numCache>
                <c:formatCode>0.000</c:formatCode>
                <c:ptCount val="3"/>
                <c:pt idx="0">
                  <c:v>9.9898144891929302E-2</c:v>
                </c:pt>
                <c:pt idx="1">
                  <c:v>9.1186221372359696E-2</c:v>
                </c:pt>
                <c:pt idx="2">
                  <c:v>7.9066928128400604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3E7D-C349-B00F-F3CC6D47FEA9}"/>
            </c:ext>
          </c:extLst>
        </c:ser>
        <c:ser>
          <c:idx val="9"/>
          <c:order val="9"/>
          <c:tx>
            <c:v>08 J13 J15</c:v>
          </c:tx>
          <c:spPr>
            <a:ln w="6350">
              <a:solidFill>
                <a:schemeClr val="accent2"/>
              </a:solidFill>
            </a:ln>
          </c:spPr>
          <c:marker>
            <c:symbol val="square"/>
            <c:size val="4"/>
            <c:spPr>
              <a:solidFill>
                <a:schemeClr val="accent2"/>
              </a:solidFill>
              <a:ln>
                <a:solidFill>
                  <a:schemeClr val="accent2"/>
                </a:solidFill>
              </a:ln>
            </c:spPr>
          </c:marker>
          <c:trendline>
            <c:spPr>
              <a:ln>
                <a:noFill/>
              </a:ln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8920'!$D$595,'08920'!$G$625,'08920'!$G$648)</c:f>
                <c:numCache>
                  <c:formatCode>General</c:formatCode>
                  <c:ptCount val="3"/>
                  <c:pt idx="1">
                    <c:v>1.8349513052893899E-2</c:v>
                  </c:pt>
                  <c:pt idx="2">
                    <c:v>3.1607726061887498E-2</c:v>
                  </c:pt>
                </c:numCache>
              </c:numRef>
            </c:plus>
            <c:minus>
              <c:numRef>
                <c:f>('08920'!$D$595,'08920'!$G$625,'08920'!$G$648)</c:f>
                <c:numCache>
                  <c:formatCode>General</c:formatCode>
                  <c:ptCount val="3"/>
                  <c:pt idx="1">
                    <c:v>1.8349513052893899E-2</c:v>
                  </c:pt>
                  <c:pt idx="2">
                    <c:v>3.1607726061887498E-2</c:v>
                  </c:pt>
                </c:numCache>
              </c:numRef>
            </c:minus>
            <c:spPr>
              <a:ln w="6350"/>
            </c:spPr>
          </c:errBars>
          <c:xVal>
            <c:numRef>
              <c:f>('08920'!$C$580,'08920'!$C$603,'08920'!$C$626)</c:f>
              <c:numCache>
                <c:formatCode>General</c:formatCode>
                <c:ptCount val="3"/>
                <c:pt idx="0">
                  <c:v>13</c:v>
                </c:pt>
                <c:pt idx="1">
                  <c:v>14</c:v>
                </c:pt>
                <c:pt idx="2">
                  <c:v>15</c:v>
                </c:pt>
              </c:numCache>
            </c:numRef>
          </c:xVal>
          <c:yVal>
            <c:numRef>
              <c:f>('08920'!$G$601,'08920'!$G$624,'08920'!$G$647)</c:f>
              <c:numCache>
                <c:formatCode>0.000</c:formatCode>
                <c:ptCount val="3"/>
                <c:pt idx="0">
                  <c:v>0.104998812598879</c:v>
                </c:pt>
                <c:pt idx="1">
                  <c:v>8.8704858083626104E-2</c:v>
                </c:pt>
                <c:pt idx="2">
                  <c:v>9.0062932361310105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3E7D-C349-B00F-F3CC6D47FEA9}"/>
            </c:ext>
          </c:extLst>
        </c:ser>
        <c:ser>
          <c:idx val="10"/>
          <c:order val="10"/>
          <c:tx>
            <c:v>75 J13 J15</c:v>
          </c:tx>
          <c:spPr>
            <a:ln w="6350">
              <a:solidFill>
                <a:schemeClr val="bg1">
                  <a:lumMod val="65000"/>
                </a:schemeClr>
              </a:solidFill>
            </a:ln>
          </c:spPr>
          <c:marker>
            <c:symbol val="triangle"/>
            <c:size val="4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</c:spPr>
          </c:marker>
          <c:trendline>
            <c:spPr>
              <a:ln>
                <a:noFill/>
              </a:ln>
            </c:spPr>
            <c:trendlineType val="linear"/>
            <c:dispRSqr val="0"/>
            <c:dispEq val="0"/>
          </c:trendline>
          <c:xVal>
            <c:numRef>
              <c:f>('75220'!$C$580,'75220'!$C$603,'75220'!$C$626)</c:f>
              <c:numCache>
                <c:formatCode>General</c:formatCode>
                <c:ptCount val="3"/>
                <c:pt idx="0">
                  <c:v>13</c:v>
                </c:pt>
                <c:pt idx="1">
                  <c:v>14</c:v>
                </c:pt>
                <c:pt idx="2">
                  <c:v>15</c:v>
                </c:pt>
              </c:numCache>
            </c:numRef>
          </c:xVal>
          <c:yVal>
            <c:numRef>
              <c:f>('75220'!$G$601,'75220'!$G$624,'75220'!$G$647)</c:f>
              <c:numCache>
                <c:formatCode>0.000</c:formatCode>
                <c:ptCount val="3"/>
                <c:pt idx="0">
                  <c:v>0.10569049230644301</c:v>
                </c:pt>
                <c:pt idx="1">
                  <c:v>8.9769135707232106E-2</c:v>
                </c:pt>
                <c:pt idx="2">
                  <c:v>7.7954961796662905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1-3E7D-C349-B00F-F3CC6D47FEA9}"/>
            </c:ext>
          </c:extLst>
        </c:ser>
        <c:ser>
          <c:idx val="11"/>
          <c:order val="11"/>
          <c:tx>
            <c:v>47 J13 J15</c:v>
          </c:tx>
          <c:spPr>
            <a:ln w="6350">
              <a:solidFill>
                <a:schemeClr val="accent4"/>
              </a:solidFill>
            </a:ln>
          </c:spPr>
          <c:marker>
            <c:symbol val="diamond"/>
            <c:size val="4"/>
            <c:spPr>
              <a:solidFill>
                <a:schemeClr val="accent4"/>
              </a:solidFill>
              <a:ln>
                <a:solidFill>
                  <a:schemeClr val="accent4"/>
                </a:solidFill>
              </a:ln>
            </c:spPr>
          </c:marker>
          <c:trendline>
            <c:spPr>
              <a:ln>
                <a:noFill/>
              </a:ln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4760'!$D$605,'04760'!$G$625,'04760'!$G$648)</c:f>
                <c:numCache>
                  <c:formatCode>General</c:formatCode>
                  <c:ptCount val="3"/>
                  <c:pt idx="1">
                    <c:v>2.01057265719062E-2</c:v>
                  </c:pt>
                  <c:pt idx="2">
                    <c:v>2.40962909524048E-2</c:v>
                  </c:pt>
                </c:numCache>
              </c:numRef>
            </c:plus>
            <c:minus>
              <c:numRef>
                <c:f>('04760'!$D$605,'04760'!$G$625,'04760'!$G$648)</c:f>
                <c:numCache>
                  <c:formatCode>General</c:formatCode>
                  <c:ptCount val="3"/>
                  <c:pt idx="1">
                    <c:v>2.01057265719062E-2</c:v>
                  </c:pt>
                  <c:pt idx="2">
                    <c:v>2.40962909524048E-2</c:v>
                  </c:pt>
                </c:numCache>
              </c:numRef>
            </c:minus>
            <c:spPr>
              <a:ln w="6350"/>
            </c:spPr>
          </c:errBars>
          <c:xVal>
            <c:numRef>
              <c:f>('04760'!$C$580,'04760'!$C$603,'04760'!$C$626)</c:f>
              <c:numCache>
                <c:formatCode>General</c:formatCode>
                <c:ptCount val="3"/>
                <c:pt idx="0">
                  <c:v>13</c:v>
                </c:pt>
                <c:pt idx="1">
                  <c:v>14</c:v>
                </c:pt>
                <c:pt idx="2">
                  <c:v>15</c:v>
                </c:pt>
              </c:numCache>
            </c:numRef>
          </c:xVal>
          <c:yVal>
            <c:numRef>
              <c:f>('04760'!$G$601,'04760'!$G$624,'04760'!$G$647)</c:f>
              <c:numCache>
                <c:formatCode>0.000</c:formatCode>
                <c:ptCount val="3"/>
                <c:pt idx="0">
                  <c:v>0.10254842120044499</c:v>
                </c:pt>
                <c:pt idx="1">
                  <c:v>8.8568604190377806E-2</c:v>
                </c:pt>
                <c:pt idx="2">
                  <c:v>7.3264617743052901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3-3E7D-C349-B00F-F3CC6D47FE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13159304"/>
        <c:axId val="813192296"/>
      </c:scatterChart>
      <c:valAx>
        <c:axId val="813159304"/>
        <c:scaling>
          <c:orientation val="minMax"/>
          <c:max val="16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13192296"/>
        <c:crosses val="autoZero"/>
        <c:crossBetween val="midCat"/>
        <c:majorUnit val="1"/>
      </c:valAx>
      <c:valAx>
        <c:axId val="813192296"/>
        <c:scaling>
          <c:orientation val="minMax"/>
          <c:max val="0.30000000000000004"/>
          <c:min val="0"/>
        </c:scaling>
        <c:delete val="0"/>
        <c:axPos val="l"/>
        <c:majorGridlines>
          <c:spPr>
            <a:ln w="6350">
              <a:solidFill>
                <a:schemeClr val="bg1">
                  <a:lumMod val="85000"/>
                </a:schemeClr>
              </a:solidFill>
            </a:ln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fr-FR" sz="1200" b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W </a:t>
                </a:r>
                <a:r>
                  <a:rPr lang="fr-FR" sz="1200" b="0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g)</a:t>
                </a:r>
                <a:endParaRPr lang="fr-FR" sz="1200" b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7.8631939133753867E-3"/>
              <c:y val="0.2398262142786505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.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13159304"/>
        <c:crossesAt val="0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558310048223888"/>
          <c:y val="0.15833736181348185"/>
          <c:w val="0.74508617280071088"/>
          <c:h val="0.706736842105263"/>
        </c:manualLayout>
      </c:layout>
      <c:scatterChart>
        <c:scatterStyle val="lineMarker"/>
        <c:varyColors val="0"/>
        <c:ser>
          <c:idx val="0"/>
          <c:order val="0"/>
          <c:tx>
            <c:v>Col0</c:v>
          </c:tx>
          <c:spPr>
            <a:ln w="6350" cap="rnd">
              <a:solidFill>
                <a:srgbClr val="4282BB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rgbClr val="4282BB"/>
              </a:solidFill>
              <a:ln w="9525">
                <a:solidFill>
                  <a:srgbClr val="4282BB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(Col0!$C$2,Col0!$C$30,Col0!$C$58,Col0!$C$86,Col0!$C$114,Col0!$C$142,Col0!$C$170,Col0!$C$198,Col0!$C$226,Col0!$C$254,Col0!$C$270,Col0!$C$286)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(Col0!$L$340,Col0!$L$368,Col0!$L$396,Col0!$L$424,Col0!$L$452,Col0!$L$480,Col0!$L$508,Col0!$L$536,Col0!$L$564)</c:f>
              <c:numCache>
                <c:formatCode>General</c:formatCode>
                <c:ptCount val="9"/>
                <c:pt idx="0">
                  <c:v>172.58799999999999</c:v>
                </c:pt>
                <c:pt idx="1">
                  <c:v>170.81200000000001</c:v>
                </c:pt>
                <c:pt idx="2">
                  <c:v>138.892</c:v>
                </c:pt>
                <c:pt idx="3">
                  <c:v>140.27857142857141</c:v>
                </c:pt>
                <c:pt idx="4">
                  <c:v>108.5535714285714</c:v>
                </c:pt>
                <c:pt idx="5">
                  <c:v>62.036000000000001</c:v>
                </c:pt>
                <c:pt idx="6">
                  <c:v>38.107999999999997</c:v>
                </c:pt>
                <c:pt idx="7">
                  <c:v>17.611200000000011</c:v>
                </c:pt>
                <c:pt idx="8">
                  <c:v>14.42857142857143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E94-0840-8245-90EF56368619}"/>
            </c:ext>
          </c:extLst>
        </c:ser>
        <c:ser>
          <c:idx val="1"/>
          <c:order val="1"/>
          <c:tx>
            <c:v>at1g08920</c:v>
          </c:tx>
          <c:spPr>
            <a:ln w="6350" cap="rnd">
              <a:solidFill>
                <a:schemeClr val="accent2"/>
              </a:solidFill>
              <a:round/>
            </a:ln>
            <a:effectLst/>
          </c:spPr>
          <c:marker>
            <c:symbol val="x"/>
            <c:size val="4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(Col0!$C$2,Col0!$C$30,Col0!$C$58,Col0!$C$86,Col0!$C$114,Col0!$C$142,Col0!$C$170,Col0!$C$198,Col0!$C$226,Col0!$C$254,Col0!$C$270,Col0!$C$286)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('08920'!$K$354,'08920'!$K$382,'08920'!$K$410,'08920'!$K$438,'08920'!$K$466,'08920'!$K$494,'08920'!$K$522,'08920'!$K$550,'08920'!$K$578)</c:f>
              <c:numCache>
                <c:formatCode>General</c:formatCode>
                <c:ptCount val="9"/>
                <c:pt idx="0">
                  <c:v>194.34</c:v>
                </c:pt>
                <c:pt idx="1">
                  <c:v>156.07</c:v>
                </c:pt>
                <c:pt idx="2">
                  <c:v>111.42</c:v>
                </c:pt>
                <c:pt idx="3">
                  <c:v>115.34</c:v>
                </c:pt>
                <c:pt idx="4">
                  <c:v>70.229999999999976</c:v>
                </c:pt>
                <c:pt idx="5">
                  <c:v>63.2</c:v>
                </c:pt>
                <c:pt idx="6">
                  <c:v>13.48</c:v>
                </c:pt>
                <c:pt idx="7">
                  <c:v>3.17</c:v>
                </c:pt>
                <c:pt idx="8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8E94-0840-8245-90EF56368619}"/>
            </c:ext>
          </c:extLst>
        </c:ser>
        <c:ser>
          <c:idx val="2"/>
          <c:order val="2"/>
          <c:tx>
            <c:v>at1g75220</c:v>
          </c:tx>
          <c:spPr>
            <a:ln w="6350" cap="rnd">
              <a:solidFill>
                <a:schemeClr val="accent3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('75220'!$C$2,'75220'!$C$30,'75220'!$C$58,'75220'!$C$86,'75220'!$C$114,'75220'!$C$142,'75220'!$C$170,'75220'!$C$198,'75220'!$C$226,'75220'!$C$254,'75220'!$C$277,'75220'!$C$300)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('75220'!$K$354,'75220'!$K$382,'75220'!$K$410,'75220'!$K$438,'75220'!$K$466,'75220'!$K$494,'75220'!$K$522,'75220'!$K$550,'75220'!$K$578)</c:f>
              <c:numCache>
                <c:formatCode>General</c:formatCode>
                <c:ptCount val="9"/>
                <c:pt idx="0">
                  <c:v>190.03</c:v>
                </c:pt>
                <c:pt idx="1">
                  <c:v>152.19999999999999</c:v>
                </c:pt>
                <c:pt idx="2">
                  <c:v>119.38</c:v>
                </c:pt>
                <c:pt idx="3">
                  <c:v>86.390000000000015</c:v>
                </c:pt>
                <c:pt idx="4">
                  <c:v>92.050000000000011</c:v>
                </c:pt>
                <c:pt idx="5">
                  <c:v>56.13000000000001</c:v>
                </c:pt>
                <c:pt idx="6">
                  <c:v>30.18</c:v>
                </c:pt>
                <c:pt idx="7">
                  <c:v>6.64</c:v>
                </c:pt>
                <c:pt idx="8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8E94-0840-8245-90EF56368619}"/>
            </c:ext>
          </c:extLst>
        </c:ser>
        <c:ser>
          <c:idx val="3"/>
          <c:order val="3"/>
          <c:tx>
            <c:v>at3g04760</c:v>
          </c:tx>
          <c:spPr>
            <a:ln w="6350" cap="rnd">
              <a:solidFill>
                <a:schemeClr val="accent4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('04760'!$C$2,'04760'!$C$30,'04760'!$C$58,'04760'!$C$86,'04760'!$C$114,'04760'!$C$142,'04760'!$C$170,'04760'!$C$198,'04760'!$C$226,'04760'!$C$254,'04760'!$C$277,'04760'!$C$300)</c:f>
              <c:numCache>
                <c:formatCode>General</c:formatCode>
                <c:ptCount val="12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9</c:v>
                </c:pt>
                <c:pt idx="6">
                  <c:v>10</c:v>
                </c:pt>
                <c:pt idx="7">
                  <c:v>11</c:v>
                </c:pt>
                <c:pt idx="8">
                  <c:v>12</c:v>
                </c:pt>
                <c:pt idx="9">
                  <c:v>13</c:v>
                </c:pt>
                <c:pt idx="10">
                  <c:v>14</c:v>
                </c:pt>
                <c:pt idx="11">
                  <c:v>15</c:v>
                </c:pt>
              </c:numCache>
            </c:numRef>
          </c:xVal>
          <c:yVal>
            <c:numRef>
              <c:f>('04760'!$K$354,'04760'!$K$382,'04760'!$K$410,'04760'!$K$438,'04760'!$K$466,'04760'!$K$494,'04760'!$K$522,'04760'!$K$550,'04760'!$K$575)</c:f>
              <c:numCache>
                <c:formatCode>General</c:formatCode>
                <c:ptCount val="9"/>
                <c:pt idx="0">
                  <c:v>188.66</c:v>
                </c:pt>
                <c:pt idx="1">
                  <c:v>157.83000000000001</c:v>
                </c:pt>
                <c:pt idx="2">
                  <c:v>95.890000000000015</c:v>
                </c:pt>
                <c:pt idx="3">
                  <c:v>90.99</c:v>
                </c:pt>
                <c:pt idx="4">
                  <c:v>101.25</c:v>
                </c:pt>
                <c:pt idx="5">
                  <c:v>69.750000000000014</c:v>
                </c:pt>
                <c:pt idx="6">
                  <c:v>37.08</c:v>
                </c:pt>
                <c:pt idx="7">
                  <c:v>4.0999999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8E94-0840-8245-90EF5636861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04781016"/>
        <c:axId val="689970152"/>
      </c:scatterChart>
      <c:valAx>
        <c:axId val="804781016"/>
        <c:scaling>
          <c:orientation val="minMax"/>
          <c:max val="16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689970152"/>
        <c:crosses val="autoZero"/>
        <c:crossBetween val="midCat"/>
        <c:majorUnit val="1"/>
      </c:valAx>
      <c:valAx>
        <c:axId val="689970152"/>
        <c:scaling>
          <c:orientation val="minMax"/>
          <c:max val="250"/>
          <c:min val="0"/>
        </c:scaling>
        <c:delete val="0"/>
        <c:axPos val="l"/>
        <c:majorGridlines>
          <c:spPr>
            <a:ln w="6350">
              <a:solidFill>
                <a:schemeClr val="bg1">
                  <a:lumMod val="85000"/>
                </a:schemeClr>
              </a:solidFill>
            </a:ln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fr-FR" sz="1200" b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S </a:t>
                </a:r>
                <a:r>
                  <a:rPr lang="fr-FR" sz="1200" b="0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g/mol/m</a:t>
                </a:r>
                <a:r>
                  <a:rPr lang="fr-FR" sz="1200" b="0" baseline="3000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fr-FR" sz="1200" b="0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fr-FR" sz="1200" b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7.6834930731263318E-3"/>
              <c:y val="0.157440723447491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04781016"/>
        <c:crossesAt val="0"/>
        <c:crossBetween val="midCat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99934011834652"/>
          <c:y val="6.5543106325523973E-2"/>
          <c:w val="0.72455734852366671"/>
          <c:h val="0.57595844163396193"/>
        </c:manualLayout>
      </c:layout>
      <c:scatterChart>
        <c:scatterStyle val="lineMarker"/>
        <c:varyColors val="0"/>
        <c:ser>
          <c:idx val="0"/>
          <c:order val="0"/>
          <c:tx>
            <c:v>Col0</c:v>
          </c:tx>
          <c:spPr>
            <a:ln w="6350" cap="rnd">
              <a:solidFill>
                <a:srgbClr val="4282BB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rgbClr val="4282BB"/>
              </a:solidFill>
              <a:ln w="9525">
                <a:solidFill>
                  <a:srgbClr val="4282BB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Col0!$L$29,Col0!$L$57,Col0!$L$85,Col0!$L$113,Col0!$L$141,Col0!$L$169,Col0!$L$197,Col0!$L$225,Col0!$L$253,Col0!$L$269)</c:f>
                <c:numCache>
                  <c:formatCode>General</c:formatCode>
                  <c:ptCount val="10"/>
                  <c:pt idx="0">
                    <c:v>28.761707301172279</c:v>
                  </c:pt>
                  <c:pt idx="1">
                    <c:v>47.546938657093193</c:v>
                  </c:pt>
                  <c:pt idx="2">
                    <c:v>43.604156608572943</c:v>
                  </c:pt>
                  <c:pt idx="3">
                    <c:v>52.987191723778707</c:v>
                  </c:pt>
                  <c:pt idx="4">
                    <c:v>47.719132264172451</c:v>
                  </c:pt>
                  <c:pt idx="5">
                    <c:v>36.584285521107702</c:v>
                  </c:pt>
                  <c:pt idx="6">
                    <c:v>44.013352200868141</c:v>
                  </c:pt>
                  <c:pt idx="7">
                    <c:v>29.4633542902322</c:v>
                  </c:pt>
                  <c:pt idx="8">
                    <c:v>30.727432349843781</c:v>
                  </c:pt>
                </c:numCache>
              </c:numRef>
            </c:plus>
            <c:minus>
              <c:numRef>
                <c:f>(Col0!$L$29,Col0!$L$57,Col0!$L$85,Col0!$L$113,Col0!$L$141,Col0!$L$169,Col0!$L$197,Col0!$L$225,Col0!$L$253,Col0!$L$269)</c:f>
                <c:numCache>
                  <c:formatCode>General</c:formatCode>
                  <c:ptCount val="10"/>
                  <c:pt idx="0">
                    <c:v>28.761707301172279</c:v>
                  </c:pt>
                  <c:pt idx="1">
                    <c:v>47.546938657093193</c:v>
                  </c:pt>
                  <c:pt idx="2">
                    <c:v>43.604156608572943</c:v>
                  </c:pt>
                  <c:pt idx="3">
                    <c:v>52.987191723778707</c:v>
                  </c:pt>
                  <c:pt idx="4">
                    <c:v>47.719132264172451</c:v>
                  </c:pt>
                  <c:pt idx="5">
                    <c:v>36.584285521107702</c:v>
                  </c:pt>
                  <c:pt idx="6">
                    <c:v>44.013352200868141</c:v>
                  </c:pt>
                  <c:pt idx="7">
                    <c:v>29.4633542902322</c:v>
                  </c:pt>
                  <c:pt idx="8">
                    <c:v>30.727432349843781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Col0!$C$3,Col0!$C$31,Col0!$C$59,Col0!$C$87,Col0!$C$115,Col0!$C$143,Col0!$C$171,Col0!$C$199,Col0!$C$227,Col0!$C$255)</c:f>
              <c:numCache>
                <c:formatCode>General</c:formatCode>
                <c:ptCount val="10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</c:numCache>
            </c:numRef>
          </c:xVal>
          <c:yVal>
            <c:numRef>
              <c:f>(Col0!$L$28,Col0!$L$56,Col0!$L$84,Col0!$L$112,Col0!$L$140,Col0!$L$168,Col0!$L$196,Col0!$L$224,Col0!$L$252,Col0!$L$268)</c:f>
              <c:numCache>
                <c:formatCode>General</c:formatCode>
                <c:ptCount val="10"/>
                <c:pt idx="0">
                  <c:v>123.33928571428569</c:v>
                </c:pt>
                <c:pt idx="1">
                  <c:v>159.92142857142861</c:v>
                </c:pt>
                <c:pt idx="2">
                  <c:v>139.66071428571431</c:v>
                </c:pt>
                <c:pt idx="3">
                  <c:v>139.27857142857141</c:v>
                </c:pt>
                <c:pt idx="4">
                  <c:v>130.64074074074071</c:v>
                </c:pt>
                <c:pt idx="5">
                  <c:v>158.0428571428572</c:v>
                </c:pt>
                <c:pt idx="6">
                  <c:v>131.59642857142859</c:v>
                </c:pt>
                <c:pt idx="7">
                  <c:v>127.6035714285714</c:v>
                </c:pt>
                <c:pt idx="8">
                  <c:v>137.36521739130441</c:v>
                </c:pt>
                <c:pt idx="9">
                  <c:v>149.2874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BA7-6A4E-A65D-626ABB091FDA}"/>
            </c:ext>
          </c:extLst>
        </c:ser>
        <c:ser>
          <c:idx val="1"/>
          <c:order val="1"/>
          <c:tx>
            <c:v>at1g08920</c:v>
          </c:tx>
          <c:spPr>
            <a:ln w="6350" cap="rnd">
              <a:solidFill>
                <a:schemeClr val="accent2"/>
              </a:solidFill>
              <a:round/>
            </a:ln>
            <a:effectLst/>
          </c:spPr>
          <c:marker>
            <c:symbol val="x"/>
            <c:size val="4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8920'!$K$29,'08920'!$K$57,'08920'!$K$85,'08920'!$K$113,'08920'!$K$141,'08920'!$K$169,'08920'!$K$197,'08920'!$K$225,'08920'!$K$253,'08920'!$K$276)</c:f>
                <c:numCache>
                  <c:formatCode>General</c:formatCode>
                  <c:ptCount val="10"/>
                  <c:pt idx="0">
                    <c:v>79.264435354109978</c:v>
                  </c:pt>
                  <c:pt idx="1">
                    <c:v>21.601442259541599</c:v>
                  </c:pt>
                  <c:pt idx="2">
                    <c:v>43.253894148092087</c:v>
                  </c:pt>
                  <c:pt idx="3">
                    <c:v>48.622099808046023</c:v>
                  </c:pt>
                  <c:pt idx="4">
                    <c:v>46.972535619914112</c:v>
                  </c:pt>
                  <c:pt idx="5">
                    <c:v>33.251043939655858</c:v>
                  </c:pt>
                  <c:pt idx="6">
                    <c:v>27.585182756188281</c:v>
                  </c:pt>
                  <c:pt idx="7">
                    <c:v>30.77417332098031</c:v>
                  </c:pt>
                  <c:pt idx="8">
                    <c:v>53.372308675317093</c:v>
                  </c:pt>
                  <c:pt idx="9">
                    <c:v>15.909850198331011</c:v>
                  </c:pt>
                </c:numCache>
              </c:numRef>
            </c:plus>
            <c:minus>
              <c:numRef>
                <c:f>('08920'!$K$29,'08920'!$K$57,'08920'!$K$85,'08920'!$K$113,'08920'!$K$141,'08920'!$K$169,'08920'!$K$197,'08920'!$K$225,'08920'!$K$253,'08920'!$K$276)</c:f>
                <c:numCache>
                  <c:formatCode>General</c:formatCode>
                  <c:ptCount val="10"/>
                  <c:pt idx="0">
                    <c:v>79.264435354109978</c:v>
                  </c:pt>
                  <c:pt idx="1">
                    <c:v>21.601442259541599</c:v>
                  </c:pt>
                  <c:pt idx="2">
                    <c:v>43.253894148092087</c:v>
                  </c:pt>
                  <c:pt idx="3">
                    <c:v>48.622099808046023</c:v>
                  </c:pt>
                  <c:pt idx="4">
                    <c:v>46.972535619914112</c:v>
                  </c:pt>
                  <c:pt idx="5">
                    <c:v>33.251043939655858</c:v>
                  </c:pt>
                  <c:pt idx="6">
                    <c:v>27.585182756188281</c:v>
                  </c:pt>
                  <c:pt idx="7">
                    <c:v>30.77417332098031</c:v>
                  </c:pt>
                  <c:pt idx="8">
                    <c:v>53.372308675317093</c:v>
                  </c:pt>
                  <c:pt idx="9">
                    <c:v>15.909850198331011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Col0!$C$3,Col0!$C$31,Col0!$C$59,Col0!$C$87,Col0!$C$115,Col0!$C$143,Col0!$C$171,Col0!$C$199,Col0!$C$227,Col0!$C$255,Col0!$C$271,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'08920'!$K$28,'08920'!$K$56,'08920'!$K$84,'08920'!$K$112,'08920'!$K$140,'08920'!$K$168,'08920'!$K$196,'08920'!$K$224,'08920'!$K$252,'08920'!$K$275,'08920'!$K$295,'08920'!$K$323)</c:f>
              <c:numCache>
                <c:formatCode>General</c:formatCode>
                <c:ptCount val="12"/>
                <c:pt idx="0">
                  <c:v>218.12483846153839</c:v>
                </c:pt>
                <c:pt idx="1">
                  <c:v>134.6307692307692</c:v>
                </c:pt>
                <c:pt idx="2">
                  <c:v>155.64615384615379</c:v>
                </c:pt>
                <c:pt idx="3">
                  <c:v>172.9769230769231</c:v>
                </c:pt>
                <c:pt idx="4">
                  <c:v>156.59230769230771</c:v>
                </c:pt>
                <c:pt idx="5">
                  <c:v>131.37692307692311</c:v>
                </c:pt>
                <c:pt idx="6">
                  <c:v>141.76923076923069</c:v>
                </c:pt>
                <c:pt idx="7">
                  <c:v>124.5846153846154</c:v>
                </c:pt>
                <c:pt idx="8">
                  <c:v>142.53333333333339</c:v>
                </c:pt>
                <c:pt idx="9" formatCode="0.000">
                  <c:v>167.2666666666667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4BA7-6A4E-A65D-626ABB091FDA}"/>
            </c:ext>
          </c:extLst>
        </c:ser>
        <c:ser>
          <c:idx val="2"/>
          <c:order val="2"/>
          <c:tx>
            <c:v>at1g75220</c:v>
          </c:tx>
          <c:spPr>
            <a:ln w="63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75220'!$K$29,'75220'!$K$57,'75220'!$K$85,'75220'!$K$113,'75220'!$K$141,'75220'!$K$169,'75220'!$K$197,'75220'!$K$225,'75220'!$K$253,'75220'!$K$276)</c:f>
                <c:numCache>
                  <c:formatCode>General</c:formatCode>
                  <c:ptCount val="10"/>
                  <c:pt idx="0">
                    <c:v>53.234515023089997</c:v>
                  </c:pt>
                  <c:pt idx="1">
                    <c:v>51.1872141988202</c:v>
                  </c:pt>
                  <c:pt idx="2">
                    <c:v>48.544028389779207</c:v>
                  </c:pt>
                  <c:pt idx="3">
                    <c:v>35.942676940387003</c:v>
                  </c:pt>
                  <c:pt idx="4">
                    <c:v>51.988975655840591</c:v>
                  </c:pt>
                  <c:pt idx="5">
                    <c:v>44.288965039188142</c:v>
                  </c:pt>
                  <c:pt idx="6">
                    <c:v>37.290091142767331</c:v>
                  </c:pt>
                  <c:pt idx="7">
                    <c:v>25.768120335814601</c:v>
                  </c:pt>
                  <c:pt idx="8">
                    <c:v>8.6309520525451529</c:v>
                  </c:pt>
                  <c:pt idx="9">
                    <c:v>55.04171145594939</c:v>
                  </c:pt>
                </c:numCache>
              </c:numRef>
            </c:plus>
            <c:minus>
              <c:numRef>
                <c:f>('75220'!$K$29,'75220'!$K$57,'75220'!$K$85,'75220'!$K$113,'75220'!$K$141,'75220'!$K$169,'75220'!$K$197,'75220'!$K$225,'75220'!$K$253,'75220'!$K$276)</c:f>
                <c:numCache>
                  <c:formatCode>General</c:formatCode>
                  <c:ptCount val="10"/>
                  <c:pt idx="0">
                    <c:v>53.234515023089997</c:v>
                  </c:pt>
                  <c:pt idx="1">
                    <c:v>51.1872141988202</c:v>
                  </c:pt>
                  <c:pt idx="2">
                    <c:v>48.544028389779207</c:v>
                  </c:pt>
                  <c:pt idx="3">
                    <c:v>35.942676940387003</c:v>
                  </c:pt>
                  <c:pt idx="4">
                    <c:v>51.988975655840591</c:v>
                  </c:pt>
                  <c:pt idx="5">
                    <c:v>44.288965039188142</c:v>
                  </c:pt>
                  <c:pt idx="6">
                    <c:v>37.290091142767331</c:v>
                  </c:pt>
                  <c:pt idx="7">
                    <c:v>25.768120335814601</c:v>
                  </c:pt>
                  <c:pt idx="8">
                    <c:v>8.6309520525451529</c:v>
                  </c:pt>
                  <c:pt idx="9">
                    <c:v>55.04171145594939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[1]Col0!$C$3,[1]Col0!$C$31,[1]Col0!$C$59,[1]Col0!$C$87,[1]Col0!$C$115,[1]Col0!$C$143,[1]Col0!$C$171,[1]Col0!$C$199,[1]Col0!$C$227,[1]Col0!$C$255,[1]Col0!$C$271,[1]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'75220'!$K$28,'75220'!$K$56,'75220'!$K$84,'75220'!$K$112,'75220'!$K$140,'75220'!$K$168,'75220'!$K$196,'75220'!$K$224,'75220'!$K$252,'75220'!$K$275,'75220'!$K$295,'75220'!$K$309)</c:f>
              <c:numCache>
                <c:formatCode>General</c:formatCode>
                <c:ptCount val="12"/>
                <c:pt idx="0">
                  <c:v>190.87692307692311</c:v>
                </c:pt>
                <c:pt idx="1">
                  <c:v>138.83846153846159</c:v>
                </c:pt>
                <c:pt idx="2">
                  <c:v>156.14615384615379</c:v>
                </c:pt>
                <c:pt idx="3">
                  <c:v>166.4538461538462</c:v>
                </c:pt>
                <c:pt idx="4">
                  <c:v>125.57692307692309</c:v>
                </c:pt>
                <c:pt idx="5">
                  <c:v>138.9166666666666</c:v>
                </c:pt>
                <c:pt idx="6">
                  <c:v>132.76153846153841</c:v>
                </c:pt>
                <c:pt idx="7">
                  <c:v>125.7538461538462</c:v>
                </c:pt>
                <c:pt idx="8">
                  <c:v>118.9666666666667</c:v>
                </c:pt>
                <c:pt idx="9" formatCode="0.000">
                  <c:v>169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4BA7-6A4E-A65D-626ABB091FDA}"/>
            </c:ext>
          </c:extLst>
        </c:ser>
        <c:ser>
          <c:idx val="3"/>
          <c:order val="3"/>
          <c:tx>
            <c:v>at3g04760</c:v>
          </c:tx>
          <c:spPr>
            <a:ln w="6350" cap="rnd">
              <a:solidFill>
                <a:schemeClr val="accent4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4760'!$K$29,'04760'!$K$57,'04760'!$K$85,'04760'!$K$113,'04760'!$K$141,'04760'!$K$169,'04760'!$K$197,'04760'!$K$225,'04760'!$K$253,'04760'!$K$276)</c:f>
                <c:numCache>
                  <c:formatCode>General</c:formatCode>
                  <c:ptCount val="10"/>
                  <c:pt idx="0">
                    <c:v>61.103756861293753</c:v>
                  </c:pt>
                  <c:pt idx="1">
                    <c:v>42.936292998001832</c:v>
                  </c:pt>
                  <c:pt idx="2">
                    <c:v>20.358202530095909</c:v>
                  </c:pt>
                  <c:pt idx="3">
                    <c:v>31.78685222476372</c:v>
                  </c:pt>
                  <c:pt idx="4">
                    <c:v>39.946225071161543</c:v>
                  </c:pt>
                  <c:pt idx="5">
                    <c:v>38.302132229594413</c:v>
                  </c:pt>
                  <c:pt idx="6">
                    <c:v>36.007235740070712</c:v>
                  </c:pt>
                  <c:pt idx="7">
                    <c:v>40.983981965857993</c:v>
                  </c:pt>
                  <c:pt idx="8">
                    <c:v>26.995511972671739</c:v>
                  </c:pt>
                  <c:pt idx="9">
                    <c:v>27.51259127329574</c:v>
                  </c:pt>
                </c:numCache>
              </c:numRef>
            </c:plus>
            <c:minus>
              <c:numRef>
                <c:f>('04760'!$K$29,'04760'!$K$57,'04760'!$K$85,'04760'!$K$113,'04760'!$K$141,'04760'!$K$169,'04760'!$K$197,'04760'!$K$225,'04760'!$K$253,'04760'!$K$276)</c:f>
                <c:numCache>
                  <c:formatCode>General</c:formatCode>
                  <c:ptCount val="10"/>
                  <c:pt idx="0">
                    <c:v>61.103756861293753</c:v>
                  </c:pt>
                  <c:pt idx="1">
                    <c:v>42.936292998001832</c:v>
                  </c:pt>
                  <c:pt idx="2">
                    <c:v>20.358202530095909</c:v>
                  </c:pt>
                  <c:pt idx="3">
                    <c:v>31.78685222476372</c:v>
                  </c:pt>
                  <c:pt idx="4">
                    <c:v>39.946225071161543</c:v>
                  </c:pt>
                  <c:pt idx="5">
                    <c:v>38.302132229594413</c:v>
                  </c:pt>
                  <c:pt idx="6">
                    <c:v>36.007235740070712</c:v>
                  </c:pt>
                  <c:pt idx="7">
                    <c:v>40.983981965857993</c:v>
                  </c:pt>
                  <c:pt idx="8">
                    <c:v>26.995511972671739</c:v>
                  </c:pt>
                  <c:pt idx="9">
                    <c:v>27.51259127329574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Col0!$C$3,Col0!$C$31,Col0!$C$59,Col0!$C$87,Col0!$C$115,Col0!$C$143,Col0!$C$171,Col0!$C$199,Col0!$C$227,Col0!$C$255,Col0!$C$271,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'04760'!$K$28,'04760'!$K$56,'04760'!$K$84,'04760'!$K$112,'04760'!$K$140,'04760'!$K$168,'04760'!$K$196,'04760'!$K$224,'04760'!$K$252,'04760'!$K$275,'04760'!$K$295,'04760'!$K$323)</c:f>
              <c:numCache>
                <c:formatCode>General</c:formatCode>
                <c:ptCount val="12"/>
                <c:pt idx="0">
                  <c:v>179.09230769230771</c:v>
                </c:pt>
                <c:pt idx="1">
                  <c:v>160.17692307692309</c:v>
                </c:pt>
                <c:pt idx="2">
                  <c:v>154.21538461538461</c:v>
                </c:pt>
                <c:pt idx="3">
                  <c:v>175.33076923076919</c:v>
                </c:pt>
                <c:pt idx="4">
                  <c:v>135.36153846153849</c:v>
                </c:pt>
                <c:pt idx="5">
                  <c:v>147.6</c:v>
                </c:pt>
                <c:pt idx="6">
                  <c:v>140.14615384615379</c:v>
                </c:pt>
                <c:pt idx="7">
                  <c:v>117.77</c:v>
                </c:pt>
                <c:pt idx="8">
                  <c:v>136.51666666666671</c:v>
                </c:pt>
                <c:pt idx="9" formatCode="0.000">
                  <c:v>116.5374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4BA7-6A4E-A65D-626ABB091F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13443368"/>
        <c:axId val="810844728"/>
      </c:scatterChart>
      <c:valAx>
        <c:axId val="813443368"/>
        <c:scaling>
          <c:orientation val="minMax"/>
          <c:max val="51"/>
          <c:min val="35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200" b="0" dirty="0" err="1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ys</a:t>
                </a:r>
                <a:r>
                  <a:rPr lang="fr-FR" sz="1200" b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post </a:t>
                </a:r>
                <a:r>
                  <a:rPr lang="fr-FR" sz="1200" b="0" dirty="0" err="1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owing</a:t>
                </a:r>
                <a:endParaRPr lang="fr-FR" sz="1200" b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5732821130474784"/>
              <c:y val="0.8246798834320783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10844728"/>
        <c:crosses val="autoZero"/>
        <c:crossBetween val="midCat"/>
        <c:majorUnit val="1"/>
      </c:valAx>
      <c:valAx>
        <c:axId val="810844728"/>
        <c:scaling>
          <c:orientation val="minMax"/>
          <c:max val="250"/>
          <c:min val="0"/>
        </c:scaling>
        <c:delete val="0"/>
        <c:axPos val="l"/>
        <c:majorGridlines>
          <c:spPr>
            <a:ln w="6350">
              <a:solidFill>
                <a:schemeClr val="bg1">
                  <a:lumMod val="85000"/>
                </a:schemeClr>
              </a:solidFill>
            </a:ln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fr-FR" sz="1200" b="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S (g/mol/cm</a:t>
                </a:r>
                <a:r>
                  <a:rPr lang="fr-FR" sz="1200" b="0" baseline="3000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fr-FR" sz="1200" b="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fr-FR" sz="1200" b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7.6893992858750298E-3"/>
              <c:y val="7.4769797688279585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13443368"/>
        <c:crossesAt val="0"/>
        <c:crossBetween val="midCat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353607866298845"/>
          <c:y val="0.15255482456140401"/>
          <c:w val="0.78236651756322662"/>
          <c:h val="0.706736842105263"/>
        </c:manualLayout>
      </c:layout>
      <c:scatterChart>
        <c:scatterStyle val="lineMarker"/>
        <c:varyColors val="0"/>
        <c:ser>
          <c:idx val="0"/>
          <c:order val="0"/>
          <c:tx>
            <c:v>Col0</c:v>
          </c:tx>
          <c:spPr>
            <a:ln w="63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Col0!$E$29,Col0!$E$57,Col0!$E$85,Col0!$E$113,Col0!$E$141,Col0!$E$169,Col0!$E$197,Col0!$E$225,Col0!$E$253,Col0!$E$269,Col0!$E$285,Col0!$E$313)</c:f>
                <c:numCache>
                  <c:formatCode>General</c:formatCode>
                  <c:ptCount val="12"/>
                  <c:pt idx="0">
                    <c:v>6.5679597469910894E-2</c:v>
                  </c:pt>
                  <c:pt idx="1">
                    <c:v>8.8626718533946006E-2</c:v>
                  </c:pt>
                  <c:pt idx="2">
                    <c:v>0.24853998432752</c:v>
                  </c:pt>
                  <c:pt idx="3">
                    <c:v>0.23182160628996001</c:v>
                  </c:pt>
                  <c:pt idx="4">
                    <c:v>0.41889051871183203</c:v>
                  </c:pt>
                  <c:pt idx="5">
                    <c:v>0.39532653170090398</c:v>
                  </c:pt>
                  <c:pt idx="6">
                    <c:v>0.34086316204320999</c:v>
                  </c:pt>
                  <c:pt idx="7">
                    <c:v>0.32320976529330497</c:v>
                  </c:pt>
                  <c:pt idx="8">
                    <c:v>0.49458022605033403</c:v>
                  </c:pt>
                  <c:pt idx="11">
                    <c:v>0.32272480877335702</c:v>
                  </c:pt>
                </c:numCache>
              </c:numRef>
            </c:plus>
            <c:minus>
              <c:numRef>
                <c:f>(Col0!$E$29,Col0!$E$57,Col0!$E$85,Col0!$E$113,Col0!$E$141,Col0!$E$169,Col0!$E$197,Col0!$E$225,Col0!$E$253,Col0!$E$269,Col0!$E$285,Col0!$E$313)</c:f>
                <c:numCache>
                  <c:formatCode>General</c:formatCode>
                  <c:ptCount val="12"/>
                  <c:pt idx="0">
                    <c:v>6.5679597469910894E-2</c:v>
                  </c:pt>
                  <c:pt idx="1">
                    <c:v>8.8626718533946006E-2</c:v>
                  </c:pt>
                  <c:pt idx="2">
                    <c:v>0.24853998432752</c:v>
                  </c:pt>
                  <c:pt idx="3">
                    <c:v>0.23182160628996001</c:v>
                  </c:pt>
                  <c:pt idx="4">
                    <c:v>0.41889051871183203</c:v>
                  </c:pt>
                  <c:pt idx="5">
                    <c:v>0.39532653170090398</c:v>
                  </c:pt>
                  <c:pt idx="6">
                    <c:v>0.34086316204320999</c:v>
                  </c:pt>
                  <c:pt idx="7">
                    <c:v>0.32320976529330497</c:v>
                  </c:pt>
                  <c:pt idx="8">
                    <c:v>0.49458022605033403</c:v>
                  </c:pt>
                  <c:pt idx="11">
                    <c:v>0.3227248087733570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Col0!$C$3,Col0!$C$31,Col0!$C$59,Col0!$C$87,Col0!$C$115,Col0!$C$143,Col0!$C$171,Col0!$C$199,Col0!$C$227,Col0!$C$255,Col0!$C$271,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Col0!$E$28,Col0!$E$56,Col0!$E$84,Col0!$E$112,Col0!$E$140,Col0!$E$168,Col0!$E$196,Col0!$E$224,Col0!$E$252,Col0!$E$268,Col0!$E$284,Col0!$E$312)</c:f>
              <c:numCache>
                <c:formatCode>0.000</c:formatCode>
                <c:ptCount val="12"/>
                <c:pt idx="0">
                  <c:v>0.230333333333333</c:v>
                </c:pt>
                <c:pt idx="1">
                  <c:v>0.44613333333333299</c:v>
                </c:pt>
                <c:pt idx="2">
                  <c:v>0.74786666666666701</c:v>
                </c:pt>
                <c:pt idx="3">
                  <c:v>0.91239999999999999</c:v>
                </c:pt>
                <c:pt idx="4">
                  <c:v>1.1151333333333331</c:v>
                </c:pt>
                <c:pt idx="5">
                  <c:v>1.4740666666666671</c:v>
                </c:pt>
                <c:pt idx="6">
                  <c:v>1.573466666666667</c:v>
                </c:pt>
                <c:pt idx="7">
                  <c:v>1.862533333333334</c:v>
                </c:pt>
                <c:pt idx="8">
                  <c:v>2.0402</c:v>
                </c:pt>
                <c:pt idx="9">
                  <c:v>2.3471000000000002</c:v>
                </c:pt>
                <c:pt idx="10">
                  <c:v>2.6305999999999989</c:v>
                </c:pt>
                <c:pt idx="11">
                  <c:v>2.698928571428571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8C2-C94E-9A0B-9F3C10849388}"/>
            </c:ext>
          </c:extLst>
        </c:ser>
        <c:ser>
          <c:idx val="1"/>
          <c:order val="1"/>
          <c:tx>
            <c:v>at1g08920</c:v>
          </c:tx>
          <c:spPr>
            <a:ln w="6350" cap="rnd">
              <a:solidFill>
                <a:schemeClr val="accent2"/>
              </a:solidFill>
              <a:round/>
            </a:ln>
            <a:effectLst/>
          </c:spPr>
          <c:marker>
            <c:symbol val="x"/>
            <c:size val="4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8920'!$E$29,'08920'!$E$57,'08920'!$E$85,'08920'!$E$113,'08920'!$E$141,'08920'!$E$169,'08920'!$E$197,'08920'!$E$225,'08920'!$E$253,'08920'!$E$276,'08920'!$E$299,'08920'!$E$327)</c:f>
                <c:numCache>
                  <c:formatCode>General</c:formatCode>
                  <c:ptCount val="12"/>
                  <c:pt idx="0">
                    <c:v>3.8201470926554397E-2</c:v>
                  </c:pt>
                  <c:pt idx="1">
                    <c:v>0.118513531475765</c:v>
                  </c:pt>
                  <c:pt idx="2">
                    <c:v>0.235994693241384</c:v>
                  </c:pt>
                  <c:pt idx="3">
                    <c:v>0.30661415181827101</c:v>
                  </c:pt>
                  <c:pt idx="4">
                    <c:v>0.19088922242519299</c:v>
                  </c:pt>
                  <c:pt idx="5">
                    <c:v>0.21780904699387599</c:v>
                  </c:pt>
                  <c:pt idx="6">
                    <c:v>0.30885106597255202</c:v>
                  </c:pt>
                  <c:pt idx="7">
                    <c:v>0.337453164298749</c:v>
                  </c:pt>
                  <c:pt idx="8">
                    <c:v>0.41411952495913501</c:v>
                  </c:pt>
                  <c:pt idx="9">
                    <c:v>0.47812817568194999</c:v>
                  </c:pt>
                  <c:pt idx="10">
                    <c:v>0.543518755973737</c:v>
                  </c:pt>
                  <c:pt idx="11">
                    <c:v>0.339359200061918</c:v>
                  </c:pt>
                </c:numCache>
              </c:numRef>
            </c:plus>
            <c:minus>
              <c:numRef>
                <c:f>('08920'!$E$29,'08920'!$E$57,'08920'!$E$85,'08920'!$E$113,'08920'!$E$141,'08920'!$E$169,'08920'!$E$197,'08920'!$E$225,'08920'!$E$253,'08920'!$E$276,'08920'!$E$299,'08920'!$E$327)</c:f>
                <c:numCache>
                  <c:formatCode>General</c:formatCode>
                  <c:ptCount val="12"/>
                  <c:pt idx="0">
                    <c:v>3.8201470926554397E-2</c:v>
                  </c:pt>
                  <c:pt idx="1">
                    <c:v>0.118513531475765</c:v>
                  </c:pt>
                  <c:pt idx="2">
                    <c:v>0.235994693241384</c:v>
                  </c:pt>
                  <c:pt idx="3">
                    <c:v>0.30661415181827101</c:v>
                  </c:pt>
                  <c:pt idx="4">
                    <c:v>0.19088922242519299</c:v>
                  </c:pt>
                  <c:pt idx="5">
                    <c:v>0.21780904699387599</c:v>
                  </c:pt>
                  <c:pt idx="6">
                    <c:v>0.30885106597255202</c:v>
                  </c:pt>
                  <c:pt idx="7">
                    <c:v>0.337453164298749</c:v>
                  </c:pt>
                  <c:pt idx="8">
                    <c:v>0.41411952495913501</c:v>
                  </c:pt>
                  <c:pt idx="9">
                    <c:v>0.47812817568194999</c:v>
                  </c:pt>
                  <c:pt idx="10">
                    <c:v>0.543518755973737</c:v>
                  </c:pt>
                  <c:pt idx="11">
                    <c:v>0.339359200061918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Col0!$C$3,Col0!$C$31,Col0!$C$59,Col0!$C$87,Col0!$C$115,Col0!$C$143,Col0!$C$171,Col0!$C$199,Col0!$C$227,Col0!$C$255,Col0!$C$271,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'08920'!$E$28,'08920'!$E$56,'08920'!$E$84,'08920'!$E$112,'08920'!$E$140,'08920'!$E$168,'08920'!$E$196,'08920'!$E$224,'08920'!$E$252,'08920'!$E$275,'08920'!$E$298,'08920'!$E$326)</c:f>
              <c:numCache>
                <c:formatCode>0.000</c:formatCode>
                <c:ptCount val="12"/>
                <c:pt idx="0">
                  <c:v>0.227066666666667</c:v>
                </c:pt>
                <c:pt idx="1">
                  <c:v>0.44119999999999998</c:v>
                </c:pt>
                <c:pt idx="2">
                  <c:v>0.73006666666666697</c:v>
                </c:pt>
                <c:pt idx="3">
                  <c:v>0.88933333333333298</c:v>
                </c:pt>
                <c:pt idx="4">
                  <c:v>1.1474666666666671</c:v>
                </c:pt>
                <c:pt idx="5">
                  <c:v>1.3462666666666669</c:v>
                </c:pt>
                <c:pt idx="6">
                  <c:v>1.4595333333333329</c:v>
                </c:pt>
                <c:pt idx="7">
                  <c:v>1.6247333333333329</c:v>
                </c:pt>
                <c:pt idx="8">
                  <c:v>1.967466666666666</c:v>
                </c:pt>
                <c:pt idx="9">
                  <c:v>2.4825333333333339</c:v>
                </c:pt>
                <c:pt idx="10">
                  <c:v>2.3289333333333331</c:v>
                </c:pt>
                <c:pt idx="11">
                  <c:v>2.839333333333334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D8C2-C94E-9A0B-9F3C10849388}"/>
            </c:ext>
          </c:extLst>
        </c:ser>
        <c:ser>
          <c:idx val="2"/>
          <c:order val="2"/>
          <c:tx>
            <c:v>at1g75220</c:v>
          </c:tx>
          <c:spPr>
            <a:ln w="6350" cap="rnd">
              <a:solidFill>
                <a:schemeClr val="accent3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75220'!$E$29,'75220'!$E$57,'75220'!$E$85,'75220'!$E$113,'75220'!$E$141,'75220'!$E$169,'75220'!$E$197,'75220'!$E$225,'75220'!$E$253,'75220'!$E$276,'75220'!$E$299,'75220'!$E$327)</c:f>
                <c:numCache>
                  <c:formatCode>General</c:formatCode>
                  <c:ptCount val="12"/>
                  <c:pt idx="0">
                    <c:v>8.9996719516933096E-2</c:v>
                  </c:pt>
                  <c:pt idx="1">
                    <c:v>0.132067515201235</c:v>
                  </c:pt>
                  <c:pt idx="2">
                    <c:v>0.232786986217832</c:v>
                  </c:pt>
                  <c:pt idx="3">
                    <c:v>0.30675571170993099</c:v>
                  </c:pt>
                  <c:pt idx="4">
                    <c:v>0.40145657418004899</c:v>
                  </c:pt>
                  <c:pt idx="5">
                    <c:v>0.34233564704555097</c:v>
                  </c:pt>
                  <c:pt idx="6">
                    <c:v>0.46366197662891101</c:v>
                  </c:pt>
                  <c:pt idx="7">
                    <c:v>0.529181641332927</c:v>
                  </c:pt>
                  <c:pt idx="8">
                    <c:v>0.63226529995232905</c:v>
                  </c:pt>
                  <c:pt idx="9">
                    <c:v>0.65602687227190404</c:v>
                  </c:pt>
                  <c:pt idx="10">
                    <c:v>0.80429840470407699</c:v>
                  </c:pt>
                  <c:pt idx="11">
                    <c:v>0.97669283078882296</c:v>
                  </c:pt>
                </c:numCache>
              </c:numRef>
            </c:plus>
            <c:minus>
              <c:numRef>
                <c:f>('75220'!$E$29,'75220'!$E$57,'75220'!$E$85,'75220'!$E$113,'75220'!$E$141,'75220'!$E$169,'75220'!$E$197,'75220'!$E$225,'75220'!$E$253,'75220'!$E$276,'75220'!$E$299,'75220'!$E$327)</c:f>
                <c:numCache>
                  <c:formatCode>General</c:formatCode>
                  <c:ptCount val="12"/>
                  <c:pt idx="0">
                    <c:v>8.9996719516933096E-2</c:v>
                  </c:pt>
                  <c:pt idx="1">
                    <c:v>0.132067515201235</c:v>
                  </c:pt>
                  <c:pt idx="2">
                    <c:v>0.232786986217832</c:v>
                  </c:pt>
                  <c:pt idx="3">
                    <c:v>0.30675571170993099</c:v>
                  </c:pt>
                  <c:pt idx="4">
                    <c:v>0.40145657418004899</c:v>
                  </c:pt>
                  <c:pt idx="5">
                    <c:v>0.34233564704555097</c:v>
                  </c:pt>
                  <c:pt idx="6">
                    <c:v>0.46366197662891101</c:v>
                  </c:pt>
                  <c:pt idx="7">
                    <c:v>0.529181641332927</c:v>
                  </c:pt>
                  <c:pt idx="8">
                    <c:v>0.63226529995232905</c:v>
                  </c:pt>
                  <c:pt idx="9">
                    <c:v>0.65602687227190404</c:v>
                  </c:pt>
                  <c:pt idx="10">
                    <c:v>0.80429840470407699</c:v>
                  </c:pt>
                  <c:pt idx="11">
                    <c:v>0.97669283078882296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[1]Col0!$C$3,[1]Col0!$C$31,[1]Col0!$C$59,[1]Col0!$C$87,[1]Col0!$C$115,[1]Col0!$C$143,[1]Col0!$C$171,[1]Col0!$C$199,[1]Col0!$C$227,[1]Col0!$C$255,[1]Col0!$C$271,[1]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'75220'!$E$28,'75220'!$E$56,'75220'!$E$84,'75220'!$E$112,'75220'!$E$140,'75220'!$E$168,'75220'!$E$196,'75220'!$E$224,'75220'!$E$252,'75220'!$E$275,'75220'!$E$298,'75220'!$E$326)</c:f>
              <c:numCache>
                <c:formatCode>0.000</c:formatCode>
                <c:ptCount val="12"/>
                <c:pt idx="0">
                  <c:v>0.205866666666667</c:v>
                </c:pt>
                <c:pt idx="1">
                  <c:v>0.3614</c:v>
                </c:pt>
                <c:pt idx="2">
                  <c:v>0.61526666666666696</c:v>
                </c:pt>
                <c:pt idx="3">
                  <c:v>0.91726666666666701</c:v>
                </c:pt>
                <c:pt idx="4">
                  <c:v>1.062666666666666</c:v>
                </c:pt>
                <c:pt idx="5">
                  <c:v>1.2994666666666661</c:v>
                </c:pt>
                <c:pt idx="6">
                  <c:v>1.3919999999999999</c:v>
                </c:pt>
                <c:pt idx="7">
                  <c:v>1.618066666666667</c:v>
                </c:pt>
                <c:pt idx="8">
                  <c:v>1.7671333333333341</c:v>
                </c:pt>
                <c:pt idx="9">
                  <c:v>2.1474000000000002</c:v>
                </c:pt>
                <c:pt idx="10">
                  <c:v>2.1930666666666672</c:v>
                </c:pt>
                <c:pt idx="11">
                  <c:v>2.2511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D8C2-C94E-9A0B-9F3C10849388}"/>
            </c:ext>
          </c:extLst>
        </c:ser>
        <c:ser>
          <c:idx val="3"/>
          <c:order val="3"/>
          <c:tx>
            <c:v>at3g04760</c:v>
          </c:tx>
          <c:spPr>
            <a:ln w="6350" cap="rnd">
              <a:solidFill>
                <a:schemeClr val="accent4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4760'!$E$29,'04760'!$E$57,'04760'!$E$85,'04760'!$E$113,'04760'!$E$141,'04760'!$E$169,'04760'!$E$197,'04760'!$E$225,'04760'!$E$253,'04760'!$E$276,'04760'!$E$299,'04760'!$E$327)</c:f>
                <c:numCache>
                  <c:formatCode>General</c:formatCode>
                  <c:ptCount val="12"/>
                  <c:pt idx="0">
                    <c:v>5.58741783789597E-2</c:v>
                  </c:pt>
                  <c:pt idx="1">
                    <c:v>0.13485328888762599</c:v>
                  </c:pt>
                  <c:pt idx="2">
                    <c:v>0.27750516082717103</c:v>
                  </c:pt>
                  <c:pt idx="3">
                    <c:v>0.24271494156137699</c:v>
                  </c:pt>
                  <c:pt idx="4">
                    <c:v>0.18172800187826399</c:v>
                  </c:pt>
                  <c:pt idx="5">
                    <c:v>0.236784710735502</c:v>
                  </c:pt>
                  <c:pt idx="6">
                    <c:v>0.40101154240602299</c:v>
                  </c:pt>
                  <c:pt idx="7">
                    <c:v>0.42358959247972899</c:v>
                  </c:pt>
                  <c:pt idx="8">
                    <c:v>0.48461902562734799</c:v>
                  </c:pt>
                  <c:pt idx="9">
                    <c:v>0.49507198129834301</c:v>
                  </c:pt>
                  <c:pt idx="10">
                    <c:v>0.66359004125826204</c:v>
                  </c:pt>
                  <c:pt idx="11">
                    <c:v>0.84314819914074901</c:v>
                  </c:pt>
                </c:numCache>
              </c:numRef>
            </c:plus>
            <c:minus>
              <c:numRef>
                <c:f>('04760'!$E$29,'04760'!$E$57,'04760'!$E$85,'04760'!$E$113,'04760'!$E$141,'04760'!$E$169,'04760'!$E$197,'04760'!$E$225,'04760'!$E$253,'04760'!$E$276,'04760'!$E$299,'04760'!$E$327)</c:f>
                <c:numCache>
                  <c:formatCode>General</c:formatCode>
                  <c:ptCount val="12"/>
                  <c:pt idx="0">
                    <c:v>5.58741783789597E-2</c:v>
                  </c:pt>
                  <c:pt idx="1">
                    <c:v>0.13485328888762599</c:v>
                  </c:pt>
                  <c:pt idx="2">
                    <c:v>0.27750516082717103</c:v>
                  </c:pt>
                  <c:pt idx="3">
                    <c:v>0.24271494156137699</c:v>
                  </c:pt>
                  <c:pt idx="4">
                    <c:v>0.18172800187826399</c:v>
                  </c:pt>
                  <c:pt idx="5">
                    <c:v>0.236784710735502</c:v>
                  </c:pt>
                  <c:pt idx="6">
                    <c:v>0.40101154240602299</c:v>
                  </c:pt>
                  <c:pt idx="7">
                    <c:v>0.42358959247972899</c:v>
                  </c:pt>
                  <c:pt idx="8">
                    <c:v>0.48461902562734799</c:v>
                  </c:pt>
                  <c:pt idx="9">
                    <c:v>0.49507198129834301</c:v>
                  </c:pt>
                  <c:pt idx="10">
                    <c:v>0.66359004125826204</c:v>
                  </c:pt>
                  <c:pt idx="11">
                    <c:v>0.84314819914074901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Col0!$C$3,Col0!$C$31,Col0!$C$59,Col0!$C$87,Col0!$C$115,Col0!$C$143,Col0!$C$171,Col0!$C$199,Col0!$C$227,Col0!$C$255,Col0!$C$271,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'04760'!$E$28,'04760'!$E$56,'04760'!$E$84,'04760'!$E$112,'04760'!$E$140,'04760'!$E$168,'04760'!$E$196,'04760'!$E$224,'04760'!$E$252,'04760'!$E$275,'04760'!$E$298,'04760'!$E$326)</c:f>
              <c:numCache>
                <c:formatCode>0.000</c:formatCode>
                <c:ptCount val="12"/>
                <c:pt idx="0">
                  <c:v>0.16873333333333301</c:v>
                </c:pt>
                <c:pt idx="1">
                  <c:v>0.35513333333333302</c:v>
                </c:pt>
                <c:pt idx="2">
                  <c:v>0.59840000000000004</c:v>
                </c:pt>
                <c:pt idx="3">
                  <c:v>0.71460000000000001</c:v>
                </c:pt>
                <c:pt idx="4">
                  <c:v>0.88693333333333402</c:v>
                </c:pt>
                <c:pt idx="5">
                  <c:v>0.907893333333333</c:v>
                </c:pt>
                <c:pt idx="6">
                  <c:v>1.2254</c:v>
                </c:pt>
                <c:pt idx="7">
                  <c:v>1.4630000000000001</c:v>
                </c:pt>
                <c:pt idx="8">
                  <c:v>1.7622</c:v>
                </c:pt>
                <c:pt idx="9">
                  <c:v>2.0064666666666668</c:v>
                </c:pt>
                <c:pt idx="10">
                  <c:v>1.9672000000000001</c:v>
                </c:pt>
                <c:pt idx="11">
                  <c:v>2.294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D8C2-C94E-9A0B-9F3C1084938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01485160"/>
        <c:axId val="621246840"/>
      </c:scatterChart>
      <c:valAx>
        <c:axId val="801485160"/>
        <c:scaling>
          <c:orientation val="minMax"/>
          <c:max val="51"/>
          <c:min val="35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621246840"/>
        <c:crosses val="autoZero"/>
        <c:crossBetween val="midCat"/>
        <c:majorUnit val="1"/>
      </c:valAx>
      <c:valAx>
        <c:axId val="621246840"/>
        <c:scaling>
          <c:orientation val="minMax"/>
          <c:max val="4"/>
          <c:min val="0"/>
        </c:scaling>
        <c:delete val="0"/>
        <c:axPos val="l"/>
        <c:majorGridlines>
          <c:spPr>
            <a:ln w="6350">
              <a:solidFill>
                <a:schemeClr val="bg1">
                  <a:lumMod val="85000"/>
                </a:schemeClr>
              </a:solidFill>
            </a:ln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fr-FR" sz="1200" b="0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W (g)</a:t>
                </a:r>
                <a:endParaRPr lang="fr-FR" sz="1200" b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2.4694121927042907E-3"/>
              <c:y val="0.3064660500687750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01485160"/>
        <c:crossesAt val="0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161335981594644"/>
          <c:y val="0.15255482456140401"/>
          <c:w val="0.79565692305810332"/>
          <c:h val="0.706736842105263"/>
        </c:manualLayout>
      </c:layout>
      <c:scatterChart>
        <c:scatterStyle val="lineMarker"/>
        <c:varyColors val="0"/>
        <c:ser>
          <c:idx val="0"/>
          <c:order val="0"/>
          <c:tx>
            <c:v>Col0</c:v>
          </c:tx>
          <c:spPr>
            <a:ln w="63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Col0!$K$29,Col0!$K$57,Col0!$K$85,Col0!$K$113,Col0!$K$141,Col0!$K$169,Col0!$K$197,Col0!$K$225,Col0!$K$253,Col0!$K$269,Col0!$K$285,Col0!$K$313)</c:f>
                <c:numCache>
                  <c:formatCode>General</c:formatCode>
                  <c:ptCount val="12"/>
                  <c:pt idx="0">
                    <c:v>3.2118202741878652</c:v>
                  </c:pt>
                  <c:pt idx="1">
                    <c:v>5.5295854988844884</c:v>
                  </c:pt>
                  <c:pt idx="2">
                    <c:v>8.9846360087944745</c:v>
                  </c:pt>
                  <c:pt idx="3">
                    <c:v>10.388083591392331</c:v>
                  </c:pt>
                  <c:pt idx="4">
                    <c:v>9.9387598506262904</c:v>
                  </c:pt>
                  <c:pt idx="5">
                    <c:v>10.2412992596797</c:v>
                  </c:pt>
                  <c:pt idx="6">
                    <c:v>11.344370270848231</c:v>
                  </c:pt>
                  <c:pt idx="7">
                    <c:v>11.93579314058085</c:v>
                  </c:pt>
                  <c:pt idx="8">
                    <c:v>12.58351051344995</c:v>
                  </c:pt>
                  <c:pt idx="11">
                    <c:v>14.10962717251482</c:v>
                  </c:pt>
                </c:numCache>
              </c:numRef>
            </c:plus>
            <c:minus>
              <c:numRef>
                <c:f>(Col0!$K$29,Col0!$K$57,Col0!$K$85,Col0!$K$113,Col0!$K$141,Col0!$K$169,Col0!$K$197,Col0!$K$225,Col0!$K$253,Col0!$K$269,Col0!$K$285,Col0!$K$313)</c:f>
                <c:numCache>
                  <c:formatCode>General</c:formatCode>
                  <c:ptCount val="12"/>
                  <c:pt idx="0">
                    <c:v>3.2118202741878652</c:v>
                  </c:pt>
                  <c:pt idx="1">
                    <c:v>5.5295854988844884</c:v>
                  </c:pt>
                  <c:pt idx="2">
                    <c:v>8.9846360087944745</c:v>
                  </c:pt>
                  <c:pt idx="3">
                    <c:v>10.388083591392331</c:v>
                  </c:pt>
                  <c:pt idx="4">
                    <c:v>9.9387598506262904</c:v>
                  </c:pt>
                  <c:pt idx="5">
                    <c:v>10.2412992596797</c:v>
                  </c:pt>
                  <c:pt idx="6">
                    <c:v>11.344370270848231</c:v>
                  </c:pt>
                  <c:pt idx="7">
                    <c:v>11.93579314058085</c:v>
                  </c:pt>
                  <c:pt idx="8">
                    <c:v>12.58351051344995</c:v>
                  </c:pt>
                  <c:pt idx="11">
                    <c:v>14.109627172514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(Col0!$C$3,Col0!$C$31,Col0!$C$59,Col0!$C$87,Col0!$C$115,Col0!$C$143,Col0!$C$171,Col0!$C$199,Col0!$C$227,Col0!$C$255,Col0!$C$271,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Col0!$K$28,Col0!$K$56,Col0!$K$84,Col0!$K$112,Col0!$K$140,Col0!$K$168,Col0!$K$196,Col0!$K$224,Col0!$K$252,Col0!$K$268,Col0!$K$284,Col0!$K$312)</c:f>
              <c:numCache>
                <c:formatCode>General</c:formatCode>
                <c:ptCount val="12"/>
                <c:pt idx="0">
                  <c:v>11</c:v>
                </c:pt>
                <c:pt idx="1">
                  <c:v>17.45</c:v>
                </c:pt>
                <c:pt idx="2">
                  <c:v>28.25</c:v>
                </c:pt>
                <c:pt idx="3">
                  <c:v>31.368421052631579</c:v>
                </c:pt>
                <c:pt idx="4">
                  <c:v>34.6</c:v>
                </c:pt>
                <c:pt idx="5">
                  <c:v>37.6</c:v>
                </c:pt>
                <c:pt idx="6">
                  <c:v>42.8</c:v>
                </c:pt>
                <c:pt idx="7">
                  <c:v>47.4</c:v>
                </c:pt>
                <c:pt idx="8">
                  <c:v>52.15</c:v>
                </c:pt>
                <c:pt idx="9">
                  <c:v>51.5</c:v>
                </c:pt>
                <c:pt idx="10">
                  <c:v>54.8</c:v>
                </c:pt>
                <c:pt idx="11">
                  <c:v>66.1500000000000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EDD-7740-9274-A54D00729E5D}"/>
            </c:ext>
          </c:extLst>
        </c:ser>
        <c:ser>
          <c:idx val="1"/>
          <c:order val="1"/>
          <c:tx>
            <c:v>at1g08920</c:v>
          </c:tx>
          <c:spPr>
            <a:ln w="6350" cap="rnd">
              <a:solidFill>
                <a:schemeClr val="accent2"/>
              </a:solidFill>
              <a:round/>
            </a:ln>
            <a:effectLst/>
          </c:spPr>
          <c:marker>
            <c:symbol val="x"/>
            <c:size val="4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8920'!$J$29,'08920'!$J$57,'08920'!$J$85,'08920'!$J$113,'08920'!$J$141,'08920'!$J$169,'08920'!$J$197,'08920'!$J$225,'08920'!$J$253,'08920'!$J$276,'08920'!$J$299,'08920'!$J$327)</c:f>
                <c:numCache>
                  <c:formatCode>General</c:formatCode>
                  <c:ptCount val="12"/>
                  <c:pt idx="0">
                    <c:v>2.8999178970315338</c:v>
                  </c:pt>
                  <c:pt idx="1">
                    <c:v>6.2449979983983974</c:v>
                  </c:pt>
                  <c:pt idx="2">
                    <c:v>8.6475980700395798</c:v>
                  </c:pt>
                  <c:pt idx="3">
                    <c:v>9.9847502770594208</c:v>
                  </c:pt>
                  <c:pt idx="4">
                    <c:v>8.4953768940188095</c:v>
                  </c:pt>
                  <c:pt idx="5">
                    <c:v>12.299825782738321</c:v>
                  </c:pt>
                  <c:pt idx="6">
                    <c:v>11.88155833935215</c:v>
                  </c:pt>
                  <c:pt idx="7">
                    <c:v>12.82185633985968</c:v>
                  </c:pt>
                  <c:pt idx="8">
                    <c:v>10.86584863996673</c:v>
                  </c:pt>
                  <c:pt idx="9">
                    <c:v>12.959785644679631</c:v>
                  </c:pt>
                  <c:pt idx="10">
                    <c:v>16.383208593237281</c:v>
                  </c:pt>
                  <c:pt idx="11">
                    <c:v>15.88627163224986</c:v>
                  </c:pt>
                </c:numCache>
              </c:numRef>
            </c:plus>
            <c:minus>
              <c:numRef>
                <c:f>('08920'!$J$29,'08920'!$J$57,'08920'!$J$85,'08920'!$J$113,'08920'!$J$141,'08920'!$J$169,'08920'!$J$197,'08920'!$J$225,'08920'!$J$253,'08920'!$J$276,'08920'!$J$299,'08920'!$J$327)</c:f>
                <c:numCache>
                  <c:formatCode>General</c:formatCode>
                  <c:ptCount val="12"/>
                  <c:pt idx="0">
                    <c:v>2.8999178970315338</c:v>
                  </c:pt>
                  <c:pt idx="1">
                    <c:v>6.2449979983983974</c:v>
                  </c:pt>
                  <c:pt idx="2">
                    <c:v>8.6475980700395798</c:v>
                  </c:pt>
                  <c:pt idx="3">
                    <c:v>9.9847502770594208</c:v>
                  </c:pt>
                  <c:pt idx="4">
                    <c:v>8.4953768940188095</c:v>
                  </c:pt>
                  <c:pt idx="5">
                    <c:v>12.299825782738321</c:v>
                  </c:pt>
                  <c:pt idx="6">
                    <c:v>11.88155833935215</c:v>
                  </c:pt>
                  <c:pt idx="7">
                    <c:v>12.82185633985968</c:v>
                  </c:pt>
                  <c:pt idx="8">
                    <c:v>10.86584863996673</c:v>
                  </c:pt>
                  <c:pt idx="9">
                    <c:v>12.959785644679631</c:v>
                  </c:pt>
                  <c:pt idx="10">
                    <c:v>16.383208593237281</c:v>
                  </c:pt>
                  <c:pt idx="11">
                    <c:v>15.88627163224986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Col0!$C$3,Col0!$C$31,Col0!$C$59,Col0!$C$87,Col0!$C$115,Col0!$C$143,Col0!$C$171,Col0!$C$199,Col0!$C$227,Col0!$C$255,Col0!$C$271,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'08920'!$J$28,'08920'!$J$56,'08920'!$J$84,'08920'!$J$112,'08920'!$J$140,'08920'!$J$168,'08920'!$J$196,'08920'!$J$224,'08920'!$J$252,'08920'!$J$275,'08920'!$J$298,'08920'!$J$326)</c:f>
              <c:numCache>
                <c:formatCode>General</c:formatCode>
                <c:ptCount val="12"/>
                <c:pt idx="0">
                  <c:v>14.46666666666667</c:v>
                </c:pt>
                <c:pt idx="1">
                  <c:v>22</c:v>
                </c:pt>
                <c:pt idx="2">
                  <c:v>34.733333333333341</c:v>
                </c:pt>
                <c:pt idx="3">
                  <c:v>38.866666666666553</c:v>
                </c:pt>
                <c:pt idx="4">
                  <c:v>41.2</c:v>
                </c:pt>
                <c:pt idx="5">
                  <c:v>48</c:v>
                </c:pt>
                <c:pt idx="6">
                  <c:v>52.8</c:v>
                </c:pt>
                <c:pt idx="7">
                  <c:v>59.4</c:v>
                </c:pt>
                <c:pt idx="8">
                  <c:v>60.26666666666658</c:v>
                </c:pt>
                <c:pt idx="9" formatCode="0.000">
                  <c:v>66.428571428571345</c:v>
                </c:pt>
                <c:pt idx="10" formatCode="0.000">
                  <c:v>76.133333333333255</c:v>
                </c:pt>
                <c:pt idx="11">
                  <c:v>77.71428571428572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4EDD-7740-9274-A54D00729E5D}"/>
            </c:ext>
          </c:extLst>
        </c:ser>
        <c:ser>
          <c:idx val="2"/>
          <c:order val="2"/>
          <c:tx>
            <c:v>at1g75220</c:v>
          </c:tx>
          <c:spPr>
            <a:ln w="6350" cap="rnd">
              <a:solidFill>
                <a:schemeClr val="accent3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75220'!$J$29,'75220'!$J$57,'75220'!$J$85,'75220'!$J$113,'75220'!$J$141,'75220'!$J$169,'75220'!$J$197,'75220'!$J$225,'75220'!$J$253,'75220'!$J$276,'75220'!$J$299,'75220'!$J$327)</c:f>
                <c:numCache>
                  <c:formatCode>General</c:formatCode>
                  <c:ptCount val="12"/>
                  <c:pt idx="0">
                    <c:v>4.2054386555642784</c:v>
                  </c:pt>
                  <c:pt idx="1">
                    <c:v>8.5821818993683792</c:v>
                  </c:pt>
                  <c:pt idx="2">
                    <c:v>9.7575367695706827</c:v>
                  </c:pt>
                  <c:pt idx="3">
                    <c:v>11.94909839196885</c:v>
                  </c:pt>
                  <c:pt idx="4">
                    <c:v>11.308656608356021</c:v>
                  </c:pt>
                  <c:pt idx="5">
                    <c:v>13.48967859407438</c:v>
                  </c:pt>
                  <c:pt idx="6">
                    <c:v>14.316158037419861</c:v>
                  </c:pt>
                  <c:pt idx="7">
                    <c:v>16.272091211056811</c:v>
                  </c:pt>
                  <c:pt idx="8">
                    <c:v>17.212398631993921</c:v>
                  </c:pt>
                  <c:pt idx="9">
                    <c:v>15.154878081671569</c:v>
                  </c:pt>
                  <c:pt idx="10">
                    <c:v>15.93229723668547</c:v>
                  </c:pt>
                  <c:pt idx="11">
                    <c:v>17.773174007073521</c:v>
                  </c:pt>
                </c:numCache>
              </c:numRef>
            </c:plus>
            <c:minus>
              <c:numRef>
                <c:f>('75220'!$J$29,'75220'!$J$57,'75220'!$J$85,'75220'!$J$113,'75220'!$J$141,'75220'!$J$169,'75220'!$J$197,'75220'!$J$225,'75220'!$J$253,'75220'!$J$276,'75220'!$J$299,'75220'!$J$327)</c:f>
                <c:numCache>
                  <c:formatCode>General</c:formatCode>
                  <c:ptCount val="12"/>
                  <c:pt idx="0">
                    <c:v>4.2054386555642784</c:v>
                  </c:pt>
                  <c:pt idx="1">
                    <c:v>8.5821818993683792</c:v>
                  </c:pt>
                  <c:pt idx="2">
                    <c:v>9.7575367695706827</c:v>
                  </c:pt>
                  <c:pt idx="3">
                    <c:v>11.94909839196885</c:v>
                  </c:pt>
                  <c:pt idx="4">
                    <c:v>11.308656608356021</c:v>
                  </c:pt>
                  <c:pt idx="5">
                    <c:v>13.48967859407438</c:v>
                  </c:pt>
                  <c:pt idx="6">
                    <c:v>14.316158037419861</c:v>
                  </c:pt>
                  <c:pt idx="7">
                    <c:v>16.272091211056811</c:v>
                  </c:pt>
                  <c:pt idx="8">
                    <c:v>17.212398631993921</c:v>
                  </c:pt>
                  <c:pt idx="9">
                    <c:v>15.154878081671569</c:v>
                  </c:pt>
                  <c:pt idx="10">
                    <c:v>15.93229723668547</c:v>
                  </c:pt>
                  <c:pt idx="11">
                    <c:v>17.773174007073521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[2]Col0!$C$3,[2]Col0!$C$31,[2]Col0!$C$59,[2]Col0!$C$87,[2]Col0!$C$115,[2]Col0!$C$143,[2]Col0!$C$171,[2]Col0!$C$199,[2]Col0!$C$227,[2]Col0!$C$255,[2]Col0!$C$271,[2]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'75220'!$J$28,'75220'!$J$56,'75220'!$J$84,'75220'!$J$112,'75220'!$J$140,'75220'!$J$168,'75220'!$J$196,'75220'!$J$224,'75220'!$J$252,'75220'!$J$275,'75220'!$J$298,'75220'!$J$326)</c:f>
              <c:numCache>
                <c:formatCode>General</c:formatCode>
                <c:ptCount val="12"/>
                <c:pt idx="0">
                  <c:v>14.6</c:v>
                </c:pt>
                <c:pt idx="1">
                  <c:v>22.5</c:v>
                </c:pt>
                <c:pt idx="2">
                  <c:v>33.93333333333333</c:v>
                </c:pt>
                <c:pt idx="3">
                  <c:v>38.066666666666578</c:v>
                </c:pt>
                <c:pt idx="4">
                  <c:v>42.2</c:v>
                </c:pt>
                <c:pt idx="5">
                  <c:v>46.4</c:v>
                </c:pt>
                <c:pt idx="6" formatCode="0.000">
                  <c:v>51.666666666666579</c:v>
                </c:pt>
                <c:pt idx="7">
                  <c:v>60.733333333333341</c:v>
                </c:pt>
                <c:pt idx="8">
                  <c:v>63.533333333333331</c:v>
                </c:pt>
                <c:pt idx="9" formatCode="0.000">
                  <c:v>66.142857142857025</c:v>
                </c:pt>
                <c:pt idx="10" formatCode="0.000">
                  <c:v>73.466666666666697</c:v>
                </c:pt>
                <c:pt idx="11">
                  <c:v>77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4EDD-7740-9274-A54D00729E5D}"/>
            </c:ext>
          </c:extLst>
        </c:ser>
        <c:ser>
          <c:idx val="3"/>
          <c:order val="3"/>
          <c:tx>
            <c:v>at4g04760</c:v>
          </c:tx>
          <c:spPr>
            <a:ln w="6350" cap="rnd">
              <a:solidFill>
                <a:schemeClr val="accent4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4760'!$J$29,'04760'!$J$57,'04760'!$J$85,'04760'!$J$113,'04760'!$J$141,'04760'!$J$169,'04760'!$J$197,'04760'!$J$225,'04760'!$J$253,'04760'!$J$276,'04760'!$J$299,'04760'!$J$327)</c:f>
                <c:numCache>
                  <c:formatCode>General</c:formatCode>
                  <c:ptCount val="12"/>
                  <c:pt idx="0">
                    <c:v>3.8631346758571001</c:v>
                  </c:pt>
                  <c:pt idx="1">
                    <c:v>8.2968726179263026</c:v>
                  </c:pt>
                  <c:pt idx="2">
                    <c:v>11.66476174924574</c:v>
                  </c:pt>
                  <c:pt idx="3">
                    <c:v>12.788759945842321</c:v>
                  </c:pt>
                  <c:pt idx="4">
                    <c:v>12.073978316236641</c:v>
                  </c:pt>
                  <c:pt idx="5">
                    <c:v>15.991962266803201</c:v>
                  </c:pt>
                  <c:pt idx="6">
                    <c:v>15.68615808780326</c:v>
                  </c:pt>
                  <c:pt idx="7">
                    <c:v>18.162537757091599</c:v>
                  </c:pt>
                  <c:pt idx="8">
                    <c:v>18.182714624365339</c:v>
                  </c:pt>
                  <c:pt idx="9">
                    <c:v>21.30727575266252</c:v>
                  </c:pt>
                  <c:pt idx="10">
                    <c:v>21.24173041706138</c:v>
                  </c:pt>
                  <c:pt idx="11">
                    <c:v>21.649736975564132</c:v>
                  </c:pt>
                </c:numCache>
              </c:numRef>
            </c:plus>
            <c:minus>
              <c:numRef>
                <c:f>('04760'!$J$29,'04760'!$J$57,'04760'!$J$85,'04760'!$J$113,'04760'!$J$141,'04760'!$J$169,'04760'!$J$197,'04760'!$J$225,'04760'!$J$253,'04760'!$J$276,'04760'!$J$299,'04760'!$J$327)</c:f>
                <c:numCache>
                  <c:formatCode>General</c:formatCode>
                  <c:ptCount val="12"/>
                  <c:pt idx="0">
                    <c:v>3.8631346758571001</c:v>
                  </c:pt>
                  <c:pt idx="1">
                    <c:v>8.2968726179263026</c:v>
                  </c:pt>
                  <c:pt idx="2">
                    <c:v>11.66476174924574</c:v>
                  </c:pt>
                  <c:pt idx="3">
                    <c:v>12.788759945842321</c:v>
                  </c:pt>
                  <c:pt idx="4">
                    <c:v>12.073978316236641</c:v>
                  </c:pt>
                  <c:pt idx="5">
                    <c:v>15.991962266803201</c:v>
                  </c:pt>
                  <c:pt idx="6">
                    <c:v>15.68615808780326</c:v>
                  </c:pt>
                  <c:pt idx="7">
                    <c:v>18.162537757091599</c:v>
                  </c:pt>
                  <c:pt idx="8">
                    <c:v>18.182714624365339</c:v>
                  </c:pt>
                  <c:pt idx="9">
                    <c:v>21.30727575266252</c:v>
                  </c:pt>
                  <c:pt idx="10">
                    <c:v>21.24173041706138</c:v>
                  </c:pt>
                  <c:pt idx="11">
                    <c:v>21.649736975564132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Col0!$C$3,Col0!$C$31,Col0!$C$59,Col0!$C$87,Col0!$C$115,Col0!$C$143,Col0!$C$171,Col0!$C$199,Col0!$C$227,Col0!$C$255,Col0!$C$271,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'04760'!$J$28,'04760'!$J$56,'04760'!$J$84,'04760'!$J$112,'04760'!$J$140,'04760'!$J$168,'04760'!$J$196,'04760'!$J$224,'04760'!$J$252,'04760'!$J$275,'04760'!$J$298,'04760'!$J$326)</c:f>
              <c:numCache>
                <c:formatCode>General</c:formatCode>
                <c:ptCount val="12"/>
                <c:pt idx="0">
                  <c:v>12.266666666666669</c:v>
                </c:pt>
                <c:pt idx="1">
                  <c:v>20.466666666666661</c:v>
                </c:pt>
                <c:pt idx="2">
                  <c:v>31.73333333333327</c:v>
                </c:pt>
                <c:pt idx="3">
                  <c:v>34.133333333333333</c:v>
                </c:pt>
                <c:pt idx="4">
                  <c:v>38.066666666666578</c:v>
                </c:pt>
                <c:pt idx="5">
                  <c:v>44.2</c:v>
                </c:pt>
                <c:pt idx="6">
                  <c:v>51.5</c:v>
                </c:pt>
                <c:pt idx="7">
                  <c:v>58.1</c:v>
                </c:pt>
                <c:pt idx="8">
                  <c:v>59.8888888888889</c:v>
                </c:pt>
                <c:pt idx="9" formatCode="0.000">
                  <c:v>67.666666666666671</c:v>
                </c:pt>
                <c:pt idx="10" formatCode="0.000">
                  <c:v>75.099999999999994</c:v>
                </c:pt>
                <c:pt idx="11">
                  <c:v>77.4000000000000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4EDD-7740-9274-A54D00729E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01749432"/>
        <c:axId val="809653000"/>
      </c:scatterChart>
      <c:valAx>
        <c:axId val="801749432"/>
        <c:scaling>
          <c:orientation val="minMax"/>
          <c:max val="51"/>
          <c:min val="35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09653000"/>
        <c:crosses val="autoZero"/>
        <c:crossBetween val="midCat"/>
        <c:majorUnit val="1"/>
      </c:valAx>
      <c:valAx>
        <c:axId val="809653000"/>
        <c:scaling>
          <c:orientation val="minMax"/>
          <c:max val="100"/>
          <c:min val="0"/>
        </c:scaling>
        <c:delete val="0"/>
        <c:axPos val="l"/>
        <c:majorGridlines>
          <c:spPr>
            <a:ln w="6350">
              <a:solidFill>
                <a:schemeClr val="bg1">
                  <a:lumMod val="85000"/>
                </a:schemeClr>
              </a:solidFill>
            </a:ln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fr-FR" sz="1200" b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LA (</a:t>
                </a:r>
                <a:r>
                  <a:rPr lang="fr-FR" sz="1200" b="0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m</a:t>
                </a:r>
                <a:r>
                  <a:rPr lang="fr-FR" sz="1200" b="0" baseline="3000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fr-FR" sz="1200" b="0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fr-FR" sz="1200" b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3.7104301097405355E-3"/>
              <c:y val="0.2825300055807907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01749432"/>
        <c:crossesAt val="0"/>
        <c:crossBetween val="midCat"/>
        <c:majorUnit val="2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349979451555188"/>
          <c:y val="0.16212195061317319"/>
          <c:w val="0.81202294546685894"/>
          <c:h val="0.706736842105263"/>
        </c:manualLayout>
      </c:layout>
      <c:scatterChart>
        <c:scatterStyle val="lineMarker"/>
        <c:varyColors val="0"/>
        <c:ser>
          <c:idx val="0"/>
          <c:order val="0"/>
          <c:tx>
            <c:v>Col0</c:v>
          </c:tx>
          <c:spPr>
            <a:ln w="63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4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Col0!$F$29,Col0!$F$57,Col0!$F$85,Col0!$F$113,Col0!$F$141,Col0!$F$169,Col0!$F$197,Col0!$F$225,Col0!$F$253,Col0!$F$269,Col0!$F$285,Col0!$F$313)</c:f>
                <c:numCache>
                  <c:formatCode>General</c:formatCode>
                  <c:ptCount val="12"/>
                  <c:pt idx="0">
                    <c:v>6.8129549101544298E-2</c:v>
                  </c:pt>
                  <c:pt idx="1">
                    <c:v>9.6123625088921305E-2</c:v>
                  </c:pt>
                  <c:pt idx="2">
                    <c:v>0.25267397986219098</c:v>
                  </c:pt>
                  <c:pt idx="3">
                    <c:v>0.27629479132288398</c:v>
                  </c:pt>
                  <c:pt idx="4">
                    <c:v>0.54172975993543004</c:v>
                  </c:pt>
                  <c:pt idx="5">
                    <c:v>0.410762432115584</c:v>
                  </c:pt>
                  <c:pt idx="6">
                    <c:v>0.414814900867225</c:v>
                  </c:pt>
                  <c:pt idx="7">
                    <c:v>0.372600092073125</c:v>
                  </c:pt>
                  <c:pt idx="8">
                    <c:v>0.58366139300279496</c:v>
                  </c:pt>
                  <c:pt idx="11">
                    <c:v>0.47391944315684398</c:v>
                  </c:pt>
                </c:numCache>
              </c:numRef>
            </c:plus>
            <c:minus>
              <c:numRef>
                <c:f>(Col0!$F$29,Col0!$F$57,Col0!$F$85,Col0!$F$113,Col0!$F$141,Col0!$F$169,Col0!$F$197,Col0!$F$225,Col0!$F$253,Col0!$F$269,Col0!$F$285,Col0!$F$313)</c:f>
                <c:numCache>
                  <c:formatCode>General</c:formatCode>
                  <c:ptCount val="12"/>
                  <c:pt idx="0">
                    <c:v>6.8129549101544298E-2</c:v>
                  </c:pt>
                  <c:pt idx="1">
                    <c:v>9.6123625088921305E-2</c:v>
                  </c:pt>
                  <c:pt idx="2">
                    <c:v>0.25267397986219098</c:v>
                  </c:pt>
                  <c:pt idx="3">
                    <c:v>0.27629479132288398</c:v>
                  </c:pt>
                  <c:pt idx="4">
                    <c:v>0.54172975993543004</c:v>
                  </c:pt>
                  <c:pt idx="5">
                    <c:v>0.410762432115584</c:v>
                  </c:pt>
                  <c:pt idx="6">
                    <c:v>0.414814900867225</c:v>
                  </c:pt>
                  <c:pt idx="7">
                    <c:v>0.372600092073125</c:v>
                  </c:pt>
                  <c:pt idx="8">
                    <c:v>0.58366139300279496</c:v>
                  </c:pt>
                  <c:pt idx="11">
                    <c:v>0.47391944315684398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Col0!$C$3,Col0!$C$31,Col0!$C$59,Col0!$C$87,Col0!$C$115,Col0!$C$143,Col0!$C$171,Col0!$C$199,Col0!$C$227,Col0!$C$255,Col0!$C$271,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Col0!$F$28,Col0!$F$56,Col0!$F$84,Col0!$F$112,Col0!$F$140,Col0!$F$168,Col0!$F$196,Col0!$F$224,Col0!$F$252,Col0!$F$268,Col0!$F$284,Col0!$F$312)</c:f>
              <c:numCache>
                <c:formatCode>0.000</c:formatCode>
                <c:ptCount val="12"/>
                <c:pt idx="0">
                  <c:v>0.25528777238508799</c:v>
                </c:pt>
                <c:pt idx="1">
                  <c:v>0.49359362280039298</c:v>
                </c:pt>
                <c:pt idx="2">
                  <c:v>0.80892839747225798</c:v>
                </c:pt>
                <c:pt idx="3">
                  <c:v>0.97947329807437</c:v>
                </c:pt>
                <c:pt idx="4">
                  <c:v>1.29804598413343</c:v>
                </c:pt>
                <c:pt idx="5">
                  <c:v>1.624343614169022</c:v>
                </c:pt>
                <c:pt idx="6">
                  <c:v>1.7847024311095381</c:v>
                </c:pt>
                <c:pt idx="7">
                  <c:v>2.0609206997203251</c:v>
                </c:pt>
                <c:pt idx="8">
                  <c:v>2.3093731499358738</c:v>
                </c:pt>
                <c:pt idx="9">
                  <c:v>2.7130095577187712</c:v>
                </c:pt>
                <c:pt idx="10">
                  <c:v>3.048556486617171</c:v>
                </c:pt>
                <c:pt idx="11">
                  <c:v>3.1713498861462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A9C-F042-8DBD-2266D28D7835}"/>
            </c:ext>
          </c:extLst>
        </c:ser>
        <c:ser>
          <c:idx val="1"/>
          <c:order val="1"/>
          <c:tx>
            <c:v>at1g08920</c:v>
          </c:tx>
          <c:spPr>
            <a:ln w="6350" cap="rnd">
              <a:solidFill>
                <a:schemeClr val="accent2"/>
              </a:solidFill>
              <a:round/>
            </a:ln>
            <a:effectLst/>
          </c:spPr>
          <c:marker>
            <c:symbol val="x"/>
            <c:size val="4"/>
            <c:spPr>
              <a:solidFill>
                <a:schemeClr val="accent2"/>
              </a:solidFill>
              <a:ln w="6350">
                <a:solidFill>
                  <a:schemeClr val="accent2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8920'!$F$29,'08920'!$F$57,'08920'!$F$85,'08920'!$F$113,'08920'!$F$141,'08920'!$F$169,'08920'!$F$197,'08920'!$F$225,'08920'!$F$253,'08920'!$F$276,'08920'!$F$299,'08920'!$F$327)</c:f>
                <c:numCache>
                  <c:formatCode>General</c:formatCode>
                  <c:ptCount val="12"/>
                  <c:pt idx="0">
                    <c:v>4.8696388401985202E-2</c:v>
                  </c:pt>
                  <c:pt idx="1">
                    <c:v>0.12931224785814699</c:v>
                  </c:pt>
                  <c:pt idx="2">
                    <c:v>0.24195408659022</c:v>
                  </c:pt>
                  <c:pt idx="3">
                    <c:v>0.309825821696052</c:v>
                  </c:pt>
                  <c:pt idx="4">
                    <c:v>0.206834180740704</c:v>
                  </c:pt>
                  <c:pt idx="5">
                    <c:v>0.25810461870753398</c:v>
                  </c:pt>
                  <c:pt idx="6">
                    <c:v>0.36228196203462398</c:v>
                  </c:pt>
                  <c:pt idx="7">
                    <c:v>0.404234059995074</c:v>
                  </c:pt>
                  <c:pt idx="8">
                    <c:v>0.46980967032338</c:v>
                  </c:pt>
                  <c:pt idx="9">
                    <c:v>0.61089370613711502</c:v>
                  </c:pt>
                  <c:pt idx="10">
                    <c:v>0.590038997943372</c:v>
                  </c:pt>
                  <c:pt idx="11">
                    <c:v>0.45034534888824301</c:v>
                  </c:pt>
                </c:numCache>
              </c:numRef>
            </c:plus>
            <c:minus>
              <c:numRef>
                <c:f>('08920'!$F$29,'08920'!$F$57,'08920'!$F$85,'08920'!$F$113,'08920'!$F$141,'08920'!$F$169,'08920'!$F$197,'08920'!$F$225,'08920'!$F$253,'08920'!$F$276,'08920'!$F$299,'08920'!$F$327)</c:f>
                <c:numCache>
                  <c:formatCode>General</c:formatCode>
                  <c:ptCount val="12"/>
                  <c:pt idx="0">
                    <c:v>4.8696388401985202E-2</c:v>
                  </c:pt>
                  <c:pt idx="1">
                    <c:v>0.12931224785814699</c:v>
                  </c:pt>
                  <c:pt idx="2">
                    <c:v>0.24195408659022</c:v>
                  </c:pt>
                  <c:pt idx="3">
                    <c:v>0.309825821696052</c:v>
                  </c:pt>
                  <c:pt idx="4">
                    <c:v>0.206834180740704</c:v>
                  </c:pt>
                  <c:pt idx="5">
                    <c:v>0.25810461870753398</c:v>
                  </c:pt>
                  <c:pt idx="6">
                    <c:v>0.36228196203462398</c:v>
                  </c:pt>
                  <c:pt idx="7">
                    <c:v>0.404234059995074</c:v>
                  </c:pt>
                  <c:pt idx="8">
                    <c:v>0.46980967032338</c:v>
                  </c:pt>
                  <c:pt idx="9">
                    <c:v>0.61089370613711502</c:v>
                  </c:pt>
                  <c:pt idx="10">
                    <c:v>0.590038997943372</c:v>
                  </c:pt>
                  <c:pt idx="11">
                    <c:v>0.45034534888824301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Col0!$C$3,Col0!$C$31,Col0!$C$59,Col0!$C$87,Col0!$C$115,Col0!$C$143,Col0!$C$171,Col0!$C$199,Col0!$C$227,Col0!$C$255,Col0!$C$271,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'08920'!$F$28,'08920'!$F$56,'08920'!$F$84,'08920'!$F$112,'08920'!$F$140,'08920'!$F$168,'08920'!$F$196,'08920'!$F$224,'08920'!$F$252,'08920'!$F$275,'08920'!$F$298,'08920'!$F$326)</c:f>
              <c:numCache>
                <c:formatCode>0.000</c:formatCode>
                <c:ptCount val="12"/>
                <c:pt idx="0">
                  <c:v>0.240704247946986</c:v>
                </c:pt>
                <c:pt idx="1">
                  <c:v>0.48877762572297201</c:v>
                </c:pt>
                <c:pt idx="2">
                  <c:v>0.76860039504305899</c:v>
                </c:pt>
                <c:pt idx="3">
                  <c:v>0.95912113738049098</c:v>
                </c:pt>
                <c:pt idx="4">
                  <c:v>1.2527690880900679</c:v>
                </c:pt>
                <c:pt idx="5">
                  <c:v>1.465204452527052</c:v>
                </c:pt>
                <c:pt idx="6">
                  <c:v>1.6652707539638749</c:v>
                </c:pt>
                <c:pt idx="7">
                  <c:v>1.8874971661858551</c:v>
                </c:pt>
                <c:pt idx="8">
                  <c:v>2.197476601625405</c:v>
                </c:pt>
                <c:pt idx="9">
                  <c:v>2.8571480084069338</c:v>
                </c:pt>
                <c:pt idx="10">
                  <c:v>2.6377100387472971</c:v>
                </c:pt>
                <c:pt idx="11">
                  <c:v>3.210385672383238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CA9C-F042-8DBD-2266D28D7835}"/>
            </c:ext>
          </c:extLst>
        </c:ser>
        <c:ser>
          <c:idx val="2"/>
          <c:order val="2"/>
          <c:tx>
            <c:v>at1g75220</c:v>
          </c:tx>
          <c:spPr>
            <a:ln w="6350" cap="rnd">
              <a:solidFill>
                <a:schemeClr val="accent3"/>
              </a:solidFill>
              <a:round/>
            </a:ln>
            <a:effectLst/>
          </c:spPr>
          <c:marker>
            <c:symbol val="triangle"/>
            <c:size val="4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75220'!$F$29,'75220'!$F$57,'75220'!$F$85,'75220'!$F$113,'75220'!$F$141,'75220'!$F$169,'75220'!$F$197,'75220'!$F$225,'75220'!$F$253,'75220'!$F$276,'75220'!$F$299,'75220'!$F$327)</c:f>
                <c:numCache>
                  <c:formatCode>General</c:formatCode>
                  <c:ptCount val="12"/>
                  <c:pt idx="0">
                    <c:v>9.9850579791842003E-2</c:v>
                  </c:pt>
                  <c:pt idx="1">
                    <c:v>0.14718939028995701</c:v>
                  </c:pt>
                  <c:pt idx="2">
                    <c:v>0.25367800608843899</c:v>
                  </c:pt>
                  <c:pt idx="3">
                    <c:v>0.33520455011019101</c:v>
                  </c:pt>
                  <c:pt idx="4">
                    <c:v>0.301811128834854</c:v>
                  </c:pt>
                  <c:pt idx="5">
                    <c:v>0.42881205356018598</c:v>
                  </c:pt>
                  <c:pt idx="6">
                    <c:v>0.54210885897201799</c:v>
                  </c:pt>
                  <c:pt idx="7">
                    <c:v>0.64846358309128105</c:v>
                  </c:pt>
                  <c:pt idx="8">
                    <c:v>0.731757407010591</c:v>
                  </c:pt>
                  <c:pt idx="9">
                    <c:v>0.78541154393614099</c:v>
                  </c:pt>
                  <c:pt idx="10">
                    <c:v>0.60970940989432798</c:v>
                  </c:pt>
                  <c:pt idx="11">
                    <c:v>0.98691406629933198</c:v>
                  </c:pt>
                </c:numCache>
              </c:numRef>
            </c:plus>
            <c:minus>
              <c:numRef>
                <c:f>('75220'!$F$29,'75220'!$F$57,'75220'!$F$85,'75220'!$F$113,'75220'!$F$141,'75220'!$F$169,'75220'!$F$197,'75220'!$F$225,'75220'!$F$253,'75220'!$F$276,'75220'!$F$299,'75220'!$F$327)</c:f>
                <c:numCache>
                  <c:formatCode>General</c:formatCode>
                  <c:ptCount val="12"/>
                  <c:pt idx="0">
                    <c:v>9.9850579791842003E-2</c:v>
                  </c:pt>
                  <c:pt idx="1">
                    <c:v>0.14718939028995701</c:v>
                  </c:pt>
                  <c:pt idx="2">
                    <c:v>0.25367800608843899</c:v>
                  </c:pt>
                  <c:pt idx="3">
                    <c:v>0.33520455011019101</c:v>
                  </c:pt>
                  <c:pt idx="4">
                    <c:v>0.301811128834854</c:v>
                  </c:pt>
                  <c:pt idx="5">
                    <c:v>0.42881205356018598</c:v>
                  </c:pt>
                  <c:pt idx="6">
                    <c:v>0.54210885897201799</c:v>
                  </c:pt>
                  <c:pt idx="7">
                    <c:v>0.64846358309128105</c:v>
                  </c:pt>
                  <c:pt idx="8">
                    <c:v>0.731757407010591</c:v>
                  </c:pt>
                  <c:pt idx="9">
                    <c:v>0.78541154393614099</c:v>
                  </c:pt>
                  <c:pt idx="10">
                    <c:v>0.60970940989432798</c:v>
                  </c:pt>
                  <c:pt idx="11">
                    <c:v>0.98691406629933198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[1]Col0!$C$3,[1]Col0!$C$31,[1]Col0!$C$59,[1]Col0!$C$87,[1]Col0!$C$115,[1]Col0!$C$143,[1]Col0!$C$171,[1]Col0!$C$199,[1]Col0!$C$227,[1]Col0!$C$255,[1]Col0!$C$271,[1]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'75220'!$F$28,'75220'!$F$56,'75220'!$F$84,'75220'!$F$112,'75220'!$F$140,'75220'!$F$168,'75220'!$F$196,'75220'!$F$224,'75220'!$F$252,'75220'!$F$275,'75220'!$F$298,'75220'!$F$326)</c:f>
              <c:numCache>
                <c:formatCode>0.000</c:formatCode>
                <c:ptCount val="12"/>
                <c:pt idx="0">
                  <c:v>0.22364253162452699</c:v>
                </c:pt>
                <c:pt idx="1">
                  <c:v>0.40482416748559602</c:v>
                </c:pt>
                <c:pt idx="2">
                  <c:v>0.673755703938688</c:v>
                </c:pt>
                <c:pt idx="3">
                  <c:v>1.0074923329652501</c:v>
                </c:pt>
                <c:pt idx="4">
                  <c:v>1.2555177154674459</c:v>
                </c:pt>
                <c:pt idx="5">
                  <c:v>1.467013952922652</c:v>
                </c:pt>
                <c:pt idx="6">
                  <c:v>1.6049943252117</c:v>
                </c:pt>
                <c:pt idx="7">
                  <c:v>1.8601426034714541</c:v>
                </c:pt>
                <c:pt idx="8">
                  <c:v>1.98624040852391</c:v>
                </c:pt>
                <c:pt idx="9">
                  <c:v>2.5084511394023128</c:v>
                </c:pt>
                <c:pt idx="10">
                  <c:v>2.6244911100567689</c:v>
                </c:pt>
                <c:pt idx="11">
                  <c:v>2.947016930513838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CA9C-F042-8DBD-2266D28D7835}"/>
            </c:ext>
          </c:extLst>
        </c:ser>
        <c:ser>
          <c:idx val="3"/>
          <c:order val="3"/>
          <c:tx>
            <c:v>at3g04760</c:v>
          </c:tx>
          <c:spPr>
            <a:ln w="6350" cap="rnd">
              <a:solidFill>
                <a:schemeClr val="accent4"/>
              </a:solidFill>
              <a:round/>
            </a:ln>
            <a:effectLst/>
          </c:spPr>
          <c:marker>
            <c:symbol val="diamond"/>
            <c:size val="4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trendline>
            <c:spPr>
              <a:ln w="19050" cap="rnd">
                <a:noFill/>
                <a:prstDash val="sysDot"/>
              </a:ln>
              <a:effectLst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('04760'!$F$29,'04760'!$F$57,'04760'!$F$85,'04760'!$F$113,'04760'!$F$141,'04760'!$F$169,'04760'!$F$197,'04760'!$F$225,'04760'!$F$253,'04760'!$F$276,'04760'!$F$299,'04760'!$F$327)</c:f>
                <c:numCache>
                  <c:formatCode>General</c:formatCode>
                  <c:ptCount val="12"/>
                  <c:pt idx="0">
                    <c:v>6.2285542783769403E-2</c:v>
                  </c:pt>
                  <c:pt idx="1">
                    <c:v>0.15892093180544101</c:v>
                  </c:pt>
                  <c:pt idx="2">
                    <c:v>0.31142146591615899</c:v>
                  </c:pt>
                  <c:pt idx="3">
                    <c:v>0.26412555695927598</c:v>
                  </c:pt>
                  <c:pt idx="4">
                    <c:v>0.213274090354101</c:v>
                  </c:pt>
                  <c:pt idx="5">
                    <c:v>0.31998680620865499</c:v>
                  </c:pt>
                  <c:pt idx="6">
                    <c:v>0.45646406031512599</c:v>
                  </c:pt>
                  <c:pt idx="7">
                    <c:v>0.43718175889500899</c:v>
                  </c:pt>
                  <c:pt idx="8">
                    <c:v>0.51499261003872698</c:v>
                  </c:pt>
                  <c:pt idx="9">
                    <c:v>0.54839921747976705</c:v>
                  </c:pt>
                  <c:pt idx="10">
                    <c:v>0.74540744197683195</c:v>
                  </c:pt>
                  <c:pt idx="11">
                    <c:v>0.891675307348896</c:v>
                  </c:pt>
                </c:numCache>
              </c:numRef>
            </c:plus>
            <c:minus>
              <c:numRef>
                <c:f>('04760'!$F$29,'04760'!$F$57,'04760'!$F$85,'04760'!$F$113,'04760'!$F$141,'04760'!$F$169,'04760'!$F$197,'04760'!$F$225,'04760'!$F$253,'04760'!$F$276,'04760'!$F$299,'04760'!$F$327)</c:f>
                <c:numCache>
                  <c:formatCode>General</c:formatCode>
                  <c:ptCount val="12"/>
                  <c:pt idx="0">
                    <c:v>6.2285542783769403E-2</c:v>
                  </c:pt>
                  <c:pt idx="1">
                    <c:v>0.15892093180544101</c:v>
                  </c:pt>
                  <c:pt idx="2">
                    <c:v>0.31142146591615899</c:v>
                  </c:pt>
                  <c:pt idx="3">
                    <c:v>0.26412555695927598</c:v>
                  </c:pt>
                  <c:pt idx="4">
                    <c:v>0.213274090354101</c:v>
                  </c:pt>
                  <c:pt idx="5">
                    <c:v>0.31998680620865499</c:v>
                  </c:pt>
                  <c:pt idx="6">
                    <c:v>0.45646406031512599</c:v>
                  </c:pt>
                  <c:pt idx="7">
                    <c:v>0.43718175889500899</c:v>
                  </c:pt>
                  <c:pt idx="8">
                    <c:v>0.51499261003872698</c:v>
                  </c:pt>
                  <c:pt idx="9">
                    <c:v>0.54839921747976705</c:v>
                  </c:pt>
                  <c:pt idx="10">
                    <c:v>0.74540744197683195</c:v>
                  </c:pt>
                  <c:pt idx="11">
                    <c:v>0.891675307348896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xVal>
            <c:numRef>
              <c:f>(Col0!$C$3,Col0!$C$31,Col0!$C$59,Col0!$C$87,Col0!$C$115,Col0!$C$143,Col0!$C$171,Col0!$C$199,Col0!$C$227,Col0!$C$255,Col0!$C$271,Col0!$C$287)</c:f>
              <c:numCache>
                <c:formatCode>General</c:formatCode>
                <c:ptCount val="12"/>
                <c:pt idx="0">
                  <c:v>35</c:v>
                </c:pt>
                <c:pt idx="1">
                  <c:v>38</c:v>
                </c:pt>
                <c:pt idx="2">
                  <c:v>41</c:v>
                </c:pt>
                <c:pt idx="3">
                  <c:v>42</c:v>
                </c:pt>
                <c:pt idx="4">
                  <c:v>43</c:v>
                </c:pt>
                <c:pt idx="5">
                  <c:v>44</c:v>
                </c:pt>
                <c:pt idx="6">
                  <c:v>45</c:v>
                </c:pt>
                <c:pt idx="7">
                  <c:v>46</c:v>
                </c:pt>
                <c:pt idx="8">
                  <c:v>47</c:v>
                </c:pt>
                <c:pt idx="9">
                  <c:v>48</c:v>
                </c:pt>
                <c:pt idx="10">
                  <c:v>49</c:v>
                </c:pt>
                <c:pt idx="11">
                  <c:v>50</c:v>
                </c:pt>
              </c:numCache>
            </c:numRef>
          </c:xVal>
          <c:yVal>
            <c:numRef>
              <c:f>('04760'!$F$28,'04760'!$F$56,'04760'!$F$84,'04760'!$F$112,'04760'!$F$140,'04760'!$F$168,'04760'!$F$196,'04760'!$F$224,'04760'!$F$252,'04760'!$F$275,'04760'!$F$298,'04760'!$F$326)</c:f>
              <c:numCache>
                <c:formatCode>0.000</c:formatCode>
                <c:ptCount val="12"/>
                <c:pt idx="0">
                  <c:v>0.181028203754766</c:v>
                </c:pt>
                <c:pt idx="1">
                  <c:v>0.40606044812146502</c:v>
                </c:pt>
                <c:pt idx="2">
                  <c:v>0.66187823542458402</c:v>
                </c:pt>
                <c:pt idx="3">
                  <c:v>0.77874656057133096</c:v>
                </c:pt>
                <c:pt idx="4">
                  <c:v>1.0154606600536971</c:v>
                </c:pt>
                <c:pt idx="5">
                  <c:v>1.016386022251915</c:v>
                </c:pt>
                <c:pt idx="6">
                  <c:v>1.3981296369010261</c:v>
                </c:pt>
                <c:pt idx="7">
                  <c:v>1.6376021264976099</c:v>
                </c:pt>
                <c:pt idx="8">
                  <c:v>1.895503958099316</c:v>
                </c:pt>
                <c:pt idx="9">
                  <c:v>2.3270438118889549</c:v>
                </c:pt>
                <c:pt idx="10">
                  <c:v>2.2219573856825319</c:v>
                </c:pt>
                <c:pt idx="11">
                  <c:v>2.61033797077047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CA9C-F042-8DBD-2266D28D78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00992184"/>
        <c:axId val="813963192"/>
      </c:scatterChart>
      <c:valAx>
        <c:axId val="800992184"/>
        <c:scaling>
          <c:orientation val="minMax"/>
          <c:max val="51"/>
          <c:min val="35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13963192"/>
        <c:crosses val="autoZero"/>
        <c:crossBetween val="midCat"/>
        <c:majorUnit val="1"/>
      </c:valAx>
      <c:valAx>
        <c:axId val="813963192"/>
        <c:scaling>
          <c:orientation val="minMax"/>
          <c:max val="4"/>
          <c:min val="0"/>
        </c:scaling>
        <c:delete val="0"/>
        <c:axPos val="l"/>
        <c:majorGridlines>
          <c:spPr>
            <a:ln w="6350">
              <a:solidFill>
                <a:schemeClr val="bg1">
                  <a:lumMod val="85000"/>
                </a:schemeClr>
              </a:solidFill>
            </a:ln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fr-FR" sz="1200" b="0" baseline="0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W (g)</a:t>
                </a:r>
                <a:endParaRPr lang="fr-FR" sz="1200" b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31305619316593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fr-FR"/>
          </a:p>
        </c:txPr>
        <c:crossAx val="800992184"/>
        <c:crossesAt val="0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736BEA8-012B-EE49-8237-1D0AC6B2215A}" type="datetimeFigureOut">
              <a:rPr lang="fr-FR" smtClean="0"/>
              <a:pPr/>
              <a:t>08/07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87575" y="685800"/>
            <a:ext cx="24828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C31E6C-0349-A141-A1E6-5F78B3497BF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C31E6C-0349-A141-A1E6-5F78B3497BFF}" type="slidenum">
              <a:rPr lang="fr-FR" smtClean="0"/>
              <a:pPr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2693657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C31E6C-0349-A141-A1E6-5F78B3497BFF}" type="slidenum">
              <a:rPr lang="fr-FR" smtClean="0"/>
              <a:pPr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951593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67216" y="3243970"/>
            <a:ext cx="6428423" cy="2238385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134430" y="5917459"/>
            <a:ext cx="5293995" cy="266865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2F8B-540C-1E49-B2A9-A3F6EFA0ABD5}" type="datetimeFigureOut">
              <a:rPr lang="fr-FR" smtClean="0"/>
              <a:pPr/>
              <a:t>08/07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7079F-FB2A-6446-8EA6-EB6F61EE165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2F8B-540C-1E49-B2A9-A3F6EFA0ABD5}" type="datetimeFigureOut">
              <a:rPr lang="fr-FR" smtClean="0"/>
              <a:pPr/>
              <a:t>08/07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7079F-FB2A-6446-8EA6-EB6F61EE165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535084" y="635744"/>
            <a:ext cx="1407530" cy="13568096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12494" y="635744"/>
            <a:ext cx="4096544" cy="13568096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2F8B-540C-1E49-B2A9-A3F6EFA0ABD5}" type="datetimeFigureOut">
              <a:rPr lang="fr-FR" smtClean="0"/>
              <a:pPr/>
              <a:t>08/07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7079F-FB2A-6446-8EA6-EB6F61EE165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2F8B-540C-1E49-B2A9-A3F6EFA0ABD5}" type="datetimeFigureOut">
              <a:rPr lang="fr-FR" smtClean="0"/>
              <a:pPr/>
              <a:t>08/07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7079F-FB2A-6446-8EA6-EB6F61EE165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97415" y="6710322"/>
            <a:ext cx="6428423" cy="2074011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97415" y="4426011"/>
            <a:ext cx="6428423" cy="2284313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2F8B-540C-1E49-B2A9-A3F6EFA0ABD5}" type="datetimeFigureOut">
              <a:rPr lang="fr-FR" smtClean="0"/>
              <a:pPr/>
              <a:t>08/07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7079F-FB2A-6446-8EA6-EB6F61EE165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12495" y="3710502"/>
            <a:ext cx="2752037" cy="1049333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190579" y="3710502"/>
            <a:ext cx="2752037" cy="1049333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2F8B-540C-1E49-B2A9-A3F6EFA0ABD5}" type="datetimeFigureOut">
              <a:rPr lang="fr-FR" smtClean="0"/>
              <a:pPr/>
              <a:t>08/07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7079F-FB2A-6446-8EA6-EB6F61EE165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78144" y="418190"/>
            <a:ext cx="6806565" cy="1740429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78143" y="2337495"/>
            <a:ext cx="3341572" cy="97415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78143" y="3311651"/>
            <a:ext cx="3341572" cy="601656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841824" y="2337495"/>
            <a:ext cx="3342885" cy="97415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841824" y="3311651"/>
            <a:ext cx="3342885" cy="601656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2F8B-540C-1E49-B2A9-A3F6EFA0ABD5}" type="datetimeFigureOut">
              <a:rPr lang="fr-FR" smtClean="0"/>
              <a:pPr/>
              <a:t>08/07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7079F-FB2A-6446-8EA6-EB6F61EE165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2F8B-540C-1E49-B2A9-A3F6EFA0ABD5}" type="datetimeFigureOut">
              <a:rPr lang="fr-FR" smtClean="0"/>
              <a:pPr/>
              <a:t>08/07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7079F-FB2A-6446-8EA6-EB6F61EE165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2F8B-540C-1E49-B2A9-A3F6EFA0ABD5}" type="datetimeFigureOut">
              <a:rPr lang="fr-FR" smtClean="0"/>
              <a:pPr/>
              <a:t>08/07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7079F-FB2A-6446-8EA6-EB6F61EE165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78143" y="415769"/>
            <a:ext cx="2488126" cy="176943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956866" y="415772"/>
            <a:ext cx="4227843" cy="891244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78143" y="2185206"/>
            <a:ext cx="2488126" cy="714301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2F8B-540C-1E49-B2A9-A3F6EFA0ABD5}" type="datetimeFigureOut">
              <a:rPr lang="fr-FR" smtClean="0"/>
              <a:pPr/>
              <a:t>08/07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7079F-FB2A-6446-8EA6-EB6F61EE165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482372" y="7309804"/>
            <a:ext cx="4537710" cy="86296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482372" y="933064"/>
            <a:ext cx="4537710" cy="626554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482372" y="8172766"/>
            <a:ext cx="4537710" cy="122555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62F8B-540C-1E49-B2A9-A3F6EFA0ABD5}" type="datetimeFigureOut">
              <a:rPr lang="fr-FR" smtClean="0"/>
              <a:pPr/>
              <a:t>08/07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7079F-FB2A-6446-8EA6-EB6F61EE165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78144" y="418190"/>
            <a:ext cx="6806565" cy="174042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78144" y="2436601"/>
            <a:ext cx="6806565" cy="68916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78145" y="9678723"/>
            <a:ext cx="1764665" cy="5559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E62F8B-540C-1E49-B2A9-A3F6EFA0ABD5}" type="datetimeFigureOut">
              <a:rPr lang="fr-FR" smtClean="0"/>
              <a:pPr/>
              <a:t>08/07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583975" y="9678723"/>
            <a:ext cx="2394903" cy="5559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5420045" y="9678723"/>
            <a:ext cx="1764665" cy="5559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67079F-FB2A-6446-8EA6-EB6F61EE165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13" Type="http://schemas.openxmlformats.org/officeDocument/2006/relationships/chart" Target="../charts/chart11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12" Type="http://schemas.openxmlformats.org/officeDocument/2006/relationships/chart" Target="../charts/chart10.xml"/><Relationship Id="rId17" Type="http://schemas.openxmlformats.org/officeDocument/2006/relationships/chart" Target="../charts/chart15.xml"/><Relationship Id="rId2" Type="http://schemas.openxmlformats.org/officeDocument/2006/relationships/notesSlide" Target="../notesSlides/notesSlide1.xml"/><Relationship Id="rId16" Type="http://schemas.openxmlformats.org/officeDocument/2006/relationships/chart" Target="../charts/chart14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11" Type="http://schemas.openxmlformats.org/officeDocument/2006/relationships/chart" Target="../charts/chart9.xml"/><Relationship Id="rId5" Type="http://schemas.openxmlformats.org/officeDocument/2006/relationships/chart" Target="../charts/chart3.xml"/><Relationship Id="rId15" Type="http://schemas.openxmlformats.org/officeDocument/2006/relationships/chart" Target="../charts/chart13.xml"/><Relationship Id="rId10" Type="http://schemas.openxmlformats.org/officeDocument/2006/relationships/chart" Target="../charts/chart8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Relationship Id="rId14" Type="http://schemas.openxmlformats.org/officeDocument/2006/relationships/chart" Target="../charts/chart1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1.xml"/><Relationship Id="rId13" Type="http://schemas.openxmlformats.org/officeDocument/2006/relationships/chart" Target="../charts/chart26.xml"/><Relationship Id="rId3" Type="http://schemas.openxmlformats.org/officeDocument/2006/relationships/chart" Target="../charts/chart16.xml"/><Relationship Id="rId7" Type="http://schemas.openxmlformats.org/officeDocument/2006/relationships/chart" Target="../charts/chart20.xml"/><Relationship Id="rId12" Type="http://schemas.openxmlformats.org/officeDocument/2006/relationships/chart" Target="../charts/chart25.xml"/><Relationship Id="rId2" Type="http://schemas.openxmlformats.org/officeDocument/2006/relationships/notesSlide" Target="../notesSlides/notesSlide2.xml"/><Relationship Id="rId16" Type="http://schemas.openxmlformats.org/officeDocument/2006/relationships/chart" Target="../charts/chart29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9.xml"/><Relationship Id="rId11" Type="http://schemas.openxmlformats.org/officeDocument/2006/relationships/chart" Target="../charts/chart24.xml"/><Relationship Id="rId5" Type="http://schemas.openxmlformats.org/officeDocument/2006/relationships/chart" Target="../charts/chart18.xml"/><Relationship Id="rId15" Type="http://schemas.openxmlformats.org/officeDocument/2006/relationships/chart" Target="../charts/chart28.xml"/><Relationship Id="rId10" Type="http://schemas.openxmlformats.org/officeDocument/2006/relationships/chart" Target="../charts/chart23.xml"/><Relationship Id="rId4" Type="http://schemas.openxmlformats.org/officeDocument/2006/relationships/chart" Target="../charts/chart17.xml"/><Relationship Id="rId9" Type="http://schemas.openxmlformats.org/officeDocument/2006/relationships/chart" Target="../charts/chart22.xml"/><Relationship Id="rId14" Type="http://schemas.openxmlformats.org/officeDocument/2006/relationships/chart" Target="../charts/chart2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DECA8616-64CB-E44C-821B-B5D82A92B7F0}"/>
              </a:ext>
            </a:extLst>
          </p:cNvPr>
          <p:cNvSpPr/>
          <p:nvPr/>
        </p:nvSpPr>
        <p:spPr>
          <a:xfrm>
            <a:off x="3199028" y="9839733"/>
            <a:ext cx="209223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5</a:t>
            </a:r>
            <a:endParaRPr lang="fr-FR" sz="1400" dirty="0"/>
          </a:p>
        </p:txBody>
      </p:sp>
      <p:grpSp>
        <p:nvGrpSpPr>
          <p:cNvPr id="6" name="Groupe 5">
            <a:extLst>
              <a:ext uri="{FF2B5EF4-FFF2-40B4-BE49-F238E27FC236}">
                <a16:creationId xmlns:a16="http://schemas.microsoft.com/office/drawing/2014/main" id="{4E1E8A07-460D-E848-9D39-9FC6362A556D}"/>
              </a:ext>
            </a:extLst>
          </p:cNvPr>
          <p:cNvGrpSpPr/>
          <p:nvPr/>
        </p:nvGrpSpPr>
        <p:grpSpPr>
          <a:xfrm>
            <a:off x="326465" y="167455"/>
            <a:ext cx="7255392" cy="9687709"/>
            <a:chOff x="326465" y="167455"/>
            <a:chExt cx="7255392" cy="9687709"/>
          </a:xfrm>
        </p:grpSpPr>
        <p:graphicFrame>
          <p:nvGraphicFramePr>
            <p:cNvPr id="3" name="Graphique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72044126"/>
                </p:ext>
              </p:extLst>
            </p:nvPr>
          </p:nvGraphicFramePr>
          <p:xfrm>
            <a:off x="326939" y="3240363"/>
            <a:ext cx="3528234" cy="133721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1" name="ZoneTexte 20"/>
            <p:cNvSpPr txBox="1"/>
            <p:nvPr/>
          </p:nvSpPr>
          <p:spPr>
            <a:xfrm>
              <a:off x="1506757" y="544968"/>
              <a:ext cx="1482338" cy="283831"/>
            </a:xfrm>
            <a:prstGeom prst="rect">
              <a:avLst/>
            </a:prstGeom>
            <a:noFill/>
          </p:spPr>
          <p:txBody>
            <a:bodyPr wrap="none" lIns="98207" tIns="49103" rIns="98207" bIns="49103" rtlCol="0">
              <a:spAutoFit/>
            </a:bodyPr>
            <a:lstStyle/>
            <a:p>
              <a:r>
                <a:rPr lang="fr-FR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ell-Watered</a:t>
              </a:r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lants</a:t>
              </a:r>
            </a:p>
          </p:txBody>
        </p:sp>
        <p:sp>
          <p:nvSpPr>
            <p:cNvPr id="22" name="ZoneTexte 21"/>
            <p:cNvSpPr txBox="1"/>
            <p:nvPr/>
          </p:nvSpPr>
          <p:spPr>
            <a:xfrm>
              <a:off x="4824408" y="544968"/>
              <a:ext cx="1608975" cy="283831"/>
            </a:xfrm>
            <a:prstGeom prst="rect">
              <a:avLst/>
            </a:prstGeom>
            <a:noFill/>
          </p:spPr>
          <p:txBody>
            <a:bodyPr wrap="none" lIns="98207" tIns="49103" rIns="98207" bIns="49103" rtlCol="0">
              <a:spAutoFit/>
            </a:bodyPr>
            <a:lstStyle/>
            <a:p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ater-</a:t>
              </a:r>
              <a:r>
                <a:rPr lang="fr-FR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eprived</a:t>
              </a:r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lants</a:t>
              </a:r>
            </a:p>
          </p:txBody>
        </p:sp>
        <p:graphicFrame>
          <p:nvGraphicFramePr>
            <p:cNvPr id="24" name="Graphique 2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63695017"/>
                </p:ext>
              </p:extLst>
            </p:nvPr>
          </p:nvGraphicFramePr>
          <p:xfrm>
            <a:off x="3750020" y="719958"/>
            <a:ext cx="3629353" cy="14305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27" name="Graphique 2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03122778"/>
                </p:ext>
              </p:extLst>
            </p:nvPr>
          </p:nvGraphicFramePr>
          <p:xfrm>
            <a:off x="3774077" y="1968410"/>
            <a:ext cx="3708511" cy="131960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31" name="Graphique 3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11760116"/>
                </p:ext>
              </p:extLst>
            </p:nvPr>
          </p:nvGraphicFramePr>
          <p:xfrm>
            <a:off x="3781425" y="3202242"/>
            <a:ext cx="3800432" cy="135500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35" name="ZoneTexte 34"/>
            <p:cNvSpPr txBox="1"/>
            <p:nvPr/>
          </p:nvSpPr>
          <p:spPr>
            <a:xfrm>
              <a:off x="4362941" y="881995"/>
              <a:ext cx="275276" cy="283831"/>
            </a:xfrm>
            <a:prstGeom prst="rect">
              <a:avLst/>
            </a:prstGeom>
            <a:noFill/>
          </p:spPr>
          <p:txBody>
            <a:bodyPr wrap="none" lIns="98207" tIns="49103" rIns="98207" bIns="49103" rtlCol="0">
              <a:spAutoFit/>
            </a:bodyPr>
            <a:lstStyle/>
            <a:p>
              <a:r>
                <a:rPr lang="fr-FR" sz="1200" b="1" dirty="0">
                  <a:latin typeface="Times New Roman" panose="02020603050405020304" pitchFamily="18" charset="0"/>
                  <a:cs typeface="Times New Roman"/>
                </a:rPr>
                <a:t>a</a:t>
              </a:r>
            </a:p>
          </p:txBody>
        </p:sp>
        <p:sp>
          <p:nvSpPr>
            <p:cNvPr id="37" name="ZoneTexte 36"/>
            <p:cNvSpPr txBox="1"/>
            <p:nvPr/>
          </p:nvSpPr>
          <p:spPr>
            <a:xfrm flipH="1">
              <a:off x="4362941" y="2082929"/>
              <a:ext cx="221021" cy="283831"/>
            </a:xfrm>
            <a:prstGeom prst="rect">
              <a:avLst/>
            </a:prstGeom>
            <a:noFill/>
          </p:spPr>
          <p:txBody>
            <a:bodyPr wrap="square" lIns="98207" tIns="49103" rIns="98207" bIns="49103" rtlCol="0">
              <a:spAutoFit/>
            </a:bodyPr>
            <a:lstStyle/>
            <a:p>
              <a:r>
                <a:rPr lang="fr-FR" sz="1200" b="1" dirty="0">
                  <a:latin typeface="Times New Roman" panose="02020603050405020304" pitchFamily="18" charset="0"/>
                  <a:cs typeface="Times New Roman"/>
                </a:rPr>
                <a:t>b</a:t>
              </a:r>
            </a:p>
          </p:txBody>
        </p:sp>
        <p:sp>
          <p:nvSpPr>
            <p:cNvPr id="38" name="ZoneTexte 37"/>
            <p:cNvSpPr txBox="1"/>
            <p:nvPr/>
          </p:nvSpPr>
          <p:spPr>
            <a:xfrm>
              <a:off x="940264" y="3313759"/>
              <a:ext cx="308940" cy="283831"/>
            </a:xfrm>
            <a:prstGeom prst="rect">
              <a:avLst/>
            </a:prstGeom>
            <a:noFill/>
          </p:spPr>
          <p:txBody>
            <a:bodyPr wrap="none" lIns="98207" tIns="49103" rIns="98207" bIns="49103" rtlCol="0">
              <a:spAutoFit/>
            </a:bodyPr>
            <a:lstStyle/>
            <a:p>
              <a:r>
                <a:rPr lang="fr-FR" sz="1200" b="1" dirty="0">
                  <a:latin typeface="Times New Roman" panose="02020603050405020304" pitchFamily="18" charset="0"/>
                  <a:cs typeface="Times New Roman"/>
                </a:rPr>
                <a:t>C</a:t>
              </a:r>
            </a:p>
          </p:txBody>
        </p:sp>
        <p:sp>
          <p:nvSpPr>
            <p:cNvPr id="39" name="ZoneTexte 38"/>
            <p:cNvSpPr txBox="1"/>
            <p:nvPr/>
          </p:nvSpPr>
          <p:spPr>
            <a:xfrm>
              <a:off x="4362941" y="3329039"/>
              <a:ext cx="267262" cy="283831"/>
            </a:xfrm>
            <a:prstGeom prst="rect">
              <a:avLst/>
            </a:prstGeom>
            <a:noFill/>
          </p:spPr>
          <p:txBody>
            <a:bodyPr wrap="none" lIns="98207" tIns="49103" rIns="98207" bIns="49103" rtlCol="0">
              <a:spAutoFit/>
            </a:bodyPr>
            <a:lstStyle/>
            <a:p>
              <a:r>
                <a:rPr lang="fr-FR" sz="1200" b="1" dirty="0">
                  <a:latin typeface="Times New Roman" panose="02020603050405020304" pitchFamily="18" charset="0"/>
                  <a:cs typeface="Times New Roman"/>
                </a:rPr>
                <a:t>c</a:t>
              </a:r>
            </a:p>
          </p:txBody>
        </p:sp>
        <p:graphicFrame>
          <p:nvGraphicFramePr>
            <p:cNvPr id="84" name="Graphique 83">
              <a:extLst>
                <a:ext uri="{FF2B5EF4-FFF2-40B4-BE49-F238E27FC236}">
                  <a16:creationId xmlns:a16="http://schemas.microsoft.com/office/drawing/2014/main" id="{59F83E9D-1267-334C-9D4B-5496C31D160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57860790"/>
                </p:ext>
              </p:extLst>
            </p:nvPr>
          </p:nvGraphicFramePr>
          <p:xfrm>
            <a:off x="3791168" y="8057544"/>
            <a:ext cx="3691420" cy="138182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85" name="Graphique 84">
              <a:extLst>
                <a:ext uri="{FF2B5EF4-FFF2-40B4-BE49-F238E27FC236}">
                  <a16:creationId xmlns:a16="http://schemas.microsoft.com/office/drawing/2014/main" id="{3F8C2910-8AF0-5D49-8D23-CCB141663A5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85389113"/>
                </p:ext>
              </p:extLst>
            </p:nvPr>
          </p:nvGraphicFramePr>
          <p:xfrm>
            <a:off x="326465" y="8204281"/>
            <a:ext cx="3702179" cy="165088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90" name="ZoneTexte 89">
              <a:extLst>
                <a:ext uri="{FF2B5EF4-FFF2-40B4-BE49-F238E27FC236}">
                  <a16:creationId xmlns:a16="http://schemas.microsoft.com/office/drawing/2014/main" id="{EE6961F3-DB84-9D44-BD32-E09A70BD9F33}"/>
                </a:ext>
              </a:extLst>
            </p:cNvPr>
            <p:cNvSpPr txBox="1"/>
            <p:nvPr/>
          </p:nvSpPr>
          <p:spPr>
            <a:xfrm>
              <a:off x="940264" y="8249824"/>
              <a:ext cx="318558" cy="283831"/>
            </a:xfrm>
            <a:prstGeom prst="rect">
              <a:avLst/>
            </a:prstGeom>
            <a:noFill/>
          </p:spPr>
          <p:txBody>
            <a:bodyPr wrap="none" lIns="98207" tIns="49103" rIns="98207" bIns="49103" rtlCol="0">
              <a:spAutoFit/>
            </a:bodyPr>
            <a:lstStyle/>
            <a:p>
              <a:r>
                <a:rPr lang="fr-FR" sz="1200" b="1" dirty="0">
                  <a:latin typeface="Times New Roman" panose="02020603050405020304" pitchFamily="18" charset="0"/>
                  <a:cs typeface="Times New Roman"/>
                </a:rPr>
                <a:t>G</a:t>
              </a:r>
            </a:p>
          </p:txBody>
        </p:sp>
        <p:sp>
          <p:nvSpPr>
            <p:cNvPr id="91" name="ZoneTexte 90">
              <a:extLst>
                <a:ext uri="{FF2B5EF4-FFF2-40B4-BE49-F238E27FC236}">
                  <a16:creationId xmlns:a16="http://schemas.microsoft.com/office/drawing/2014/main" id="{AFC7730D-F384-4F46-A282-289AA018BBA8}"/>
                </a:ext>
              </a:extLst>
            </p:cNvPr>
            <p:cNvSpPr txBox="1"/>
            <p:nvPr/>
          </p:nvSpPr>
          <p:spPr>
            <a:xfrm>
              <a:off x="4362941" y="8212829"/>
              <a:ext cx="275276" cy="283831"/>
            </a:xfrm>
            <a:prstGeom prst="rect">
              <a:avLst/>
            </a:prstGeom>
            <a:noFill/>
          </p:spPr>
          <p:txBody>
            <a:bodyPr wrap="none" lIns="98207" tIns="49103" rIns="98207" bIns="49103" rtlCol="0">
              <a:spAutoFit/>
            </a:bodyPr>
            <a:lstStyle/>
            <a:p>
              <a:r>
                <a:rPr lang="fr-FR" sz="1200" b="1" dirty="0">
                  <a:latin typeface="Times New Roman" panose="02020603050405020304" pitchFamily="18" charset="0"/>
                  <a:cs typeface="Times New Roman"/>
                </a:rPr>
                <a:t>g</a:t>
              </a:r>
            </a:p>
          </p:txBody>
        </p:sp>
        <p:sp>
          <p:nvSpPr>
            <p:cNvPr id="97" name="ZoneTexte 96">
              <a:extLst>
                <a:ext uri="{FF2B5EF4-FFF2-40B4-BE49-F238E27FC236}">
                  <a16:creationId xmlns:a16="http://schemas.microsoft.com/office/drawing/2014/main" id="{19279AF1-9AA1-4348-9490-2C42DF2D2433}"/>
                </a:ext>
              </a:extLst>
            </p:cNvPr>
            <p:cNvSpPr txBox="1"/>
            <p:nvPr/>
          </p:nvSpPr>
          <p:spPr>
            <a:xfrm>
              <a:off x="2185923" y="175265"/>
              <a:ext cx="5357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>
                  <a:latin typeface="Times New Roman" panose="02020603050405020304" pitchFamily="18" charset="0"/>
                </a:rPr>
                <a:t>Col-0</a:t>
              </a:r>
            </a:p>
          </p:txBody>
        </p:sp>
        <p:sp>
          <p:nvSpPr>
            <p:cNvPr id="98" name="ZoneTexte 97">
              <a:extLst>
                <a:ext uri="{FF2B5EF4-FFF2-40B4-BE49-F238E27FC236}">
                  <a16:creationId xmlns:a16="http://schemas.microsoft.com/office/drawing/2014/main" id="{29A0A8AC-4070-4D43-8DDC-5E1432BA6960}"/>
                </a:ext>
              </a:extLst>
            </p:cNvPr>
            <p:cNvSpPr txBox="1"/>
            <p:nvPr/>
          </p:nvSpPr>
          <p:spPr>
            <a:xfrm>
              <a:off x="4946834" y="167455"/>
              <a:ext cx="10374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i="1" dirty="0">
                  <a:latin typeface="Times New Roman" panose="02020603050405020304" pitchFamily="18" charset="0"/>
                </a:rPr>
                <a:t>atesl3.07/esl1</a:t>
              </a:r>
            </a:p>
          </p:txBody>
        </p:sp>
        <p:sp>
          <p:nvSpPr>
            <p:cNvPr id="99" name="ZoneTexte 98">
              <a:extLst>
                <a:ext uri="{FF2B5EF4-FFF2-40B4-BE49-F238E27FC236}">
                  <a16:creationId xmlns:a16="http://schemas.microsoft.com/office/drawing/2014/main" id="{CFA87F5B-31BA-C942-97A9-8F94210C8DE6}"/>
                </a:ext>
              </a:extLst>
            </p:cNvPr>
            <p:cNvSpPr txBox="1"/>
            <p:nvPr/>
          </p:nvSpPr>
          <p:spPr>
            <a:xfrm>
              <a:off x="2936071" y="175265"/>
              <a:ext cx="11144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i="1" dirty="0">
                  <a:latin typeface="Times New Roman" panose="02020603050405020304" pitchFamily="18" charset="0"/>
                </a:rPr>
                <a:t>atesl1.02/erdl6</a:t>
              </a:r>
            </a:p>
          </p:txBody>
        </p:sp>
        <p:sp>
          <p:nvSpPr>
            <p:cNvPr id="100" name="ZoneTexte 99">
              <a:extLst>
                <a:ext uri="{FF2B5EF4-FFF2-40B4-BE49-F238E27FC236}">
                  <a16:creationId xmlns:a16="http://schemas.microsoft.com/office/drawing/2014/main" id="{81EFF896-365D-3A4F-B225-4740EF750C16}"/>
                </a:ext>
              </a:extLst>
            </p:cNvPr>
            <p:cNvSpPr txBox="1"/>
            <p:nvPr/>
          </p:nvSpPr>
          <p:spPr>
            <a:xfrm>
              <a:off x="4084290" y="167455"/>
              <a:ext cx="7457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i="1" dirty="0">
                  <a:latin typeface="Times New Roman" panose="02020603050405020304" pitchFamily="18" charset="0"/>
                </a:rPr>
                <a:t>atesl3.03</a:t>
              </a:r>
            </a:p>
          </p:txBody>
        </p:sp>
        <p:sp>
          <p:nvSpPr>
            <p:cNvPr id="105" name="Rectangle 104">
              <a:extLst>
                <a:ext uri="{FF2B5EF4-FFF2-40B4-BE49-F238E27FC236}">
                  <a16:creationId xmlns:a16="http://schemas.microsoft.com/office/drawing/2014/main" id="{D54DD62B-20E7-AD48-B1B0-A3E8E56A4CE7}"/>
                </a:ext>
              </a:extLst>
            </p:cNvPr>
            <p:cNvSpPr/>
            <p:nvPr/>
          </p:nvSpPr>
          <p:spPr>
            <a:xfrm>
              <a:off x="4896407" y="269040"/>
              <a:ext cx="94695" cy="98832"/>
            </a:xfrm>
            <a:prstGeom prst="rect">
              <a:avLst/>
            </a:prstGeom>
            <a:solidFill>
              <a:srgbClr val="C74F4D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Times New Roman" panose="02020603050405020304" pitchFamily="18" charset="0"/>
              </a:endParaRPr>
            </a:p>
          </p:txBody>
        </p:sp>
        <p:graphicFrame>
          <p:nvGraphicFramePr>
            <p:cNvPr id="108" name="Graphique 107">
              <a:extLst>
                <a:ext uri="{FF2B5EF4-FFF2-40B4-BE49-F238E27FC236}">
                  <a16:creationId xmlns:a16="http://schemas.microsoft.com/office/drawing/2014/main" id="{EC03AA2D-688D-9944-A00E-AD50130664A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57887084"/>
                </p:ext>
              </p:extLst>
            </p:nvPr>
          </p:nvGraphicFramePr>
          <p:xfrm>
            <a:off x="393689" y="1890190"/>
            <a:ext cx="3394735" cy="150708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109" name="Graphique 108">
              <a:extLst>
                <a:ext uri="{FF2B5EF4-FFF2-40B4-BE49-F238E27FC236}">
                  <a16:creationId xmlns:a16="http://schemas.microsoft.com/office/drawing/2014/main" id="{FE872045-EADE-E247-8CED-9DE095DB0D4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97146291"/>
                </p:ext>
              </p:extLst>
            </p:nvPr>
          </p:nvGraphicFramePr>
          <p:xfrm>
            <a:off x="426348" y="756465"/>
            <a:ext cx="3351633" cy="141557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36" name="ZoneTexte 35"/>
            <p:cNvSpPr txBox="1"/>
            <p:nvPr/>
          </p:nvSpPr>
          <p:spPr>
            <a:xfrm flipH="1">
              <a:off x="940264" y="2053022"/>
              <a:ext cx="194661" cy="283831"/>
            </a:xfrm>
            <a:prstGeom prst="rect">
              <a:avLst/>
            </a:prstGeom>
            <a:noFill/>
          </p:spPr>
          <p:txBody>
            <a:bodyPr wrap="square" lIns="98207" tIns="49103" rIns="98207" bIns="49103" rtlCol="0">
              <a:spAutoFit/>
            </a:bodyPr>
            <a:lstStyle/>
            <a:p>
              <a:r>
                <a:rPr lang="fr-FR" sz="1200" b="1" dirty="0">
                  <a:latin typeface="Times New Roman" panose="02020603050405020304" pitchFamily="18" charset="0"/>
                  <a:cs typeface="Times New Roman"/>
                </a:rPr>
                <a:t>B</a:t>
              </a:r>
            </a:p>
          </p:txBody>
        </p:sp>
        <p:sp>
          <p:nvSpPr>
            <p:cNvPr id="20" name="Ellipse 19">
              <a:extLst>
                <a:ext uri="{FF2B5EF4-FFF2-40B4-BE49-F238E27FC236}">
                  <a16:creationId xmlns:a16="http://schemas.microsoft.com/office/drawing/2014/main" id="{1C1D4247-3358-BD46-AA3F-E09F5D68D8E8}"/>
                </a:ext>
              </a:extLst>
            </p:cNvPr>
            <p:cNvSpPr/>
            <p:nvPr/>
          </p:nvSpPr>
          <p:spPr>
            <a:xfrm>
              <a:off x="2123025" y="269040"/>
              <a:ext cx="114099" cy="109113"/>
            </a:xfrm>
            <a:prstGeom prst="ellipse">
              <a:avLst/>
            </a:prstGeom>
            <a:solidFill>
              <a:srgbClr val="4282BB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Times New Roman" panose="02020603050405020304" pitchFamily="18" charset="0"/>
              </a:endParaRPr>
            </a:p>
          </p:txBody>
        </p:sp>
        <p:sp>
          <p:nvSpPr>
            <p:cNvPr id="23" name="Triangle 22">
              <a:extLst>
                <a:ext uri="{FF2B5EF4-FFF2-40B4-BE49-F238E27FC236}">
                  <a16:creationId xmlns:a16="http://schemas.microsoft.com/office/drawing/2014/main" id="{A33D40B1-1DA6-E944-BB55-7FFE24E5E737}"/>
                </a:ext>
              </a:extLst>
            </p:cNvPr>
            <p:cNvSpPr/>
            <p:nvPr/>
          </p:nvSpPr>
          <p:spPr>
            <a:xfrm>
              <a:off x="2892852" y="231620"/>
              <a:ext cx="102777" cy="122857"/>
            </a:xfrm>
            <a:prstGeom prst="triangle">
              <a:avLst/>
            </a:prstGeom>
            <a:solidFill>
              <a:srgbClr val="A0BE6B"/>
            </a:solidFill>
            <a:ln>
              <a:solidFill>
                <a:srgbClr val="A0BE6B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Times New Roman" panose="02020603050405020304" pitchFamily="18" charset="0"/>
              </a:endParaRPr>
            </a:p>
          </p:txBody>
        </p:sp>
        <p:sp>
          <p:nvSpPr>
            <p:cNvPr id="25" name="Losange 24">
              <a:extLst>
                <a:ext uri="{FF2B5EF4-FFF2-40B4-BE49-F238E27FC236}">
                  <a16:creationId xmlns:a16="http://schemas.microsoft.com/office/drawing/2014/main" id="{C72A5B0D-D554-B449-997A-1F31AB69A0D3}"/>
                </a:ext>
              </a:extLst>
            </p:cNvPr>
            <p:cNvSpPr/>
            <p:nvPr/>
          </p:nvSpPr>
          <p:spPr>
            <a:xfrm>
              <a:off x="4017889" y="235686"/>
              <a:ext cx="93385" cy="140535"/>
            </a:xfrm>
            <a:prstGeom prst="diamond">
              <a:avLst/>
            </a:prstGeom>
            <a:solidFill>
              <a:srgbClr val="8065A0"/>
            </a:solidFill>
            <a:ln>
              <a:solidFill>
                <a:srgbClr val="8065A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>
                <a:latin typeface="Times New Roman" panose="02020603050405020304" pitchFamily="18" charset="0"/>
              </a:endParaRPr>
            </a:p>
          </p:txBody>
        </p:sp>
        <p:sp>
          <p:nvSpPr>
            <p:cNvPr id="34" name="ZoneTexte 1"/>
            <p:cNvSpPr txBox="1"/>
            <p:nvPr/>
          </p:nvSpPr>
          <p:spPr>
            <a:xfrm>
              <a:off x="940264" y="897701"/>
              <a:ext cx="308940" cy="283831"/>
            </a:xfrm>
            <a:prstGeom prst="rect">
              <a:avLst/>
            </a:prstGeom>
            <a:noFill/>
          </p:spPr>
          <p:txBody>
            <a:bodyPr wrap="none" lIns="98207" tIns="49103" rIns="98207" bIns="49103" rtlCol="0">
              <a:spAutoFit/>
            </a:bodyPr>
            <a:lstStyle/>
            <a:p>
              <a:r>
                <a:rPr lang="fr-FR" sz="1200" b="1" dirty="0">
                  <a:latin typeface="Times New Roman" panose="02020603050405020304" pitchFamily="18" charset="0"/>
                  <a:cs typeface="Times New Roman"/>
                </a:rPr>
                <a:t>A</a:t>
              </a:r>
            </a:p>
          </p:txBody>
        </p:sp>
        <p:graphicFrame>
          <p:nvGraphicFramePr>
            <p:cNvPr id="40" name="Graphique 39">
              <a:extLst>
                <a:ext uri="{FF2B5EF4-FFF2-40B4-BE49-F238E27FC236}">
                  <a16:creationId xmlns:a16="http://schemas.microsoft.com/office/drawing/2014/main" id="{36D57B8C-B916-3A43-910C-9E5EB21487D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85358977"/>
                </p:ext>
              </p:extLst>
            </p:nvPr>
          </p:nvGraphicFramePr>
          <p:xfrm>
            <a:off x="415906" y="4429319"/>
            <a:ext cx="3372518" cy="132743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graphicFrame>
          <p:nvGraphicFramePr>
            <p:cNvPr id="41" name="Graphique 40">
              <a:extLst>
                <a:ext uri="{FF2B5EF4-FFF2-40B4-BE49-F238E27FC236}">
                  <a16:creationId xmlns:a16="http://schemas.microsoft.com/office/drawing/2014/main" id="{1C5A7A72-5964-F443-9728-8E78C57F0DE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65118313"/>
                </p:ext>
              </p:extLst>
            </p:nvPr>
          </p:nvGraphicFramePr>
          <p:xfrm>
            <a:off x="3790851" y="4526745"/>
            <a:ext cx="3602649" cy="124851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graphicFrame>
          <p:nvGraphicFramePr>
            <p:cNvPr id="42" name="Graphique 41">
              <a:extLst>
                <a:ext uri="{FF2B5EF4-FFF2-40B4-BE49-F238E27FC236}">
                  <a16:creationId xmlns:a16="http://schemas.microsoft.com/office/drawing/2014/main" id="{E5152174-463B-164A-A7AD-E016E1CBB9F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81020478"/>
                </p:ext>
              </p:extLst>
            </p:nvPr>
          </p:nvGraphicFramePr>
          <p:xfrm>
            <a:off x="3829809" y="5589286"/>
            <a:ext cx="3524735" cy="139330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graphicFrame>
          <p:nvGraphicFramePr>
            <p:cNvPr id="43" name="Graphique 42">
              <a:extLst>
                <a:ext uri="{FF2B5EF4-FFF2-40B4-BE49-F238E27FC236}">
                  <a16:creationId xmlns:a16="http://schemas.microsoft.com/office/drawing/2014/main" id="{0140DC41-3767-7349-B648-E7273702ABB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98195086"/>
                </p:ext>
              </p:extLst>
            </p:nvPr>
          </p:nvGraphicFramePr>
          <p:xfrm>
            <a:off x="381896" y="5618430"/>
            <a:ext cx="3696795" cy="137978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4"/>
            </a:graphicData>
          </a:graphic>
        </p:graphicFrame>
        <p:graphicFrame>
          <p:nvGraphicFramePr>
            <p:cNvPr id="55" name="Graphique 54">
              <a:extLst>
                <a:ext uri="{FF2B5EF4-FFF2-40B4-BE49-F238E27FC236}">
                  <a16:creationId xmlns:a16="http://schemas.microsoft.com/office/drawing/2014/main" id="{5BC5B794-087A-F84B-BF51-7969EEDDD45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30119361"/>
                </p:ext>
              </p:extLst>
            </p:nvPr>
          </p:nvGraphicFramePr>
          <p:xfrm>
            <a:off x="374409" y="6919765"/>
            <a:ext cx="3506875" cy="129921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5"/>
            </a:graphicData>
          </a:graphic>
        </p:graphicFrame>
        <p:graphicFrame>
          <p:nvGraphicFramePr>
            <p:cNvPr id="57" name="Graphique 56">
              <a:extLst>
                <a:ext uri="{FF2B5EF4-FFF2-40B4-BE49-F238E27FC236}">
                  <a16:creationId xmlns:a16="http://schemas.microsoft.com/office/drawing/2014/main" id="{F3AE1F38-B7C7-B14B-A3D4-F625767B240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13169004"/>
                </p:ext>
              </p:extLst>
            </p:nvPr>
          </p:nvGraphicFramePr>
          <p:xfrm>
            <a:off x="3815462" y="6909765"/>
            <a:ext cx="3667126" cy="129921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6"/>
            </a:graphicData>
          </a:graphic>
        </p:graphicFrame>
        <p:sp>
          <p:nvSpPr>
            <p:cNvPr id="58" name="ZoneTexte 57">
              <a:extLst>
                <a:ext uri="{FF2B5EF4-FFF2-40B4-BE49-F238E27FC236}">
                  <a16:creationId xmlns:a16="http://schemas.microsoft.com/office/drawing/2014/main" id="{407BA2CF-6AD4-A948-9D8A-9DC031102EEA}"/>
                </a:ext>
              </a:extLst>
            </p:cNvPr>
            <p:cNvSpPr txBox="1"/>
            <p:nvPr/>
          </p:nvSpPr>
          <p:spPr>
            <a:xfrm>
              <a:off x="5786455" y="7093349"/>
              <a:ext cx="262452" cy="253053"/>
            </a:xfrm>
            <a:prstGeom prst="rect">
              <a:avLst/>
            </a:prstGeom>
            <a:noFill/>
          </p:spPr>
          <p:txBody>
            <a:bodyPr wrap="none" lIns="98207" tIns="49103" rIns="98207" bIns="49103" rtlCol="0">
              <a:spAutoFit/>
            </a:bodyPr>
            <a:lstStyle/>
            <a:p>
              <a:r>
                <a:rPr lang="fr-FR" sz="1000" b="1" dirty="0">
                  <a:solidFill>
                    <a:schemeClr val="bg1">
                      <a:lumMod val="6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62" name="ZoneTexte 61">
              <a:extLst>
                <a:ext uri="{FF2B5EF4-FFF2-40B4-BE49-F238E27FC236}">
                  <a16:creationId xmlns:a16="http://schemas.microsoft.com/office/drawing/2014/main" id="{28635AE5-8691-E543-9C0E-0A9ED039E3C3}"/>
                </a:ext>
              </a:extLst>
            </p:cNvPr>
            <p:cNvSpPr txBox="1"/>
            <p:nvPr/>
          </p:nvSpPr>
          <p:spPr>
            <a:xfrm>
              <a:off x="5622318" y="7080879"/>
              <a:ext cx="306985" cy="137212"/>
            </a:xfrm>
            <a:prstGeom prst="rect">
              <a:avLst/>
            </a:prstGeom>
            <a:noFill/>
          </p:spPr>
          <p:txBody>
            <a:bodyPr wrap="none" lIns="98207" tIns="49103" rIns="98207" bIns="49103" rtlCol="0">
              <a:spAutoFit/>
            </a:bodyPr>
            <a:lstStyle/>
            <a:p>
              <a:r>
                <a:rPr lang="fr-FR" sz="1000" b="1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63" name="ZoneTexte 62">
              <a:extLst>
                <a:ext uri="{FF2B5EF4-FFF2-40B4-BE49-F238E27FC236}">
                  <a16:creationId xmlns:a16="http://schemas.microsoft.com/office/drawing/2014/main" id="{354573AF-4DE8-9447-AB59-B3525F6EC112}"/>
                </a:ext>
              </a:extLst>
            </p:cNvPr>
            <p:cNvSpPr txBox="1"/>
            <p:nvPr/>
          </p:nvSpPr>
          <p:spPr>
            <a:xfrm>
              <a:off x="4362941" y="6846838"/>
              <a:ext cx="249628" cy="283831"/>
            </a:xfrm>
            <a:prstGeom prst="rect">
              <a:avLst/>
            </a:prstGeom>
            <a:noFill/>
          </p:spPr>
          <p:txBody>
            <a:bodyPr wrap="none" lIns="98207" tIns="49103" rIns="98207" bIns="49103" rtlCol="0">
              <a:spAutoFit/>
            </a:bodyPr>
            <a:lstStyle/>
            <a:p>
              <a:r>
                <a:rPr lang="fr-FR" sz="1200" b="1" dirty="0">
                  <a:latin typeface="Times New Roman" panose="02020603050405020304" pitchFamily="18" charset="0"/>
                  <a:cs typeface="Times New Roman"/>
                </a:rPr>
                <a:t>f</a:t>
              </a:r>
            </a:p>
          </p:txBody>
        </p:sp>
        <p:graphicFrame>
          <p:nvGraphicFramePr>
            <p:cNvPr id="64" name="Graphique 63">
              <a:extLst>
                <a:ext uri="{FF2B5EF4-FFF2-40B4-BE49-F238E27FC236}">
                  <a16:creationId xmlns:a16="http://schemas.microsoft.com/office/drawing/2014/main" id="{CAA5EB56-2995-1443-ADEA-A2340DAD9A7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11475168"/>
                </p:ext>
              </p:extLst>
            </p:nvPr>
          </p:nvGraphicFramePr>
          <p:xfrm>
            <a:off x="4602613" y="7370602"/>
            <a:ext cx="1321864" cy="6119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7"/>
            </a:graphicData>
          </a:graphic>
        </p:graphicFrame>
        <p:sp>
          <p:nvSpPr>
            <p:cNvPr id="67" name="ZoneTexte 66">
              <a:extLst>
                <a:ext uri="{FF2B5EF4-FFF2-40B4-BE49-F238E27FC236}">
                  <a16:creationId xmlns:a16="http://schemas.microsoft.com/office/drawing/2014/main" id="{BD783D52-62F2-E849-8EFA-91C55805B3F7}"/>
                </a:ext>
              </a:extLst>
            </p:cNvPr>
            <p:cNvSpPr txBox="1"/>
            <p:nvPr/>
          </p:nvSpPr>
          <p:spPr>
            <a:xfrm>
              <a:off x="5264304" y="7555570"/>
              <a:ext cx="672811" cy="253053"/>
            </a:xfrm>
            <a:prstGeom prst="rect">
              <a:avLst/>
            </a:prstGeom>
            <a:noFill/>
          </p:spPr>
          <p:txBody>
            <a:bodyPr wrap="square" lIns="98207" tIns="49103" rIns="98207" bIns="49103" rtlCol="0">
              <a:spAutoFit/>
            </a:bodyPr>
            <a:lstStyle/>
            <a:p>
              <a:r>
                <a:rPr lang="fr-FR" sz="1000" b="1" dirty="0">
                  <a:solidFill>
                    <a:schemeClr val="bg1">
                      <a:lumMod val="6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68" name="ZoneTexte 67">
              <a:extLst>
                <a:ext uri="{FF2B5EF4-FFF2-40B4-BE49-F238E27FC236}">
                  <a16:creationId xmlns:a16="http://schemas.microsoft.com/office/drawing/2014/main" id="{4E5E66C0-CC7E-BB4C-A49B-C1A502F9D0A9}"/>
                </a:ext>
              </a:extLst>
            </p:cNvPr>
            <p:cNvSpPr txBox="1"/>
            <p:nvPr/>
          </p:nvSpPr>
          <p:spPr>
            <a:xfrm>
              <a:off x="5001093" y="7542453"/>
              <a:ext cx="262452" cy="253053"/>
            </a:xfrm>
            <a:prstGeom prst="rect">
              <a:avLst/>
            </a:prstGeom>
            <a:noFill/>
          </p:spPr>
          <p:txBody>
            <a:bodyPr wrap="none" lIns="98207" tIns="49103" rIns="98207" bIns="49103" rtlCol="0">
              <a:spAutoFit/>
            </a:bodyPr>
            <a:lstStyle/>
            <a:p>
              <a:r>
                <a:rPr lang="fr-FR" sz="1000" b="1" dirty="0">
                  <a:solidFill>
                    <a:schemeClr val="bg1">
                      <a:lumMod val="65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69" name="ZoneTexte 68">
              <a:extLst>
                <a:ext uri="{FF2B5EF4-FFF2-40B4-BE49-F238E27FC236}">
                  <a16:creationId xmlns:a16="http://schemas.microsoft.com/office/drawing/2014/main" id="{04B5FFDE-099E-4E49-BE8A-08B3F6C81845}"/>
                </a:ext>
              </a:extLst>
            </p:cNvPr>
            <p:cNvSpPr txBox="1"/>
            <p:nvPr/>
          </p:nvSpPr>
          <p:spPr>
            <a:xfrm>
              <a:off x="4475548" y="8053701"/>
              <a:ext cx="467540" cy="83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tIns="0" rIns="36000" bIns="0" rtlCol="0">
              <a:spAutoFit/>
            </a:bodyPr>
            <a:lstStyle/>
            <a:p>
              <a:r>
                <a:rPr lang="fr-FR" sz="100" dirty="0">
                  <a:latin typeface="Times New Roman" panose="02020603050405020304" pitchFamily="18" charset="0"/>
                </a:rPr>
                <a:t>35  36  37  38  39  40  41 42  43   44  45  46  47  48  49  50  51  </a:t>
              </a:r>
            </a:p>
          </p:txBody>
        </p:sp>
        <p:sp>
          <p:nvSpPr>
            <p:cNvPr id="117" name="ZoneTexte 116">
              <a:extLst>
                <a:ext uri="{FF2B5EF4-FFF2-40B4-BE49-F238E27FC236}">
                  <a16:creationId xmlns:a16="http://schemas.microsoft.com/office/drawing/2014/main" id="{7B3003A7-1D5E-F348-A39D-BA39AB99959D}"/>
                </a:ext>
              </a:extLst>
            </p:cNvPr>
            <p:cNvSpPr txBox="1"/>
            <p:nvPr/>
          </p:nvSpPr>
          <p:spPr>
            <a:xfrm>
              <a:off x="5783999" y="7152763"/>
              <a:ext cx="262452" cy="253053"/>
            </a:xfrm>
            <a:prstGeom prst="rect">
              <a:avLst/>
            </a:prstGeom>
            <a:noFill/>
          </p:spPr>
          <p:txBody>
            <a:bodyPr wrap="none" lIns="98207" tIns="49103" rIns="98207" bIns="49103" rtlCol="0">
              <a:spAutoFit/>
            </a:bodyPr>
            <a:lstStyle/>
            <a:p>
              <a:r>
                <a:rPr lang="fr-FR" sz="1000" b="1" dirty="0">
                  <a:solidFill>
                    <a:schemeClr val="accent4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118" name="ZoneTexte 117">
              <a:extLst>
                <a:ext uri="{FF2B5EF4-FFF2-40B4-BE49-F238E27FC236}">
                  <a16:creationId xmlns:a16="http://schemas.microsoft.com/office/drawing/2014/main" id="{1974A018-58B8-1647-900A-CBA31587CBA7}"/>
                </a:ext>
              </a:extLst>
            </p:cNvPr>
            <p:cNvSpPr txBox="1"/>
            <p:nvPr/>
          </p:nvSpPr>
          <p:spPr>
            <a:xfrm>
              <a:off x="5783999" y="7220878"/>
              <a:ext cx="262452" cy="253053"/>
            </a:xfrm>
            <a:prstGeom prst="rect">
              <a:avLst/>
            </a:prstGeom>
            <a:noFill/>
          </p:spPr>
          <p:txBody>
            <a:bodyPr wrap="none" lIns="98207" tIns="49103" rIns="98207" bIns="49103" rtlCol="0">
              <a:spAutoFit/>
            </a:bodyPr>
            <a:lstStyle/>
            <a:p>
              <a:r>
                <a:rPr lang="fr-FR" sz="1000" b="1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119" name="ZoneTexte 118">
              <a:extLst>
                <a:ext uri="{FF2B5EF4-FFF2-40B4-BE49-F238E27FC236}">
                  <a16:creationId xmlns:a16="http://schemas.microsoft.com/office/drawing/2014/main" id="{23F76676-20DE-8744-8627-305CCE69D5DC}"/>
                </a:ext>
              </a:extLst>
            </p:cNvPr>
            <p:cNvSpPr txBox="1"/>
            <p:nvPr/>
          </p:nvSpPr>
          <p:spPr>
            <a:xfrm>
              <a:off x="5003025" y="7611653"/>
              <a:ext cx="262452" cy="253053"/>
            </a:xfrm>
            <a:prstGeom prst="rect">
              <a:avLst/>
            </a:prstGeom>
            <a:noFill/>
          </p:spPr>
          <p:txBody>
            <a:bodyPr wrap="none" lIns="98207" tIns="49103" rIns="98207" bIns="49103" rtlCol="0">
              <a:spAutoFit/>
            </a:bodyPr>
            <a:lstStyle/>
            <a:p>
              <a:r>
                <a:rPr lang="fr-FR" sz="1000" b="1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120" name="ZoneTexte 119">
              <a:extLst>
                <a:ext uri="{FF2B5EF4-FFF2-40B4-BE49-F238E27FC236}">
                  <a16:creationId xmlns:a16="http://schemas.microsoft.com/office/drawing/2014/main" id="{419671E2-CCFC-1740-A564-EB54842C8AC0}"/>
                </a:ext>
              </a:extLst>
            </p:cNvPr>
            <p:cNvSpPr txBox="1"/>
            <p:nvPr/>
          </p:nvSpPr>
          <p:spPr>
            <a:xfrm>
              <a:off x="5271769" y="7619326"/>
              <a:ext cx="672811" cy="253053"/>
            </a:xfrm>
            <a:prstGeom prst="rect">
              <a:avLst/>
            </a:prstGeom>
            <a:noFill/>
          </p:spPr>
          <p:txBody>
            <a:bodyPr wrap="square" lIns="98207" tIns="49103" rIns="98207" bIns="49103" rtlCol="0">
              <a:spAutoFit/>
            </a:bodyPr>
            <a:lstStyle/>
            <a:p>
              <a:r>
                <a:rPr lang="fr-FR" sz="1000" b="1" dirty="0">
                  <a:solidFill>
                    <a:schemeClr val="accent4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121" name="ZoneTexte 120">
              <a:extLst>
                <a:ext uri="{FF2B5EF4-FFF2-40B4-BE49-F238E27FC236}">
                  <a16:creationId xmlns:a16="http://schemas.microsoft.com/office/drawing/2014/main" id="{89235052-6E0B-5840-818B-E360193D64A7}"/>
                </a:ext>
              </a:extLst>
            </p:cNvPr>
            <p:cNvSpPr txBox="1"/>
            <p:nvPr/>
          </p:nvSpPr>
          <p:spPr>
            <a:xfrm>
              <a:off x="5272377" y="7676564"/>
              <a:ext cx="672811" cy="253053"/>
            </a:xfrm>
            <a:prstGeom prst="rect">
              <a:avLst/>
            </a:prstGeom>
            <a:noFill/>
          </p:spPr>
          <p:txBody>
            <a:bodyPr wrap="square" lIns="98207" tIns="49103" rIns="98207" bIns="49103" rtlCol="0">
              <a:spAutoFit/>
            </a:bodyPr>
            <a:lstStyle/>
            <a:p>
              <a:r>
                <a:rPr lang="fr-FR" sz="1000" b="1" dirty="0">
                  <a:solidFill>
                    <a:schemeClr val="accent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E467AC36-A21F-7940-939C-C1D6420D01A1}"/>
                </a:ext>
              </a:extLst>
            </p:cNvPr>
            <p:cNvSpPr/>
            <p:nvPr/>
          </p:nvSpPr>
          <p:spPr>
            <a:xfrm>
              <a:off x="979103" y="1986309"/>
              <a:ext cx="3030509" cy="904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12" name="Groupe 11">
              <a:extLst>
                <a:ext uri="{FF2B5EF4-FFF2-40B4-BE49-F238E27FC236}">
                  <a16:creationId xmlns:a16="http://schemas.microsoft.com/office/drawing/2014/main" id="{3FF2B0CF-54EE-CD4C-BAEA-E7283AA22837}"/>
                </a:ext>
              </a:extLst>
            </p:cNvPr>
            <p:cNvGrpSpPr/>
            <p:nvPr/>
          </p:nvGrpSpPr>
          <p:grpSpPr>
            <a:xfrm>
              <a:off x="3046207" y="1545650"/>
              <a:ext cx="266810" cy="420266"/>
              <a:chOff x="211080" y="190602"/>
              <a:chExt cx="266810" cy="420266"/>
            </a:xfrm>
          </p:grpSpPr>
          <p:sp>
            <p:nvSpPr>
              <p:cNvPr id="65" name="ZoneTexte 57">
                <a:extLst>
                  <a:ext uri="{FF2B5EF4-FFF2-40B4-BE49-F238E27FC236}">
                    <a16:creationId xmlns:a16="http://schemas.microsoft.com/office/drawing/2014/main" id="{54AD3444-8CC6-124B-876D-1A3664273C6C}"/>
                  </a:ext>
                </a:extLst>
              </p:cNvPr>
              <p:cNvSpPr txBox="1"/>
              <p:nvPr/>
            </p:nvSpPr>
            <p:spPr>
              <a:xfrm>
                <a:off x="212232" y="350120"/>
                <a:ext cx="265658" cy="260748"/>
              </a:xfrm>
              <a:prstGeom prst="rect">
                <a:avLst/>
              </a:prstGeom>
              <a:noFill/>
            </p:spPr>
            <p:txBody>
              <a:bodyPr wrap="none" lIns="98207" tIns="49103" rIns="98207" bIns="49103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fr-FR" sz="1050" b="1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  <p:sp>
            <p:nvSpPr>
              <p:cNvPr id="66" name="ZoneTexte 57">
                <a:extLst>
                  <a:ext uri="{FF2B5EF4-FFF2-40B4-BE49-F238E27FC236}">
                    <a16:creationId xmlns:a16="http://schemas.microsoft.com/office/drawing/2014/main" id="{2E83BEA9-7D26-C040-8765-45FA1872821A}"/>
                  </a:ext>
                </a:extLst>
              </p:cNvPr>
              <p:cNvSpPr txBox="1"/>
              <p:nvPr/>
            </p:nvSpPr>
            <p:spPr>
              <a:xfrm>
                <a:off x="211080" y="190602"/>
                <a:ext cx="265658" cy="260748"/>
              </a:xfrm>
              <a:prstGeom prst="rect">
                <a:avLst/>
              </a:prstGeom>
              <a:noFill/>
            </p:spPr>
            <p:txBody>
              <a:bodyPr wrap="none" lIns="98207" tIns="49103" rIns="98207" bIns="49103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fr-FR" sz="1050" b="1" dirty="0">
                    <a:solidFill>
                      <a:schemeClr val="bg1">
                        <a:lumMod val="6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  <p:sp>
            <p:nvSpPr>
              <p:cNvPr id="94" name="ZoneTexte 57">
                <a:extLst>
                  <a:ext uri="{FF2B5EF4-FFF2-40B4-BE49-F238E27FC236}">
                    <a16:creationId xmlns:a16="http://schemas.microsoft.com/office/drawing/2014/main" id="{3106C5EC-20C5-7442-9EEC-47D72816F7AF}"/>
                  </a:ext>
                </a:extLst>
              </p:cNvPr>
              <p:cNvSpPr txBox="1"/>
              <p:nvPr/>
            </p:nvSpPr>
            <p:spPr>
              <a:xfrm>
                <a:off x="211080" y="261230"/>
                <a:ext cx="265658" cy="260748"/>
              </a:xfrm>
              <a:prstGeom prst="rect">
                <a:avLst/>
              </a:prstGeom>
              <a:noFill/>
            </p:spPr>
            <p:txBody>
              <a:bodyPr wrap="none" lIns="98207" tIns="49103" rIns="98207" bIns="49103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fr-FR" sz="1050" b="1" dirty="0">
                    <a:solidFill>
                      <a:schemeClr val="accent4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</p:grpSp>
        <p:grpSp>
          <p:nvGrpSpPr>
            <p:cNvPr id="95" name="Groupe 94">
              <a:extLst>
                <a:ext uri="{FF2B5EF4-FFF2-40B4-BE49-F238E27FC236}">
                  <a16:creationId xmlns:a16="http://schemas.microsoft.com/office/drawing/2014/main" id="{D9561187-684C-6747-B5E2-C057AB0337F7}"/>
                </a:ext>
              </a:extLst>
            </p:cNvPr>
            <p:cNvGrpSpPr/>
            <p:nvPr/>
          </p:nvGrpSpPr>
          <p:grpSpPr>
            <a:xfrm>
              <a:off x="3208237" y="1496318"/>
              <a:ext cx="266810" cy="420266"/>
              <a:chOff x="211080" y="190602"/>
              <a:chExt cx="266810" cy="420266"/>
            </a:xfrm>
          </p:grpSpPr>
          <p:sp>
            <p:nvSpPr>
              <p:cNvPr id="96" name="ZoneTexte 57">
                <a:extLst>
                  <a:ext uri="{FF2B5EF4-FFF2-40B4-BE49-F238E27FC236}">
                    <a16:creationId xmlns:a16="http://schemas.microsoft.com/office/drawing/2014/main" id="{476976A0-0A97-444B-BCC3-9A55D82F7956}"/>
                  </a:ext>
                </a:extLst>
              </p:cNvPr>
              <p:cNvSpPr txBox="1"/>
              <p:nvPr/>
            </p:nvSpPr>
            <p:spPr>
              <a:xfrm>
                <a:off x="212232" y="350120"/>
                <a:ext cx="265658" cy="260748"/>
              </a:xfrm>
              <a:prstGeom prst="rect">
                <a:avLst/>
              </a:prstGeom>
              <a:noFill/>
            </p:spPr>
            <p:txBody>
              <a:bodyPr wrap="none" lIns="98207" tIns="49103" rIns="98207" bIns="49103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fr-FR" sz="1050" b="1" dirty="0">
                    <a:solidFill>
                      <a:schemeClr val="accent2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  <p:sp>
            <p:nvSpPr>
              <p:cNvPr id="101" name="ZoneTexte 57">
                <a:extLst>
                  <a:ext uri="{FF2B5EF4-FFF2-40B4-BE49-F238E27FC236}">
                    <a16:creationId xmlns:a16="http://schemas.microsoft.com/office/drawing/2014/main" id="{71E1BA34-8BB5-F14A-A984-1273F6818BD2}"/>
                  </a:ext>
                </a:extLst>
              </p:cNvPr>
              <p:cNvSpPr txBox="1"/>
              <p:nvPr/>
            </p:nvSpPr>
            <p:spPr>
              <a:xfrm>
                <a:off x="211080" y="190602"/>
                <a:ext cx="265658" cy="260748"/>
              </a:xfrm>
              <a:prstGeom prst="rect">
                <a:avLst/>
              </a:prstGeom>
              <a:noFill/>
            </p:spPr>
            <p:txBody>
              <a:bodyPr wrap="none" lIns="98207" tIns="49103" rIns="98207" bIns="49103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fr-FR" sz="1050" b="1" dirty="0">
                    <a:solidFill>
                      <a:schemeClr val="bg1">
                        <a:lumMod val="65000"/>
                      </a:schemeClr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  <p:sp>
            <p:nvSpPr>
              <p:cNvPr id="102" name="ZoneTexte 57">
                <a:extLst>
                  <a:ext uri="{FF2B5EF4-FFF2-40B4-BE49-F238E27FC236}">
                    <a16:creationId xmlns:a16="http://schemas.microsoft.com/office/drawing/2014/main" id="{62CFA2DC-D706-2C4A-AA10-271080F22CF1}"/>
                  </a:ext>
                </a:extLst>
              </p:cNvPr>
              <p:cNvSpPr txBox="1"/>
              <p:nvPr/>
            </p:nvSpPr>
            <p:spPr>
              <a:xfrm>
                <a:off x="211080" y="261230"/>
                <a:ext cx="265658" cy="260748"/>
              </a:xfrm>
              <a:prstGeom prst="rect">
                <a:avLst/>
              </a:prstGeom>
              <a:noFill/>
            </p:spPr>
            <p:txBody>
              <a:bodyPr wrap="none" lIns="98207" tIns="49103" rIns="98207" bIns="49103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fr-FR" sz="1050" b="1" dirty="0">
                    <a:solidFill>
                      <a:schemeClr val="accent4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</a:p>
            </p:txBody>
          </p:sp>
        </p:grpSp>
        <p:sp>
          <p:nvSpPr>
            <p:cNvPr id="103" name="Rectangle 102">
              <a:extLst>
                <a:ext uri="{FF2B5EF4-FFF2-40B4-BE49-F238E27FC236}">
                  <a16:creationId xmlns:a16="http://schemas.microsoft.com/office/drawing/2014/main" id="{4F0157A4-0012-6F48-8140-28EBF4D95FE2}"/>
                </a:ext>
              </a:extLst>
            </p:cNvPr>
            <p:cNvSpPr/>
            <p:nvPr/>
          </p:nvSpPr>
          <p:spPr>
            <a:xfrm>
              <a:off x="4411857" y="1965851"/>
              <a:ext cx="3030509" cy="904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04" name="Rectangle 103">
              <a:extLst>
                <a:ext uri="{FF2B5EF4-FFF2-40B4-BE49-F238E27FC236}">
                  <a16:creationId xmlns:a16="http://schemas.microsoft.com/office/drawing/2014/main" id="{B7E386E3-0021-7A46-B578-C7F6014D76CF}"/>
                </a:ext>
              </a:extLst>
            </p:cNvPr>
            <p:cNvSpPr/>
            <p:nvPr/>
          </p:nvSpPr>
          <p:spPr>
            <a:xfrm>
              <a:off x="4391621" y="3179601"/>
              <a:ext cx="3030509" cy="904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06" name="Rectangle 105">
              <a:extLst>
                <a:ext uri="{FF2B5EF4-FFF2-40B4-BE49-F238E27FC236}">
                  <a16:creationId xmlns:a16="http://schemas.microsoft.com/office/drawing/2014/main" id="{7E7CCD2C-557C-924C-9ADF-34C5FCFECEBD}"/>
                </a:ext>
              </a:extLst>
            </p:cNvPr>
            <p:cNvSpPr/>
            <p:nvPr/>
          </p:nvSpPr>
          <p:spPr>
            <a:xfrm>
              <a:off x="4384001" y="4392705"/>
              <a:ext cx="3030509" cy="904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2C0941FF-64FA-1949-B0FB-DBFEE881DE7A}"/>
                </a:ext>
              </a:extLst>
            </p:cNvPr>
            <p:cNvSpPr/>
            <p:nvPr/>
          </p:nvSpPr>
          <p:spPr>
            <a:xfrm>
              <a:off x="4376381" y="5605809"/>
              <a:ext cx="3030509" cy="904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0" name="Rectangle 109">
              <a:extLst>
                <a:ext uri="{FF2B5EF4-FFF2-40B4-BE49-F238E27FC236}">
                  <a16:creationId xmlns:a16="http://schemas.microsoft.com/office/drawing/2014/main" id="{DF1F7BB5-47A3-E54E-8A01-23EC7BE063AD}"/>
                </a:ext>
              </a:extLst>
            </p:cNvPr>
            <p:cNvSpPr/>
            <p:nvPr/>
          </p:nvSpPr>
          <p:spPr>
            <a:xfrm>
              <a:off x="4355045" y="6814341"/>
              <a:ext cx="3030509" cy="904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1" name="Rectangle 110">
              <a:extLst>
                <a:ext uri="{FF2B5EF4-FFF2-40B4-BE49-F238E27FC236}">
                  <a16:creationId xmlns:a16="http://schemas.microsoft.com/office/drawing/2014/main" id="{362B8562-C18A-9749-A47A-D8E34256267F}"/>
                </a:ext>
              </a:extLst>
            </p:cNvPr>
            <p:cNvSpPr/>
            <p:nvPr/>
          </p:nvSpPr>
          <p:spPr>
            <a:xfrm>
              <a:off x="4260557" y="8036589"/>
              <a:ext cx="3030509" cy="904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2" name="Rectangle 111">
              <a:extLst>
                <a:ext uri="{FF2B5EF4-FFF2-40B4-BE49-F238E27FC236}">
                  <a16:creationId xmlns:a16="http://schemas.microsoft.com/office/drawing/2014/main" id="{0C1AB8EA-B4D0-D649-907E-F260312AB342}"/>
                </a:ext>
              </a:extLst>
            </p:cNvPr>
            <p:cNvSpPr/>
            <p:nvPr/>
          </p:nvSpPr>
          <p:spPr>
            <a:xfrm>
              <a:off x="949584" y="8046424"/>
              <a:ext cx="3030509" cy="904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3" name="Rectangle 112">
              <a:extLst>
                <a:ext uri="{FF2B5EF4-FFF2-40B4-BE49-F238E27FC236}">
                  <a16:creationId xmlns:a16="http://schemas.microsoft.com/office/drawing/2014/main" id="{5B654268-2D2C-3248-AC34-0A076958A50C}"/>
                </a:ext>
              </a:extLst>
            </p:cNvPr>
            <p:cNvSpPr/>
            <p:nvPr/>
          </p:nvSpPr>
          <p:spPr>
            <a:xfrm>
              <a:off x="942071" y="6816270"/>
              <a:ext cx="3030509" cy="904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4" name="Rectangle 113">
              <a:extLst>
                <a:ext uri="{FF2B5EF4-FFF2-40B4-BE49-F238E27FC236}">
                  <a16:creationId xmlns:a16="http://schemas.microsoft.com/office/drawing/2014/main" id="{0235A940-35F9-ED42-A12C-A612C2241B7E}"/>
                </a:ext>
              </a:extLst>
            </p:cNvPr>
            <p:cNvSpPr/>
            <p:nvPr/>
          </p:nvSpPr>
          <p:spPr>
            <a:xfrm>
              <a:off x="906760" y="5596024"/>
              <a:ext cx="3030509" cy="904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5" name="Rectangle 114">
              <a:extLst>
                <a:ext uri="{FF2B5EF4-FFF2-40B4-BE49-F238E27FC236}">
                  <a16:creationId xmlns:a16="http://schemas.microsoft.com/office/drawing/2014/main" id="{281D1349-037D-3D44-988B-98653665CBD8}"/>
                </a:ext>
              </a:extLst>
            </p:cNvPr>
            <p:cNvSpPr/>
            <p:nvPr/>
          </p:nvSpPr>
          <p:spPr>
            <a:xfrm>
              <a:off x="896549" y="4403233"/>
              <a:ext cx="3030509" cy="904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16" name="Rectangle 115">
              <a:extLst>
                <a:ext uri="{FF2B5EF4-FFF2-40B4-BE49-F238E27FC236}">
                  <a16:creationId xmlns:a16="http://schemas.microsoft.com/office/drawing/2014/main" id="{6978822D-2066-6A49-B4D9-EEED741DEE9E}"/>
                </a:ext>
              </a:extLst>
            </p:cNvPr>
            <p:cNvSpPr/>
            <p:nvPr/>
          </p:nvSpPr>
          <p:spPr>
            <a:xfrm>
              <a:off x="891414" y="3196631"/>
              <a:ext cx="3030509" cy="904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E88ECF19-A19C-6641-A4C5-B976497AACFC}"/>
                </a:ext>
              </a:extLst>
            </p:cNvPr>
            <p:cNvSpPr txBox="1"/>
            <p:nvPr/>
          </p:nvSpPr>
          <p:spPr>
            <a:xfrm>
              <a:off x="4767490" y="7825534"/>
              <a:ext cx="1080000" cy="14400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fr-FR" sz="1000" dirty="0">
                  <a:latin typeface="Times New Roman" panose="02020603050405020304" pitchFamily="18" charset="0"/>
                </a:rPr>
                <a:t>42      43      44      45</a:t>
              </a:r>
            </a:p>
          </p:txBody>
        </p:sp>
        <p:sp>
          <p:nvSpPr>
            <p:cNvPr id="71" name="ZoneTexte 70">
              <a:extLst>
                <a:ext uri="{FF2B5EF4-FFF2-40B4-BE49-F238E27FC236}">
                  <a16:creationId xmlns:a16="http://schemas.microsoft.com/office/drawing/2014/main" id="{8B798EAD-8AAF-9441-944D-5C2E9E13DBC5}"/>
                </a:ext>
              </a:extLst>
            </p:cNvPr>
            <p:cNvSpPr txBox="1"/>
            <p:nvPr/>
          </p:nvSpPr>
          <p:spPr>
            <a:xfrm>
              <a:off x="4080335" y="3248565"/>
              <a:ext cx="265127" cy="128496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rIns="36000" rtlCol="0">
              <a:spAutoFit/>
            </a:bodyPr>
            <a:lstStyle/>
            <a:p>
              <a:pPr algn="r"/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3</a:t>
              </a:r>
              <a:endParaRPr lang="fr-FR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endParaRPr lang="fr-FR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lang="fr-FR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fr-F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fr-FR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</a:t>
              </a:r>
            </a:p>
            <a:p>
              <a:pPr algn="r"/>
              <a:endParaRPr lang="fr-FR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72" name="ZoneTexte 71">
              <a:extLst>
                <a:ext uri="{FF2B5EF4-FFF2-40B4-BE49-F238E27FC236}">
                  <a16:creationId xmlns:a16="http://schemas.microsoft.com/office/drawing/2014/main" id="{BEDAAF6E-699A-6E4C-9BFF-FFEC34F001AF}"/>
                </a:ext>
              </a:extLst>
            </p:cNvPr>
            <p:cNvSpPr txBox="1"/>
            <p:nvPr/>
          </p:nvSpPr>
          <p:spPr>
            <a:xfrm>
              <a:off x="940264" y="4572624"/>
              <a:ext cx="308940" cy="283831"/>
            </a:xfrm>
            <a:prstGeom prst="rect">
              <a:avLst/>
            </a:prstGeom>
            <a:noFill/>
          </p:spPr>
          <p:txBody>
            <a:bodyPr wrap="none" lIns="98207" tIns="49103" rIns="98207" bIns="49103" rtlCol="0">
              <a:spAutoFit/>
            </a:bodyPr>
            <a:lstStyle/>
            <a:p>
              <a:r>
                <a:rPr lang="fr-FR" sz="1200" b="1" dirty="0">
                  <a:latin typeface="Times New Roman" panose="02020603050405020304" pitchFamily="18" charset="0"/>
                  <a:cs typeface="Times New Roman"/>
                </a:rPr>
                <a:t>D</a:t>
              </a:r>
            </a:p>
          </p:txBody>
        </p:sp>
        <p:sp>
          <p:nvSpPr>
            <p:cNvPr id="73" name="ZoneTexte 72">
              <a:extLst>
                <a:ext uri="{FF2B5EF4-FFF2-40B4-BE49-F238E27FC236}">
                  <a16:creationId xmlns:a16="http://schemas.microsoft.com/office/drawing/2014/main" id="{DBB9861D-6E18-144A-B604-4C9F26F67F74}"/>
                </a:ext>
              </a:extLst>
            </p:cNvPr>
            <p:cNvSpPr txBox="1"/>
            <p:nvPr/>
          </p:nvSpPr>
          <p:spPr>
            <a:xfrm>
              <a:off x="4362941" y="4568742"/>
              <a:ext cx="283292" cy="283831"/>
            </a:xfrm>
            <a:prstGeom prst="rect">
              <a:avLst/>
            </a:prstGeom>
            <a:noFill/>
          </p:spPr>
          <p:txBody>
            <a:bodyPr wrap="none" lIns="98207" tIns="49103" rIns="98207" bIns="49103" rtlCol="0">
              <a:spAutoFit/>
            </a:bodyPr>
            <a:lstStyle/>
            <a:p>
              <a:r>
                <a:rPr lang="fr-FR" sz="1200" b="1" dirty="0">
                  <a:latin typeface="Times New Roman" panose="02020603050405020304" pitchFamily="18" charset="0"/>
                  <a:cs typeface="Times New Roman"/>
                </a:rPr>
                <a:t>d</a:t>
              </a:r>
            </a:p>
          </p:txBody>
        </p:sp>
        <p:sp>
          <p:nvSpPr>
            <p:cNvPr id="74" name="ZoneTexte 73">
              <a:extLst>
                <a:ext uri="{FF2B5EF4-FFF2-40B4-BE49-F238E27FC236}">
                  <a16:creationId xmlns:a16="http://schemas.microsoft.com/office/drawing/2014/main" id="{E92F98FB-14F8-9444-ACDD-5A4145997F7B}"/>
                </a:ext>
              </a:extLst>
            </p:cNvPr>
            <p:cNvSpPr txBox="1"/>
            <p:nvPr/>
          </p:nvSpPr>
          <p:spPr>
            <a:xfrm>
              <a:off x="940264" y="5765120"/>
              <a:ext cx="300924" cy="283831"/>
            </a:xfrm>
            <a:prstGeom prst="rect">
              <a:avLst/>
            </a:prstGeom>
            <a:noFill/>
          </p:spPr>
          <p:txBody>
            <a:bodyPr wrap="none" lIns="98207" tIns="49103" rIns="98207" bIns="49103" rtlCol="0">
              <a:spAutoFit/>
            </a:bodyPr>
            <a:lstStyle/>
            <a:p>
              <a:r>
                <a:rPr lang="fr-FR" sz="1200" b="1" dirty="0">
                  <a:latin typeface="Times New Roman" panose="02020603050405020304" pitchFamily="18" charset="0"/>
                  <a:cs typeface="Times New Roman"/>
                </a:rPr>
                <a:t>E</a:t>
              </a:r>
            </a:p>
          </p:txBody>
        </p:sp>
        <p:sp>
          <p:nvSpPr>
            <p:cNvPr id="75" name="ZoneTexte 74">
              <a:extLst>
                <a:ext uri="{FF2B5EF4-FFF2-40B4-BE49-F238E27FC236}">
                  <a16:creationId xmlns:a16="http://schemas.microsoft.com/office/drawing/2014/main" id="{3792B629-FF33-964F-BBCB-40AFEA8F9348}"/>
                </a:ext>
              </a:extLst>
            </p:cNvPr>
            <p:cNvSpPr txBox="1"/>
            <p:nvPr/>
          </p:nvSpPr>
          <p:spPr>
            <a:xfrm>
              <a:off x="4362941" y="5727174"/>
              <a:ext cx="267262" cy="283831"/>
            </a:xfrm>
            <a:prstGeom prst="rect">
              <a:avLst/>
            </a:prstGeom>
            <a:noFill/>
          </p:spPr>
          <p:txBody>
            <a:bodyPr wrap="none" lIns="98207" tIns="49103" rIns="98207" bIns="49103" rtlCol="0">
              <a:spAutoFit/>
            </a:bodyPr>
            <a:lstStyle/>
            <a:p>
              <a:r>
                <a:rPr lang="fr-FR" sz="1200" b="1" dirty="0">
                  <a:latin typeface="Times New Roman" panose="02020603050405020304" pitchFamily="18" charset="0"/>
                  <a:cs typeface="Times New Roman"/>
                </a:rPr>
                <a:t>e</a:t>
              </a:r>
            </a:p>
          </p:txBody>
        </p:sp>
        <p:sp>
          <p:nvSpPr>
            <p:cNvPr id="76" name="ZoneTexte 75">
              <a:extLst>
                <a:ext uri="{FF2B5EF4-FFF2-40B4-BE49-F238E27FC236}">
                  <a16:creationId xmlns:a16="http://schemas.microsoft.com/office/drawing/2014/main" id="{C887A4A2-6EB1-A144-ABCD-4829B3FBCFCC}"/>
                </a:ext>
              </a:extLst>
            </p:cNvPr>
            <p:cNvSpPr txBox="1"/>
            <p:nvPr/>
          </p:nvSpPr>
          <p:spPr>
            <a:xfrm>
              <a:off x="940264" y="6856697"/>
              <a:ext cx="292910" cy="283831"/>
            </a:xfrm>
            <a:prstGeom prst="rect">
              <a:avLst/>
            </a:prstGeom>
            <a:noFill/>
          </p:spPr>
          <p:txBody>
            <a:bodyPr wrap="none" lIns="98207" tIns="49103" rIns="98207" bIns="49103" rtlCol="0">
              <a:spAutoFit/>
            </a:bodyPr>
            <a:lstStyle/>
            <a:p>
              <a:r>
                <a:rPr lang="fr-FR" sz="1200" b="1" dirty="0">
                  <a:latin typeface="Times New Roman" panose="02020603050405020304" pitchFamily="18" charset="0"/>
                  <a:cs typeface="Times New Roman"/>
                </a:rPr>
                <a:t>F</a:t>
              </a:r>
            </a:p>
          </p:txBody>
        </p:sp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1D1E8EE0-0938-894C-B8B1-5E8750548C8E}"/>
                </a:ext>
              </a:extLst>
            </p:cNvPr>
            <p:cNvSpPr txBox="1"/>
            <p:nvPr/>
          </p:nvSpPr>
          <p:spPr>
            <a:xfrm>
              <a:off x="4934799" y="9578165"/>
              <a:ext cx="12779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err="1">
                  <a:latin typeface="Times New Roman" panose="02020603050405020304" pitchFamily="18" charset="0"/>
                </a:rPr>
                <a:t>Days</a:t>
              </a:r>
              <a:r>
                <a:rPr lang="fr-FR" sz="1200" dirty="0">
                  <a:latin typeface="Times New Roman" panose="02020603050405020304" pitchFamily="18" charset="0"/>
                </a:rPr>
                <a:t> post </a:t>
              </a:r>
              <a:r>
                <a:rPr lang="fr-FR" sz="1200" dirty="0" err="1">
                  <a:latin typeface="Times New Roman" panose="02020603050405020304" pitchFamily="18" charset="0"/>
                </a:rPr>
                <a:t>sowing</a:t>
              </a:r>
              <a:endParaRPr lang="fr-FR" sz="1200" dirty="0">
                <a:latin typeface="Times New Roman" panose="02020603050405020304" pitchFamily="18" charset="0"/>
              </a:endParaRPr>
            </a:p>
          </p:txBody>
        </p:sp>
        <p:sp>
          <p:nvSpPr>
            <p:cNvPr id="81" name="Rectangle 80">
              <a:extLst>
                <a:ext uri="{FF2B5EF4-FFF2-40B4-BE49-F238E27FC236}">
                  <a16:creationId xmlns:a16="http://schemas.microsoft.com/office/drawing/2014/main" id="{C1888FED-6CB3-DF4B-B9DC-5E0463C3BAFA}"/>
                </a:ext>
              </a:extLst>
            </p:cNvPr>
            <p:cNvSpPr/>
            <p:nvPr/>
          </p:nvSpPr>
          <p:spPr>
            <a:xfrm>
              <a:off x="4409474" y="9256278"/>
              <a:ext cx="3030509" cy="904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" name="ZoneTexte 1">
              <a:extLst>
                <a:ext uri="{FF2B5EF4-FFF2-40B4-BE49-F238E27FC236}">
                  <a16:creationId xmlns:a16="http://schemas.microsoft.com/office/drawing/2014/main" id="{1D077F57-6AC6-C84E-86C5-A1B0B3B94C9B}"/>
                </a:ext>
              </a:extLst>
            </p:cNvPr>
            <p:cNvSpPr txBox="1"/>
            <p:nvPr/>
          </p:nvSpPr>
          <p:spPr>
            <a:xfrm>
              <a:off x="4334896" y="9239485"/>
              <a:ext cx="30251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>
                  <a:latin typeface="Times New Roman" panose="02020603050405020304" pitchFamily="18" charset="0"/>
                </a:rPr>
                <a:t>35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36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37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38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39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40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41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42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43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44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45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46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47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48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49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50</a:t>
              </a:r>
            </a:p>
          </p:txBody>
        </p:sp>
        <p:sp>
          <p:nvSpPr>
            <p:cNvPr id="82" name="ZoneTexte 81">
              <a:extLst>
                <a:ext uri="{FF2B5EF4-FFF2-40B4-BE49-F238E27FC236}">
                  <a16:creationId xmlns:a16="http://schemas.microsoft.com/office/drawing/2014/main" id="{222564DF-EAB4-3146-BA51-ACC8D9D75BBF}"/>
                </a:ext>
              </a:extLst>
            </p:cNvPr>
            <p:cNvSpPr txBox="1"/>
            <p:nvPr/>
          </p:nvSpPr>
          <p:spPr>
            <a:xfrm>
              <a:off x="636679" y="3275218"/>
              <a:ext cx="265127" cy="128496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rIns="36000" rtlCol="0">
              <a:spAutoFit/>
            </a:bodyPr>
            <a:lstStyle/>
            <a:p>
              <a:pPr algn="r"/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3</a:t>
              </a:r>
              <a:endParaRPr lang="fr-FR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endParaRPr lang="fr-FR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lang="fr-FR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fr-F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fr-FR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</a:t>
              </a:r>
            </a:p>
            <a:p>
              <a:pPr algn="r"/>
              <a:endParaRPr lang="fr-FR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EB7E123A-CA7C-D14D-BA71-2F05ABF0654F}"/>
                </a:ext>
              </a:extLst>
            </p:cNvPr>
            <p:cNvSpPr/>
            <p:nvPr/>
          </p:nvSpPr>
          <p:spPr>
            <a:xfrm>
              <a:off x="3557016" y="9322830"/>
              <a:ext cx="191547" cy="25211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ZoneTexte 9">
            <a:extLst>
              <a:ext uri="{FF2B5EF4-FFF2-40B4-BE49-F238E27FC236}">
                <a16:creationId xmlns:a16="http://schemas.microsoft.com/office/drawing/2014/main" id="{FA3C6A10-7B65-654E-B690-1AB4EA054640}"/>
              </a:ext>
            </a:extLst>
          </p:cNvPr>
          <p:cNvSpPr txBox="1"/>
          <p:nvPr/>
        </p:nvSpPr>
        <p:spPr>
          <a:xfrm>
            <a:off x="1384427" y="718404"/>
            <a:ext cx="1840887" cy="283831"/>
          </a:xfrm>
          <a:prstGeom prst="rect">
            <a:avLst/>
          </a:prstGeom>
          <a:noFill/>
        </p:spPr>
        <p:txBody>
          <a:bodyPr wrap="square" lIns="98207" tIns="49103" rIns="98207" bIns="49103" rtlCol="0">
            <a:spAutoFit/>
          </a:bodyPr>
          <a:lstStyle/>
          <a:p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ll-Water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nts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5F867B94-DAD3-5E40-90D4-AC708B955CD6}"/>
              </a:ext>
            </a:extLst>
          </p:cNvPr>
          <p:cNvSpPr txBox="1"/>
          <p:nvPr/>
        </p:nvSpPr>
        <p:spPr>
          <a:xfrm>
            <a:off x="4960208" y="675202"/>
            <a:ext cx="1862679" cy="283831"/>
          </a:xfrm>
          <a:prstGeom prst="rect">
            <a:avLst/>
          </a:prstGeom>
          <a:noFill/>
        </p:spPr>
        <p:txBody>
          <a:bodyPr wrap="square" lIns="98207" tIns="49103" rIns="98207" bIns="49103" rtlCol="0">
            <a:spAutoFit/>
          </a:bodyPr>
          <a:lstStyle/>
          <a:p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ter-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priv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nts</a:t>
            </a:r>
          </a:p>
        </p:txBody>
      </p:sp>
      <p:graphicFrame>
        <p:nvGraphicFramePr>
          <p:cNvPr id="20" name="Chart 3">
            <a:extLst>
              <a:ext uri="{FF2B5EF4-FFF2-40B4-BE49-F238E27FC236}">
                <a16:creationId xmlns:a16="http://schemas.microsoft.com/office/drawing/2014/main" id="{6818C49E-97EA-D847-9592-F200BEFB95D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25240823"/>
              </p:ext>
            </p:extLst>
          </p:nvPr>
        </p:nvGraphicFramePr>
        <p:xfrm>
          <a:off x="191058" y="1078941"/>
          <a:ext cx="3600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1" name="Chart 4">
            <a:extLst>
              <a:ext uri="{FF2B5EF4-FFF2-40B4-BE49-F238E27FC236}">
                <a16:creationId xmlns:a16="http://schemas.microsoft.com/office/drawing/2014/main" id="{C3CE8D8A-C77C-ED4D-B194-1F2824336C0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15097615"/>
              </p:ext>
            </p:extLst>
          </p:nvPr>
        </p:nvGraphicFramePr>
        <p:xfrm>
          <a:off x="3974202" y="1003661"/>
          <a:ext cx="3705688" cy="15152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Ellipse 4">
            <a:extLst>
              <a:ext uri="{FF2B5EF4-FFF2-40B4-BE49-F238E27FC236}">
                <a16:creationId xmlns:a16="http://schemas.microsoft.com/office/drawing/2014/main" id="{A7C76CC1-D374-214C-9676-9B6248CC0C17}"/>
              </a:ext>
            </a:extLst>
          </p:cNvPr>
          <p:cNvSpPr/>
          <p:nvPr/>
        </p:nvSpPr>
        <p:spPr>
          <a:xfrm>
            <a:off x="3312335" y="597158"/>
            <a:ext cx="100466" cy="103941"/>
          </a:xfrm>
          <a:prstGeom prst="ellipse">
            <a:avLst/>
          </a:prstGeom>
          <a:solidFill>
            <a:schemeClr val="bg1">
              <a:lumMod val="5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1DAE9DB2-BCCF-6744-A6F9-2D7D20B5A126}"/>
              </a:ext>
            </a:extLst>
          </p:cNvPr>
          <p:cNvSpPr/>
          <p:nvPr/>
        </p:nvSpPr>
        <p:spPr>
          <a:xfrm>
            <a:off x="796976" y="2212770"/>
            <a:ext cx="3030509" cy="904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9787DC7B-84FA-8846-B734-CF486F09179E}"/>
              </a:ext>
            </a:extLst>
          </p:cNvPr>
          <p:cNvSpPr/>
          <p:nvPr/>
        </p:nvSpPr>
        <p:spPr>
          <a:xfrm>
            <a:off x="4598494" y="2227133"/>
            <a:ext cx="3030509" cy="904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4" name="Groupe 3">
            <a:extLst>
              <a:ext uri="{FF2B5EF4-FFF2-40B4-BE49-F238E27FC236}">
                <a16:creationId xmlns:a16="http://schemas.microsoft.com/office/drawing/2014/main" id="{B137A797-B607-A340-90A7-1A8421BFDBE8}"/>
              </a:ext>
            </a:extLst>
          </p:cNvPr>
          <p:cNvGrpSpPr/>
          <p:nvPr/>
        </p:nvGrpSpPr>
        <p:grpSpPr>
          <a:xfrm>
            <a:off x="-21513" y="483568"/>
            <a:ext cx="7847943" cy="9487412"/>
            <a:chOff x="-21513" y="483568"/>
            <a:chExt cx="7847943" cy="9487412"/>
          </a:xfrm>
        </p:grpSpPr>
        <p:graphicFrame>
          <p:nvGraphicFramePr>
            <p:cNvPr id="25" name="Chart 1">
              <a:extLst>
                <a:ext uri="{FF2B5EF4-FFF2-40B4-BE49-F238E27FC236}">
                  <a16:creationId xmlns:a16="http://schemas.microsoft.com/office/drawing/2014/main" id="{00000000-0008-0000-0100-000002000000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683731249"/>
                </p:ext>
              </p:extLst>
            </p:nvPr>
          </p:nvGraphicFramePr>
          <p:xfrm>
            <a:off x="83960" y="2270313"/>
            <a:ext cx="3751520" cy="14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26" name="Chart 2">
              <a:extLst>
                <a:ext uri="{FF2B5EF4-FFF2-40B4-BE49-F238E27FC236}">
                  <a16:creationId xmlns:a16="http://schemas.microsoft.com/office/drawing/2014/main" id="{00000000-0008-0000-0100-000003000000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248595966"/>
                </p:ext>
              </p:extLst>
            </p:nvPr>
          </p:nvGraphicFramePr>
          <p:xfrm>
            <a:off x="3985136" y="2248751"/>
            <a:ext cx="3841294" cy="136957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27" name="Chart 5">
              <a:extLst>
                <a:ext uri="{FF2B5EF4-FFF2-40B4-BE49-F238E27FC236}">
                  <a16:creationId xmlns:a16="http://schemas.microsoft.com/office/drawing/2014/main" id="{00000000-0008-0000-0100-000006000000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983965834"/>
                </p:ext>
              </p:extLst>
            </p:nvPr>
          </p:nvGraphicFramePr>
          <p:xfrm>
            <a:off x="125804" y="3516951"/>
            <a:ext cx="3637857" cy="121193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30" name="Chart 4">
              <a:extLst>
                <a:ext uri="{FF2B5EF4-FFF2-40B4-BE49-F238E27FC236}">
                  <a16:creationId xmlns:a16="http://schemas.microsoft.com/office/drawing/2014/main" id="{00000000-0008-0000-0100-000005000000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925775524"/>
                </p:ext>
              </p:extLst>
            </p:nvPr>
          </p:nvGraphicFramePr>
          <p:xfrm>
            <a:off x="3998958" y="4744440"/>
            <a:ext cx="3813651" cy="117267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31" name="Chart 6">
              <a:extLst>
                <a:ext uri="{FF2B5EF4-FFF2-40B4-BE49-F238E27FC236}">
                  <a16:creationId xmlns:a16="http://schemas.microsoft.com/office/drawing/2014/main" id="{00000000-0008-0000-0100-000007000000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3777962613"/>
                </p:ext>
              </p:extLst>
            </p:nvPr>
          </p:nvGraphicFramePr>
          <p:xfrm>
            <a:off x="4002958" y="3498692"/>
            <a:ext cx="3728257" cy="124845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8" name="Chart 1">
              <a:extLst>
                <a:ext uri="{FF2B5EF4-FFF2-40B4-BE49-F238E27FC236}">
                  <a16:creationId xmlns:a16="http://schemas.microsoft.com/office/drawing/2014/main" id="{5EF2A63A-8B66-144C-985E-A7C292E9BAD4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3719790587"/>
                </p:ext>
              </p:extLst>
            </p:nvPr>
          </p:nvGraphicFramePr>
          <p:xfrm>
            <a:off x="-21513" y="8324966"/>
            <a:ext cx="3871509" cy="160455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graphicFrame>
          <p:nvGraphicFramePr>
            <p:cNvPr id="9" name="Chart 2">
              <a:extLst>
                <a:ext uri="{FF2B5EF4-FFF2-40B4-BE49-F238E27FC236}">
                  <a16:creationId xmlns:a16="http://schemas.microsoft.com/office/drawing/2014/main" id="{1B8C9C34-8437-0D4B-AF68-DB9EF16EF385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3074062230"/>
                </p:ext>
              </p:extLst>
            </p:nvPr>
          </p:nvGraphicFramePr>
          <p:xfrm>
            <a:off x="4090768" y="8240256"/>
            <a:ext cx="3577235" cy="144001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7CBFCA62-BF1D-3C4A-9457-112277EB6BB5}"/>
                </a:ext>
              </a:extLst>
            </p:cNvPr>
            <p:cNvSpPr txBox="1"/>
            <p:nvPr/>
          </p:nvSpPr>
          <p:spPr>
            <a:xfrm>
              <a:off x="3365850" y="495709"/>
              <a:ext cx="5357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>
                  <a:latin typeface="Times New Roman" panose="02020603050405020304" pitchFamily="18" charset="0"/>
                </a:rPr>
                <a:t>Col-0</a:t>
              </a:r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F80644A4-7EE9-024B-8452-7390E027894C}"/>
                </a:ext>
              </a:extLst>
            </p:cNvPr>
            <p:cNvSpPr txBox="1"/>
            <p:nvPr/>
          </p:nvSpPr>
          <p:spPr>
            <a:xfrm>
              <a:off x="4129924" y="489804"/>
              <a:ext cx="10374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i="1" dirty="0">
                  <a:latin typeface="Times New Roman" panose="02020603050405020304" pitchFamily="18" charset="0"/>
                </a:rPr>
                <a:t>atesl3.05/esl3</a:t>
              </a:r>
            </a:p>
          </p:txBody>
        </p:sp>
        <p:graphicFrame>
          <p:nvGraphicFramePr>
            <p:cNvPr id="16" name="Chart 3">
              <a:extLst>
                <a:ext uri="{FF2B5EF4-FFF2-40B4-BE49-F238E27FC236}">
                  <a16:creationId xmlns:a16="http://schemas.microsoft.com/office/drawing/2014/main" id="{D0EE1CBB-7509-324F-9BFC-2D712E6B5AAE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294330581"/>
                </p:ext>
              </p:extLst>
            </p:nvPr>
          </p:nvGraphicFramePr>
          <p:xfrm>
            <a:off x="-21513" y="5955805"/>
            <a:ext cx="3785174" cy="116380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graphicFrame>
          <p:nvGraphicFramePr>
            <p:cNvPr id="17" name="Chart 4">
              <a:extLst>
                <a:ext uri="{FF2B5EF4-FFF2-40B4-BE49-F238E27FC236}">
                  <a16:creationId xmlns:a16="http://schemas.microsoft.com/office/drawing/2014/main" id="{FAE54F52-E1BF-CC49-8227-6A2924D4DBEB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344582746"/>
                </p:ext>
              </p:extLst>
            </p:nvPr>
          </p:nvGraphicFramePr>
          <p:xfrm>
            <a:off x="3922631" y="5979193"/>
            <a:ext cx="3629509" cy="117256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graphicFrame>
          <p:nvGraphicFramePr>
            <p:cNvPr id="18" name="Chart 5">
              <a:extLst>
                <a:ext uri="{FF2B5EF4-FFF2-40B4-BE49-F238E27FC236}">
                  <a16:creationId xmlns:a16="http://schemas.microsoft.com/office/drawing/2014/main" id="{C2F2EA0C-6587-C443-9A4E-01285135096A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523831420"/>
                </p:ext>
              </p:extLst>
            </p:nvPr>
          </p:nvGraphicFramePr>
          <p:xfrm>
            <a:off x="141218" y="7096793"/>
            <a:ext cx="3699681" cy="173521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4"/>
            </a:graphicData>
          </a:graphic>
        </p:graphicFrame>
        <p:graphicFrame>
          <p:nvGraphicFramePr>
            <p:cNvPr id="19" name="Chart 6">
              <a:extLst>
                <a:ext uri="{FF2B5EF4-FFF2-40B4-BE49-F238E27FC236}">
                  <a16:creationId xmlns:a16="http://schemas.microsoft.com/office/drawing/2014/main" id="{30659C0D-2E95-AC4E-AAF5-8C58CDC266A1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2342948402"/>
                </p:ext>
              </p:extLst>
            </p:nvPr>
          </p:nvGraphicFramePr>
          <p:xfrm>
            <a:off x="4103207" y="7147593"/>
            <a:ext cx="3576683" cy="13629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5"/>
            </a:graphicData>
          </a:graphic>
        </p:graphicFrame>
        <p:graphicFrame>
          <p:nvGraphicFramePr>
            <p:cNvPr id="48" name="Chart 3">
              <a:extLst>
                <a:ext uri="{FF2B5EF4-FFF2-40B4-BE49-F238E27FC236}">
                  <a16:creationId xmlns:a16="http://schemas.microsoft.com/office/drawing/2014/main" id="{9C213BB3-5821-7241-822E-259F0EFE34BE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3928110964"/>
                </p:ext>
              </p:extLst>
            </p:nvPr>
          </p:nvGraphicFramePr>
          <p:xfrm>
            <a:off x="266765" y="4744440"/>
            <a:ext cx="3655867" cy="119581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6"/>
            </a:graphicData>
          </a:graphic>
        </p:graphicFrame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26F757E6-405F-6B41-AEAF-F5C8173F59BC}"/>
                </a:ext>
              </a:extLst>
            </p:cNvPr>
            <p:cNvSpPr/>
            <p:nvPr/>
          </p:nvSpPr>
          <p:spPr>
            <a:xfrm>
              <a:off x="7385145" y="9459307"/>
              <a:ext cx="166995" cy="22096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27EA66E8-69F0-AF4E-BC10-14B7AFD95064}"/>
                </a:ext>
              </a:extLst>
            </p:cNvPr>
            <p:cNvSpPr/>
            <p:nvPr/>
          </p:nvSpPr>
          <p:spPr>
            <a:xfrm>
              <a:off x="3598969" y="9459307"/>
              <a:ext cx="166995" cy="22096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6" name="ZoneTexte 55">
              <a:extLst>
                <a:ext uri="{FF2B5EF4-FFF2-40B4-BE49-F238E27FC236}">
                  <a16:creationId xmlns:a16="http://schemas.microsoft.com/office/drawing/2014/main" id="{27E42C4E-E2EB-3C45-8A56-0AC6B3FAF55A}"/>
                </a:ext>
              </a:extLst>
            </p:cNvPr>
            <p:cNvSpPr txBox="1"/>
            <p:nvPr/>
          </p:nvSpPr>
          <p:spPr>
            <a:xfrm>
              <a:off x="501278" y="3523388"/>
              <a:ext cx="324000" cy="126188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1200" dirty="0">
                  <a:latin typeface="Times New Roman" panose="02020603050405020304" pitchFamily="18" charset="0"/>
                </a:rPr>
                <a:t>0.3</a:t>
              </a:r>
            </a:p>
            <a:p>
              <a:endParaRPr lang="fr-FR" sz="900" dirty="0">
                <a:latin typeface="Times New Roman" panose="02020603050405020304" pitchFamily="18" charset="0"/>
              </a:endParaRPr>
            </a:p>
            <a:p>
              <a:r>
                <a:rPr lang="fr-FR" sz="1200" dirty="0">
                  <a:latin typeface="Times New Roman" panose="02020603050405020304" pitchFamily="18" charset="0"/>
                </a:rPr>
                <a:t>0.2</a:t>
              </a:r>
            </a:p>
            <a:p>
              <a:endParaRPr lang="fr-FR" sz="900" dirty="0">
                <a:latin typeface="Times New Roman" panose="02020603050405020304" pitchFamily="18" charset="0"/>
              </a:endParaRPr>
            </a:p>
            <a:p>
              <a:r>
                <a:rPr lang="fr-FR" sz="1200" dirty="0">
                  <a:latin typeface="Times New Roman" panose="02020603050405020304" pitchFamily="18" charset="0"/>
                </a:rPr>
                <a:t>0.1</a:t>
              </a:r>
            </a:p>
            <a:p>
              <a:endParaRPr lang="fr-FR" sz="900" dirty="0">
                <a:latin typeface="Times New Roman" panose="02020603050405020304" pitchFamily="18" charset="0"/>
              </a:endParaRPr>
            </a:p>
            <a:p>
              <a:r>
                <a:rPr lang="fr-FR" sz="1200" dirty="0">
                  <a:latin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57" name="ZoneTexte 56">
              <a:extLst>
                <a:ext uri="{FF2B5EF4-FFF2-40B4-BE49-F238E27FC236}">
                  <a16:creationId xmlns:a16="http://schemas.microsoft.com/office/drawing/2014/main" id="{CF79BDBC-4B70-E945-AA87-030FD1E65615}"/>
                </a:ext>
              </a:extLst>
            </p:cNvPr>
            <p:cNvSpPr txBox="1"/>
            <p:nvPr/>
          </p:nvSpPr>
          <p:spPr>
            <a:xfrm>
              <a:off x="4282154" y="3611604"/>
              <a:ext cx="324000" cy="122400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1200" dirty="0">
                  <a:latin typeface="Times New Roman" panose="02020603050405020304" pitchFamily="18" charset="0"/>
                </a:rPr>
                <a:t>0.3</a:t>
              </a:r>
            </a:p>
            <a:p>
              <a:endParaRPr lang="fr-FR" sz="900" dirty="0">
                <a:latin typeface="Times New Roman" panose="02020603050405020304" pitchFamily="18" charset="0"/>
              </a:endParaRPr>
            </a:p>
            <a:p>
              <a:r>
                <a:rPr lang="fr-FR" sz="1200" dirty="0">
                  <a:latin typeface="Times New Roman" panose="02020603050405020304" pitchFamily="18" charset="0"/>
                </a:rPr>
                <a:t>0.2</a:t>
              </a:r>
            </a:p>
            <a:p>
              <a:endParaRPr lang="fr-FR" sz="900" dirty="0">
                <a:latin typeface="Times New Roman" panose="02020603050405020304" pitchFamily="18" charset="0"/>
              </a:endParaRPr>
            </a:p>
            <a:p>
              <a:r>
                <a:rPr lang="fr-FR" sz="1200" dirty="0">
                  <a:latin typeface="Times New Roman" panose="02020603050405020304" pitchFamily="18" charset="0"/>
                </a:rPr>
                <a:t>0.1</a:t>
              </a:r>
            </a:p>
            <a:p>
              <a:endParaRPr lang="fr-FR" sz="900" dirty="0">
                <a:latin typeface="Times New Roman" panose="02020603050405020304" pitchFamily="18" charset="0"/>
              </a:endParaRPr>
            </a:p>
            <a:p>
              <a:r>
                <a:rPr lang="fr-FR" sz="1200" dirty="0">
                  <a:latin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60" name="ZoneTexte 59">
              <a:extLst>
                <a:ext uri="{FF2B5EF4-FFF2-40B4-BE49-F238E27FC236}">
                  <a16:creationId xmlns:a16="http://schemas.microsoft.com/office/drawing/2014/main" id="{644A33D1-ABBD-8E45-A712-A3E050640ED2}"/>
                </a:ext>
              </a:extLst>
            </p:cNvPr>
            <p:cNvSpPr txBox="1"/>
            <p:nvPr/>
          </p:nvSpPr>
          <p:spPr>
            <a:xfrm rot="16200000">
              <a:off x="110762" y="7463696"/>
              <a:ext cx="70243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</a:rPr>
                <a:t>WC (%)</a:t>
              </a:r>
            </a:p>
            <a:p>
              <a:endParaRPr lang="fr-FR" sz="1200" dirty="0">
                <a:latin typeface="Times New Roman" panose="02020603050405020304" pitchFamily="18" charset="0"/>
              </a:endParaRPr>
            </a:p>
          </p:txBody>
        </p:sp>
        <p:sp>
          <p:nvSpPr>
            <p:cNvPr id="28" name="ZoneTexte 27">
              <a:extLst>
                <a:ext uri="{FF2B5EF4-FFF2-40B4-BE49-F238E27FC236}">
                  <a16:creationId xmlns:a16="http://schemas.microsoft.com/office/drawing/2014/main" id="{C41DB9C6-32FF-9947-893D-0345710ED404}"/>
                </a:ext>
              </a:extLst>
            </p:cNvPr>
            <p:cNvSpPr txBox="1"/>
            <p:nvPr/>
          </p:nvSpPr>
          <p:spPr>
            <a:xfrm>
              <a:off x="5196270" y="9693981"/>
              <a:ext cx="12779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err="1">
                  <a:latin typeface="Times New Roman" panose="02020603050405020304" pitchFamily="18" charset="0"/>
                </a:rPr>
                <a:t>Days</a:t>
              </a:r>
              <a:r>
                <a:rPr lang="fr-FR" sz="1200" dirty="0">
                  <a:latin typeface="Times New Roman" panose="02020603050405020304" pitchFamily="18" charset="0"/>
                </a:rPr>
                <a:t> post </a:t>
              </a:r>
              <a:r>
                <a:rPr lang="fr-FR" sz="1200" dirty="0" err="1">
                  <a:latin typeface="Times New Roman" panose="02020603050405020304" pitchFamily="18" charset="0"/>
                </a:rPr>
                <a:t>sowing</a:t>
              </a:r>
              <a:endParaRPr lang="fr-FR" sz="1200" dirty="0">
                <a:latin typeface="Times New Roman" panose="02020603050405020304" pitchFamily="18" charset="0"/>
              </a:endParaRPr>
            </a:p>
          </p:txBody>
        </p:sp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CC4117CB-BC76-E242-990A-08080F313AE3}"/>
                </a:ext>
              </a:extLst>
            </p:cNvPr>
            <p:cNvSpPr txBox="1"/>
            <p:nvPr/>
          </p:nvSpPr>
          <p:spPr>
            <a:xfrm>
              <a:off x="4559525" y="9413609"/>
              <a:ext cx="30251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>
                  <a:latin typeface="Times New Roman" panose="02020603050405020304" pitchFamily="18" charset="0"/>
                </a:rPr>
                <a:t>35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36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37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38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39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40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41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42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43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44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45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46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47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48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49</a:t>
              </a:r>
              <a:r>
                <a:rPr lang="fr-FR" sz="700" dirty="0">
                  <a:latin typeface="Times New Roman" panose="02020603050405020304" pitchFamily="18" charset="0"/>
                </a:rPr>
                <a:t> </a:t>
              </a:r>
              <a:r>
                <a:rPr lang="fr-FR" sz="1200" dirty="0">
                  <a:latin typeface="Times New Roman" panose="02020603050405020304" pitchFamily="18" charset="0"/>
                </a:rPr>
                <a:t>50</a:t>
              </a: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D564DEC1-BE7D-1B48-8427-551176547F4B}"/>
                </a:ext>
              </a:extLst>
            </p:cNvPr>
            <p:cNvSpPr/>
            <p:nvPr/>
          </p:nvSpPr>
          <p:spPr>
            <a:xfrm>
              <a:off x="793247" y="3426403"/>
              <a:ext cx="3030509" cy="904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62C88F3F-43AA-1645-AA29-D92532ACCFD7}"/>
                </a:ext>
              </a:extLst>
            </p:cNvPr>
            <p:cNvSpPr/>
            <p:nvPr/>
          </p:nvSpPr>
          <p:spPr>
            <a:xfrm>
              <a:off x="784735" y="4638441"/>
              <a:ext cx="3030509" cy="904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9EA9A63D-1FD7-8D4C-889C-3554CA1BD433}"/>
                </a:ext>
              </a:extLst>
            </p:cNvPr>
            <p:cNvSpPr/>
            <p:nvPr/>
          </p:nvSpPr>
          <p:spPr>
            <a:xfrm>
              <a:off x="793246" y="5830778"/>
              <a:ext cx="3030509" cy="904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DC8B823D-AD2C-2044-967E-94CB4074E1F1}"/>
                </a:ext>
              </a:extLst>
            </p:cNvPr>
            <p:cNvSpPr/>
            <p:nvPr/>
          </p:nvSpPr>
          <p:spPr>
            <a:xfrm>
              <a:off x="829571" y="7042163"/>
              <a:ext cx="3030509" cy="904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70C5AA31-C8BE-7B4D-AAED-C61235EFEAD8}"/>
                </a:ext>
              </a:extLst>
            </p:cNvPr>
            <p:cNvSpPr/>
            <p:nvPr/>
          </p:nvSpPr>
          <p:spPr>
            <a:xfrm>
              <a:off x="884284" y="8236338"/>
              <a:ext cx="3030509" cy="904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FC8100D4-1646-AC46-9736-84A6FD257F16}"/>
                </a:ext>
              </a:extLst>
            </p:cNvPr>
            <p:cNvSpPr/>
            <p:nvPr/>
          </p:nvSpPr>
          <p:spPr>
            <a:xfrm>
              <a:off x="4598493" y="3443691"/>
              <a:ext cx="3030509" cy="904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2E8765D8-8B06-F74A-8C28-37FBEAD7AD3B}"/>
                </a:ext>
              </a:extLst>
            </p:cNvPr>
            <p:cNvSpPr/>
            <p:nvPr/>
          </p:nvSpPr>
          <p:spPr>
            <a:xfrm>
              <a:off x="4598492" y="4660249"/>
              <a:ext cx="3030509" cy="904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5483CF4C-0878-E241-9591-E5277D226363}"/>
                </a:ext>
              </a:extLst>
            </p:cNvPr>
            <p:cNvSpPr/>
            <p:nvPr/>
          </p:nvSpPr>
          <p:spPr>
            <a:xfrm>
              <a:off x="4594067" y="5839164"/>
              <a:ext cx="3030509" cy="904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5026128E-E8B5-1144-8065-56F14D5CDD4C}"/>
                </a:ext>
              </a:extLst>
            </p:cNvPr>
            <p:cNvSpPr/>
            <p:nvPr/>
          </p:nvSpPr>
          <p:spPr>
            <a:xfrm>
              <a:off x="4585506" y="7057147"/>
              <a:ext cx="3030509" cy="904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16ED2ADF-B643-284C-A61C-B265D03BEBF4}"/>
                </a:ext>
              </a:extLst>
            </p:cNvPr>
            <p:cNvSpPr/>
            <p:nvPr/>
          </p:nvSpPr>
          <p:spPr>
            <a:xfrm>
              <a:off x="4581244" y="8237459"/>
              <a:ext cx="3030509" cy="904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534BC8D5-4827-174E-B687-C61EA0319D22}"/>
                </a:ext>
              </a:extLst>
            </p:cNvPr>
            <p:cNvSpPr/>
            <p:nvPr/>
          </p:nvSpPr>
          <p:spPr>
            <a:xfrm>
              <a:off x="4588539" y="9389862"/>
              <a:ext cx="3030509" cy="9044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574C4AEB-55DA-4B42-B013-FC338B14F975}"/>
                </a:ext>
              </a:extLst>
            </p:cNvPr>
            <p:cNvSpPr txBox="1"/>
            <p:nvPr/>
          </p:nvSpPr>
          <p:spPr>
            <a:xfrm>
              <a:off x="3965990" y="483568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>
                  <a:solidFill>
                    <a:srgbClr val="FFC000"/>
                  </a:solidFill>
                  <a:latin typeface="Times New Roman" panose="02020603050405020304" pitchFamily="18" charset="0"/>
                </a:rPr>
                <a:t>x</a:t>
              </a:r>
            </a:p>
          </p:txBody>
        </p:sp>
      </p:grpSp>
      <p:sp>
        <p:nvSpPr>
          <p:cNvPr id="46" name="Rectangle 45">
            <a:extLst>
              <a:ext uri="{FF2B5EF4-FFF2-40B4-BE49-F238E27FC236}">
                <a16:creationId xmlns:a16="http://schemas.microsoft.com/office/drawing/2014/main" id="{4FC3CD16-3C46-A645-8019-95C2D5E9D212}"/>
              </a:ext>
            </a:extLst>
          </p:cNvPr>
          <p:cNvSpPr/>
          <p:nvPr/>
        </p:nvSpPr>
        <p:spPr>
          <a:xfrm>
            <a:off x="3117199" y="9895998"/>
            <a:ext cx="209223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5 </a:t>
            </a:r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295895101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4</TotalTime>
  <Words>253</Words>
  <Application>Microsoft Macintosh PowerPoint</Application>
  <PresentationFormat>Personnalisé</PresentationFormat>
  <Paragraphs>108</Paragraphs>
  <Slides>2</Slides>
  <Notes>2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Thème Office</vt:lpstr>
      <vt:lpstr>Présentation PowerPoint</vt:lpstr>
      <vt:lpstr>Présentation PowerPoint</vt:lpstr>
    </vt:vector>
  </TitlesOfParts>
  <Company>Université de Poitiers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Université de Poitiers SFA UFR POITIERS</dc:creator>
  <cp:lastModifiedBy>Utilisateur Microsoft Office</cp:lastModifiedBy>
  <cp:revision>157</cp:revision>
  <cp:lastPrinted>2021-05-11T15:20:45Z</cp:lastPrinted>
  <dcterms:created xsi:type="dcterms:W3CDTF">2017-10-26T20:24:41Z</dcterms:created>
  <dcterms:modified xsi:type="dcterms:W3CDTF">2021-07-08T15:45:21Z</dcterms:modified>
</cp:coreProperties>
</file>